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  <p:sldMasterId id="2147483660" r:id="rId2"/>
  </p:sldMasterIdLst>
  <p:sldIdLst>
    <p:sldId id="256" r:id="rId3"/>
  </p:sldIdLst>
  <p:sldSz cx="6858000" cy="9906000" type="A4"/>
  <p:notesSz cx="6858000" cy="9144000"/>
  <p:defaultTextStyle>
    <a:defPPr>
      <a:defRPr lang="cs-CZ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60" d="100"/>
          <a:sy n="60" d="100"/>
        </p:scale>
        <p:origin x="-2298" y="-72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1.xml"/><Relationship Id="rId7" Type="http://schemas.openxmlformats.org/officeDocument/2006/relationships/tableStyles" Target="tableStyles.xml"/><Relationship Id="rId2" Type="http://schemas.openxmlformats.org/officeDocument/2006/relationships/slideMaster" Target="slideMasters/slideMaster2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1.xlsx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2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7483281999399594"/>
          <c:y val="8.0115179398265415E-2"/>
          <c:w val="0.71813001865041004"/>
          <c:h val="0.64968658752705311"/>
        </c:manualLayout>
      </c:layout>
      <c:scatterChart>
        <c:scatterStyle val="lineMarker"/>
        <c:varyColors val="0"/>
        <c:ser>
          <c:idx val="0"/>
          <c:order val="0"/>
          <c:spPr>
            <a:ln>
              <a:noFill/>
            </a:ln>
          </c:spPr>
          <c:marker>
            <c:symbol val="circle"/>
            <c:size val="2"/>
            <c:spPr>
              <a:noFill/>
              <a:ln>
                <a:solidFill>
                  <a:schemeClr val="tx1"/>
                </a:solidFill>
              </a:ln>
            </c:spPr>
          </c:marker>
          <c:xVal>
            <c:numRef>
              <c:f>datat!$F$2:$F$600</c:f>
              <c:numCache>
                <c:formatCode>General</c:formatCode>
                <c:ptCount val="599"/>
                <c:pt idx="0">
                  <c:v>0.93466820992781718</c:v>
                </c:pt>
                <c:pt idx="1">
                  <c:v>0.93466820992781718</c:v>
                </c:pt>
                <c:pt idx="2">
                  <c:v>0.93887943667849161</c:v>
                </c:pt>
                <c:pt idx="3">
                  <c:v>0.93887943667849161</c:v>
                </c:pt>
                <c:pt idx="4">
                  <c:v>0.93969097769614651</c:v>
                </c:pt>
                <c:pt idx="5">
                  <c:v>0.9404928747138972</c:v>
                </c:pt>
                <c:pt idx="6">
                  <c:v>0.9404928747138972</c:v>
                </c:pt>
                <c:pt idx="7">
                  <c:v>0.94206866603713113</c:v>
                </c:pt>
                <c:pt idx="8">
                  <c:v>0.94206866603713113</c:v>
                </c:pt>
                <c:pt idx="9">
                  <c:v>0.94436561534226349</c:v>
                </c:pt>
                <c:pt idx="10">
                  <c:v>0.94436561534226349</c:v>
                </c:pt>
                <c:pt idx="11">
                  <c:v>0.94436561534226349</c:v>
                </c:pt>
                <c:pt idx="12">
                  <c:v>0.94511428693327026</c:v>
                </c:pt>
                <c:pt idx="13">
                  <c:v>0.94585478995418004</c:v>
                </c:pt>
                <c:pt idx="14">
                  <c:v>0.94585478995418004</c:v>
                </c:pt>
                <c:pt idx="15">
                  <c:v>0.94585478995418004</c:v>
                </c:pt>
                <c:pt idx="16">
                  <c:v>0.94585478995418004</c:v>
                </c:pt>
                <c:pt idx="17">
                  <c:v>0.94658730692345749</c:v>
                </c:pt>
                <c:pt idx="18">
                  <c:v>0.94658730692345749</c:v>
                </c:pt>
                <c:pt idx="19">
                  <c:v>0.94731201424224298</c:v>
                </c:pt>
                <c:pt idx="20">
                  <c:v>0.94731201424224298</c:v>
                </c:pt>
                <c:pt idx="21">
                  <c:v>0.94731201424224298</c:v>
                </c:pt>
                <c:pt idx="22">
                  <c:v>0.94731201424224298</c:v>
                </c:pt>
                <c:pt idx="23">
                  <c:v>0.94731201424224298</c:v>
                </c:pt>
                <c:pt idx="24">
                  <c:v>0.94802908246618312</c:v>
                </c:pt>
                <c:pt idx="25">
                  <c:v>0.94802908246618312</c:v>
                </c:pt>
                <c:pt idx="26">
                  <c:v>0.94873867656228039</c:v>
                </c:pt>
                <c:pt idx="27">
                  <c:v>0.95013607573974268</c:v>
                </c:pt>
                <c:pt idx="28">
                  <c:v>0.95013607573974268</c:v>
                </c:pt>
                <c:pt idx="29">
                  <c:v>0.9508241849329242</c:v>
                </c:pt>
                <c:pt idx="30">
                  <c:v>0.95150542864543453</c:v>
                </c:pt>
                <c:pt idx="31">
                  <c:v>0.95150542864543453</c:v>
                </c:pt>
                <c:pt idx="32">
                  <c:v>0.95150542864543453</c:v>
                </c:pt>
                <c:pt idx="33">
                  <c:v>0.95150542864543453</c:v>
                </c:pt>
                <c:pt idx="34">
                  <c:v>0.95150542864543453</c:v>
                </c:pt>
                <c:pt idx="35">
                  <c:v>0.95217994729420263</c:v>
                </c:pt>
                <c:pt idx="36">
                  <c:v>0.95350934968382206</c:v>
                </c:pt>
                <c:pt idx="37">
                  <c:v>0.95350934968382206</c:v>
                </c:pt>
                <c:pt idx="38">
                  <c:v>0.95350934968382206</c:v>
                </c:pt>
                <c:pt idx="39">
                  <c:v>0.95416449339241294</c:v>
                </c:pt>
                <c:pt idx="40">
                  <c:v>0.95416449339241294</c:v>
                </c:pt>
                <c:pt idx="41">
                  <c:v>0.95481343229805826</c:v>
                </c:pt>
                <c:pt idx="42">
                  <c:v>0.95481343229805826</c:v>
                </c:pt>
                <c:pt idx="43">
                  <c:v>0.95609317429456908</c:v>
                </c:pt>
                <c:pt idx="44">
                  <c:v>0.95609317429456908</c:v>
                </c:pt>
                <c:pt idx="45">
                  <c:v>0.95609317429456908</c:v>
                </c:pt>
                <c:pt idx="46">
                  <c:v>0.9567242080259184</c:v>
                </c:pt>
                <c:pt idx="47">
                  <c:v>0.95734949850127504</c:v>
                </c:pt>
                <c:pt idx="48">
                  <c:v>0.9579691529717026</c:v>
                </c:pt>
                <c:pt idx="49">
                  <c:v>0.9579691529717026</c:v>
                </c:pt>
                <c:pt idx="50">
                  <c:v>0.9579691529717026</c:v>
                </c:pt>
                <c:pt idx="51">
                  <c:v>0.95858327567835611</c:v>
                </c:pt>
                <c:pt idx="52">
                  <c:v>0.95858327567835611</c:v>
                </c:pt>
                <c:pt idx="53">
                  <c:v>0.95858327567835611</c:v>
                </c:pt>
                <c:pt idx="54">
                  <c:v>0.95858327567835611</c:v>
                </c:pt>
                <c:pt idx="55">
                  <c:v>0.95919196796468009</c:v>
                </c:pt>
                <c:pt idx="56">
                  <c:v>0.95919196796468009</c:v>
                </c:pt>
                <c:pt idx="57">
                  <c:v>0.95919196796468009</c:v>
                </c:pt>
                <c:pt idx="58">
                  <c:v>0.95979532838340953</c:v>
                </c:pt>
                <c:pt idx="59">
                  <c:v>0.96039345279866184</c:v>
                </c:pt>
                <c:pt idx="60">
                  <c:v>0.96039345279866184</c:v>
                </c:pt>
                <c:pt idx="61">
                  <c:v>0.96039345279866184</c:v>
                </c:pt>
                <c:pt idx="62">
                  <c:v>0.96157436421242903</c:v>
                </c:pt>
                <c:pt idx="63">
                  <c:v>0.96157436421242903</c:v>
                </c:pt>
                <c:pt idx="64">
                  <c:v>0.96215733035143081</c:v>
                </c:pt>
                <c:pt idx="65">
                  <c:v>0.96215733035143081</c:v>
                </c:pt>
                <c:pt idx="66">
                  <c:v>0.96215733035143081</c:v>
                </c:pt>
                <c:pt idx="67">
                  <c:v>0.96273541894180925</c:v>
                </c:pt>
                <c:pt idx="68">
                  <c:v>0.96273541894180925</c:v>
                </c:pt>
                <c:pt idx="69">
                  <c:v>0.96273541894180925</c:v>
                </c:pt>
                <c:pt idx="70">
                  <c:v>0.96330871378200189</c:v>
                </c:pt>
                <c:pt idx="71">
                  <c:v>0.96330871378200189</c:v>
                </c:pt>
                <c:pt idx="72">
                  <c:v>0.96330871378200189</c:v>
                </c:pt>
                <c:pt idx="73">
                  <c:v>0.96387729650518417</c:v>
                </c:pt>
                <c:pt idx="74">
                  <c:v>0.96387729650518417</c:v>
                </c:pt>
                <c:pt idx="75">
                  <c:v>0.96444124665363817</c:v>
                </c:pt>
                <c:pt idx="76">
                  <c:v>0.96500064174994526</c:v>
                </c:pt>
                <c:pt idx="77">
                  <c:v>0.96500064174994526</c:v>
                </c:pt>
                <c:pt idx="78">
                  <c:v>0.96500064174994526</c:v>
                </c:pt>
                <c:pt idx="79">
                  <c:v>0.96500064174994526</c:v>
                </c:pt>
                <c:pt idx="80">
                  <c:v>0.96500064174994526</c:v>
                </c:pt>
                <c:pt idx="81">
                  <c:v>0.96555555736516441</c:v>
                </c:pt>
                <c:pt idx="82">
                  <c:v>0.96555555736516441</c:v>
                </c:pt>
                <c:pt idx="83">
                  <c:v>0.96555555736516441</c:v>
                </c:pt>
                <c:pt idx="84">
                  <c:v>0.96610606718414871</c:v>
                </c:pt>
                <c:pt idx="85">
                  <c:v>0.9666522430681429</c:v>
                </c:pt>
                <c:pt idx="86">
                  <c:v>0.9666522430681429</c:v>
                </c:pt>
                <c:pt idx="87">
                  <c:v>0.96719415511479723</c:v>
                </c:pt>
                <c:pt idx="88">
                  <c:v>0.96719415511479723</c:v>
                </c:pt>
                <c:pt idx="89">
                  <c:v>0.96719415511479723</c:v>
                </c:pt>
                <c:pt idx="90">
                  <c:v>0.96773187171572395</c:v>
                </c:pt>
                <c:pt idx="91">
                  <c:v>0.96773187171572395</c:v>
                </c:pt>
                <c:pt idx="92">
                  <c:v>0.96773187171572395</c:v>
                </c:pt>
                <c:pt idx="93">
                  <c:v>0.96826545961171828</c:v>
                </c:pt>
                <c:pt idx="94">
                  <c:v>0.96826545961171828</c:v>
                </c:pt>
                <c:pt idx="95">
                  <c:v>0.96826545961171828</c:v>
                </c:pt>
                <c:pt idx="96">
                  <c:v>0.96879498394575514</c:v>
                </c:pt>
                <c:pt idx="97">
                  <c:v>0.96879498394575514</c:v>
                </c:pt>
                <c:pt idx="98">
                  <c:v>0.96879498394575514</c:v>
                </c:pt>
                <c:pt idx="99">
                  <c:v>0.96879498394575514</c:v>
                </c:pt>
                <c:pt idx="100">
                  <c:v>0.96932050831386884</c:v>
                </c:pt>
                <c:pt idx="101">
                  <c:v>0.96932050831386884</c:v>
                </c:pt>
                <c:pt idx="102">
                  <c:v>0.96984209481401806</c:v>
                </c:pt>
                <c:pt idx="103">
                  <c:v>0.96984209481401806</c:v>
                </c:pt>
                <c:pt idx="104">
                  <c:v>0.96984209481401806</c:v>
                </c:pt>
                <c:pt idx="105">
                  <c:v>0.97035980409302924</c:v>
                </c:pt>
                <c:pt idx="106">
                  <c:v>0.97035980409302924</c:v>
                </c:pt>
                <c:pt idx="107">
                  <c:v>0.97087369539170987</c:v>
                </c:pt>
                <c:pt idx="108">
                  <c:v>0.97087369539170987</c:v>
                </c:pt>
                <c:pt idx="109">
                  <c:v>0.97138382658821665</c:v>
                </c:pt>
                <c:pt idx="110">
                  <c:v>0.97189025423975828</c:v>
                </c:pt>
                <c:pt idx="111">
                  <c:v>0.97189025423975828</c:v>
                </c:pt>
                <c:pt idx="112">
                  <c:v>0.97189025423975828</c:v>
                </c:pt>
                <c:pt idx="113">
                  <c:v>0.97239303362271101</c:v>
                </c:pt>
                <c:pt idx="114">
                  <c:v>0.97239303362271101</c:v>
                </c:pt>
                <c:pt idx="115">
                  <c:v>0.97239303362271101</c:v>
                </c:pt>
                <c:pt idx="116">
                  <c:v>0.97239303362271101</c:v>
                </c:pt>
                <c:pt idx="117">
                  <c:v>0.97289221877121634</c:v>
                </c:pt>
                <c:pt idx="118">
                  <c:v>0.97338786251433229</c:v>
                </c:pt>
                <c:pt idx="119">
                  <c:v>0.97388001651180078</c:v>
                </c:pt>
                <c:pt idx="120">
                  <c:v>0.97436873128849366</c:v>
                </c:pt>
                <c:pt idx="121">
                  <c:v>0.97436873128849366</c:v>
                </c:pt>
                <c:pt idx="122">
                  <c:v>0.97436873128849366</c:v>
                </c:pt>
                <c:pt idx="123">
                  <c:v>0.97436873128849366</c:v>
                </c:pt>
                <c:pt idx="124">
                  <c:v>0.97436873128849366</c:v>
                </c:pt>
                <c:pt idx="125">
                  <c:v>0.97533603980257944</c:v>
                </c:pt>
                <c:pt idx="126">
                  <c:v>0.97581472920802437</c:v>
                </c:pt>
                <c:pt idx="127">
                  <c:v>0.97581472920802437</c:v>
                </c:pt>
                <c:pt idx="128">
                  <c:v>0.97581472920802437</c:v>
                </c:pt>
                <c:pt idx="129">
                  <c:v>0.97629017078933111</c:v>
                </c:pt>
                <c:pt idx="130">
                  <c:v>0.97629017078933111</c:v>
                </c:pt>
                <c:pt idx="131">
                  <c:v>0.97629017078933111</c:v>
                </c:pt>
                <c:pt idx="132">
                  <c:v>0.97629017078933111</c:v>
                </c:pt>
                <c:pt idx="133">
                  <c:v>0.97629017078933111</c:v>
                </c:pt>
                <c:pt idx="134">
                  <c:v>0.97676240987137641</c:v>
                </c:pt>
                <c:pt idx="135">
                  <c:v>0.97676240987137641</c:v>
                </c:pt>
                <c:pt idx="136">
                  <c:v>0.97723149082615601</c:v>
                </c:pt>
                <c:pt idx="137">
                  <c:v>0.97723149082615601</c:v>
                </c:pt>
                <c:pt idx="138">
                  <c:v>0.97723149082615601</c:v>
                </c:pt>
                <c:pt idx="139">
                  <c:v>0.97723149082615601</c:v>
                </c:pt>
                <c:pt idx="140">
                  <c:v>0.97769745709945599</c:v>
                </c:pt>
                <c:pt idx="141">
                  <c:v>0.97769745709945599</c:v>
                </c:pt>
                <c:pt idx="142">
                  <c:v>0.97816035123659528</c:v>
                </c:pt>
                <c:pt idx="143">
                  <c:v>0.97816035123659528</c:v>
                </c:pt>
                <c:pt idx="144">
                  <c:v>0.97816035123659528</c:v>
                </c:pt>
                <c:pt idx="145">
                  <c:v>0.97862021490727635</c:v>
                </c:pt>
                <c:pt idx="146">
                  <c:v>0.97862021490727635</c:v>
                </c:pt>
                <c:pt idx="147">
                  <c:v>0.97862021490727635</c:v>
                </c:pt>
                <c:pt idx="148">
                  <c:v>0.97862021490727635</c:v>
                </c:pt>
                <c:pt idx="149">
                  <c:v>0.97862021490727635</c:v>
                </c:pt>
                <c:pt idx="150">
                  <c:v>0.9790770889295819</c:v>
                </c:pt>
                <c:pt idx="151">
                  <c:v>0.9790770889295819</c:v>
                </c:pt>
                <c:pt idx="152">
                  <c:v>0.9790770889295819</c:v>
                </c:pt>
                <c:pt idx="153">
                  <c:v>0.97953101329315295</c:v>
                </c:pt>
                <c:pt idx="154">
                  <c:v>0.97953101329315295</c:v>
                </c:pt>
                <c:pt idx="155">
                  <c:v>0.97953101329315295</c:v>
                </c:pt>
                <c:pt idx="156">
                  <c:v>0.97953101329315295</c:v>
                </c:pt>
                <c:pt idx="157">
                  <c:v>0.97953101329315295</c:v>
                </c:pt>
                <c:pt idx="158">
                  <c:v>0.97998202718158023</c:v>
                </c:pt>
                <c:pt idx="159">
                  <c:v>0.97998202718158023</c:v>
                </c:pt>
                <c:pt idx="160">
                  <c:v>0.97998202718158023</c:v>
                </c:pt>
                <c:pt idx="161">
                  <c:v>0.97998202718158023</c:v>
                </c:pt>
                <c:pt idx="162">
                  <c:v>0.98043016899404245</c:v>
                </c:pt>
                <c:pt idx="163">
                  <c:v>0.98043016899404245</c:v>
                </c:pt>
                <c:pt idx="164">
                  <c:v>0.98043016899404245</c:v>
                </c:pt>
                <c:pt idx="165">
                  <c:v>0.98043016899404245</c:v>
                </c:pt>
                <c:pt idx="166">
                  <c:v>0.98043016899404245</c:v>
                </c:pt>
                <c:pt idx="167">
                  <c:v>0.98087547636622041</c:v>
                </c:pt>
                <c:pt idx="168">
                  <c:v>0.98087547636622041</c:v>
                </c:pt>
                <c:pt idx="169">
                  <c:v>0.98087547636622041</c:v>
                </c:pt>
                <c:pt idx="170">
                  <c:v>0.98131798619051658</c:v>
                </c:pt>
                <c:pt idx="171">
                  <c:v>0.981757734635608</c:v>
                </c:pt>
                <c:pt idx="172">
                  <c:v>0.981757734635608</c:v>
                </c:pt>
                <c:pt idx="173">
                  <c:v>0.981757734635608</c:v>
                </c:pt>
                <c:pt idx="174">
                  <c:v>0.98219475716535742</c:v>
                </c:pt>
                <c:pt idx="175">
                  <c:v>0.98262908855710951</c:v>
                </c:pt>
                <c:pt idx="176">
                  <c:v>0.98262908855710951</c:v>
                </c:pt>
                <c:pt idx="177">
                  <c:v>0.98306076291939504</c:v>
                </c:pt>
                <c:pt idx="178">
                  <c:v>0.98306076291939504</c:v>
                </c:pt>
                <c:pt idx="179">
                  <c:v>0.98306076291939504</c:v>
                </c:pt>
                <c:pt idx="180">
                  <c:v>0.98348981370906574</c:v>
                </c:pt>
                <c:pt idx="181">
                  <c:v>0.98348981370906574</c:v>
                </c:pt>
                <c:pt idx="182">
                  <c:v>0.98348981370906574</c:v>
                </c:pt>
                <c:pt idx="183">
                  <c:v>0.98348981370906574</c:v>
                </c:pt>
                <c:pt idx="184">
                  <c:v>0.98391627374788293</c:v>
                </c:pt>
                <c:pt idx="185">
                  <c:v>0.98391627374788293</c:v>
                </c:pt>
                <c:pt idx="186">
                  <c:v>0.98391627374788293</c:v>
                </c:pt>
                <c:pt idx="187">
                  <c:v>0.98434017523857897</c:v>
                </c:pt>
                <c:pt idx="188">
                  <c:v>0.98434017523857897</c:v>
                </c:pt>
                <c:pt idx="189">
                  <c:v>0.98434017523857897</c:v>
                </c:pt>
                <c:pt idx="190">
                  <c:v>0.98434017523857897</c:v>
                </c:pt>
                <c:pt idx="191">
                  <c:v>0.98476154978041353</c:v>
                </c:pt>
                <c:pt idx="192">
                  <c:v>0.98476154978041353</c:v>
                </c:pt>
                <c:pt idx="193">
                  <c:v>0.98518042838424158</c:v>
                </c:pt>
                <c:pt idx="194">
                  <c:v>0.98559684148711302</c:v>
                </c:pt>
                <c:pt idx="195">
                  <c:v>0.98559684148711302</c:v>
                </c:pt>
                <c:pt idx="196">
                  <c:v>0.98601081896642107</c:v>
                </c:pt>
                <c:pt idx="197">
                  <c:v>0.98642239015361532</c:v>
                </c:pt>
                <c:pt idx="198">
                  <c:v>0.98642239015361532</c:v>
                </c:pt>
                <c:pt idx="199">
                  <c:v>0.98642239015361532</c:v>
                </c:pt>
                <c:pt idx="200">
                  <c:v>0.98683158384749614</c:v>
                </c:pt>
                <c:pt idx="201">
                  <c:v>0.9872384283271054</c:v>
                </c:pt>
                <c:pt idx="202">
                  <c:v>0.98764295136422886</c:v>
                </c:pt>
                <c:pt idx="203">
                  <c:v>0.98764295136422886</c:v>
                </c:pt>
                <c:pt idx="204">
                  <c:v>0.98764295136422886</c:v>
                </c:pt>
                <c:pt idx="205">
                  <c:v>0.98804518023552257</c:v>
                </c:pt>
                <c:pt idx="206">
                  <c:v>0.98804518023552257</c:v>
                </c:pt>
                <c:pt idx="207">
                  <c:v>0.988445141734279</c:v>
                </c:pt>
                <c:pt idx="208">
                  <c:v>0.988445141734279</c:v>
                </c:pt>
                <c:pt idx="209">
                  <c:v>0.988445141734279</c:v>
                </c:pt>
                <c:pt idx="210">
                  <c:v>0.98884286218184414</c:v>
                </c:pt>
                <c:pt idx="211">
                  <c:v>0.98884286218184414</c:v>
                </c:pt>
                <c:pt idx="212">
                  <c:v>0.98884286218184414</c:v>
                </c:pt>
                <c:pt idx="213">
                  <c:v>0.98884286218184414</c:v>
                </c:pt>
                <c:pt idx="214">
                  <c:v>0.98884286218184414</c:v>
                </c:pt>
                <c:pt idx="215">
                  <c:v>0.98923836743869797</c:v>
                </c:pt>
                <c:pt idx="216">
                  <c:v>0.98923836743869797</c:v>
                </c:pt>
                <c:pt idx="217">
                  <c:v>0.98923836743869797</c:v>
                </c:pt>
                <c:pt idx="218">
                  <c:v>0.98923836743869797</c:v>
                </c:pt>
                <c:pt idx="219">
                  <c:v>0.99041184398050908</c:v>
                </c:pt>
                <c:pt idx="220">
                  <c:v>0.99041184398050908</c:v>
                </c:pt>
                <c:pt idx="221">
                  <c:v>0.99041184398050908</c:v>
                </c:pt>
                <c:pt idx="222">
                  <c:v>0.99079873823197928</c:v>
                </c:pt>
                <c:pt idx="223">
                  <c:v>0.99079873823197928</c:v>
                </c:pt>
                <c:pt idx="224">
                  <c:v>0.99079873823197928</c:v>
                </c:pt>
                <c:pt idx="225">
                  <c:v>0.99118354004789644</c:v>
                </c:pt>
                <c:pt idx="226">
                  <c:v>0.99118354004789644</c:v>
                </c:pt>
                <c:pt idx="227">
                  <c:v>0.99156627273884734</c:v>
                </c:pt>
                <c:pt idx="228">
                  <c:v>0.99194695922364085</c:v>
                </c:pt>
                <c:pt idx="229">
                  <c:v>0.99194695922364085</c:v>
                </c:pt>
                <c:pt idx="230">
                  <c:v>0.99270228334353128</c:v>
                </c:pt>
                <c:pt idx="231">
                  <c:v>0.99270228334353128</c:v>
                </c:pt>
                <c:pt idx="232">
                  <c:v>0.99307696493515074</c:v>
                </c:pt>
                <c:pt idx="233">
                  <c:v>0.99307696493515074</c:v>
                </c:pt>
                <c:pt idx="234">
                  <c:v>0.99307696493515074</c:v>
                </c:pt>
                <c:pt idx="235">
                  <c:v>0.99382047437496757</c:v>
                </c:pt>
                <c:pt idx="236">
                  <c:v>0.99418934405418546</c:v>
                </c:pt>
                <c:pt idx="237">
                  <c:v>0.99418934405418546</c:v>
                </c:pt>
                <c:pt idx="238">
                  <c:v>0.99455631769667496</c:v>
                </c:pt>
                <c:pt idx="239">
                  <c:v>0.99455631769667496</c:v>
                </c:pt>
                <c:pt idx="240">
                  <c:v>0.99455631769667496</c:v>
                </c:pt>
                <c:pt idx="241">
                  <c:v>0.99492141538345913</c:v>
                </c:pt>
                <c:pt idx="242">
                  <c:v>0.99492141538345913</c:v>
                </c:pt>
                <c:pt idx="243">
                  <c:v>0.99492141538345913</c:v>
                </c:pt>
                <c:pt idx="244">
                  <c:v>0.99492141538345913</c:v>
                </c:pt>
                <c:pt idx="245">
                  <c:v>0.9952846568746142</c:v>
                </c:pt>
                <c:pt idx="246">
                  <c:v>0.9952846568746142</c:v>
                </c:pt>
                <c:pt idx="247">
                  <c:v>0.99564606161611036</c:v>
                </c:pt>
                <c:pt idx="248">
                  <c:v>0.99600564874647179</c:v>
                </c:pt>
                <c:pt idx="249">
                  <c:v>0.99600564874647179</c:v>
                </c:pt>
                <c:pt idx="250">
                  <c:v>0.99636343710325903</c:v>
                </c:pt>
                <c:pt idx="251">
                  <c:v>0.99636343710325903</c:v>
                </c:pt>
                <c:pt idx="252">
                  <c:v>0.99636343710325903</c:v>
                </c:pt>
                <c:pt idx="253">
                  <c:v>0.99636343710325903</c:v>
                </c:pt>
                <c:pt idx="254">
                  <c:v>0.99636343710325903</c:v>
                </c:pt>
                <c:pt idx="255">
                  <c:v>0.99671944522938227</c:v>
                </c:pt>
                <c:pt idx="256">
                  <c:v>0.99671944522938227</c:v>
                </c:pt>
                <c:pt idx="257">
                  <c:v>0.99671944522938227</c:v>
                </c:pt>
                <c:pt idx="258">
                  <c:v>0.99671944522938227</c:v>
                </c:pt>
                <c:pt idx="259">
                  <c:v>0.99707369137924851</c:v>
                </c:pt>
                <c:pt idx="260">
                  <c:v>0.99707369137924851</c:v>
                </c:pt>
                <c:pt idx="261">
                  <c:v>0.99707369137924851</c:v>
                </c:pt>
                <c:pt idx="262">
                  <c:v>0.99742619352474848</c:v>
                </c:pt>
                <c:pt idx="263">
                  <c:v>0.99742619352474848</c:v>
                </c:pt>
                <c:pt idx="264">
                  <c:v>0.99742619352474848</c:v>
                </c:pt>
                <c:pt idx="265">
                  <c:v>0.99777696936109017</c:v>
                </c:pt>
                <c:pt idx="266">
                  <c:v>0.99777696936109017</c:v>
                </c:pt>
                <c:pt idx="267">
                  <c:v>0.99847341153765867</c:v>
                </c:pt>
                <c:pt idx="268">
                  <c:v>0.99881911193529938</c:v>
                </c:pt>
                <c:pt idx="269">
                  <c:v>0.99881911193529938</c:v>
                </c:pt>
                <c:pt idx="270">
                  <c:v>0.99881911193529938</c:v>
                </c:pt>
                <c:pt idx="271">
                  <c:v>0.99881911193529938</c:v>
                </c:pt>
                <c:pt idx="272">
                  <c:v>0.99916315414926316</c:v>
                </c:pt>
                <c:pt idx="273">
                  <c:v>0.99950555457372647</c:v>
                </c:pt>
                <c:pt idx="274">
                  <c:v>0.99984632935817819</c:v>
                </c:pt>
                <c:pt idx="275">
                  <c:v>1.0001854944122917</c:v>
                </c:pt>
                <c:pt idx="276">
                  <c:v>1.0001854944122917</c:v>
                </c:pt>
                <c:pt idx="277">
                  <c:v>1.0005230654106767</c:v>
                </c:pt>
                <c:pt idx="278">
                  <c:v>1.0008590577975127</c:v>
                </c:pt>
                <c:pt idx="279">
                  <c:v>1.0008590577975127</c:v>
                </c:pt>
                <c:pt idx="280">
                  <c:v>1.0011934867910683</c:v>
                </c:pt>
                <c:pt idx="281">
                  <c:v>1.0011934867910683</c:v>
                </c:pt>
                <c:pt idx="282">
                  <c:v>1.0011934867910683</c:v>
                </c:pt>
                <c:pt idx="283">
                  <c:v>1.0011934867910683</c:v>
                </c:pt>
                <c:pt idx="284">
                  <c:v>1.0011934867910683</c:v>
                </c:pt>
                <c:pt idx="285">
                  <c:v>1.0015263673881121</c:v>
                </c:pt>
                <c:pt idx="286">
                  <c:v>1.0015263673881121</c:v>
                </c:pt>
                <c:pt idx="287">
                  <c:v>1.0018577143682126</c:v>
                </c:pt>
                <c:pt idx="288">
                  <c:v>1.0021875422979367</c:v>
                </c:pt>
                <c:pt idx="289">
                  <c:v>1.0021875422979367</c:v>
                </c:pt>
                <c:pt idx="290">
                  <c:v>1.0021875422979367</c:v>
                </c:pt>
                <c:pt idx="291">
                  <c:v>1.0021875422979367</c:v>
                </c:pt>
                <c:pt idx="292">
                  <c:v>1.0021875422979367</c:v>
                </c:pt>
                <c:pt idx="293">
                  <c:v>1.0021875422979367</c:v>
                </c:pt>
                <c:pt idx="294">
                  <c:v>1.002515865534946</c:v>
                </c:pt>
                <c:pt idx="295">
                  <c:v>1.002515865534946</c:v>
                </c:pt>
                <c:pt idx="296">
                  <c:v>1.002515865534946</c:v>
                </c:pt>
                <c:pt idx="297">
                  <c:v>1.0028426982319942</c:v>
                </c:pt>
                <c:pt idx="298">
                  <c:v>1.0028426982319942</c:v>
                </c:pt>
                <c:pt idx="299">
                  <c:v>1.0031680543408301</c:v>
                </c:pt>
                <c:pt idx="300">
                  <c:v>1.0031680543408301</c:v>
                </c:pt>
                <c:pt idx="301">
                  <c:v>1.0034919476160074</c:v>
                </c:pt>
                <c:pt idx="302">
                  <c:v>1.0038143916186029</c:v>
                </c:pt>
                <c:pt idx="303">
                  <c:v>1.0038143916186029</c:v>
                </c:pt>
                <c:pt idx="304">
                  <c:v>1.0038143916186029</c:v>
                </c:pt>
                <c:pt idx="305">
                  <c:v>1.0044549851046871</c:v>
                </c:pt>
                <c:pt idx="306">
                  <c:v>1.0044549851046871</c:v>
                </c:pt>
                <c:pt idx="307">
                  <c:v>1.0044549851046871</c:v>
                </c:pt>
                <c:pt idx="308">
                  <c:v>1.0057193568500078</c:v>
                </c:pt>
                <c:pt idx="309">
                  <c:v>1.0057193568500078</c:v>
                </c:pt>
                <c:pt idx="310">
                  <c:v>1.0060320201444852</c:v>
                </c:pt>
                <c:pt idx="311">
                  <c:v>1.0060320201444852</c:v>
                </c:pt>
                <c:pt idx="312">
                  <c:v>1.0060320201444852</c:v>
                </c:pt>
                <c:pt idx="313">
                  <c:v>1.0060320201444852</c:v>
                </c:pt>
                <c:pt idx="314">
                  <c:v>1.0063433361084175</c:v>
                </c:pt>
                <c:pt idx="315">
                  <c:v>1.0066533167153071</c:v>
                </c:pt>
                <c:pt idx="316">
                  <c:v>1.0069619737779409</c:v>
                </c:pt>
                <c:pt idx="317">
                  <c:v>1.0078801194774685</c:v>
                </c:pt>
                <c:pt idx="318">
                  <c:v>1.0078801194774685</c:v>
                </c:pt>
                <c:pt idx="319">
                  <c:v>1.0081835973760855</c:v>
                </c:pt>
                <c:pt idx="320">
                  <c:v>1.0081835973760855</c:v>
                </c:pt>
                <c:pt idx="321">
                  <c:v>1.0081835973760855</c:v>
                </c:pt>
                <c:pt idx="322">
                  <c:v>1.0084858084822172</c:v>
                </c:pt>
                <c:pt idx="323">
                  <c:v>1.0084858084822172</c:v>
                </c:pt>
                <c:pt idx="324">
                  <c:v>1.0084858084822172</c:v>
                </c:pt>
                <c:pt idx="325">
                  <c:v>1.008786763702634</c:v>
                </c:pt>
                <c:pt idx="326">
                  <c:v>1.008786763702634</c:v>
                </c:pt>
                <c:pt idx="327">
                  <c:v>1.008786763702634</c:v>
                </c:pt>
                <c:pt idx="328">
                  <c:v>1.008786763702634</c:v>
                </c:pt>
                <c:pt idx="329">
                  <c:v>1.0090864738022527</c:v>
                </c:pt>
                <c:pt idx="330">
                  <c:v>1.0090864738022527</c:v>
                </c:pt>
                <c:pt idx="331">
                  <c:v>1.0093849494066014</c:v>
                </c:pt>
                <c:pt idx="332">
                  <c:v>1.0093849494066014</c:v>
                </c:pt>
                <c:pt idx="333">
                  <c:v>1.0093849494066014</c:v>
                </c:pt>
                <c:pt idx="334">
                  <c:v>1.0096822010042277</c:v>
                </c:pt>
                <c:pt idx="335">
                  <c:v>1.0096822010042277</c:v>
                </c:pt>
                <c:pt idx="336">
                  <c:v>1.0099782389490566</c:v>
                </c:pt>
                <c:pt idx="337">
                  <c:v>1.0102730734626981</c:v>
                </c:pt>
                <c:pt idx="338">
                  <c:v>1.0102730734626981</c:v>
                </c:pt>
                <c:pt idx="339">
                  <c:v>1.0108591724347769</c:v>
                </c:pt>
                <c:pt idx="340">
                  <c:v>1.0111504566949348</c:v>
                </c:pt>
                <c:pt idx="341">
                  <c:v>1.0111504566949348</c:v>
                </c:pt>
                <c:pt idx="342">
                  <c:v>1.0111504566949348</c:v>
                </c:pt>
                <c:pt idx="343">
                  <c:v>1.0111504566949348</c:v>
                </c:pt>
                <c:pt idx="344">
                  <c:v>1.0111504566949348</c:v>
                </c:pt>
                <c:pt idx="345">
                  <c:v>1.0114405771316255</c:v>
                </c:pt>
                <c:pt idx="346">
                  <c:v>1.0114405771316255</c:v>
                </c:pt>
                <c:pt idx="347">
                  <c:v>1.0117295433378011</c:v>
                </c:pt>
                <c:pt idx="348">
                  <c:v>1.0117295433378011</c:v>
                </c:pt>
                <c:pt idx="349">
                  <c:v>1.0120173647869453</c:v>
                </c:pt>
                <c:pt idx="350">
                  <c:v>1.0120173647869453</c:v>
                </c:pt>
                <c:pt idx="351">
                  <c:v>1.0120173647869453</c:v>
                </c:pt>
                <c:pt idx="352">
                  <c:v>1.0125896107226164</c:v>
                </c:pt>
                <c:pt idx="353">
                  <c:v>1.0125896107226164</c:v>
                </c:pt>
                <c:pt idx="354">
                  <c:v>1.0125896107226164</c:v>
                </c:pt>
                <c:pt idx="355">
                  <c:v>1.0134396241332915</c:v>
                </c:pt>
                <c:pt idx="356">
                  <c:v>1.013720769538428</c:v>
                </c:pt>
                <c:pt idx="357">
                  <c:v>1.013720769538428</c:v>
                </c:pt>
                <c:pt idx="358">
                  <c:v>1.013720769538428</c:v>
                </c:pt>
                <c:pt idx="359">
                  <c:v>1.0140008333176336</c:v>
                </c:pt>
                <c:pt idx="360">
                  <c:v>1.0140008333176336</c:v>
                </c:pt>
                <c:pt idx="361">
                  <c:v>1.0140008333176336</c:v>
                </c:pt>
                <c:pt idx="362">
                  <c:v>1.0142798240568298</c:v>
                </c:pt>
                <c:pt idx="363">
                  <c:v>1.0142798240568298</c:v>
                </c:pt>
                <c:pt idx="364">
                  <c:v>1.0145577502389478</c:v>
                </c:pt>
                <c:pt idx="365">
                  <c:v>1.0145577502389478</c:v>
                </c:pt>
                <c:pt idx="366">
                  <c:v>1.0145577502389478</c:v>
                </c:pt>
                <c:pt idx="367">
                  <c:v>1.014834620245578</c:v>
                </c:pt>
                <c:pt idx="368">
                  <c:v>1.014834620245578</c:v>
                </c:pt>
                <c:pt idx="369">
                  <c:v>1.0151104423585866</c:v>
                </c:pt>
                <c:pt idx="370">
                  <c:v>1.015385224761701</c:v>
                </c:pt>
                <c:pt idx="371">
                  <c:v>1.0159317026917469</c:v>
                </c:pt>
                <c:pt idx="372">
                  <c:v>1.0159317026917469</c:v>
                </c:pt>
                <c:pt idx="373">
                  <c:v>1.0159317026917469</c:v>
                </c:pt>
                <c:pt idx="374">
                  <c:v>1.0159317026917469</c:v>
                </c:pt>
                <c:pt idx="375">
                  <c:v>1.0159317026917469</c:v>
                </c:pt>
                <c:pt idx="376">
                  <c:v>1.0159317026917469</c:v>
                </c:pt>
                <c:pt idx="377">
                  <c:v>1.0159317026917469</c:v>
                </c:pt>
                <c:pt idx="378">
                  <c:v>1.016203414109262</c:v>
                </c:pt>
                <c:pt idx="379">
                  <c:v>1.016203414109262</c:v>
                </c:pt>
                <c:pt idx="380">
                  <c:v>1.016203414109262</c:v>
                </c:pt>
                <c:pt idx="381">
                  <c:v>1.016203414109262</c:v>
                </c:pt>
                <c:pt idx="382">
                  <c:v>1.0164741176010048</c:v>
                </c:pt>
                <c:pt idx="383">
                  <c:v>1.0164741176010048</c:v>
                </c:pt>
                <c:pt idx="384">
                  <c:v>1.0167438208827004</c:v>
                </c:pt>
                <c:pt idx="385">
                  <c:v>1.017012531580807</c:v>
                </c:pt>
                <c:pt idx="386">
                  <c:v>1.017012531580807</c:v>
                </c:pt>
                <c:pt idx="387">
                  <c:v>1.0172802572338955</c:v>
                </c:pt>
                <c:pt idx="388">
                  <c:v>1.0175470052940021</c:v>
                </c:pt>
                <c:pt idx="389">
                  <c:v>1.0175470052940021</c:v>
                </c:pt>
                <c:pt idx="390">
                  <c:v>1.0178127831279558</c:v>
                </c:pt>
                <c:pt idx="391">
                  <c:v>1.0180775980186796</c:v>
                </c:pt>
                <c:pt idx="392">
                  <c:v>1.0180775980186796</c:v>
                </c:pt>
                <c:pt idx="393">
                  <c:v>1.018866336628742</c:v>
                </c:pt>
                <c:pt idx="394">
                  <c:v>1.0191273709418216</c:v>
                </c:pt>
                <c:pt idx="395">
                  <c:v>1.0193874775115328</c:v>
                </c:pt>
                <c:pt idx="396">
                  <c:v>1.0193874775115328</c:v>
                </c:pt>
                <c:pt idx="397">
                  <c:v>1.0196466631433383</c:v>
                </c:pt>
                <c:pt idx="398">
                  <c:v>1.0196466631433383</c:v>
                </c:pt>
                <c:pt idx="399">
                  <c:v>1.0199049345672395</c:v>
                </c:pt>
                <c:pt idx="400">
                  <c:v>1.0201622984388947</c:v>
                </c:pt>
                <c:pt idx="401">
                  <c:v>1.0201622984388947</c:v>
                </c:pt>
                <c:pt idx="402">
                  <c:v>1.0201622984388947</c:v>
                </c:pt>
                <c:pt idx="403">
                  <c:v>1.0201622984388947</c:v>
                </c:pt>
                <c:pt idx="404">
                  <c:v>1.0204187613407163</c:v>
                </c:pt>
                <c:pt idx="405">
                  <c:v>1.0206743297829464</c:v>
                </c:pt>
                <c:pt idx="406">
                  <c:v>1.0209290102047159</c:v>
                </c:pt>
                <c:pt idx="407">
                  <c:v>1.0214357323940402</c:v>
                </c:pt>
                <c:pt idx="408">
                  <c:v>1.0216877866935401</c:v>
                </c:pt>
                <c:pt idx="409">
                  <c:v>1.0216877866935401</c:v>
                </c:pt>
                <c:pt idx="410">
                  <c:v>1.021938978038452</c:v>
                </c:pt>
                <c:pt idx="411">
                  <c:v>1.0226874350084108</c:v>
                </c:pt>
                <c:pt idx="412">
                  <c:v>1.023182201639657</c:v>
                </c:pt>
                <c:pt idx="413">
                  <c:v>1.023182201639657</c:v>
                </c:pt>
                <c:pt idx="414">
                  <c:v>1.023428341082619</c:v>
                </c:pt>
                <c:pt idx="415">
                  <c:v>1.0236736589259248</c:v>
                </c:pt>
                <c:pt idx="416">
                  <c:v>1.0239181608311718</c:v>
                </c:pt>
                <c:pt idx="417">
                  <c:v>1.0241618524009715</c:v>
                </c:pt>
                <c:pt idx="418">
                  <c:v>1.0241618524009715</c:v>
                </c:pt>
                <c:pt idx="419">
                  <c:v>1.0244047391797695</c:v>
                </c:pt>
                <c:pt idx="420">
                  <c:v>1.0244047391797695</c:v>
                </c:pt>
                <c:pt idx="421">
                  <c:v>1.0246468266546531</c:v>
                </c:pt>
                <c:pt idx="422">
                  <c:v>1.024888120256144</c:v>
                </c:pt>
                <c:pt idx="423">
                  <c:v>1.024888120256144</c:v>
                </c:pt>
                <c:pt idx="424">
                  <c:v>1.0251286253589775</c:v>
                </c:pt>
                <c:pt idx="425">
                  <c:v>1.0251286253589775</c:v>
                </c:pt>
                <c:pt idx="426">
                  <c:v>1.0253683472828687</c:v>
                </c:pt>
                <c:pt idx="427">
                  <c:v>1.0253683472828687</c:v>
                </c:pt>
                <c:pt idx="428">
                  <c:v>1.0253683472828687</c:v>
                </c:pt>
                <c:pt idx="429">
                  <c:v>1.0256072912932641</c:v>
                </c:pt>
                <c:pt idx="430">
                  <c:v>1.026082866368442</c:v>
                </c:pt>
                <c:pt idx="431">
                  <c:v>1.0265553916505261</c:v>
                </c:pt>
                <c:pt idx="432">
                  <c:v>1.0267905232268546</c:v>
                </c:pt>
                <c:pt idx="433">
                  <c:v>1.0270249073833015</c:v>
                </c:pt>
                <c:pt idx="434">
                  <c:v>1.0272585490254642</c:v>
                </c:pt>
                <c:pt idx="435">
                  <c:v>1.0272585490254642</c:v>
                </c:pt>
                <c:pt idx="436">
                  <c:v>1.0274914530102506</c:v>
                </c:pt>
                <c:pt idx="437">
                  <c:v>1.0277236241465264</c:v>
                </c:pt>
                <c:pt idx="438">
                  <c:v>1.0279550671957494</c:v>
                </c:pt>
                <c:pt idx="439">
                  <c:v>1.0286450747376088</c:v>
                </c:pt>
                <c:pt idx="440">
                  <c:v>1.0286450747376088</c:v>
                </c:pt>
                <c:pt idx="441">
                  <c:v>1.0288736521266912</c:v>
                </c:pt>
                <c:pt idx="442">
                  <c:v>1.0288736521266912</c:v>
                </c:pt>
                <c:pt idx="443">
                  <c:v>1.0288736521266912</c:v>
                </c:pt>
                <c:pt idx="444">
                  <c:v>1.0288736521266912</c:v>
                </c:pt>
                <c:pt idx="445">
                  <c:v>1.0288736521266912</c:v>
                </c:pt>
                <c:pt idx="446">
                  <c:v>1.0288736521266912</c:v>
                </c:pt>
                <c:pt idx="447">
                  <c:v>1.0291015245463997</c:v>
                </c:pt>
                <c:pt idx="448">
                  <c:v>1.0293286964865098</c:v>
                </c:pt>
                <c:pt idx="449">
                  <c:v>1.0295551723935519</c:v>
                </c:pt>
                <c:pt idx="450">
                  <c:v>1.0295551723935519</c:v>
                </c:pt>
                <c:pt idx="451">
                  <c:v>1.0295551723935519</c:v>
                </c:pt>
                <c:pt idx="452">
                  <c:v>1.0295551723935519</c:v>
                </c:pt>
                <c:pt idx="453">
                  <c:v>1.0297809566713694</c:v>
                </c:pt>
                <c:pt idx="454">
                  <c:v>1.0300060536816651</c:v>
                </c:pt>
                <c:pt idx="455">
                  <c:v>1.0302304677445409</c:v>
                </c:pt>
                <c:pt idx="456">
                  <c:v>1.0302304677445409</c:v>
                </c:pt>
                <c:pt idx="457">
                  <c:v>1.0302304677445409</c:v>
                </c:pt>
                <c:pt idx="458">
                  <c:v>1.0304542031390278</c:v>
                </c:pt>
                <c:pt idx="459">
                  <c:v>1.0306772641036079</c:v>
                </c:pt>
                <c:pt idx="460">
                  <c:v>1.0306772641036079</c:v>
                </c:pt>
                <c:pt idx="461">
                  <c:v>1.0306772641036079</c:v>
                </c:pt>
                <c:pt idx="462">
                  <c:v>1.0308996548367284</c:v>
                </c:pt>
                <c:pt idx="463">
                  <c:v>1.0308996548367284</c:v>
                </c:pt>
                <c:pt idx="464">
                  <c:v>1.0311213794973062</c:v>
                </c:pt>
                <c:pt idx="465">
                  <c:v>1.031342442205226</c:v>
                </c:pt>
                <c:pt idx="466">
                  <c:v>1.0317825980503998</c:v>
                </c:pt>
                <c:pt idx="467">
                  <c:v>1.0317825980503998</c:v>
                </c:pt>
                <c:pt idx="468">
                  <c:v>1.0324379679797189</c:v>
                </c:pt>
                <c:pt idx="469">
                  <c:v>1.0326551433642033</c:v>
                </c:pt>
                <c:pt idx="470">
                  <c:v>1.0328716845824994</c:v>
                </c:pt>
                <c:pt idx="471">
                  <c:v>1.0328716845824994</c:v>
                </c:pt>
                <c:pt idx="472">
                  <c:v>1.0328716845824994</c:v>
                </c:pt>
                <c:pt idx="473">
                  <c:v>1.0330875954592345</c:v>
                </c:pt>
                <c:pt idx="474">
                  <c:v>1.0330875954592345</c:v>
                </c:pt>
                <c:pt idx="475">
                  <c:v>1.0335175413125017</c:v>
                </c:pt>
                <c:pt idx="476">
                  <c:v>1.0335175413125017</c:v>
                </c:pt>
                <c:pt idx="477">
                  <c:v>1.0335175413125017</c:v>
                </c:pt>
                <c:pt idx="478">
                  <c:v>1.0337315837655319</c:v>
                </c:pt>
                <c:pt idx="479">
                  <c:v>1.0337315837655319</c:v>
                </c:pt>
                <c:pt idx="480">
                  <c:v>1.0337315837655319</c:v>
                </c:pt>
                <c:pt idx="481">
                  <c:v>1.0339450108308279</c:v>
                </c:pt>
                <c:pt idx="482">
                  <c:v>1.0339450108308279</c:v>
                </c:pt>
                <c:pt idx="483">
                  <c:v>1.0341578261627566</c:v>
                </c:pt>
                <c:pt idx="484">
                  <c:v>1.0343700333828576</c:v>
                </c:pt>
                <c:pt idx="485">
                  <c:v>1.0345816360802389</c:v>
                </c:pt>
                <c:pt idx="486">
                  <c:v>1.0345816360802389</c:v>
                </c:pt>
                <c:pt idx="487">
                  <c:v>1.0347926378119643</c:v>
                </c:pt>
                <c:pt idx="488">
                  <c:v>1.0350030421034357</c:v>
                </c:pt>
                <c:pt idx="489">
                  <c:v>1.0350030421034357</c:v>
                </c:pt>
                <c:pt idx="490">
                  <c:v>1.0352128524487711</c:v>
                </c:pt>
                <c:pt idx="491">
                  <c:v>1.0356307051233014</c:v>
                </c:pt>
                <c:pt idx="492">
                  <c:v>1.0358387542876208</c:v>
                </c:pt>
                <c:pt idx="493">
                  <c:v>1.0364594334730197</c:v>
                </c:pt>
                <c:pt idx="494">
                  <c:v>1.0366651814793528</c:v>
                </c:pt>
                <c:pt idx="495">
                  <c:v>1.0370749794925189</c:v>
                </c:pt>
                <c:pt idx="496">
                  <c:v>1.0372790359287749</c:v>
                </c:pt>
                <c:pt idx="497">
                  <c:v>1.0374825348917327</c:v>
                </c:pt>
                <c:pt idx="498">
                  <c:v>1.0374825348917327</c:v>
                </c:pt>
                <c:pt idx="499">
                  <c:v>1.0378878729554664</c:v>
                </c:pt>
                <c:pt idx="500">
                  <c:v>1.0378878729554664</c:v>
                </c:pt>
                <c:pt idx="501">
                  <c:v>1.0378878729554664</c:v>
                </c:pt>
                <c:pt idx="502">
                  <c:v>1.0380897182682485</c:v>
                </c:pt>
                <c:pt idx="503">
                  <c:v>1.0382910185323544</c:v>
                </c:pt>
                <c:pt idx="504">
                  <c:v>1.0384917767883</c:v>
                </c:pt>
                <c:pt idx="505">
                  <c:v>1.0386919960509398</c:v>
                </c:pt>
                <c:pt idx="506">
                  <c:v>1.0386919960509398</c:v>
                </c:pt>
                <c:pt idx="507">
                  <c:v>1.0386919960509398</c:v>
                </c:pt>
                <c:pt idx="508">
                  <c:v>1.0386919960509398</c:v>
                </c:pt>
                <c:pt idx="509">
                  <c:v>1.0386919960509398</c:v>
                </c:pt>
                <c:pt idx="510">
                  <c:v>1.0390908295291423</c:v>
                </c:pt>
                <c:pt idx="511">
                  <c:v>1.0396851112242631</c:v>
                </c:pt>
                <c:pt idx="512">
                  <c:v>1.0396851112242631</c:v>
                </c:pt>
                <c:pt idx="513">
                  <c:v>1.0398821584379203</c:v>
                </c:pt>
                <c:pt idx="514">
                  <c:v>1.0398821584379203</c:v>
                </c:pt>
                <c:pt idx="515">
                  <c:v>1.0402746999327668</c:v>
                </c:pt>
                <c:pt idx="516">
                  <c:v>1.040470199830059</c:v>
                </c:pt>
                <c:pt idx="517">
                  <c:v>1.0406651895329257</c:v>
                </c:pt>
                <c:pt idx="518">
                  <c:v>1.0408596717921883</c:v>
                </c:pt>
                <c:pt idx="519">
                  <c:v>1.0410536493362255</c:v>
                </c:pt>
                <c:pt idx="520">
                  <c:v>1.0410536493362255</c:v>
                </c:pt>
                <c:pt idx="521">
                  <c:v>1.0412471248712194</c:v>
                </c:pt>
                <c:pt idx="522">
                  <c:v>1.0414401010813965</c:v>
                </c:pt>
                <c:pt idx="523">
                  <c:v>1.0416325806292657</c:v>
                </c:pt>
                <c:pt idx="524">
                  <c:v>1.0418245661558536</c:v>
                </c:pt>
                <c:pt idx="525">
                  <c:v>1.0422070656032674</c:v>
                </c:pt>
                <c:pt idx="526">
                  <c:v>1.0422070656032674</c:v>
                </c:pt>
                <c:pt idx="527">
                  <c:v>1.0423975847008049</c:v>
                </c:pt>
                <c:pt idx="528">
                  <c:v>1.0425876201309325</c:v>
                </c:pt>
                <c:pt idx="529">
                  <c:v>1.0427771744306797</c:v>
                </c:pt>
                <c:pt idx="530">
                  <c:v>1.0427771744306797</c:v>
                </c:pt>
                <c:pt idx="531">
                  <c:v>1.0431548496866772</c:v>
                </c:pt>
                <c:pt idx="532">
                  <c:v>1.0439045360541885</c:v>
                </c:pt>
                <c:pt idx="533">
                  <c:v>1.0440907918131215</c:v>
                </c:pt>
                <c:pt idx="534">
                  <c:v>1.0440907918131215</c:v>
                </c:pt>
                <c:pt idx="535">
                  <c:v>1.0446467992756592</c:v>
                </c:pt>
                <c:pt idx="536">
                  <c:v>1.0448312229750794</c:v>
                </c:pt>
                <c:pt idx="537">
                  <c:v>1.04538179003473</c:v>
                </c:pt>
                <c:pt idx="538">
                  <c:v>1.0455644186204762</c:v>
                </c:pt>
                <c:pt idx="539">
                  <c:v>1.046290523721171</c:v>
                </c:pt>
                <c:pt idx="540">
                  <c:v>1.0464709586697551</c:v>
                </c:pt>
                <c:pt idx="541">
                  <c:v>1.0466509614233528</c:v>
                </c:pt>
                <c:pt idx="542">
                  <c:v>1.0470096788868413</c:v>
                </c:pt>
                <c:pt idx="543">
                  <c:v>1.0471883978274525</c:v>
                </c:pt>
                <c:pt idx="544">
                  <c:v>1.0471883978274525</c:v>
                </c:pt>
                <c:pt idx="545">
                  <c:v>1.0478990569424937</c:v>
                </c:pt>
                <c:pt idx="546">
                  <c:v>1.0478990569424937</c:v>
                </c:pt>
                <c:pt idx="547">
                  <c:v>1.0478990569424937</c:v>
                </c:pt>
                <c:pt idx="548">
                  <c:v>1.0480756778254614</c:v>
                </c:pt>
                <c:pt idx="549">
                  <c:v>1.0480756778254614</c:v>
                </c:pt>
                <c:pt idx="550">
                  <c:v>1.0484276810776139</c:v>
                </c:pt>
                <c:pt idx="551">
                  <c:v>1.0487780462429175</c:v>
                </c:pt>
                <c:pt idx="552">
                  <c:v>1.048952619462918</c:v>
                </c:pt>
                <c:pt idx="553">
                  <c:v>1.048952619462918</c:v>
                </c:pt>
                <c:pt idx="554">
                  <c:v>1.0491267890364866</c:v>
                </c:pt>
                <c:pt idx="555">
                  <c:v>1.0493005568924803</c:v>
                </c:pt>
                <c:pt idx="556">
                  <c:v>1.0499916492323909</c:v>
                </c:pt>
                <c:pt idx="557">
                  <c:v>1.0506764648283833</c:v>
                </c:pt>
                <c:pt idx="558">
                  <c:v>1.0508467017666578</c:v>
                </c:pt>
                <c:pt idx="559">
                  <c:v>1.0510165555303657</c:v>
                </c:pt>
                <c:pt idx="560">
                  <c:v>1.0511860279020637</c:v>
                </c:pt>
                <c:pt idx="561">
                  <c:v>1.0511860279020637</c:v>
                </c:pt>
                <c:pt idx="562">
                  <c:v>1.0515238355370169</c:v>
                </c:pt>
                <c:pt idx="563">
                  <c:v>1.0521949511564448</c:v>
                </c:pt>
                <c:pt idx="564">
                  <c:v>1.0528601583960004</c:v>
                </c:pt>
                <c:pt idx="565">
                  <c:v>1.0531905798507959</c:v>
                </c:pt>
                <c:pt idx="566">
                  <c:v>1.0531905798507959</c:v>
                </c:pt>
                <c:pt idx="567">
                  <c:v>1.0536835211529267</c:v>
                </c:pt>
                <c:pt idx="568">
                  <c:v>1.0543358204761502</c:v>
                </c:pt>
                <c:pt idx="569">
                  <c:v>1.0543358204761502</c:v>
                </c:pt>
                <c:pt idx="570">
                  <c:v>1.0548213830539264</c:v>
                </c:pt>
                <c:pt idx="571">
                  <c:v>1.0548213830539264</c:v>
                </c:pt>
                <c:pt idx="572">
                  <c:v>1.0553038528797285</c:v>
                </c:pt>
                <c:pt idx="573">
                  <c:v>1.0556238012857457</c:v>
                </c:pt>
                <c:pt idx="574">
                  <c:v>1.0556238012857457</c:v>
                </c:pt>
                <c:pt idx="575">
                  <c:v>1.0556238012857457</c:v>
                </c:pt>
                <c:pt idx="576">
                  <c:v>1.0567331072239152</c:v>
                </c:pt>
                <c:pt idx="577">
                  <c:v>1.0581359391754208</c:v>
                </c:pt>
                <c:pt idx="578">
                  <c:v>1.0581359391754208</c:v>
                </c:pt>
                <c:pt idx="579">
                  <c:v>1.0581359391754208</c:v>
                </c:pt>
                <c:pt idx="580">
                  <c:v>1.0582902220390038</c:v>
                </c:pt>
                <c:pt idx="581">
                  <c:v>1.0589042407750635</c:v>
                </c:pt>
                <c:pt idx="582">
                  <c:v>1.0590569737635356</c:v>
                </c:pt>
                <c:pt idx="583">
                  <c:v>1.0599669874328947</c:v>
                </c:pt>
                <c:pt idx="584">
                  <c:v>1.0601176039886195</c:v>
                </c:pt>
                <c:pt idx="585">
                  <c:v>1.060567674108444</c:v>
                </c:pt>
                <c:pt idx="586">
                  <c:v>1.061015100167386</c:v>
                </c:pt>
                <c:pt idx="587">
                  <c:v>1.0620489904004125</c:v>
                </c:pt>
                <c:pt idx="588">
                  <c:v>1.0629241612782827</c:v>
                </c:pt>
                <c:pt idx="589">
                  <c:v>1.063932671516417</c:v>
                </c:pt>
                <c:pt idx="590">
                  <c:v>1.0652100704040877</c:v>
                </c:pt>
                <c:pt idx="591">
                  <c:v>1.0661890603923527</c:v>
                </c:pt>
                <c:pt idx="592">
                  <c:v>1.066742913107545</c:v>
                </c:pt>
                <c:pt idx="593">
                  <c:v>1.0677026242723158</c:v>
                </c:pt>
                <c:pt idx="594">
                  <c:v>1.0718141866119901</c:v>
                </c:pt>
                <c:pt idx="595">
                  <c:v>1.0724572256539335</c:v>
                </c:pt>
                <c:pt idx="596">
                  <c:v>1.0748529748349003</c:v>
                </c:pt>
                <c:pt idx="597">
                  <c:v>1.0758398717132465</c:v>
                </c:pt>
                <c:pt idx="598">
                  <c:v>1.0809389386010504</c:v>
                </c:pt>
              </c:numCache>
            </c:numRef>
          </c:xVal>
          <c:yVal>
            <c:numRef>
              <c:f>datat!$G$2:$G$600</c:f>
              <c:numCache>
                <c:formatCode>General</c:formatCode>
                <c:ptCount val="599"/>
                <c:pt idx="0">
                  <c:v>0.80350318910630392</c:v>
                </c:pt>
                <c:pt idx="1">
                  <c:v>0.79435548969781133</c:v>
                </c:pt>
                <c:pt idx="2">
                  <c:v>0.80329184579448309</c:v>
                </c:pt>
                <c:pt idx="3">
                  <c:v>0.83568862360449769</c:v>
                </c:pt>
                <c:pt idx="4">
                  <c:v>0.82516867623705936</c:v>
                </c:pt>
                <c:pt idx="5">
                  <c:v>0.80778006536632418</c:v>
                </c:pt>
                <c:pt idx="6">
                  <c:v>0.82385312231500774</c:v>
                </c:pt>
                <c:pt idx="7">
                  <c:v>0.90015632017487213</c:v>
                </c:pt>
                <c:pt idx="8">
                  <c:v>0.83109941664468256</c:v>
                </c:pt>
                <c:pt idx="9">
                  <c:v>0.79878228277289498</c:v>
                </c:pt>
                <c:pt idx="10">
                  <c:v>0.86413521867670484</c:v>
                </c:pt>
                <c:pt idx="11">
                  <c:v>0.83175519332671022</c:v>
                </c:pt>
                <c:pt idx="12">
                  <c:v>0.86389216966139204</c:v>
                </c:pt>
                <c:pt idx="13">
                  <c:v>0.80737251542900623</c:v>
                </c:pt>
                <c:pt idx="14">
                  <c:v>0.85800812998529941</c:v>
                </c:pt>
                <c:pt idx="15">
                  <c:v>0.83845697882910886</c:v>
                </c:pt>
                <c:pt idx="16">
                  <c:v>0.80015996448554283</c:v>
                </c:pt>
                <c:pt idx="17">
                  <c:v>0.92417086721452468</c:v>
                </c:pt>
                <c:pt idx="18">
                  <c:v>0.87753515367316692</c:v>
                </c:pt>
                <c:pt idx="19">
                  <c:v>0.7943269409916095</c:v>
                </c:pt>
                <c:pt idx="20">
                  <c:v>0.73002796126945335</c:v>
                </c:pt>
                <c:pt idx="21">
                  <c:v>0.83486585295268634</c:v>
                </c:pt>
                <c:pt idx="22">
                  <c:v>0.84218375342902407</c:v>
                </c:pt>
                <c:pt idx="23">
                  <c:v>0.90694421314299689</c:v>
                </c:pt>
                <c:pt idx="24">
                  <c:v>0.83175519332671022</c:v>
                </c:pt>
                <c:pt idx="25">
                  <c:v>0.80689535835456572</c:v>
                </c:pt>
                <c:pt idx="26">
                  <c:v>0.8196078009483847</c:v>
                </c:pt>
                <c:pt idx="27">
                  <c:v>0.8781098960248821</c:v>
                </c:pt>
                <c:pt idx="28">
                  <c:v>0.89464541002299203</c:v>
                </c:pt>
                <c:pt idx="29">
                  <c:v>0.90449094605343083</c:v>
                </c:pt>
                <c:pt idx="30">
                  <c:v>0.94638764674657394</c:v>
                </c:pt>
                <c:pt idx="31">
                  <c:v>0.89345555805530574</c:v>
                </c:pt>
                <c:pt idx="32">
                  <c:v>0.81968043708919958</c:v>
                </c:pt>
                <c:pt idx="33">
                  <c:v>0.82518133079849576</c:v>
                </c:pt>
                <c:pt idx="34">
                  <c:v>0.91810078002300821</c:v>
                </c:pt>
                <c:pt idx="35">
                  <c:v>0.88377189276021395</c:v>
                </c:pt>
                <c:pt idx="36">
                  <c:v>0.94608507821774079</c:v>
                </c:pt>
                <c:pt idx="37">
                  <c:v>0.79907360819935891</c:v>
                </c:pt>
                <c:pt idx="38">
                  <c:v>0.8435856915021438</c:v>
                </c:pt>
                <c:pt idx="39">
                  <c:v>0.809908846987203</c:v>
                </c:pt>
                <c:pt idx="40">
                  <c:v>0.87274445958955016</c:v>
                </c:pt>
                <c:pt idx="41">
                  <c:v>0.80845638572093614</c:v>
                </c:pt>
                <c:pt idx="42">
                  <c:v>0.86709796031802511</c:v>
                </c:pt>
                <c:pt idx="43">
                  <c:v>0.91217740044490292</c:v>
                </c:pt>
                <c:pt idx="44">
                  <c:v>0.92277931866028118</c:v>
                </c:pt>
                <c:pt idx="45">
                  <c:v>0.87732041901463353</c:v>
                </c:pt>
                <c:pt idx="46">
                  <c:v>0.95350929675047968</c:v>
                </c:pt>
                <c:pt idx="47">
                  <c:v>0.86077809306926911</c:v>
                </c:pt>
                <c:pt idx="48">
                  <c:v>0.92368914921086276</c:v>
                </c:pt>
                <c:pt idx="49">
                  <c:v>0.85800812998529941</c:v>
                </c:pt>
                <c:pt idx="50">
                  <c:v>0.87349267312490586</c:v>
                </c:pt>
                <c:pt idx="51">
                  <c:v>0.8832465481802716</c:v>
                </c:pt>
                <c:pt idx="52">
                  <c:v>0.95464305577388708</c:v>
                </c:pt>
                <c:pt idx="53">
                  <c:v>0.9466351624178575</c:v>
                </c:pt>
                <c:pt idx="54">
                  <c:v>0.892008473331385</c:v>
                </c:pt>
                <c:pt idx="55">
                  <c:v>0.94197891607644912</c:v>
                </c:pt>
                <c:pt idx="56">
                  <c:v>0.89191663534513177</c:v>
                </c:pt>
                <c:pt idx="57">
                  <c:v>0.87721404155621974</c:v>
                </c:pt>
                <c:pt idx="58">
                  <c:v>0.96694953341659806</c:v>
                </c:pt>
                <c:pt idx="59">
                  <c:v>0.92999122970842929</c:v>
                </c:pt>
                <c:pt idx="60">
                  <c:v>0.85251931765027511</c:v>
                </c:pt>
                <c:pt idx="61">
                  <c:v>0.88351895098102351</c:v>
                </c:pt>
                <c:pt idx="62">
                  <c:v>0.85303795923900105</c:v>
                </c:pt>
                <c:pt idx="63">
                  <c:v>0.92688937942982519</c:v>
                </c:pt>
                <c:pt idx="64">
                  <c:v>0.77204429080340675</c:v>
                </c:pt>
                <c:pt idx="65">
                  <c:v>0.81367543131568709</c:v>
                </c:pt>
                <c:pt idx="66">
                  <c:v>0.9381970371919971</c:v>
                </c:pt>
                <c:pt idx="67">
                  <c:v>0.97556634578289947</c:v>
                </c:pt>
                <c:pt idx="68">
                  <c:v>0.95445567159748157</c:v>
                </c:pt>
                <c:pt idx="69">
                  <c:v>0.88736852199408034</c:v>
                </c:pt>
                <c:pt idx="70">
                  <c:v>0.87473785209384669</c:v>
                </c:pt>
                <c:pt idx="71">
                  <c:v>0.95170292833313219</c:v>
                </c:pt>
                <c:pt idx="72">
                  <c:v>0.92021074504006672</c:v>
                </c:pt>
                <c:pt idx="73">
                  <c:v>0.78265193938844468</c:v>
                </c:pt>
                <c:pt idx="74">
                  <c:v>0.81309160601266661</c:v>
                </c:pt>
                <c:pt idx="75">
                  <c:v>0.9245774350475896</c:v>
                </c:pt>
                <c:pt idx="76">
                  <c:v>0.95137293468843398</c:v>
                </c:pt>
                <c:pt idx="77">
                  <c:v>0.80710007699014685</c:v>
                </c:pt>
                <c:pt idx="78">
                  <c:v>0.96996151886144488</c:v>
                </c:pt>
                <c:pt idx="79">
                  <c:v>0.89279253547451098</c:v>
                </c:pt>
                <c:pt idx="80">
                  <c:v>0.87391924709156266</c:v>
                </c:pt>
                <c:pt idx="81">
                  <c:v>0.90374836732623853</c:v>
                </c:pt>
                <c:pt idx="82">
                  <c:v>0.81471202284745037</c:v>
                </c:pt>
                <c:pt idx="83">
                  <c:v>0.87624686431309629</c:v>
                </c:pt>
                <c:pt idx="84">
                  <c:v>0.88951968998589281</c:v>
                </c:pt>
                <c:pt idx="85">
                  <c:v>0.84967176783892351</c:v>
                </c:pt>
                <c:pt idx="86">
                  <c:v>0.95016643463299577</c:v>
                </c:pt>
                <c:pt idx="87">
                  <c:v>0.96597805051130015</c:v>
                </c:pt>
                <c:pt idx="88">
                  <c:v>0.96695677572092187</c:v>
                </c:pt>
                <c:pt idx="89">
                  <c:v>0.85917836590624008</c:v>
                </c:pt>
                <c:pt idx="90">
                  <c:v>0.87157255121386823</c:v>
                </c:pt>
                <c:pt idx="91">
                  <c:v>0.97460522153037132</c:v>
                </c:pt>
                <c:pt idx="92">
                  <c:v>1.0250999700473777</c:v>
                </c:pt>
                <c:pt idx="93">
                  <c:v>0.90911882328522997</c:v>
                </c:pt>
                <c:pt idx="94">
                  <c:v>0.91025882510780998</c:v>
                </c:pt>
                <c:pt idx="95">
                  <c:v>0.97284131530844808</c:v>
                </c:pt>
                <c:pt idx="96">
                  <c:v>0.88581839729287759</c:v>
                </c:pt>
                <c:pt idx="97">
                  <c:v>0.98721865175024959</c:v>
                </c:pt>
                <c:pt idx="98">
                  <c:v>0.93347298923077704</c:v>
                </c:pt>
                <c:pt idx="99">
                  <c:v>0.91043889032371816</c:v>
                </c:pt>
                <c:pt idx="100">
                  <c:v>0.8739074684564696</c:v>
                </c:pt>
                <c:pt idx="101">
                  <c:v>0.9550189588135114</c:v>
                </c:pt>
                <c:pt idx="102">
                  <c:v>0.89671258423080891</c:v>
                </c:pt>
                <c:pt idx="103">
                  <c:v>1.0204639743570845</c:v>
                </c:pt>
                <c:pt idx="104">
                  <c:v>0.98169956859614749</c:v>
                </c:pt>
                <c:pt idx="105">
                  <c:v>1.0087236542565932</c:v>
                </c:pt>
                <c:pt idx="106">
                  <c:v>0.91856478363101168</c:v>
                </c:pt>
                <c:pt idx="107">
                  <c:v>0.85553143627887196</c:v>
                </c:pt>
                <c:pt idx="108">
                  <c:v>0.88006571270178502</c:v>
                </c:pt>
                <c:pt idx="109">
                  <c:v>0.89851445659918938</c:v>
                </c:pt>
                <c:pt idx="110">
                  <c:v>0.90644016312774367</c:v>
                </c:pt>
                <c:pt idx="111">
                  <c:v>0.98341573215314848</c:v>
                </c:pt>
                <c:pt idx="112">
                  <c:v>0.93452998441928403</c:v>
                </c:pt>
                <c:pt idx="113">
                  <c:v>0.87877121518272527</c:v>
                </c:pt>
                <c:pt idx="114">
                  <c:v>0.92873337167603753</c:v>
                </c:pt>
                <c:pt idx="115">
                  <c:v>0.819309381954613</c:v>
                </c:pt>
                <c:pt idx="116">
                  <c:v>0.83068657937362322</c:v>
                </c:pt>
                <c:pt idx="117">
                  <c:v>1.0784952373897394</c:v>
                </c:pt>
                <c:pt idx="118">
                  <c:v>0.9602741789131729</c:v>
                </c:pt>
                <c:pt idx="119">
                  <c:v>1.0048024306347374</c:v>
                </c:pt>
                <c:pt idx="120">
                  <c:v>0.9400703714563915</c:v>
                </c:pt>
                <c:pt idx="121">
                  <c:v>0.95492303400130385</c:v>
                </c:pt>
                <c:pt idx="122">
                  <c:v>0.86258356189397067</c:v>
                </c:pt>
                <c:pt idx="123">
                  <c:v>0.93474435525555521</c:v>
                </c:pt>
                <c:pt idx="124">
                  <c:v>0.985564804594249</c:v>
                </c:pt>
                <c:pt idx="125">
                  <c:v>0.83930999818678576</c:v>
                </c:pt>
                <c:pt idx="126">
                  <c:v>0.90424765403242624</c:v>
                </c:pt>
                <c:pt idx="127">
                  <c:v>0.96166932664619031</c:v>
                </c:pt>
                <c:pt idx="128">
                  <c:v>0.9764280747374412</c:v>
                </c:pt>
                <c:pt idx="129">
                  <c:v>1.1056125533596626</c:v>
                </c:pt>
                <c:pt idx="130">
                  <c:v>0.94282719835055862</c:v>
                </c:pt>
                <c:pt idx="131">
                  <c:v>0.91994817701193099</c:v>
                </c:pt>
                <c:pt idx="132">
                  <c:v>0.78082461659926294</c:v>
                </c:pt>
                <c:pt idx="133">
                  <c:v>0.97937122399955234</c:v>
                </c:pt>
                <c:pt idx="134">
                  <c:v>0.94312992125754969</c:v>
                </c:pt>
                <c:pt idx="135">
                  <c:v>0.91387317693526315</c:v>
                </c:pt>
                <c:pt idx="136">
                  <c:v>0.95291684216349481</c:v>
                </c:pt>
                <c:pt idx="137">
                  <c:v>0.98285783966272977</c:v>
                </c:pt>
                <c:pt idx="138">
                  <c:v>0.96434502379734333</c:v>
                </c:pt>
                <c:pt idx="139">
                  <c:v>0.97073847419170356</c:v>
                </c:pt>
                <c:pt idx="140">
                  <c:v>0.98481578753937493</c:v>
                </c:pt>
                <c:pt idx="141">
                  <c:v>0.97895629528468675</c:v>
                </c:pt>
                <c:pt idx="142">
                  <c:v>0.91781824948592716</c:v>
                </c:pt>
                <c:pt idx="143">
                  <c:v>0.98290289003635034</c:v>
                </c:pt>
                <c:pt idx="144">
                  <c:v>1.0231379932680609</c:v>
                </c:pt>
                <c:pt idx="145">
                  <c:v>0.90074107056985819</c:v>
                </c:pt>
                <c:pt idx="146">
                  <c:v>0.97383047169737291</c:v>
                </c:pt>
                <c:pt idx="147">
                  <c:v>0.98197187235325212</c:v>
                </c:pt>
                <c:pt idx="148">
                  <c:v>0.7621856949696495</c:v>
                </c:pt>
                <c:pt idx="149">
                  <c:v>0.89557295364710243</c:v>
                </c:pt>
                <c:pt idx="150">
                  <c:v>0.9457087116680527</c:v>
                </c:pt>
                <c:pt idx="151">
                  <c:v>0.89951711738916906</c:v>
                </c:pt>
                <c:pt idx="152">
                  <c:v>0.95879824836257665</c:v>
                </c:pt>
                <c:pt idx="153">
                  <c:v>0.89345555805530574</c:v>
                </c:pt>
                <c:pt idx="154">
                  <c:v>0.98901087618320827</c:v>
                </c:pt>
                <c:pt idx="155">
                  <c:v>1.0307220603128675</c:v>
                </c:pt>
                <c:pt idx="156">
                  <c:v>0.95942639232542137</c:v>
                </c:pt>
                <c:pt idx="157">
                  <c:v>1.0088335451991579</c:v>
                </c:pt>
                <c:pt idx="158">
                  <c:v>0.94067831177165651</c:v>
                </c:pt>
                <c:pt idx="159">
                  <c:v>0.94365160776907142</c:v>
                </c:pt>
                <c:pt idx="160">
                  <c:v>0.95551756882671024</c:v>
                </c:pt>
                <c:pt idx="161">
                  <c:v>0.96909928155328862</c:v>
                </c:pt>
                <c:pt idx="162">
                  <c:v>1.1043555414527384</c:v>
                </c:pt>
                <c:pt idx="163">
                  <c:v>0.98342069396009435</c:v>
                </c:pt>
                <c:pt idx="164">
                  <c:v>0.95597823659893955</c:v>
                </c:pt>
                <c:pt idx="165">
                  <c:v>0.8197368232821961</c:v>
                </c:pt>
                <c:pt idx="166">
                  <c:v>1.0154342883234315</c:v>
                </c:pt>
                <c:pt idx="167">
                  <c:v>0.98747683404819042</c:v>
                </c:pt>
                <c:pt idx="168">
                  <c:v>1.0632956248993506</c:v>
                </c:pt>
                <c:pt idx="169">
                  <c:v>0.99278032117269177</c:v>
                </c:pt>
                <c:pt idx="170">
                  <c:v>0.94253010420365169</c:v>
                </c:pt>
                <c:pt idx="171">
                  <c:v>0.96084237146534801</c:v>
                </c:pt>
                <c:pt idx="172">
                  <c:v>1.0153814846927616</c:v>
                </c:pt>
                <c:pt idx="173">
                  <c:v>0.95161195380282704</c:v>
                </c:pt>
                <c:pt idx="174">
                  <c:v>0.90980650990132195</c:v>
                </c:pt>
                <c:pt idx="175">
                  <c:v>0.98537925476331556</c:v>
                </c:pt>
                <c:pt idx="176">
                  <c:v>0.83695977421589185</c:v>
                </c:pt>
                <c:pt idx="177">
                  <c:v>0.99172602492732131</c:v>
                </c:pt>
                <c:pt idx="178">
                  <c:v>0.95516602179480981</c:v>
                </c:pt>
                <c:pt idx="179">
                  <c:v>0.8112578791196855</c:v>
                </c:pt>
                <c:pt idx="180">
                  <c:v>0.89345555805530574</c:v>
                </c:pt>
                <c:pt idx="181">
                  <c:v>1.0486383426634209</c:v>
                </c:pt>
                <c:pt idx="182">
                  <c:v>1.050143166532107</c:v>
                </c:pt>
                <c:pt idx="183">
                  <c:v>0.98618272680735575</c:v>
                </c:pt>
                <c:pt idx="184">
                  <c:v>0.87823158412791902</c:v>
                </c:pt>
                <c:pt idx="185">
                  <c:v>0.95601066930896628</c:v>
                </c:pt>
                <c:pt idx="186">
                  <c:v>1.0076690343036809</c:v>
                </c:pt>
                <c:pt idx="187">
                  <c:v>0.99298840344517358</c:v>
                </c:pt>
                <c:pt idx="188">
                  <c:v>0.9202632016832325</c:v>
                </c:pt>
                <c:pt idx="189">
                  <c:v>0.96592819395548757</c:v>
                </c:pt>
                <c:pt idx="190">
                  <c:v>0.942831472828358</c:v>
                </c:pt>
                <c:pt idx="191">
                  <c:v>0.98174247823697369</c:v>
                </c:pt>
                <c:pt idx="192">
                  <c:v>0.93332703788151072</c:v>
                </c:pt>
                <c:pt idx="193">
                  <c:v>0.91131470693490835</c:v>
                </c:pt>
                <c:pt idx="194">
                  <c:v>0.9662624372703964</c:v>
                </c:pt>
                <c:pt idx="195">
                  <c:v>0.94471854411638412</c:v>
                </c:pt>
                <c:pt idx="196">
                  <c:v>0.97081582116086873</c:v>
                </c:pt>
                <c:pt idx="197">
                  <c:v>0.88586633306333673</c:v>
                </c:pt>
                <c:pt idx="198">
                  <c:v>0.95744509685514168</c:v>
                </c:pt>
                <c:pt idx="199">
                  <c:v>0.99690105415314434</c:v>
                </c:pt>
                <c:pt idx="200">
                  <c:v>0.96777994429999026</c:v>
                </c:pt>
                <c:pt idx="201">
                  <c:v>0.93654481141318058</c:v>
                </c:pt>
                <c:pt idx="202">
                  <c:v>1.0695558946841175</c:v>
                </c:pt>
                <c:pt idx="203">
                  <c:v>0.91474799450630173</c:v>
                </c:pt>
                <c:pt idx="204">
                  <c:v>0.9681550348383906</c:v>
                </c:pt>
                <c:pt idx="205">
                  <c:v>0.97577966067689825</c:v>
                </c:pt>
                <c:pt idx="206">
                  <c:v>0.84630543410080683</c:v>
                </c:pt>
                <c:pt idx="207">
                  <c:v>0.95532768198191065</c:v>
                </c:pt>
                <c:pt idx="208">
                  <c:v>0.95538236607806237</c:v>
                </c:pt>
                <c:pt idx="209">
                  <c:v>0.93534964756995009</c:v>
                </c:pt>
                <c:pt idx="210">
                  <c:v>1.0473429868485933</c:v>
                </c:pt>
                <c:pt idx="211">
                  <c:v>0.81309160601266661</c:v>
                </c:pt>
                <c:pt idx="212">
                  <c:v>0.86309336243138279</c:v>
                </c:pt>
                <c:pt idx="213">
                  <c:v>0.93289856688750439</c:v>
                </c:pt>
                <c:pt idx="214">
                  <c:v>0.96843801589069745</c:v>
                </c:pt>
                <c:pt idx="215">
                  <c:v>1.0065921708776617</c:v>
                </c:pt>
                <c:pt idx="216">
                  <c:v>1.0531147208033911</c:v>
                </c:pt>
                <c:pt idx="217">
                  <c:v>1.0421233116478297</c:v>
                </c:pt>
                <c:pt idx="218">
                  <c:v>0.96061953380829568</c:v>
                </c:pt>
                <c:pt idx="219">
                  <c:v>1.0142780487111176</c:v>
                </c:pt>
                <c:pt idx="220">
                  <c:v>0.86598683074896921</c:v>
                </c:pt>
                <c:pt idx="221">
                  <c:v>0.96548330670645943</c:v>
                </c:pt>
                <c:pt idx="222">
                  <c:v>0.95651438139782441</c:v>
                </c:pt>
                <c:pt idx="223">
                  <c:v>1.0263886519139906</c:v>
                </c:pt>
                <c:pt idx="224">
                  <c:v>0.95771524382443041</c:v>
                </c:pt>
                <c:pt idx="225">
                  <c:v>0.99859217474372497</c:v>
                </c:pt>
                <c:pt idx="226">
                  <c:v>0.93838752216763921</c:v>
                </c:pt>
                <c:pt idx="227">
                  <c:v>1.0183982711425792</c:v>
                </c:pt>
                <c:pt idx="228">
                  <c:v>1.0802428701365905</c:v>
                </c:pt>
                <c:pt idx="229">
                  <c:v>1.0370742861925819</c:v>
                </c:pt>
                <c:pt idx="230">
                  <c:v>0.82977540237433656</c:v>
                </c:pt>
                <c:pt idx="231">
                  <c:v>1.0081261390625911</c:v>
                </c:pt>
                <c:pt idx="232">
                  <c:v>1.0194511697683621</c:v>
                </c:pt>
                <c:pt idx="233">
                  <c:v>1.0231482331924031</c:v>
                </c:pt>
                <c:pt idx="234">
                  <c:v>1.0546796975725836</c:v>
                </c:pt>
                <c:pt idx="235">
                  <c:v>0.95735888331894259</c:v>
                </c:pt>
                <c:pt idx="236">
                  <c:v>0.98640046233215084</c:v>
                </c:pt>
                <c:pt idx="237">
                  <c:v>1.0011376851931075</c:v>
                </c:pt>
                <c:pt idx="238">
                  <c:v>1.0653035387320426</c:v>
                </c:pt>
                <c:pt idx="239">
                  <c:v>0.93870854592402098</c:v>
                </c:pt>
                <c:pt idx="240">
                  <c:v>0.88409785202066671</c:v>
                </c:pt>
                <c:pt idx="241">
                  <c:v>1.0531966726409907</c:v>
                </c:pt>
                <c:pt idx="242">
                  <c:v>0.98003972093330627</c:v>
                </c:pt>
                <c:pt idx="243">
                  <c:v>1.0031907390805892</c:v>
                </c:pt>
                <c:pt idx="244">
                  <c:v>0.96326335006020603</c:v>
                </c:pt>
                <c:pt idx="245">
                  <c:v>0.94941729944309283</c:v>
                </c:pt>
                <c:pt idx="246">
                  <c:v>1.0962477746314037</c:v>
                </c:pt>
                <c:pt idx="247">
                  <c:v>1.0300597785815429</c:v>
                </c:pt>
                <c:pt idx="248">
                  <c:v>0.96843801589069745</c:v>
                </c:pt>
                <c:pt idx="249">
                  <c:v>0.96037296448182496</c:v>
                </c:pt>
                <c:pt idx="250">
                  <c:v>1.0104569695024141</c:v>
                </c:pt>
                <c:pt idx="251">
                  <c:v>0.98163289707330015</c:v>
                </c:pt>
                <c:pt idx="252">
                  <c:v>1.00863527152663</c:v>
                </c:pt>
                <c:pt idx="253">
                  <c:v>0.83542459335173369</c:v>
                </c:pt>
                <c:pt idx="254">
                  <c:v>0.97952223884220302</c:v>
                </c:pt>
                <c:pt idx="255">
                  <c:v>0.94989008439657752</c:v>
                </c:pt>
                <c:pt idx="256">
                  <c:v>0.97601567513097365</c:v>
                </c:pt>
                <c:pt idx="257">
                  <c:v>1.0692578016265275</c:v>
                </c:pt>
                <c:pt idx="258">
                  <c:v>0.95263838746236928</c:v>
                </c:pt>
                <c:pt idx="259">
                  <c:v>0.99697347694335314</c:v>
                </c:pt>
                <c:pt idx="260">
                  <c:v>0.96494915176825813</c:v>
                </c:pt>
                <c:pt idx="261">
                  <c:v>0.97152885951050671</c:v>
                </c:pt>
                <c:pt idx="262">
                  <c:v>1.0134994721251289</c:v>
                </c:pt>
                <c:pt idx="263">
                  <c:v>1.1101884925440726</c:v>
                </c:pt>
                <c:pt idx="264">
                  <c:v>1.0337409118390548</c:v>
                </c:pt>
                <c:pt idx="265">
                  <c:v>1.0186872336644888</c:v>
                </c:pt>
                <c:pt idx="266">
                  <c:v>0.93555611893279911</c:v>
                </c:pt>
                <c:pt idx="267">
                  <c:v>0.83850980020849264</c:v>
                </c:pt>
                <c:pt idx="268">
                  <c:v>0.98088910786681094</c:v>
                </c:pt>
                <c:pt idx="269">
                  <c:v>1.0197824466763383</c:v>
                </c:pt>
                <c:pt idx="270">
                  <c:v>0.93742970589875185</c:v>
                </c:pt>
                <c:pt idx="271">
                  <c:v>1.0077105130474446</c:v>
                </c:pt>
                <c:pt idx="272">
                  <c:v>1.0817956908740134</c:v>
                </c:pt>
                <c:pt idx="273">
                  <c:v>0.99077561468514441</c:v>
                </c:pt>
                <c:pt idx="274">
                  <c:v>1.0380005037645876</c:v>
                </c:pt>
                <c:pt idx="275">
                  <c:v>1.0592215233139264</c:v>
                </c:pt>
                <c:pt idx="276">
                  <c:v>1.0198786507045694</c:v>
                </c:pt>
                <c:pt idx="277">
                  <c:v>1.0442036669105361</c:v>
                </c:pt>
                <c:pt idx="278">
                  <c:v>1.0203190885628393</c:v>
                </c:pt>
                <c:pt idx="279">
                  <c:v>0.81425658718524585</c:v>
                </c:pt>
                <c:pt idx="280">
                  <c:v>0.98431922871515365</c:v>
                </c:pt>
                <c:pt idx="281">
                  <c:v>0.98599001314257351</c:v>
                </c:pt>
                <c:pt idx="282">
                  <c:v>1.0642811528944334</c:v>
                </c:pt>
                <c:pt idx="283">
                  <c:v>0.99888397132688367</c:v>
                </c:pt>
                <c:pt idx="284">
                  <c:v>1.0274480846190579</c:v>
                </c:pt>
                <c:pt idx="285">
                  <c:v>0.98254065384053757</c:v>
                </c:pt>
                <c:pt idx="286">
                  <c:v>1.0644612806049127</c:v>
                </c:pt>
                <c:pt idx="287">
                  <c:v>0.95035025157120001</c:v>
                </c:pt>
                <c:pt idx="288">
                  <c:v>1.0082533593182552</c:v>
                </c:pt>
                <c:pt idx="289">
                  <c:v>0.99443598895911511</c:v>
                </c:pt>
                <c:pt idx="290">
                  <c:v>1.0506728721558021</c:v>
                </c:pt>
                <c:pt idx="291">
                  <c:v>1.0446569671757646</c:v>
                </c:pt>
                <c:pt idx="292">
                  <c:v>1.0064127890612073</c:v>
                </c:pt>
                <c:pt idx="293">
                  <c:v>0.99390536336315971</c:v>
                </c:pt>
                <c:pt idx="294">
                  <c:v>1.0722809133538804</c:v>
                </c:pt>
                <c:pt idx="295">
                  <c:v>1.0019109816320624</c:v>
                </c:pt>
                <c:pt idx="296">
                  <c:v>0.93132291144427448</c:v>
                </c:pt>
                <c:pt idx="297">
                  <c:v>1.0315442158441492</c:v>
                </c:pt>
                <c:pt idx="298">
                  <c:v>0.94316982275037697</c:v>
                </c:pt>
                <c:pt idx="299">
                  <c:v>0.99000845165390794</c:v>
                </c:pt>
                <c:pt idx="300">
                  <c:v>0.82429049232508789</c:v>
                </c:pt>
                <c:pt idx="301">
                  <c:v>0.98654475204109349</c:v>
                </c:pt>
                <c:pt idx="302">
                  <c:v>0.9993383300664398</c:v>
                </c:pt>
                <c:pt idx="303">
                  <c:v>1.0052198978178302</c:v>
                </c:pt>
                <c:pt idx="304">
                  <c:v>0.9936061894854491</c:v>
                </c:pt>
                <c:pt idx="305">
                  <c:v>1.0158933867641662</c:v>
                </c:pt>
                <c:pt idx="306">
                  <c:v>1.0681972891787992</c:v>
                </c:pt>
                <c:pt idx="307">
                  <c:v>1.0146828911994079</c:v>
                </c:pt>
                <c:pt idx="308">
                  <c:v>0.95567052550729481</c:v>
                </c:pt>
                <c:pt idx="309">
                  <c:v>0.95246003582033134</c:v>
                </c:pt>
                <c:pt idx="310">
                  <c:v>1.0079460095722375</c:v>
                </c:pt>
                <c:pt idx="311">
                  <c:v>0.85991253147633051</c:v>
                </c:pt>
                <c:pt idx="312">
                  <c:v>1.0699057009194406</c:v>
                </c:pt>
                <c:pt idx="313">
                  <c:v>1.1408123978997924</c:v>
                </c:pt>
                <c:pt idx="314">
                  <c:v>1.0739432579963171</c:v>
                </c:pt>
                <c:pt idx="315">
                  <c:v>0.97913833358766755</c:v>
                </c:pt>
                <c:pt idx="316">
                  <c:v>1.0825330576071228</c:v>
                </c:pt>
                <c:pt idx="317">
                  <c:v>1.0629073686016048</c:v>
                </c:pt>
                <c:pt idx="318">
                  <c:v>1.0377338927074911</c:v>
                </c:pt>
                <c:pt idx="319">
                  <c:v>1.0275422785275556</c:v>
                </c:pt>
                <c:pt idx="320">
                  <c:v>0.971779835493224</c:v>
                </c:pt>
                <c:pt idx="321">
                  <c:v>0.9696625696582567</c:v>
                </c:pt>
                <c:pt idx="322">
                  <c:v>0.98289812399169141</c:v>
                </c:pt>
                <c:pt idx="323">
                  <c:v>1.0952687976993523</c:v>
                </c:pt>
                <c:pt idx="324">
                  <c:v>1.0354418614145284</c:v>
                </c:pt>
                <c:pt idx="325">
                  <c:v>1.0795813689356299</c:v>
                </c:pt>
                <c:pt idx="326">
                  <c:v>0.99377543065628593</c:v>
                </c:pt>
                <c:pt idx="327">
                  <c:v>1.0001509807884119</c:v>
                </c:pt>
                <c:pt idx="328">
                  <c:v>0.98919229069575365</c:v>
                </c:pt>
                <c:pt idx="329">
                  <c:v>1.0322488784568566</c:v>
                </c:pt>
                <c:pt idx="330">
                  <c:v>1.1088825690922626</c:v>
                </c:pt>
                <c:pt idx="331">
                  <c:v>0.91824337486643848</c:v>
                </c:pt>
                <c:pt idx="332">
                  <c:v>0.86889130237767298</c:v>
                </c:pt>
                <c:pt idx="333">
                  <c:v>1.0403004522732076</c:v>
                </c:pt>
                <c:pt idx="334">
                  <c:v>0.96965965740688853</c:v>
                </c:pt>
                <c:pt idx="335">
                  <c:v>0.9856999919894549</c:v>
                </c:pt>
                <c:pt idx="336">
                  <c:v>1.0712583002627976</c:v>
                </c:pt>
                <c:pt idx="337">
                  <c:v>1.0345706129902288</c:v>
                </c:pt>
                <c:pt idx="338">
                  <c:v>0.88868408349071826</c:v>
                </c:pt>
                <c:pt idx="339">
                  <c:v>1.0188736261135087</c:v>
                </c:pt>
                <c:pt idx="340">
                  <c:v>1.0885418600420551</c:v>
                </c:pt>
                <c:pt idx="341">
                  <c:v>1.1002407258766418</c:v>
                </c:pt>
                <c:pt idx="342">
                  <c:v>1.0890152316569965</c:v>
                </c:pt>
                <c:pt idx="343">
                  <c:v>0.9865406965329252</c:v>
                </c:pt>
                <c:pt idx="344">
                  <c:v>0.86254925396533677</c:v>
                </c:pt>
                <c:pt idx="345">
                  <c:v>1.0976790831907544</c:v>
                </c:pt>
                <c:pt idx="346">
                  <c:v>1.0584062189606376</c:v>
                </c:pt>
                <c:pt idx="347">
                  <c:v>1.0821779804341323</c:v>
                </c:pt>
                <c:pt idx="348">
                  <c:v>1.1096713891634387</c:v>
                </c:pt>
                <c:pt idx="349">
                  <c:v>1.0787826066851258</c:v>
                </c:pt>
                <c:pt idx="350">
                  <c:v>1.0462760573885608</c:v>
                </c:pt>
                <c:pt idx="351">
                  <c:v>0.98891196336015574</c:v>
                </c:pt>
                <c:pt idx="352">
                  <c:v>0.95646447996181827</c:v>
                </c:pt>
                <c:pt idx="353">
                  <c:v>1.008052265812081</c:v>
                </c:pt>
                <c:pt idx="354">
                  <c:v>1.0886534778896988</c:v>
                </c:pt>
                <c:pt idx="355">
                  <c:v>1.0374207363150161</c:v>
                </c:pt>
                <c:pt idx="356">
                  <c:v>1.0843056821961794</c:v>
                </c:pt>
                <c:pt idx="357">
                  <c:v>1.0894978906067871</c:v>
                </c:pt>
                <c:pt idx="358">
                  <c:v>0.97586787083350468</c:v>
                </c:pt>
                <c:pt idx="359">
                  <c:v>1.0033787142339485</c:v>
                </c:pt>
                <c:pt idx="360">
                  <c:v>1.0663513748503937</c:v>
                </c:pt>
                <c:pt idx="361">
                  <c:v>1.0318578504472773</c:v>
                </c:pt>
                <c:pt idx="362">
                  <c:v>1.0341336901837537</c:v>
                </c:pt>
                <c:pt idx="363">
                  <c:v>0.87481573293861481</c:v>
                </c:pt>
                <c:pt idx="364">
                  <c:v>1.02631618451518</c:v>
                </c:pt>
                <c:pt idx="365">
                  <c:v>1.0284581823505465</c:v>
                </c:pt>
                <c:pt idx="366">
                  <c:v>1.0572708201806946</c:v>
                </c:pt>
                <c:pt idx="367">
                  <c:v>1.0171582866712554</c:v>
                </c:pt>
                <c:pt idx="368">
                  <c:v>1.0157048873886665</c:v>
                </c:pt>
                <c:pt idx="369">
                  <c:v>1.1010392255940575</c:v>
                </c:pt>
                <c:pt idx="370">
                  <c:v>1.0540046240166023</c:v>
                </c:pt>
                <c:pt idx="371">
                  <c:v>1.0186295296900556</c:v>
                </c:pt>
                <c:pt idx="372">
                  <c:v>0.88249031387118371</c:v>
                </c:pt>
                <c:pt idx="373">
                  <c:v>0.99511519691690387</c:v>
                </c:pt>
                <c:pt idx="374">
                  <c:v>1.0304642168568992</c:v>
                </c:pt>
                <c:pt idx="375">
                  <c:v>1.0244664641832002</c:v>
                </c:pt>
                <c:pt idx="376">
                  <c:v>1.015583754474817</c:v>
                </c:pt>
                <c:pt idx="377">
                  <c:v>1.0484247547076684</c:v>
                </c:pt>
                <c:pt idx="378">
                  <c:v>0.95452161857342721</c:v>
                </c:pt>
                <c:pt idx="379">
                  <c:v>0.92592975256315113</c:v>
                </c:pt>
                <c:pt idx="380">
                  <c:v>1.0364816937559838</c:v>
                </c:pt>
                <c:pt idx="381">
                  <c:v>1.1110306925596558</c:v>
                </c:pt>
                <c:pt idx="382">
                  <c:v>0.95300151690292612</c:v>
                </c:pt>
                <c:pt idx="383">
                  <c:v>1.0167071028073464</c:v>
                </c:pt>
                <c:pt idx="384">
                  <c:v>1.0353705688017016</c:v>
                </c:pt>
                <c:pt idx="385">
                  <c:v>1.0333051522370333</c:v>
                </c:pt>
                <c:pt idx="386">
                  <c:v>0.99779860640608631</c:v>
                </c:pt>
                <c:pt idx="387">
                  <c:v>1.112454749907434</c:v>
                </c:pt>
                <c:pt idx="388">
                  <c:v>1.0562178923275025</c:v>
                </c:pt>
                <c:pt idx="389">
                  <c:v>0.98304188537271431</c:v>
                </c:pt>
                <c:pt idx="390">
                  <c:v>1.0531799749530937</c:v>
                </c:pt>
                <c:pt idx="391">
                  <c:v>1.0301062957467877</c:v>
                </c:pt>
                <c:pt idx="392">
                  <c:v>1.1022528010710821</c:v>
                </c:pt>
                <c:pt idx="393">
                  <c:v>1.0600351682319475</c:v>
                </c:pt>
                <c:pt idx="394">
                  <c:v>1.0651981149135856</c:v>
                </c:pt>
                <c:pt idx="395">
                  <c:v>1.0188736261135087</c:v>
                </c:pt>
                <c:pt idx="396">
                  <c:v>1.0392742010500908</c:v>
                </c:pt>
                <c:pt idx="397">
                  <c:v>1.0226825840368516</c:v>
                </c:pt>
                <c:pt idx="398">
                  <c:v>1.0254484497844365</c:v>
                </c:pt>
                <c:pt idx="399">
                  <c:v>0.98384186213615099</c:v>
                </c:pt>
                <c:pt idx="400">
                  <c:v>1.0222159191407421</c:v>
                </c:pt>
                <c:pt idx="401">
                  <c:v>1.0041891968003349</c:v>
                </c:pt>
                <c:pt idx="402">
                  <c:v>1.1099920843629871</c:v>
                </c:pt>
                <c:pt idx="403">
                  <c:v>1.0004682170148143</c:v>
                </c:pt>
                <c:pt idx="404">
                  <c:v>1.0820728879433339</c:v>
                </c:pt>
                <c:pt idx="405">
                  <c:v>1.0107520475609315</c:v>
                </c:pt>
                <c:pt idx="406">
                  <c:v>1.025926284269904</c:v>
                </c:pt>
                <c:pt idx="407">
                  <c:v>1.0312316575666949</c:v>
                </c:pt>
                <c:pt idx="408">
                  <c:v>1.0290158096767046</c:v>
                </c:pt>
                <c:pt idx="409">
                  <c:v>1.0254484497844365</c:v>
                </c:pt>
                <c:pt idx="410">
                  <c:v>1.0636897361285738</c:v>
                </c:pt>
                <c:pt idx="411">
                  <c:v>0.97116517946432224</c:v>
                </c:pt>
                <c:pt idx="412">
                  <c:v>1.1236039528117301</c:v>
                </c:pt>
                <c:pt idx="413">
                  <c:v>1.0318997108403003</c:v>
                </c:pt>
                <c:pt idx="414">
                  <c:v>1.1462721549362915</c:v>
                </c:pt>
                <c:pt idx="415">
                  <c:v>1.1595278233392763</c:v>
                </c:pt>
                <c:pt idx="416">
                  <c:v>1.0370187500089791</c:v>
                </c:pt>
                <c:pt idx="417">
                  <c:v>1.0258984318389082</c:v>
                </c:pt>
                <c:pt idx="418">
                  <c:v>0.93593173585992151</c:v>
                </c:pt>
                <c:pt idx="419">
                  <c:v>1.0790425699781159</c:v>
                </c:pt>
                <c:pt idx="420">
                  <c:v>1.0119504434789084</c:v>
                </c:pt>
                <c:pt idx="421">
                  <c:v>1.1593888272942137</c:v>
                </c:pt>
                <c:pt idx="422">
                  <c:v>1.1197503141527407</c:v>
                </c:pt>
                <c:pt idx="423">
                  <c:v>1.0643607827580264</c:v>
                </c:pt>
                <c:pt idx="424">
                  <c:v>0.98005166304220437</c:v>
                </c:pt>
                <c:pt idx="425">
                  <c:v>1.1548827138420354</c:v>
                </c:pt>
                <c:pt idx="426">
                  <c:v>0.9867664978106726</c:v>
                </c:pt>
                <c:pt idx="427">
                  <c:v>1.1099568916130815</c:v>
                </c:pt>
                <c:pt idx="428">
                  <c:v>1.083548474149516</c:v>
                </c:pt>
                <c:pt idx="429">
                  <c:v>0.89644637242047687</c:v>
                </c:pt>
                <c:pt idx="430">
                  <c:v>1.1825303756372105</c:v>
                </c:pt>
                <c:pt idx="431">
                  <c:v>1.1125660000796114</c:v>
                </c:pt>
                <c:pt idx="432">
                  <c:v>0.90552552257235575</c:v>
                </c:pt>
                <c:pt idx="433">
                  <c:v>1.0818259097662641</c:v>
                </c:pt>
                <c:pt idx="434">
                  <c:v>1.1829029433360754</c:v>
                </c:pt>
                <c:pt idx="435">
                  <c:v>1.0902324777866597</c:v>
                </c:pt>
                <c:pt idx="436">
                  <c:v>1.0528205894404914</c:v>
                </c:pt>
                <c:pt idx="437">
                  <c:v>1.1747878359599178</c:v>
                </c:pt>
                <c:pt idx="438">
                  <c:v>1.0920963550975418</c:v>
                </c:pt>
                <c:pt idx="439">
                  <c:v>1.1697291819957392</c:v>
                </c:pt>
                <c:pt idx="440">
                  <c:v>1.055879731286125</c:v>
                </c:pt>
                <c:pt idx="441">
                  <c:v>1.1047438502501581</c:v>
                </c:pt>
                <c:pt idx="442">
                  <c:v>1.0252182381344679</c:v>
                </c:pt>
                <c:pt idx="443">
                  <c:v>1.1150514819538331</c:v>
                </c:pt>
                <c:pt idx="444">
                  <c:v>1.1659067356894479</c:v>
                </c:pt>
                <c:pt idx="445">
                  <c:v>1.1406885606296724</c:v>
                </c:pt>
                <c:pt idx="446">
                  <c:v>1.0694274741197065</c:v>
                </c:pt>
                <c:pt idx="447">
                  <c:v>1.1459571774180199</c:v>
                </c:pt>
                <c:pt idx="448">
                  <c:v>1.1423905622923629</c:v>
                </c:pt>
                <c:pt idx="449">
                  <c:v>1.0824062655714839</c:v>
                </c:pt>
                <c:pt idx="450">
                  <c:v>1.0871937738323034</c:v>
                </c:pt>
                <c:pt idx="451">
                  <c:v>1.1164080838825075</c:v>
                </c:pt>
                <c:pt idx="452">
                  <c:v>1.0446822836421086</c:v>
                </c:pt>
                <c:pt idx="453">
                  <c:v>0.97571494059080766</c:v>
                </c:pt>
                <c:pt idx="454">
                  <c:v>1.0468956522431716</c:v>
                </c:pt>
                <c:pt idx="455">
                  <c:v>1.0925679178090306</c:v>
                </c:pt>
                <c:pt idx="456">
                  <c:v>1.0866924632352897</c:v>
                </c:pt>
                <c:pt idx="457">
                  <c:v>1.1481197293124779</c:v>
                </c:pt>
                <c:pt idx="458">
                  <c:v>1.0712620341929882</c:v>
                </c:pt>
                <c:pt idx="459">
                  <c:v>1.0344110461122662</c:v>
                </c:pt>
                <c:pt idx="460">
                  <c:v>0.97360844825328918</c:v>
                </c:pt>
                <c:pt idx="461">
                  <c:v>1.0674224178653235</c:v>
                </c:pt>
                <c:pt idx="462">
                  <c:v>1.0352345541030101</c:v>
                </c:pt>
                <c:pt idx="463">
                  <c:v>1.1813243664706858</c:v>
                </c:pt>
                <c:pt idx="464">
                  <c:v>1.1296451289948251</c:v>
                </c:pt>
                <c:pt idx="465">
                  <c:v>1.1679691844672497</c:v>
                </c:pt>
                <c:pt idx="466">
                  <c:v>1.0468214904387119</c:v>
                </c:pt>
                <c:pt idx="467">
                  <c:v>1.0602160739947162</c:v>
                </c:pt>
                <c:pt idx="468">
                  <c:v>1.0418941918762048</c:v>
                </c:pt>
                <c:pt idx="469">
                  <c:v>1.0428371376143135</c:v>
                </c:pt>
                <c:pt idx="470">
                  <c:v>1.0580889501654178</c:v>
                </c:pt>
                <c:pt idx="471">
                  <c:v>1.132764366764639</c:v>
                </c:pt>
                <c:pt idx="472">
                  <c:v>1.0626602381737413</c:v>
                </c:pt>
                <c:pt idx="473">
                  <c:v>0.94066634239031766</c:v>
                </c:pt>
                <c:pt idx="474">
                  <c:v>1.1348476203458084</c:v>
                </c:pt>
                <c:pt idx="475">
                  <c:v>1.0818485406333205</c:v>
                </c:pt>
                <c:pt idx="476">
                  <c:v>1.035783299661255</c:v>
                </c:pt>
                <c:pt idx="477">
                  <c:v>1.0723167436872219</c:v>
                </c:pt>
                <c:pt idx="478">
                  <c:v>1.0785759111042159</c:v>
                </c:pt>
                <c:pt idx="479">
                  <c:v>1.069865153076776</c:v>
                </c:pt>
                <c:pt idx="480">
                  <c:v>1.0053338491312425</c:v>
                </c:pt>
                <c:pt idx="481">
                  <c:v>1.0906936876453261</c:v>
                </c:pt>
                <c:pt idx="482">
                  <c:v>1.0408499866967083</c:v>
                </c:pt>
                <c:pt idx="483">
                  <c:v>1.0379426747835385</c:v>
                </c:pt>
                <c:pt idx="484">
                  <c:v>1.100368745162952</c:v>
                </c:pt>
                <c:pt idx="485">
                  <c:v>1.0831557667451481</c:v>
                </c:pt>
                <c:pt idx="486">
                  <c:v>1.1305264124494265</c:v>
                </c:pt>
                <c:pt idx="487">
                  <c:v>1.187477876867032</c:v>
                </c:pt>
                <c:pt idx="488">
                  <c:v>1.0531205016556544</c:v>
                </c:pt>
                <c:pt idx="489">
                  <c:v>1.2144846747539362</c:v>
                </c:pt>
                <c:pt idx="490">
                  <c:v>1.067967272447121</c:v>
                </c:pt>
                <c:pt idx="491">
                  <c:v>1.0773214057395208</c:v>
                </c:pt>
                <c:pt idx="492">
                  <c:v>1.0906632895526611</c:v>
                </c:pt>
                <c:pt idx="493">
                  <c:v>1.0541576217235824</c:v>
                </c:pt>
                <c:pt idx="494">
                  <c:v>1.071726465520993</c:v>
                </c:pt>
                <c:pt idx="495">
                  <c:v>1.1441356425288962</c:v>
                </c:pt>
                <c:pt idx="496">
                  <c:v>1.0468926935062746</c:v>
                </c:pt>
                <c:pt idx="497">
                  <c:v>1.0774259032502846</c:v>
                </c:pt>
                <c:pt idx="498">
                  <c:v>1.1810704674991512</c:v>
                </c:pt>
                <c:pt idx="499">
                  <c:v>1.1887307837173082</c:v>
                </c:pt>
                <c:pt idx="500">
                  <c:v>1.0741538481135229</c:v>
                </c:pt>
                <c:pt idx="501">
                  <c:v>1.1596392195315774</c:v>
                </c:pt>
                <c:pt idx="502">
                  <c:v>1.0145154774010474</c:v>
                </c:pt>
                <c:pt idx="503">
                  <c:v>1.1435334867617306</c:v>
                </c:pt>
                <c:pt idx="504">
                  <c:v>1.0334861369566291</c:v>
                </c:pt>
                <c:pt idx="505">
                  <c:v>1.0997406857280152</c:v>
                </c:pt>
                <c:pt idx="506">
                  <c:v>1.1610785387119202</c:v>
                </c:pt>
                <c:pt idx="507">
                  <c:v>1.0849574332502119</c:v>
                </c:pt>
                <c:pt idx="508">
                  <c:v>1.1517581143227191</c:v>
                </c:pt>
                <c:pt idx="509">
                  <c:v>1.174112531855185</c:v>
                </c:pt>
                <c:pt idx="510">
                  <c:v>1.0201783709325865</c:v>
                </c:pt>
                <c:pt idx="511">
                  <c:v>1.1300011478529031</c:v>
                </c:pt>
                <c:pt idx="512">
                  <c:v>1.0571753592838835</c:v>
                </c:pt>
                <c:pt idx="513">
                  <c:v>1.1531557488915221</c:v>
                </c:pt>
                <c:pt idx="514">
                  <c:v>1.0214374757758824</c:v>
                </c:pt>
                <c:pt idx="515">
                  <c:v>1.1706645831588038</c:v>
                </c:pt>
                <c:pt idx="516">
                  <c:v>1.1575269852899517</c:v>
                </c:pt>
                <c:pt idx="517">
                  <c:v>1.1470352366257632</c:v>
                </c:pt>
                <c:pt idx="518">
                  <c:v>1.0878708206164123</c:v>
                </c:pt>
                <c:pt idx="519">
                  <c:v>1.1137141084504967</c:v>
                </c:pt>
                <c:pt idx="520">
                  <c:v>1.0533818206532963</c:v>
                </c:pt>
                <c:pt idx="521">
                  <c:v>1.2017443212658803</c:v>
                </c:pt>
                <c:pt idx="522">
                  <c:v>1.2050026361240436</c:v>
                </c:pt>
                <c:pt idx="523">
                  <c:v>1.132805938563924</c:v>
                </c:pt>
                <c:pt idx="524">
                  <c:v>1.0529573244610269</c:v>
                </c:pt>
                <c:pt idx="525">
                  <c:v>1.1639775241087549</c:v>
                </c:pt>
                <c:pt idx="526">
                  <c:v>1.1658461383196177</c:v>
                </c:pt>
                <c:pt idx="527">
                  <c:v>1.0546848147427939</c:v>
                </c:pt>
                <c:pt idx="528">
                  <c:v>1.084522856421513</c:v>
                </c:pt>
                <c:pt idx="529">
                  <c:v>1.0662698477835395</c:v>
                </c:pt>
                <c:pt idx="530">
                  <c:v>1.1163819230017851</c:v>
                </c:pt>
                <c:pt idx="531">
                  <c:v>1.1636599316756544</c:v>
                </c:pt>
                <c:pt idx="532">
                  <c:v>1.2093564471729112</c:v>
                </c:pt>
                <c:pt idx="533">
                  <c:v>1.1053940817092149</c:v>
                </c:pt>
                <c:pt idx="534">
                  <c:v>1.1145317828010952</c:v>
                </c:pt>
                <c:pt idx="535">
                  <c:v>1.1299958807624302</c:v>
                </c:pt>
                <c:pt idx="536">
                  <c:v>1.1060991028509997</c:v>
                </c:pt>
                <c:pt idx="537">
                  <c:v>1.1148566668461248</c:v>
                </c:pt>
                <c:pt idx="538">
                  <c:v>1.1736926923247764</c:v>
                </c:pt>
                <c:pt idx="539">
                  <c:v>1.0715487084296322</c:v>
                </c:pt>
                <c:pt idx="540">
                  <c:v>1.1169964037962146</c:v>
                </c:pt>
                <c:pt idx="541">
                  <c:v>1.1417240901559107</c:v>
                </c:pt>
                <c:pt idx="542">
                  <c:v>1.2232570225233053</c:v>
                </c:pt>
                <c:pt idx="543">
                  <c:v>1.1863356968139611</c:v>
                </c:pt>
                <c:pt idx="544">
                  <c:v>1.177430712243988</c:v>
                </c:pt>
                <c:pt idx="545">
                  <c:v>1.1852526151472551</c:v>
                </c:pt>
                <c:pt idx="546">
                  <c:v>1.0462113099644517</c:v>
                </c:pt>
                <c:pt idx="547">
                  <c:v>1.0624575352717853</c:v>
                </c:pt>
                <c:pt idx="548">
                  <c:v>1.0941628700100905</c:v>
                </c:pt>
                <c:pt idx="549">
                  <c:v>1.1898811572059069</c:v>
                </c:pt>
                <c:pt idx="550">
                  <c:v>1.2501390670635393</c:v>
                </c:pt>
                <c:pt idx="551">
                  <c:v>1.1397929951844963</c:v>
                </c:pt>
                <c:pt idx="552">
                  <c:v>1.2251439851373036</c:v>
                </c:pt>
                <c:pt idx="553">
                  <c:v>1.0734403576855045</c:v>
                </c:pt>
                <c:pt idx="554">
                  <c:v>1.2195471270819305</c:v>
                </c:pt>
                <c:pt idx="555">
                  <c:v>1.2130027989649874</c:v>
                </c:pt>
                <c:pt idx="556">
                  <c:v>1.1412498584502693</c:v>
                </c:pt>
                <c:pt idx="557">
                  <c:v>1.0526551583849615</c:v>
                </c:pt>
                <c:pt idx="558">
                  <c:v>1.1422381685447693</c:v>
                </c:pt>
                <c:pt idx="559">
                  <c:v>1.1312332175392921</c:v>
                </c:pt>
                <c:pt idx="560">
                  <c:v>1.0955211173450714</c:v>
                </c:pt>
                <c:pt idx="561">
                  <c:v>1.1433849786858619</c:v>
                </c:pt>
                <c:pt idx="562">
                  <c:v>1.1954638154012958</c:v>
                </c:pt>
                <c:pt idx="563">
                  <c:v>1.1076981477812535</c:v>
                </c:pt>
                <c:pt idx="564">
                  <c:v>1.1552567811890708</c:v>
                </c:pt>
                <c:pt idx="565">
                  <c:v>1.1251587562838397</c:v>
                </c:pt>
                <c:pt idx="566">
                  <c:v>1.1536815360470154</c:v>
                </c:pt>
                <c:pt idx="567">
                  <c:v>1.1296007556532526</c:v>
                </c:pt>
                <c:pt idx="568">
                  <c:v>1.0986912459089366</c:v>
                </c:pt>
                <c:pt idx="569">
                  <c:v>1.1593365196761045</c:v>
                </c:pt>
                <c:pt idx="570">
                  <c:v>1.2008215338393946</c:v>
                </c:pt>
                <c:pt idx="571">
                  <c:v>1.1445612769815319</c:v>
                </c:pt>
                <c:pt idx="572">
                  <c:v>1.2218386400134729</c:v>
                </c:pt>
                <c:pt idx="573">
                  <c:v>1.196437545506924</c:v>
                </c:pt>
                <c:pt idx="574">
                  <c:v>1.2278987755864859</c:v>
                </c:pt>
                <c:pt idx="575">
                  <c:v>1.1501981008134463</c:v>
                </c:pt>
                <c:pt idx="576">
                  <c:v>1.1392856092426618</c:v>
                </c:pt>
                <c:pt idx="577">
                  <c:v>1.1531757047767623</c:v>
                </c:pt>
                <c:pt idx="578">
                  <c:v>1.2543107809118017</c:v>
                </c:pt>
                <c:pt idx="579">
                  <c:v>1.0354873673739888</c:v>
                </c:pt>
                <c:pt idx="580">
                  <c:v>1.1620065249904488</c:v>
                </c:pt>
                <c:pt idx="581">
                  <c:v>1.1260485249454728</c:v>
                </c:pt>
                <c:pt idx="582">
                  <c:v>1.1409311258366597</c:v>
                </c:pt>
                <c:pt idx="583">
                  <c:v>1.1401892513918406</c:v>
                </c:pt>
                <c:pt idx="584">
                  <c:v>1.1930822234546437</c:v>
                </c:pt>
                <c:pt idx="585">
                  <c:v>1.1640029605943569</c:v>
                </c:pt>
                <c:pt idx="586">
                  <c:v>1.1280469766436965</c:v>
                </c:pt>
                <c:pt idx="587">
                  <c:v>1.2550498806792356</c:v>
                </c:pt>
                <c:pt idx="588">
                  <c:v>1.2600940193890402</c:v>
                </c:pt>
                <c:pt idx="589">
                  <c:v>1.1595207009419035</c:v>
                </c:pt>
                <c:pt idx="590">
                  <c:v>1.1389026592094613</c:v>
                </c:pt>
                <c:pt idx="591">
                  <c:v>1.1947106511791783</c:v>
                </c:pt>
                <c:pt idx="592">
                  <c:v>1.0586494401852433</c:v>
                </c:pt>
                <c:pt idx="593">
                  <c:v>1.1365386528465358</c:v>
                </c:pt>
                <c:pt idx="594">
                  <c:v>1.2407169073057716</c:v>
                </c:pt>
                <c:pt idx="595">
                  <c:v>1.2093633869716363</c:v>
                </c:pt>
                <c:pt idx="596">
                  <c:v>1.1384887819956129</c:v>
                </c:pt>
                <c:pt idx="597">
                  <c:v>1.2161372056746114</c:v>
                </c:pt>
                <c:pt idx="598">
                  <c:v>1.2753005569493687</c:v>
                </c:pt>
              </c:numCache>
            </c:numRef>
          </c:yVal>
          <c:smooth val="0"/>
        </c:ser>
        <c:ser>
          <c:idx val="1"/>
          <c:order val="1"/>
          <c:spPr>
            <a:ln w="19050">
              <a:solidFill>
                <a:schemeClr val="tx1"/>
              </a:solidFill>
            </a:ln>
          </c:spPr>
          <c:marker>
            <c:symbol val="none"/>
          </c:marker>
          <c:xVal>
            <c:numRef>
              <c:f>datat!$F$2:$F$600</c:f>
              <c:numCache>
                <c:formatCode>General</c:formatCode>
                <c:ptCount val="599"/>
                <c:pt idx="0">
                  <c:v>0.93466820992781718</c:v>
                </c:pt>
                <c:pt idx="1">
                  <c:v>0.93466820992781718</c:v>
                </c:pt>
                <c:pt idx="2">
                  <c:v>0.93887943667849161</c:v>
                </c:pt>
                <c:pt idx="3">
                  <c:v>0.93887943667849161</c:v>
                </c:pt>
                <c:pt idx="4">
                  <c:v>0.93969097769614651</c:v>
                </c:pt>
                <c:pt idx="5">
                  <c:v>0.9404928747138972</c:v>
                </c:pt>
                <c:pt idx="6">
                  <c:v>0.9404928747138972</c:v>
                </c:pt>
                <c:pt idx="7">
                  <c:v>0.94206866603713113</c:v>
                </c:pt>
                <c:pt idx="8">
                  <c:v>0.94206866603713113</c:v>
                </c:pt>
                <c:pt idx="9">
                  <c:v>0.94436561534226349</c:v>
                </c:pt>
                <c:pt idx="10">
                  <c:v>0.94436561534226349</c:v>
                </c:pt>
                <c:pt idx="11">
                  <c:v>0.94436561534226349</c:v>
                </c:pt>
                <c:pt idx="12">
                  <c:v>0.94511428693327026</c:v>
                </c:pt>
                <c:pt idx="13">
                  <c:v>0.94585478995418004</c:v>
                </c:pt>
                <c:pt idx="14">
                  <c:v>0.94585478995418004</c:v>
                </c:pt>
                <c:pt idx="15">
                  <c:v>0.94585478995418004</c:v>
                </c:pt>
                <c:pt idx="16">
                  <c:v>0.94585478995418004</c:v>
                </c:pt>
                <c:pt idx="17">
                  <c:v>0.94658730692345749</c:v>
                </c:pt>
                <c:pt idx="18">
                  <c:v>0.94658730692345749</c:v>
                </c:pt>
                <c:pt idx="19">
                  <c:v>0.94731201424224298</c:v>
                </c:pt>
                <c:pt idx="20">
                  <c:v>0.94731201424224298</c:v>
                </c:pt>
                <c:pt idx="21">
                  <c:v>0.94731201424224298</c:v>
                </c:pt>
                <c:pt idx="22">
                  <c:v>0.94731201424224298</c:v>
                </c:pt>
                <c:pt idx="23">
                  <c:v>0.94731201424224298</c:v>
                </c:pt>
                <c:pt idx="24">
                  <c:v>0.94802908246618312</c:v>
                </c:pt>
                <c:pt idx="25">
                  <c:v>0.94802908246618312</c:v>
                </c:pt>
                <c:pt idx="26">
                  <c:v>0.94873867656228039</c:v>
                </c:pt>
                <c:pt idx="27">
                  <c:v>0.95013607573974268</c:v>
                </c:pt>
                <c:pt idx="28">
                  <c:v>0.95013607573974268</c:v>
                </c:pt>
                <c:pt idx="29">
                  <c:v>0.9508241849329242</c:v>
                </c:pt>
                <c:pt idx="30">
                  <c:v>0.95150542864543453</c:v>
                </c:pt>
                <c:pt idx="31">
                  <c:v>0.95150542864543453</c:v>
                </c:pt>
                <c:pt idx="32">
                  <c:v>0.95150542864543453</c:v>
                </c:pt>
                <c:pt idx="33">
                  <c:v>0.95150542864543453</c:v>
                </c:pt>
                <c:pt idx="34">
                  <c:v>0.95150542864543453</c:v>
                </c:pt>
                <c:pt idx="35">
                  <c:v>0.95217994729420263</c:v>
                </c:pt>
                <c:pt idx="36">
                  <c:v>0.95350934968382206</c:v>
                </c:pt>
                <c:pt idx="37">
                  <c:v>0.95350934968382206</c:v>
                </c:pt>
                <c:pt idx="38">
                  <c:v>0.95350934968382206</c:v>
                </c:pt>
                <c:pt idx="39">
                  <c:v>0.95416449339241294</c:v>
                </c:pt>
                <c:pt idx="40">
                  <c:v>0.95416449339241294</c:v>
                </c:pt>
                <c:pt idx="41">
                  <c:v>0.95481343229805826</c:v>
                </c:pt>
                <c:pt idx="42">
                  <c:v>0.95481343229805826</c:v>
                </c:pt>
                <c:pt idx="43">
                  <c:v>0.95609317429456908</c:v>
                </c:pt>
                <c:pt idx="44">
                  <c:v>0.95609317429456908</c:v>
                </c:pt>
                <c:pt idx="45">
                  <c:v>0.95609317429456908</c:v>
                </c:pt>
                <c:pt idx="46">
                  <c:v>0.9567242080259184</c:v>
                </c:pt>
                <c:pt idx="47">
                  <c:v>0.95734949850127504</c:v>
                </c:pt>
                <c:pt idx="48">
                  <c:v>0.9579691529717026</c:v>
                </c:pt>
                <c:pt idx="49">
                  <c:v>0.9579691529717026</c:v>
                </c:pt>
                <c:pt idx="50">
                  <c:v>0.9579691529717026</c:v>
                </c:pt>
                <c:pt idx="51">
                  <c:v>0.95858327567835611</c:v>
                </c:pt>
                <c:pt idx="52">
                  <c:v>0.95858327567835611</c:v>
                </c:pt>
                <c:pt idx="53">
                  <c:v>0.95858327567835611</c:v>
                </c:pt>
                <c:pt idx="54">
                  <c:v>0.95858327567835611</c:v>
                </c:pt>
                <c:pt idx="55">
                  <c:v>0.95919196796468009</c:v>
                </c:pt>
                <c:pt idx="56">
                  <c:v>0.95919196796468009</c:v>
                </c:pt>
                <c:pt idx="57">
                  <c:v>0.95919196796468009</c:v>
                </c:pt>
                <c:pt idx="58">
                  <c:v>0.95979532838340953</c:v>
                </c:pt>
                <c:pt idx="59">
                  <c:v>0.96039345279866184</c:v>
                </c:pt>
                <c:pt idx="60">
                  <c:v>0.96039345279866184</c:v>
                </c:pt>
                <c:pt idx="61">
                  <c:v>0.96039345279866184</c:v>
                </c:pt>
                <c:pt idx="62">
                  <c:v>0.96157436421242903</c:v>
                </c:pt>
                <c:pt idx="63">
                  <c:v>0.96157436421242903</c:v>
                </c:pt>
                <c:pt idx="64">
                  <c:v>0.96215733035143081</c:v>
                </c:pt>
                <c:pt idx="65">
                  <c:v>0.96215733035143081</c:v>
                </c:pt>
                <c:pt idx="66">
                  <c:v>0.96215733035143081</c:v>
                </c:pt>
                <c:pt idx="67">
                  <c:v>0.96273541894180925</c:v>
                </c:pt>
                <c:pt idx="68">
                  <c:v>0.96273541894180925</c:v>
                </c:pt>
                <c:pt idx="69">
                  <c:v>0.96273541894180925</c:v>
                </c:pt>
                <c:pt idx="70">
                  <c:v>0.96330871378200189</c:v>
                </c:pt>
                <c:pt idx="71">
                  <c:v>0.96330871378200189</c:v>
                </c:pt>
                <c:pt idx="72">
                  <c:v>0.96330871378200189</c:v>
                </c:pt>
                <c:pt idx="73">
                  <c:v>0.96387729650518417</c:v>
                </c:pt>
                <c:pt idx="74">
                  <c:v>0.96387729650518417</c:v>
                </c:pt>
                <c:pt idx="75">
                  <c:v>0.96444124665363817</c:v>
                </c:pt>
                <c:pt idx="76">
                  <c:v>0.96500064174994526</c:v>
                </c:pt>
                <c:pt idx="77">
                  <c:v>0.96500064174994526</c:v>
                </c:pt>
                <c:pt idx="78">
                  <c:v>0.96500064174994526</c:v>
                </c:pt>
                <c:pt idx="79">
                  <c:v>0.96500064174994526</c:v>
                </c:pt>
                <c:pt idx="80">
                  <c:v>0.96500064174994526</c:v>
                </c:pt>
                <c:pt idx="81">
                  <c:v>0.96555555736516441</c:v>
                </c:pt>
                <c:pt idx="82">
                  <c:v>0.96555555736516441</c:v>
                </c:pt>
                <c:pt idx="83">
                  <c:v>0.96555555736516441</c:v>
                </c:pt>
                <c:pt idx="84">
                  <c:v>0.96610606718414871</c:v>
                </c:pt>
                <c:pt idx="85">
                  <c:v>0.9666522430681429</c:v>
                </c:pt>
                <c:pt idx="86">
                  <c:v>0.9666522430681429</c:v>
                </c:pt>
                <c:pt idx="87">
                  <c:v>0.96719415511479723</c:v>
                </c:pt>
                <c:pt idx="88">
                  <c:v>0.96719415511479723</c:v>
                </c:pt>
                <c:pt idx="89">
                  <c:v>0.96719415511479723</c:v>
                </c:pt>
                <c:pt idx="90">
                  <c:v>0.96773187171572395</c:v>
                </c:pt>
                <c:pt idx="91">
                  <c:v>0.96773187171572395</c:v>
                </c:pt>
                <c:pt idx="92">
                  <c:v>0.96773187171572395</c:v>
                </c:pt>
                <c:pt idx="93">
                  <c:v>0.96826545961171828</c:v>
                </c:pt>
                <c:pt idx="94">
                  <c:v>0.96826545961171828</c:v>
                </c:pt>
                <c:pt idx="95">
                  <c:v>0.96826545961171828</c:v>
                </c:pt>
                <c:pt idx="96">
                  <c:v>0.96879498394575514</c:v>
                </c:pt>
                <c:pt idx="97">
                  <c:v>0.96879498394575514</c:v>
                </c:pt>
                <c:pt idx="98">
                  <c:v>0.96879498394575514</c:v>
                </c:pt>
                <c:pt idx="99">
                  <c:v>0.96879498394575514</c:v>
                </c:pt>
                <c:pt idx="100">
                  <c:v>0.96932050831386884</c:v>
                </c:pt>
                <c:pt idx="101">
                  <c:v>0.96932050831386884</c:v>
                </c:pt>
                <c:pt idx="102">
                  <c:v>0.96984209481401806</c:v>
                </c:pt>
                <c:pt idx="103">
                  <c:v>0.96984209481401806</c:v>
                </c:pt>
                <c:pt idx="104">
                  <c:v>0.96984209481401806</c:v>
                </c:pt>
                <c:pt idx="105">
                  <c:v>0.97035980409302924</c:v>
                </c:pt>
                <c:pt idx="106">
                  <c:v>0.97035980409302924</c:v>
                </c:pt>
                <c:pt idx="107">
                  <c:v>0.97087369539170987</c:v>
                </c:pt>
                <c:pt idx="108">
                  <c:v>0.97087369539170987</c:v>
                </c:pt>
                <c:pt idx="109">
                  <c:v>0.97138382658821665</c:v>
                </c:pt>
                <c:pt idx="110">
                  <c:v>0.97189025423975828</c:v>
                </c:pt>
                <c:pt idx="111">
                  <c:v>0.97189025423975828</c:v>
                </c:pt>
                <c:pt idx="112">
                  <c:v>0.97189025423975828</c:v>
                </c:pt>
                <c:pt idx="113">
                  <c:v>0.97239303362271101</c:v>
                </c:pt>
                <c:pt idx="114">
                  <c:v>0.97239303362271101</c:v>
                </c:pt>
                <c:pt idx="115">
                  <c:v>0.97239303362271101</c:v>
                </c:pt>
                <c:pt idx="116">
                  <c:v>0.97239303362271101</c:v>
                </c:pt>
                <c:pt idx="117">
                  <c:v>0.97289221877121634</c:v>
                </c:pt>
                <c:pt idx="118">
                  <c:v>0.97338786251433229</c:v>
                </c:pt>
                <c:pt idx="119">
                  <c:v>0.97388001651180078</c:v>
                </c:pt>
                <c:pt idx="120">
                  <c:v>0.97436873128849366</c:v>
                </c:pt>
                <c:pt idx="121">
                  <c:v>0.97436873128849366</c:v>
                </c:pt>
                <c:pt idx="122">
                  <c:v>0.97436873128849366</c:v>
                </c:pt>
                <c:pt idx="123">
                  <c:v>0.97436873128849366</c:v>
                </c:pt>
                <c:pt idx="124">
                  <c:v>0.97436873128849366</c:v>
                </c:pt>
                <c:pt idx="125">
                  <c:v>0.97533603980257944</c:v>
                </c:pt>
                <c:pt idx="126">
                  <c:v>0.97581472920802437</c:v>
                </c:pt>
                <c:pt idx="127">
                  <c:v>0.97581472920802437</c:v>
                </c:pt>
                <c:pt idx="128">
                  <c:v>0.97581472920802437</c:v>
                </c:pt>
                <c:pt idx="129">
                  <c:v>0.97629017078933111</c:v>
                </c:pt>
                <c:pt idx="130">
                  <c:v>0.97629017078933111</c:v>
                </c:pt>
                <c:pt idx="131">
                  <c:v>0.97629017078933111</c:v>
                </c:pt>
                <c:pt idx="132">
                  <c:v>0.97629017078933111</c:v>
                </c:pt>
                <c:pt idx="133">
                  <c:v>0.97629017078933111</c:v>
                </c:pt>
                <c:pt idx="134">
                  <c:v>0.97676240987137641</c:v>
                </c:pt>
                <c:pt idx="135">
                  <c:v>0.97676240987137641</c:v>
                </c:pt>
                <c:pt idx="136">
                  <c:v>0.97723149082615601</c:v>
                </c:pt>
                <c:pt idx="137">
                  <c:v>0.97723149082615601</c:v>
                </c:pt>
                <c:pt idx="138">
                  <c:v>0.97723149082615601</c:v>
                </c:pt>
                <c:pt idx="139">
                  <c:v>0.97723149082615601</c:v>
                </c:pt>
                <c:pt idx="140">
                  <c:v>0.97769745709945599</c:v>
                </c:pt>
                <c:pt idx="141">
                  <c:v>0.97769745709945599</c:v>
                </c:pt>
                <c:pt idx="142">
                  <c:v>0.97816035123659528</c:v>
                </c:pt>
                <c:pt idx="143">
                  <c:v>0.97816035123659528</c:v>
                </c:pt>
                <c:pt idx="144">
                  <c:v>0.97816035123659528</c:v>
                </c:pt>
                <c:pt idx="145">
                  <c:v>0.97862021490727635</c:v>
                </c:pt>
                <c:pt idx="146">
                  <c:v>0.97862021490727635</c:v>
                </c:pt>
                <c:pt idx="147">
                  <c:v>0.97862021490727635</c:v>
                </c:pt>
                <c:pt idx="148">
                  <c:v>0.97862021490727635</c:v>
                </c:pt>
                <c:pt idx="149">
                  <c:v>0.97862021490727635</c:v>
                </c:pt>
                <c:pt idx="150">
                  <c:v>0.9790770889295819</c:v>
                </c:pt>
                <c:pt idx="151">
                  <c:v>0.9790770889295819</c:v>
                </c:pt>
                <c:pt idx="152">
                  <c:v>0.9790770889295819</c:v>
                </c:pt>
                <c:pt idx="153">
                  <c:v>0.97953101329315295</c:v>
                </c:pt>
                <c:pt idx="154">
                  <c:v>0.97953101329315295</c:v>
                </c:pt>
                <c:pt idx="155">
                  <c:v>0.97953101329315295</c:v>
                </c:pt>
                <c:pt idx="156">
                  <c:v>0.97953101329315295</c:v>
                </c:pt>
                <c:pt idx="157">
                  <c:v>0.97953101329315295</c:v>
                </c:pt>
                <c:pt idx="158">
                  <c:v>0.97998202718158023</c:v>
                </c:pt>
                <c:pt idx="159">
                  <c:v>0.97998202718158023</c:v>
                </c:pt>
                <c:pt idx="160">
                  <c:v>0.97998202718158023</c:v>
                </c:pt>
                <c:pt idx="161">
                  <c:v>0.97998202718158023</c:v>
                </c:pt>
                <c:pt idx="162">
                  <c:v>0.98043016899404245</c:v>
                </c:pt>
                <c:pt idx="163">
                  <c:v>0.98043016899404245</c:v>
                </c:pt>
                <c:pt idx="164">
                  <c:v>0.98043016899404245</c:v>
                </c:pt>
                <c:pt idx="165">
                  <c:v>0.98043016899404245</c:v>
                </c:pt>
                <c:pt idx="166">
                  <c:v>0.98043016899404245</c:v>
                </c:pt>
                <c:pt idx="167">
                  <c:v>0.98087547636622041</c:v>
                </c:pt>
                <c:pt idx="168">
                  <c:v>0.98087547636622041</c:v>
                </c:pt>
                <c:pt idx="169">
                  <c:v>0.98087547636622041</c:v>
                </c:pt>
                <c:pt idx="170">
                  <c:v>0.98131798619051658</c:v>
                </c:pt>
                <c:pt idx="171">
                  <c:v>0.981757734635608</c:v>
                </c:pt>
                <c:pt idx="172">
                  <c:v>0.981757734635608</c:v>
                </c:pt>
                <c:pt idx="173">
                  <c:v>0.981757734635608</c:v>
                </c:pt>
                <c:pt idx="174">
                  <c:v>0.98219475716535742</c:v>
                </c:pt>
                <c:pt idx="175">
                  <c:v>0.98262908855710951</c:v>
                </c:pt>
                <c:pt idx="176">
                  <c:v>0.98262908855710951</c:v>
                </c:pt>
                <c:pt idx="177">
                  <c:v>0.98306076291939504</c:v>
                </c:pt>
                <c:pt idx="178">
                  <c:v>0.98306076291939504</c:v>
                </c:pt>
                <c:pt idx="179">
                  <c:v>0.98306076291939504</c:v>
                </c:pt>
                <c:pt idx="180">
                  <c:v>0.98348981370906574</c:v>
                </c:pt>
                <c:pt idx="181">
                  <c:v>0.98348981370906574</c:v>
                </c:pt>
                <c:pt idx="182">
                  <c:v>0.98348981370906574</c:v>
                </c:pt>
                <c:pt idx="183">
                  <c:v>0.98348981370906574</c:v>
                </c:pt>
                <c:pt idx="184">
                  <c:v>0.98391627374788293</c:v>
                </c:pt>
                <c:pt idx="185">
                  <c:v>0.98391627374788293</c:v>
                </c:pt>
                <c:pt idx="186">
                  <c:v>0.98391627374788293</c:v>
                </c:pt>
                <c:pt idx="187">
                  <c:v>0.98434017523857897</c:v>
                </c:pt>
                <c:pt idx="188">
                  <c:v>0.98434017523857897</c:v>
                </c:pt>
                <c:pt idx="189">
                  <c:v>0.98434017523857897</c:v>
                </c:pt>
                <c:pt idx="190">
                  <c:v>0.98434017523857897</c:v>
                </c:pt>
                <c:pt idx="191">
                  <c:v>0.98476154978041353</c:v>
                </c:pt>
                <c:pt idx="192">
                  <c:v>0.98476154978041353</c:v>
                </c:pt>
                <c:pt idx="193">
                  <c:v>0.98518042838424158</c:v>
                </c:pt>
                <c:pt idx="194">
                  <c:v>0.98559684148711302</c:v>
                </c:pt>
                <c:pt idx="195">
                  <c:v>0.98559684148711302</c:v>
                </c:pt>
                <c:pt idx="196">
                  <c:v>0.98601081896642107</c:v>
                </c:pt>
                <c:pt idx="197">
                  <c:v>0.98642239015361532</c:v>
                </c:pt>
                <c:pt idx="198">
                  <c:v>0.98642239015361532</c:v>
                </c:pt>
                <c:pt idx="199">
                  <c:v>0.98642239015361532</c:v>
                </c:pt>
                <c:pt idx="200">
                  <c:v>0.98683158384749614</c:v>
                </c:pt>
                <c:pt idx="201">
                  <c:v>0.9872384283271054</c:v>
                </c:pt>
                <c:pt idx="202">
                  <c:v>0.98764295136422886</c:v>
                </c:pt>
                <c:pt idx="203">
                  <c:v>0.98764295136422886</c:v>
                </c:pt>
                <c:pt idx="204">
                  <c:v>0.98764295136422886</c:v>
                </c:pt>
                <c:pt idx="205">
                  <c:v>0.98804518023552257</c:v>
                </c:pt>
                <c:pt idx="206">
                  <c:v>0.98804518023552257</c:v>
                </c:pt>
                <c:pt idx="207">
                  <c:v>0.988445141734279</c:v>
                </c:pt>
                <c:pt idx="208">
                  <c:v>0.988445141734279</c:v>
                </c:pt>
                <c:pt idx="209">
                  <c:v>0.988445141734279</c:v>
                </c:pt>
                <c:pt idx="210">
                  <c:v>0.98884286218184414</c:v>
                </c:pt>
                <c:pt idx="211">
                  <c:v>0.98884286218184414</c:v>
                </c:pt>
                <c:pt idx="212">
                  <c:v>0.98884286218184414</c:v>
                </c:pt>
                <c:pt idx="213">
                  <c:v>0.98884286218184414</c:v>
                </c:pt>
                <c:pt idx="214">
                  <c:v>0.98884286218184414</c:v>
                </c:pt>
                <c:pt idx="215">
                  <c:v>0.98923836743869797</c:v>
                </c:pt>
                <c:pt idx="216">
                  <c:v>0.98923836743869797</c:v>
                </c:pt>
                <c:pt idx="217">
                  <c:v>0.98923836743869797</c:v>
                </c:pt>
                <c:pt idx="218">
                  <c:v>0.98923836743869797</c:v>
                </c:pt>
                <c:pt idx="219">
                  <c:v>0.99041184398050908</c:v>
                </c:pt>
                <c:pt idx="220">
                  <c:v>0.99041184398050908</c:v>
                </c:pt>
                <c:pt idx="221">
                  <c:v>0.99041184398050908</c:v>
                </c:pt>
                <c:pt idx="222">
                  <c:v>0.99079873823197928</c:v>
                </c:pt>
                <c:pt idx="223">
                  <c:v>0.99079873823197928</c:v>
                </c:pt>
                <c:pt idx="224">
                  <c:v>0.99079873823197928</c:v>
                </c:pt>
                <c:pt idx="225">
                  <c:v>0.99118354004789644</c:v>
                </c:pt>
                <c:pt idx="226">
                  <c:v>0.99118354004789644</c:v>
                </c:pt>
                <c:pt idx="227">
                  <c:v>0.99156627273884734</c:v>
                </c:pt>
                <c:pt idx="228">
                  <c:v>0.99194695922364085</c:v>
                </c:pt>
                <c:pt idx="229">
                  <c:v>0.99194695922364085</c:v>
                </c:pt>
                <c:pt idx="230">
                  <c:v>0.99270228334353128</c:v>
                </c:pt>
                <c:pt idx="231">
                  <c:v>0.99270228334353128</c:v>
                </c:pt>
                <c:pt idx="232">
                  <c:v>0.99307696493515074</c:v>
                </c:pt>
                <c:pt idx="233">
                  <c:v>0.99307696493515074</c:v>
                </c:pt>
                <c:pt idx="234">
                  <c:v>0.99307696493515074</c:v>
                </c:pt>
                <c:pt idx="235">
                  <c:v>0.99382047437496757</c:v>
                </c:pt>
                <c:pt idx="236">
                  <c:v>0.99418934405418546</c:v>
                </c:pt>
                <c:pt idx="237">
                  <c:v>0.99418934405418546</c:v>
                </c:pt>
                <c:pt idx="238">
                  <c:v>0.99455631769667496</c:v>
                </c:pt>
                <c:pt idx="239">
                  <c:v>0.99455631769667496</c:v>
                </c:pt>
                <c:pt idx="240">
                  <c:v>0.99455631769667496</c:v>
                </c:pt>
                <c:pt idx="241">
                  <c:v>0.99492141538345913</c:v>
                </c:pt>
                <c:pt idx="242">
                  <c:v>0.99492141538345913</c:v>
                </c:pt>
                <c:pt idx="243">
                  <c:v>0.99492141538345913</c:v>
                </c:pt>
                <c:pt idx="244">
                  <c:v>0.99492141538345913</c:v>
                </c:pt>
                <c:pt idx="245">
                  <c:v>0.9952846568746142</c:v>
                </c:pt>
                <c:pt idx="246">
                  <c:v>0.9952846568746142</c:v>
                </c:pt>
                <c:pt idx="247">
                  <c:v>0.99564606161611036</c:v>
                </c:pt>
                <c:pt idx="248">
                  <c:v>0.99600564874647179</c:v>
                </c:pt>
                <c:pt idx="249">
                  <c:v>0.99600564874647179</c:v>
                </c:pt>
                <c:pt idx="250">
                  <c:v>0.99636343710325903</c:v>
                </c:pt>
                <c:pt idx="251">
                  <c:v>0.99636343710325903</c:v>
                </c:pt>
                <c:pt idx="252">
                  <c:v>0.99636343710325903</c:v>
                </c:pt>
                <c:pt idx="253">
                  <c:v>0.99636343710325903</c:v>
                </c:pt>
                <c:pt idx="254">
                  <c:v>0.99636343710325903</c:v>
                </c:pt>
                <c:pt idx="255">
                  <c:v>0.99671944522938227</c:v>
                </c:pt>
                <c:pt idx="256">
                  <c:v>0.99671944522938227</c:v>
                </c:pt>
                <c:pt idx="257">
                  <c:v>0.99671944522938227</c:v>
                </c:pt>
                <c:pt idx="258">
                  <c:v>0.99671944522938227</c:v>
                </c:pt>
                <c:pt idx="259">
                  <c:v>0.99707369137924851</c:v>
                </c:pt>
                <c:pt idx="260">
                  <c:v>0.99707369137924851</c:v>
                </c:pt>
                <c:pt idx="261">
                  <c:v>0.99707369137924851</c:v>
                </c:pt>
                <c:pt idx="262">
                  <c:v>0.99742619352474848</c:v>
                </c:pt>
                <c:pt idx="263">
                  <c:v>0.99742619352474848</c:v>
                </c:pt>
                <c:pt idx="264">
                  <c:v>0.99742619352474848</c:v>
                </c:pt>
                <c:pt idx="265">
                  <c:v>0.99777696936109017</c:v>
                </c:pt>
                <c:pt idx="266">
                  <c:v>0.99777696936109017</c:v>
                </c:pt>
                <c:pt idx="267">
                  <c:v>0.99847341153765867</c:v>
                </c:pt>
                <c:pt idx="268">
                  <c:v>0.99881911193529938</c:v>
                </c:pt>
                <c:pt idx="269">
                  <c:v>0.99881911193529938</c:v>
                </c:pt>
                <c:pt idx="270">
                  <c:v>0.99881911193529938</c:v>
                </c:pt>
                <c:pt idx="271">
                  <c:v>0.99881911193529938</c:v>
                </c:pt>
                <c:pt idx="272">
                  <c:v>0.99916315414926316</c:v>
                </c:pt>
                <c:pt idx="273">
                  <c:v>0.99950555457372647</c:v>
                </c:pt>
                <c:pt idx="274">
                  <c:v>0.99984632935817819</c:v>
                </c:pt>
                <c:pt idx="275">
                  <c:v>1.0001854944122917</c:v>
                </c:pt>
                <c:pt idx="276">
                  <c:v>1.0001854944122917</c:v>
                </c:pt>
                <c:pt idx="277">
                  <c:v>1.0005230654106767</c:v>
                </c:pt>
                <c:pt idx="278">
                  <c:v>1.0008590577975127</c:v>
                </c:pt>
                <c:pt idx="279">
                  <c:v>1.0008590577975127</c:v>
                </c:pt>
                <c:pt idx="280">
                  <c:v>1.0011934867910683</c:v>
                </c:pt>
                <c:pt idx="281">
                  <c:v>1.0011934867910683</c:v>
                </c:pt>
                <c:pt idx="282">
                  <c:v>1.0011934867910683</c:v>
                </c:pt>
                <c:pt idx="283">
                  <c:v>1.0011934867910683</c:v>
                </c:pt>
                <c:pt idx="284">
                  <c:v>1.0011934867910683</c:v>
                </c:pt>
                <c:pt idx="285">
                  <c:v>1.0015263673881121</c:v>
                </c:pt>
                <c:pt idx="286">
                  <c:v>1.0015263673881121</c:v>
                </c:pt>
                <c:pt idx="287">
                  <c:v>1.0018577143682126</c:v>
                </c:pt>
                <c:pt idx="288">
                  <c:v>1.0021875422979367</c:v>
                </c:pt>
                <c:pt idx="289">
                  <c:v>1.0021875422979367</c:v>
                </c:pt>
                <c:pt idx="290">
                  <c:v>1.0021875422979367</c:v>
                </c:pt>
                <c:pt idx="291">
                  <c:v>1.0021875422979367</c:v>
                </c:pt>
                <c:pt idx="292">
                  <c:v>1.0021875422979367</c:v>
                </c:pt>
                <c:pt idx="293">
                  <c:v>1.0021875422979367</c:v>
                </c:pt>
                <c:pt idx="294">
                  <c:v>1.002515865534946</c:v>
                </c:pt>
                <c:pt idx="295">
                  <c:v>1.002515865534946</c:v>
                </c:pt>
                <c:pt idx="296">
                  <c:v>1.002515865534946</c:v>
                </c:pt>
                <c:pt idx="297">
                  <c:v>1.0028426982319942</c:v>
                </c:pt>
                <c:pt idx="298">
                  <c:v>1.0028426982319942</c:v>
                </c:pt>
                <c:pt idx="299">
                  <c:v>1.0031680543408301</c:v>
                </c:pt>
                <c:pt idx="300">
                  <c:v>1.0031680543408301</c:v>
                </c:pt>
                <c:pt idx="301">
                  <c:v>1.0034919476160074</c:v>
                </c:pt>
                <c:pt idx="302">
                  <c:v>1.0038143916186029</c:v>
                </c:pt>
                <c:pt idx="303">
                  <c:v>1.0038143916186029</c:v>
                </c:pt>
                <c:pt idx="304">
                  <c:v>1.0038143916186029</c:v>
                </c:pt>
                <c:pt idx="305">
                  <c:v>1.0044549851046871</c:v>
                </c:pt>
                <c:pt idx="306">
                  <c:v>1.0044549851046871</c:v>
                </c:pt>
                <c:pt idx="307">
                  <c:v>1.0044549851046871</c:v>
                </c:pt>
                <c:pt idx="308">
                  <c:v>1.0057193568500078</c:v>
                </c:pt>
                <c:pt idx="309">
                  <c:v>1.0057193568500078</c:v>
                </c:pt>
                <c:pt idx="310">
                  <c:v>1.0060320201444852</c:v>
                </c:pt>
                <c:pt idx="311">
                  <c:v>1.0060320201444852</c:v>
                </c:pt>
                <c:pt idx="312">
                  <c:v>1.0060320201444852</c:v>
                </c:pt>
                <c:pt idx="313">
                  <c:v>1.0060320201444852</c:v>
                </c:pt>
                <c:pt idx="314">
                  <c:v>1.0063433361084175</c:v>
                </c:pt>
                <c:pt idx="315">
                  <c:v>1.0066533167153071</c:v>
                </c:pt>
                <c:pt idx="316">
                  <c:v>1.0069619737779409</c:v>
                </c:pt>
                <c:pt idx="317">
                  <c:v>1.0078801194774685</c:v>
                </c:pt>
                <c:pt idx="318">
                  <c:v>1.0078801194774685</c:v>
                </c:pt>
                <c:pt idx="319">
                  <c:v>1.0081835973760855</c:v>
                </c:pt>
                <c:pt idx="320">
                  <c:v>1.0081835973760855</c:v>
                </c:pt>
                <c:pt idx="321">
                  <c:v>1.0081835973760855</c:v>
                </c:pt>
                <c:pt idx="322">
                  <c:v>1.0084858084822172</c:v>
                </c:pt>
                <c:pt idx="323">
                  <c:v>1.0084858084822172</c:v>
                </c:pt>
                <c:pt idx="324">
                  <c:v>1.0084858084822172</c:v>
                </c:pt>
                <c:pt idx="325">
                  <c:v>1.008786763702634</c:v>
                </c:pt>
                <c:pt idx="326">
                  <c:v>1.008786763702634</c:v>
                </c:pt>
                <c:pt idx="327">
                  <c:v>1.008786763702634</c:v>
                </c:pt>
                <c:pt idx="328">
                  <c:v>1.008786763702634</c:v>
                </c:pt>
                <c:pt idx="329">
                  <c:v>1.0090864738022527</c:v>
                </c:pt>
                <c:pt idx="330">
                  <c:v>1.0090864738022527</c:v>
                </c:pt>
                <c:pt idx="331">
                  <c:v>1.0093849494066014</c:v>
                </c:pt>
                <c:pt idx="332">
                  <c:v>1.0093849494066014</c:v>
                </c:pt>
                <c:pt idx="333">
                  <c:v>1.0093849494066014</c:v>
                </c:pt>
                <c:pt idx="334">
                  <c:v>1.0096822010042277</c:v>
                </c:pt>
                <c:pt idx="335">
                  <c:v>1.0096822010042277</c:v>
                </c:pt>
                <c:pt idx="336">
                  <c:v>1.0099782389490566</c:v>
                </c:pt>
                <c:pt idx="337">
                  <c:v>1.0102730734626981</c:v>
                </c:pt>
                <c:pt idx="338">
                  <c:v>1.0102730734626981</c:v>
                </c:pt>
                <c:pt idx="339">
                  <c:v>1.0108591724347769</c:v>
                </c:pt>
                <c:pt idx="340">
                  <c:v>1.0111504566949348</c:v>
                </c:pt>
                <c:pt idx="341">
                  <c:v>1.0111504566949348</c:v>
                </c:pt>
                <c:pt idx="342">
                  <c:v>1.0111504566949348</c:v>
                </c:pt>
                <c:pt idx="343">
                  <c:v>1.0111504566949348</c:v>
                </c:pt>
                <c:pt idx="344">
                  <c:v>1.0111504566949348</c:v>
                </c:pt>
                <c:pt idx="345">
                  <c:v>1.0114405771316255</c:v>
                </c:pt>
                <c:pt idx="346">
                  <c:v>1.0114405771316255</c:v>
                </c:pt>
                <c:pt idx="347">
                  <c:v>1.0117295433378011</c:v>
                </c:pt>
                <c:pt idx="348">
                  <c:v>1.0117295433378011</c:v>
                </c:pt>
                <c:pt idx="349">
                  <c:v>1.0120173647869453</c:v>
                </c:pt>
                <c:pt idx="350">
                  <c:v>1.0120173647869453</c:v>
                </c:pt>
                <c:pt idx="351">
                  <c:v>1.0120173647869453</c:v>
                </c:pt>
                <c:pt idx="352">
                  <c:v>1.0125896107226164</c:v>
                </c:pt>
                <c:pt idx="353">
                  <c:v>1.0125896107226164</c:v>
                </c:pt>
                <c:pt idx="354">
                  <c:v>1.0125896107226164</c:v>
                </c:pt>
                <c:pt idx="355">
                  <c:v>1.0134396241332915</c:v>
                </c:pt>
                <c:pt idx="356">
                  <c:v>1.013720769538428</c:v>
                </c:pt>
                <c:pt idx="357">
                  <c:v>1.013720769538428</c:v>
                </c:pt>
                <c:pt idx="358">
                  <c:v>1.013720769538428</c:v>
                </c:pt>
                <c:pt idx="359">
                  <c:v>1.0140008333176336</c:v>
                </c:pt>
                <c:pt idx="360">
                  <c:v>1.0140008333176336</c:v>
                </c:pt>
                <c:pt idx="361">
                  <c:v>1.0140008333176336</c:v>
                </c:pt>
                <c:pt idx="362">
                  <c:v>1.0142798240568298</c:v>
                </c:pt>
                <c:pt idx="363">
                  <c:v>1.0142798240568298</c:v>
                </c:pt>
                <c:pt idx="364">
                  <c:v>1.0145577502389478</c:v>
                </c:pt>
                <c:pt idx="365">
                  <c:v>1.0145577502389478</c:v>
                </c:pt>
                <c:pt idx="366">
                  <c:v>1.0145577502389478</c:v>
                </c:pt>
                <c:pt idx="367">
                  <c:v>1.014834620245578</c:v>
                </c:pt>
                <c:pt idx="368">
                  <c:v>1.014834620245578</c:v>
                </c:pt>
                <c:pt idx="369">
                  <c:v>1.0151104423585866</c:v>
                </c:pt>
                <c:pt idx="370">
                  <c:v>1.015385224761701</c:v>
                </c:pt>
                <c:pt idx="371">
                  <c:v>1.0159317026917469</c:v>
                </c:pt>
                <c:pt idx="372">
                  <c:v>1.0159317026917469</c:v>
                </c:pt>
                <c:pt idx="373">
                  <c:v>1.0159317026917469</c:v>
                </c:pt>
                <c:pt idx="374">
                  <c:v>1.0159317026917469</c:v>
                </c:pt>
                <c:pt idx="375">
                  <c:v>1.0159317026917469</c:v>
                </c:pt>
                <c:pt idx="376">
                  <c:v>1.0159317026917469</c:v>
                </c:pt>
                <c:pt idx="377">
                  <c:v>1.0159317026917469</c:v>
                </c:pt>
                <c:pt idx="378">
                  <c:v>1.016203414109262</c:v>
                </c:pt>
                <c:pt idx="379">
                  <c:v>1.016203414109262</c:v>
                </c:pt>
                <c:pt idx="380">
                  <c:v>1.016203414109262</c:v>
                </c:pt>
                <c:pt idx="381">
                  <c:v>1.016203414109262</c:v>
                </c:pt>
                <c:pt idx="382">
                  <c:v>1.0164741176010048</c:v>
                </c:pt>
                <c:pt idx="383">
                  <c:v>1.0164741176010048</c:v>
                </c:pt>
                <c:pt idx="384">
                  <c:v>1.0167438208827004</c:v>
                </c:pt>
                <c:pt idx="385">
                  <c:v>1.017012531580807</c:v>
                </c:pt>
                <c:pt idx="386">
                  <c:v>1.017012531580807</c:v>
                </c:pt>
                <c:pt idx="387">
                  <c:v>1.0172802572338955</c:v>
                </c:pt>
                <c:pt idx="388">
                  <c:v>1.0175470052940021</c:v>
                </c:pt>
                <c:pt idx="389">
                  <c:v>1.0175470052940021</c:v>
                </c:pt>
                <c:pt idx="390">
                  <c:v>1.0178127831279558</c:v>
                </c:pt>
                <c:pt idx="391">
                  <c:v>1.0180775980186796</c:v>
                </c:pt>
                <c:pt idx="392">
                  <c:v>1.0180775980186796</c:v>
                </c:pt>
                <c:pt idx="393">
                  <c:v>1.018866336628742</c:v>
                </c:pt>
                <c:pt idx="394">
                  <c:v>1.0191273709418216</c:v>
                </c:pt>
                <c:pt idx="395">
                  <c:v>1.0193874775115328</c:v>
                </c:pt>
                <c:pt idx="396">
                  <c:v>1.0193874775115328</c:v>
                </c:pt>
                <c:pt idx="397">
                  <c:v>1.0196466631433383</c:v>
                </c:pt>
                <c:pt idx="398">
                  <c:v>1.0196466631433383</c:v>
                </c:pt>
                <c:pt idx="399">
                  <c:v>1.0199049345672395</c:v>
                </c:pt>
                <c:pt idx="400">
                  <c:v>1.0201622984388947</c:v>
                </c:pt>
                <c:pt idx="401">
                  <c:v>1.0201622984388947</c:v>
                </c:pt>
                <c:pt idx="402">
                  <c:v>1.0201622984388947</c:v>
                </c:pt>
                <c:pt idx="403">
                  <c:v>1.0201622984388947</c:v>
                </c:pt>
                <c:pt idx="404">
                  <c:v>1.0204187613407163</c:v>
                </c:pt>
                <c:pt idx="405">
                  <c:v>1.0206743297829464</c:v>
                </c:pt>
                <c:pt idx="406">
                  <c:v>1.0209290102047159</c:v>
                </c:pt>
                <c:pt idx="407">
                  <c:v>1.0214357323940402</c:v>
                </c:pt>
                <c:pt idx="408">
                  <c:v>1.0216877866935401</c:v>
                </c:pt>
                <c:pt idx="409">
                  <c:v>1.0216877866935401</c:v>
                </c:pt>
                <c:pt idx="410">
                  <c:v>1.021938978038452</c:v>
                </c:pt>
                <c:pt idx="411">
                  <c:v>1.0226874350084108</c:v>
                </c:pt>
                <c:pt idx="412">
                  <c:v>1.023182201639657</c:v>
                </c:pt>
                <c:pt idx="413">
                  <c:v>1.023182201639657</c:v>
                </c:pt>
                <c:pt idx="414">
                  <c:v>1.023428341082619</c:v>
                </c:pt>
                <c:pt idx="415">
                  <c:v>1.0236736589259248</c:v>
                </c:pt>
                <c:pt idx="416">
                  <c:v>1.0239181608311718</c:v>
                </c:pt>
                <c:pt idx="417">
                  <c:v>1.0241618524009715</c:v>
                </c:pt>
                <c:pt idx="418">
                  <c:v>1.0241618524009715</c:v>
                </c:pt>
                <c:pt idx="419">
                  <c:v>1.0244047391797695</c:v>
                </c:pt>
                <c:pt idx="420">
                  <c:v>1.0244047391797695</c:v>
                </c:pt>
                <c:pt idx="421">
                  <c:v>1.0246468266546531</c:v>
                </c:pt>
                <c:pt idx="422">
                  <c:v>1.024888120256144</c:v>
                </c:pt>
                <c:pt idx="423">
                  <c:v>1.024888120256144</c:v>
                </c:pt>
                <c:pt idx="424">
                  <c:v>1.0251286253589775</c:v>
                </c:pt>
                <c:pt idx="425">
                  <c:v>1.0251286253589775</c:v>
                </c:pt>
                <c:pt idx="426">
                  <c:v>1.0253683472828687</c:v>
                </c:pt>
                <c:pt idx="427">
                  <c:v>1.0253683472828687</c:v>
                </c:pt>
                <c:pt idx="428">
                  <c:v>1.0253683472828687</c:v>
                </c:pt>
                <c:pt idx="429">
                  <c:v>1.0256072912932641</c:v>
                </c:pt>
                <c:pt idx="430">
                  <c:v>1.026082866368442</c:v>
                </c:pt>
                <c:pt idx="431">
                  <c:v>1.0265553916505261</c:v>
                </c:pt>
                <c:pt idx="432">
                  <c:v>1.0267905232268546</c:v>
                </c:pt>
                <c:pt idx="433">
                  <c:v>1.0270249073833015</c:v>
                </c:pt>
                <c:pt idx="434">
                  <c:v>1.0272585490254642</c:v>
                </c:pt>
                <c:pt idx="435">
                  <c:v>1.0272585490254642</c:v>
                </c:pt>
                <c:pt idx="436">
                  <c:v>1.0274914530102506</c:v>
                </c:pt>
                <c:pt idx="437">
                  <c:v>1.0277236241465264</c:v>
                </c:pt>
                <c:pt idx="438">
                  <c:v>1.0279550671957494</c:v>
                </c:pt>
                <c:pt idx="439">
                  <c:v>1.0286450747376088</c:v>
                </c:pt>
                <c:pt idx="440">
                  <c:v>1.0286450747376088</c:v>
                </c:pt>
                <c:pt idx="441">
                  <c:v>1.0288736521266912</c:v>
                </c:pt>
                <c:pt idx="442">
                  <c:v>1.0288736521266912</c:v>
                </c:pt>
                <c:pt idx="443">
                  <c:v>1.0288736521266912</c:v>
                </c:pt>
                <c:pt idx="444">
                  <c:v>1.0288736521266912</c:v>
                </c:pt>
                <c:pt idx="445">
                  <c:v>1.0288736521266912</c:v>
                </c:pt>
                <c:pt idx="446">
                  <c:v>1.0288736521266912</c:v>
                </c:pt>
                <c:pt idx="447">
                  <c:v>1.0291015245463997</c:v>
                </c:pt>
                <c:pt idx="448">
                  <c:v>1.0293286964865098</c:v>
                </c:pt>
                <c:pt idx="449">
                  <c:v>1.0295551723935519</c:v>
                </c:pt>
                <c:pt idx="450">
                  <c:v>1.0295551723935519</c:v>
                </c:pt>
                <c:pt idx="451">
                  <c:v>1.0295551723935519</c:v>
                </c:pt>
                <c:pt idx="452">
                  <c:v>1.0295551723935519</c:v>
                </c:pt>
                <c:pt idx="453">
                  <c:v>1.0297809566713694</c:v>
                </c:pt>
                <c:pt idx="454">
                  <c:v>1.0300060536816651</c:v>
                </c:pt>
                <c:pt idx="455">
                  <c:v>1.0302304677445409</c:v>
                </c:pt>
                <c:pt idx="456">
                  <c:v>1.0302304677445409</c:v>
                </c:pt>
                <c:pt idx="457">
                  <c:v>1.0302304677445409</c:v>
                </c:pt>
                <c:pt idx="458">
                  <c:v>1.0304542031390278</c:v>
                </c:pt>
                <c:pt idx="459">
                  <c:v>1.0306772641036079</c:v>
                </c:pt>
                <c:pt idx="460">
                  <c:v>1.0306772641036079</c:v>
                </c:pt>
                <c:pt idx="461">
                  <c:v>1.0306772641036079</c:v>
                </c:pt>
                <c:pt idx="462">
                  <c:v>1.0308996548367284</c:v>
                </c:pt>
                <c:pt idx="463">
                  <c:v>1.0308996548367284</c:v>
                </c:pt>
                <c:pt idx="464">
                  <c:v>1.0311213794973062</c:v>
                </c:pt>
                <c:pt idx="465">
                  <c:v>1.031342442205226</c:v>
                </c:pt>
                <c:pt idx="466">
                  <c:v>1.0317825980503998</c:v>
                </c:pt>
                <c:pt idx="467">
                  <c:v>1.0317825980503998</c:v>
                </c:pt>
                <c:pt idx="468">
                  <c:v>1.0324379679797189</c:v>
                </c:pt>
                <c:pt idx="469">
                  <c:v>1.0326551433642033</c:v>
                </c:pt>
                <c:pt idx="470">
                  <c:v>1.0328716845824994</c:v>
                </c:pt>
                <c:pt idx="471">
                  <c:v>1.0328716845824994</c:v>
                </c:pt>
                <c:pt idx="472">
                  <c:v>1.0328716845824994</c:v>
                </c:pt>
                <c:pt idx="473">
                  <c:v>1.0330875954592345</c:v>
                </c:pt>
                <c:pt idx="474">
                  <c:v>1.0330875954592345</c:v>
                </c:pt>
                <c:pt idx="475">
                  <c:v>1.0335175413125017</c:v>
                </c:pt>
                <c:pt idx="476">
                  <c:v>1.0335175413125017</c:v>
                </c:pt>
                <c:pt idx="477">
                  <c:v>1.0335175413125017</c:v>
                </c:pt>
                <c:pt idx="478">
                  <c:v>1.0337315837655319</c:v>
                </c:pt>
                <c:pt idx="479">
                  <c:v>1.0337315837655319</c:v>
                </c:pt>
                <c:pt idx="480">
                  <c:v>1.0337315837655319</c:v>
                </c:pt>
                <c:pt idx="481">
                  <c:v>1.0339450108308279</c:v>
                </c:pt>
                <c:pt idx="482">
                  <c:v>1.0339450108308279</c:v>
                </c:pt>
                <c:pt idx="483">
                  <c:v>1.0341578261627566</c:v>
                </c:pt>
                <c:pt idx="484">
                  <c:v>1.0343700333828576</c:v>
                </c:pt>
                <c:pt idx="485">
                  <c:v>1.0345816360802389</c:v>
                </c:pt>
                <c:pt idx="486">
                  <c:v>1.0345816360802389</c:v>
                </c:pt>
                <c:pt idx="487">
                  <c:v>1.0347926378119643</c:v>
                </c:pt>
                <c:pt idx="488">
                  <c:v>1.0350030421034357</c:v>
                </c:pt>
                <c:pt idx="489">
                  <c:v>1.0350030421034357</c:v>
                </c:pt>
                <c:pt idx="490">
                  <c:v>1.0352128524487711</c:v>
                </c:pt>
                <c:pt idx="491">
                  <c:v>1.0356307051233014</c:v>
                </c:pt>
                <c:pt idx="492">
                  <c:v>1.0358387542876208</c:v>
                </c:pt>
                <c:pt idx="493">
                  <c:v>1.0364594334730197</c:v>
                </c:pt>
                <c:pt idx="494">
                  <c:v>1.0366651814793528</c:v>
                </c:pt>
                <c:pt idx="495">
                  <c:v>1.0370749794925189</c:v>
                </c:pt>
                <c:pt idx="496">
                  <c:v>1.0372790359287749</c:v>
                </c:pt>
                <c:pt idx="497">
                  <c:v>1.0374825348917327</c:v>
                </c:pt>
                <c:pt idx="498">
                  <c:v>1.0374825348917327</c:v>
                </c:pt>
                <c:pt idx="499">
                  <c:v>1.0378878729554664</c:v>
                </c:pt>
                <c:pt idx="500">
                  <c:v>1.0378878729554664</c:v>
                </c:pt>
                <c:pt idx="501">
                  <c:v>1.0378878729554664</c:v>
                </c:pt>
                <c:pt idx="502">
                  <c:v>1.0380897182682485</c:v>
                </c:pt>
                <c:pt idx="503">
                  <c:v>1.0382910185323544</c:v>
                </c:pt>
                <c:pt idx="504">
                  <c:v>1.0384917767883</c:v>
                </c:pt>
                <c:pt idx="505">
                  <c:v>1.0386919960509398</c:v>
                </c:pt>
                <c:pt idx="506">
                  <c:v>1.0386919960509398</c:v>
                </c:pt>
                <c:pt idx="507">
                  <c:v>1.0386919960509398</c:v>
                </c:pt>
                <c:pt idx="508">
                  <c:v>1.0386919960509398</c:v>
                </c:pt>
                <c:pt idx="509">
                  <c:v>1.0386919960509398</c:v>
                </c:pt>
                <c:pt idx="510">
                  <c:v>1.0390908295291423</c:v>
                </c:pt>
                <c:pt idx="511">
                  <c:v>1.0396851112242631</c:v>
                </c:pt>
                <c:pt idx="512">
                  <c:v>1.0396851112242631</c:v>
                </c:pt>
                <c:pt idx="513">
                  <c:v>1.0398821584379203</c:v>
                </c:pt>
                <c:pt idx="514">
                  <c:v>1.0398821584379203</c:v>
                </c:pt>
                <c:pt idx="515">
                  <c:v>1.0402746999327668</c:v>
                </c:pt>
                <c:pt idx="516">
                  <c:v>1.040470199830059</c:v>
                </c:pt>
                <c:pt idx="517">
                  <c:v>1.0406651895329257</c:v>
                </c:pt>
                <c:pt idx="518">
                  <c:v>1.0408596717921883</c:v>
                </c:pt>
                <c:pt idx="519">
                  <c:v>1.0410536493362255</c:v>
                </c:pt>
                <c:pt idx="520">
                  <c:v>1.0410536493362255</c:v>
                </c:pt>
                <c:pt idx="521">
                  <c:v>1.0412471248712194</c:v>
                </c:pt>
                <c:pt idx="522">
                  <c:v>1.0414401010813965</c:v>
                </c:pt>
                <c:pt idx="523">
                  <c:v>1.0416325806292657</c:v>
                </c:pt>
                <c:pt idx="524">
                  <c:v>1.0418245661558536</c:v>
                </c:pt>
                <c:pt idx="525">
                  <c:v>1.0422070656032674</c:v>
                </c:pt>
                <c:pt idx="526">
                  <c:v>1.0422070656032674</c:v>
                </c:pt>
                <c:pt idx="527">
                  <c:v>1.0423975847008049</c:v>
                </c:pt>
                <c:pt idx="528">
                  <c:v>1.0425876201309325</c:v>
                </c:pt>
                <c:pt idx="529">
                  <c:v>1.0427771744306797</c:v>
                </c:pt>
                <c:pt idx="530">
                  <c:v>1.0427771744306797</c:v>
                </c:pt>
                <c:pt idx="531">
                  <c:v>1.0431548496866772</c:v>
                </c:pt>
                <c:pt idx="532">
                  <c:v>1.0439045360541885</c:v>
                </c:pt>
                <c:pt idx="533">
                  <c:v>1.0440907918131215</c:v>
                </c:pt>
                <c:pt idx="534">
                  <c:v>1.0440907918131215</c:v>
                </c:pt>
                <c:pt idx="535">
                  <c:v>1.0446467992756592</c:v>
                </c:pt>
                <c:pt idx="536">
                  <c:v>1.0448312229750794</c:v>
                </c:pt>
                <c:pt idx="537">
                  <c:v>1.04538179003473</c:v>
                </c:pt>
                <c:pt idx="538">
                  <c:v>1.0455644186204762</c:v>
                </c:pt>
                <c:pt idx="539">
                  <c:v>1.046290523721171</c:v>
                </c:pt>
                <c:pt idx="540">
                  <c:v>1.0464709586697551</c:v>
                </c:pt>
                <c:pt idx="541">
                  <c:v>1.0466509614233528</c:v>
                </c:pt>
                <c:pt idx="542">
                  <c:v>1.0470096788868413</c:v>
                </c:pt>
                <c:pt idx="543">
                  <c:v>1.0471883978274525</c:v>
                </c:pt>
                <c:pt idx="544">
                  <c:v>1.0471883978274525</c:v>
                </c:pt>
                <c:pt idx="545">
                  <c:v>1.0478990569424937</c:v>
                </c:pt>
                <c:pt idx="546">
                  <c:v>1.0478990569424937</c:v>
                </c:pt>
                <c:pt idx="547">
                  <c:v>1.0478990569424937</c:v>
                </c:pt>
                <c:pt idx="548">
                  <c:v>1.0480756778254614</c:v>
                </c:pt>
                <c:pt idx="549">
                  <c:v>1.0480756778254614</c:v>
                </c:pt>
                <c:pt idx="550">
                  <c:v>1.0484276810776139</c:v>
                </c:pt>
                <c:pt idx="551">
                  <c:v>1.0487780462429175</c:v>
                </c:pt>
                <c:pt idx="552">
                  <c:v>1.048952619462918</c:v>
                </c:pt>
                <c:pt idx="553">
                  <c:v>1.048952619462918</c:v>
                </c:pt>
                <c:pt idx="554">
                  <c:v>1.0491267890364866</c:v>
                </c:pt>
                <c:pt idx="555">
                  <c:v>1.0493005568924803</c:v>
                </c:pt>
                <c:pt idx="556">
                  <c:v>1.0499916492323909</c:v>
                </c:pt>
                <c:pt idx="557">
                  <c:v>1.0506764648283833</c:v>
                </c:pt>
                <c:pt idx="558">
                  <c:v>1.0508467017666578</c:v>
                </c:pt>
                <c:pt idx="559">
                  <c:v>1.0510165555303657</c:v>
                </c:pt>
                <c:pt idx="560">
                  <c:v>1.0511860279020637</c:v>
                </c:pt>
                <c:pt idx="561">
                  <c:v>1.0511860279020637</c:v>
                </c:pt>
                <c:pt idx="562">
                  <c:v>1.0515238355370169</c:v>
                </c:pt>
                <c:pt idx="563">
                  <c:v>1.0521949511564448</c:v>
                </c:pt>
                <c:pt idx="564">
                  <c:v>1.0528601583960004</c:v>
                </c:pt>
                <c:pt idx="565">
                  <c:v>1.0531905798507959</c:v>
                </c:pt>
                <c:pt idx="566">
                  <c:v>1.0531905798507959</c:v>
                </c:pt>
                <c:pt idx="567">
                  <c:v>1.0536835211529267</c:v>
                </c:pt>
                <c:pt idx="568">
                  <c:v>1.0543358204761502</c:v>
                </c:pt>
                <c:pt idx="569">
                  <c:v>1.0543358204761502</c:v>
                </c:pt>
                <c:pt idx="570">
                  <c:v>1.0548213830539264</c:v>
                </c:pt>
                <c:pt idx="571">
                  <c:v>1.0548213830539264</c:v>
                </c:pt>
                <c:pt idx="572">
                  <c:v>1.0553038528797285</c:v>
                </c:pt>
                <c:pt idx="573">
                  <c:v>1.0556238012857457</c:v>
                </c:pt>
                <c:pt idx="574">
                  <c:v>1.0556238012857457</c:v>
                </c:pt>
                <c:pt idx="575">
                  <c:v>1.0556238012857457</c:v>
                </c:pt>
                <c:pt idx="576">
                  <c:v>1.0567331072239152</c:v>
                </c:pt>
                <c:pt idx="577">
                  <c:v>1.0581359391754208</c:v>
                </c:pt>
                <c:pt idx="578">
                  <c:v>1.0581359391754208</c:v>
                </c:pt>
                <c:pt idx="579">
                  <c:v>1.0581359391754208</c:v>
                </c:pt>
                <c:pt idx="580">
                  <c:v>1.0582902220390038</c:v>
                </c:pt>
                <c:pt idx="581">
                  <c:v>1.0589042407750635</c:v>
                </c:pt>
                <c:pt idx="582">
                  <c:v>1.0590569737635356</c:v>
                </c:pt>
                <c:pt idx="583">
                  <c:v>1.0599669874328947</c:v>
                </c:pt>
                <c:pt idx="584">
                  <c:v>1.0601176039886195</c:v>
                </c:pt>
                <c:pt idx="585">
                  <c:v>1.060567674108444</c:v>
                </c:pt>
                <c:pt idx="586">
                  <c:v>1.061015100167386</c:v>
                </c:pt>
                <c:pt idx="587">
                  <c:v>1.0620489904004125</c:v>
                </c:pt>
                <c:pt idx="588">
                  <c:v>1.0629241612782827</c:v>
                </c:pt>
                <c:pt idx="589">
                  <c:v>1.063932671516417</c:v>
                </c:pt>
                <c:pt idx="590">
                  <c:v>1.0652100704040877</c:v>
                </c:pt>
                <c:pt idx="591">
                  <c:v>1.0661890603923527</c:v>
                </c:pt>
                <c:pt idx="592">
                  <c:v>1.066742913107545</c:v>
                </c:pt>
                <c:pt idx="593">
                  <c:v>1.0677026242723158</c:v>
                </c:pt>
                <c:pt idx="594">
                  <c:v>1.0718141866119901</c:v>
                </c:pt>
                <c:pt idx="595">
                  <c:v>1.0724572256539335</c:v>
                </c:pt>
                <c:pt idx="596">
                  <c:v>1.0748529748349003</c:v>
                </c:pt>
                <c:pt idx="597">
                  <c:v>1.0758398717132465</c:v>
                </c:pt>
                <c:pt idx="598">
                  <c:v>1.0809389386010504</c:v>
                </c:pt>
              </c:numCache>
            </c:numRef>
          </c:xVal>
          <c:yVal>
            <c:numRef>
              <c:f>datat!$J$2:$J$600</c:f>
              <c:numCache>
                <c:formatCode>General</c:formatCode>
                <c:ptCount val="599"/>
                <c:pt idx="0">
                  <c:v>0.78176013439118108</c:v>
                </c:pt>
                <c:pt idx="1">
                  <c:v>0.78176013439118108</c:v>
                </c:pt>
                <c:pt idx="2">
                  <c:v>0.79562754137243719</c:v>
                </c:pt>
                <c:pt idx="3">
                  <c:v>0.79562754137243719</c:v>
                </c:pt>
                <c:pt idx="4">
                  <c:v>0.79829991458815153</c:v>
                </c:pt>
                <c:pt idx="5">
                  <c:v>0.80094053048479585</c:v>
                </c:pt>
                <c:pt idx="6">
                  <c:v>0.80094053048479585</c:v>
                </c:pt>
                <c:pt idx="7">
                  <c:v>0.8061295504285253</c:v>
                </c:pt>
                <c:pt idx="8">
                  <c:v>0.8061295504285253</c:v>
                </c:pt>
                <c:pt idx="9">
                  <c:v>0.8136933157433428</c:v>
                </c:pt>
                <c:pt idx="10">
                  <c:v>0.8136933157433428</c:v>
                </c:pt>
                <c:pt idx="11">
                  <c:v>0.8136933157433428</c:v>
                </c:pt>
                <c:pt idx="12">
                  <c:v>0.81615866236618428</c:v>
                </c:pt>
                <c:pt idx="13">
                  <c:v>0.81859711020330472</c:v>
                </c:pt>
                <c:pt idx="14">
                  <c:v>0.81859711020330472</c:v>
                </c:pt>
                <c:pt idx="15">
                  <c:v>0.81859711020330472</c:v>
                </c:pt>
                <c:pt idx="16">
                  <c:v>0.81859711020330472</c:v>
                </c:pt>
                <c:pt idx="17">
                  <c:v>0.821009260280956</c:v>
                </c:pt>
                <c:pt idx="18">
                  <c:v>0.821009260280956</c:v>
                </c:pt>
                <c:pt idx="19">
                  <c:v>0.82339569348127783</c:v>
                </c:pt>
                <c:pt idx="20">
                  <c:v>0.82339569348127783</c:v>
                </c:pt>
                <c:pt idx="21">
                  <c:v>0.82339569348127783</c:v>
                </c:pt>
                <c:pt idx="22">
                  <c:v>0.82339569348127783</c:v>
                </c:pt>
                <c:pt idx="23">
                  <c:v>0.82339569348127783</c:v>
                </c:pt>
                <c:pt idx="24">
                  <c:v>0.82575697143742488</c:v>
                </c:pt>
                <c:pt idx="25">
                  <c:v>0.82575697143742488</c:v>
                </c:pt>
                <c:pt idx="26">
                  <c:v>0.82809363737936259</c:v>
                </c:pt>
                <c:pt idx="27">
                  <c:v>0.83269521887958398</c:v>
                </c:pt>
                <c:pt idx="28">
                  <c:v>0.83269521887958398</c:v>
                </c:pt>
                <c:pt idx="29">
                  <c:v>0.83496113586633003</c:v>
                </c:pt>
                <c:pt idx="30">
                  <c:v>0.83720444509048653</c:v>
                </c:pt>
                <c:pt idx="31">
                  <c:v>0.83720444509048653</c:v>
                </c:pt>
                <c:pt idx="32">
                  <c:v>0.83720444509048653</c:v>
                </c:pt>
                <c:pt idx="33">
                  <c:v>0.83720444509048653</c:v>
                </c:pt>
                <c:pt idx="34">
                  <c:v>0.83720444509048653</c:v>
                </c:pt>
                <c:pt idx="35">
                  <c:v>0.83942560893957507</c:v>
                </c:pt>
                <c:pt idx="36">
                  <c:v>0.84380327964461488</c:v>
                </c:pt>
                <c:pt idx="37">
                  <c:v>0.84380327964461488</c:v>
                </c:pt>
                <c:pt idx="38">
                  <c:v>0.84380327964461488</c:v>
                </c:pt>
                <c:pt idx="39">
                  <c:v>0.84596064256428782</c:v>
                </c:pt>
                <c:pt idx="40">
                  <c:v>0.84596064256428782</c:v>
                </c:pt>
                <c:pt idx="41">
                  <c:v>0.84809757330759483</c:v>
                </c:pt>
                <c:pt idx="42">
                  <c:v>0.84809757330759483</c:v>
                </c:pt>
                <c:pt idx="43">
                  <c:v>0.85231171425685126</c:v>
                </c:pt>
                <c:pt idx="44">
                  <c:v>0.85231171425685126</c:v>
                </c:pt>
                <c:pt idx="45">
                  <c:v>0.85231171425685126</c:v>
                </c:pt>
                <c:pt idx="46">
                  <c:v>0.85438968395300208</c:v>
                </c:pt>
                <c:pt idx="47">
                  <c:v>0.8564487413290709</c:v>
                </c:pt>
                <c:pt idx="48">
                  <c:v>0.85848923955866541</c:v>
                </c:pt>
                <c:pt idx="49">
                  <c:v>0.85848923955866541</c:v>
                </c:pt>
                <c:pt idx="50">
                  <c:v>0.85848923955866541</c:v>
                </c:pt>
                <c:pt idx="51">
                  <c:v>0.86051152190388258</c:v>
                </c:pt>
                <c:pt idx="52">
                  <c:v>0.86051152190388258</c:v>
                </c:pt>
                <c:pt idx="53">
                  <c:v>0.86051152190388258</c:v>
                </c:pt>
                <c:pt idx="54">
                  <c:v>0.86051152190388258</c:v>
                </c:pt>
                <c:pt idx="55">
                  <c:v>0.86251592208476913</c:v>
                </c:pt>
                <c:pt idx="56">
                  <c:v>0.86251592208476913</c:v>
                </c:pt>
                <c:pt idx="57">
                  <c:v>0.86251592208476913</c:v>
                </c:pt>
                <c:pt idx="58">
                  <c:v>0.86450276463167341</c:v>
                </c:pt>
                <c:pt idx="59">
                  <c:v>0.86647236522143078</c:v>
                </c:pt>
                <c:pt idx="60">
                  <c:v>0.86647236522143078</c:v>
                </c:pt>
                <c:pt idx="61">
                  <c:v>0.86647236522143078</c:v>
                </c:pt>
                <c:pt idx="62">
                  <c:v>0.87036106088021858</c:v>
                </c:pt>
                <c:pt idx="63">
                  <c:v>0.87036106088021858</c:v>
                </c:pt>
                <c:pt idx="64">
                  <c:v>0.8722807458519517</c:v>
                </c:pt>
                <c:pt idx="65">
                  <c:v>0.8722807458519517</c:v>
                </c:pt>
                <c:pt idx="66">
                  <c:v>0.8722807458519517</c:v>
                </c:pt>
                <c:pt idx="67">
                  <c:v>0.87418436924452125</c:v>
                </c:pt>
                <c:pt idx="68">
                  <c:v>0.87418436924452125</c:v>
                </c:pt>
                <c:pt idx="69">
                  <c:v>0.87418436924452125</c:v>
                </c:pt>
                <c:pt idx="70">
                  <c:v>0.8760722070029443</c:v>
                </c:pt>
                <c:pt idx="71">
                  <c:v>0.8760722070029443</c:v>
                </c:pt>
                <c:pt idx="72">
                  <c:v>0.8760722070029443</c:v>
                </c:pt>
                <c:pt idx="73">
                  <c:v>0.87794452794211431</c:v>
                </c:pt>
                <c:pt idx="74">
                  <c:v>0.87794452794211431</c:v>
                </c:pt>
                <c:pt idx="75">
                  <c:v>0.87980159399169189</c:v>
                </c:pt>
                <c:pt idx="76">
                  <c:v>0.8816436604305431</c:v>
                </c:pt>
                <c:pt idx="77">
                  <c:v>0.8816436604305431</c:v>
                </c:pt>
                <c:pt idx="78">
                  <c:v>0.8816436604305431</c:v>
                </c:pt>
                <c:pt idx="79">
                  <c:v>0.8816436604305431</c:v>
                </c:pt>
                <c:pt idx="80">
                  <c:v>0.8816436604305431</c:v>
                </c:pt>
                <c:pt idx="81">
                  <c:v>0.8834709761112447</c:v>
                </c:pt>
                <c:pt idx="82">
                  <c:v>0.8834709761112447</c:v>
                </c:pt>
                <c:pt idx="83">
                  <c:v>0.8834709761112447</c:v>
                </c:pt>
                <c:pt idx="84">
                  <c:v>0.88528378367517124</c:v>
                </c:pt>
                <c:pt idx="85">
                  <c:v>0.88708231975862528</c:v>
                </c:pt>
                <c:pt idx="86">
                  <c:v>0.88708231975862528</c:v>
                </c:pt>
                <c:pt idx="87">
                  <c:v>0.88886681519046062</c:v>
                </c:pt>
                <c:pt idx="88">
                  <c:v>0.88886681519046062</c:v>
                </c:pt>
                <c:pt idx="89">
                  <c:v>0.88886681519046062</c:v>
                </c:pt>
                <c:pt idx="90">
                  <c:v>0.89063749518161384</c:v>
                </c:pt>
                <c:pt idx="91">
                  <c:v>0.89063749518161384</c:v>
                </c:pt>
                <c:pt idx="92">
                  <c:v>0.89063749518161384</c:v>
                </c:pt>
                <c:pt idx="93">
                  <c:v>0.89239457950694501</c:v>
                </c:pt>
                <c:pt idx="94">
                  <c:v>0.89239457950694501</c:v>
                </c:pt>
                <c:pt idx="95">
                  <c:v>0.89239457950694501</c:v>
                </c:pt>
                <c:pt idx="96">
                  <c:v>0.8941382826797537</c:v>
                </c:pt>
                <c:pt idx="97">
                  <c:v>0.8941382826797537</c:v>
                </c:pt>
                <c:pt idx="98">
                  <c:v>0.8941382826797537</c:v>
                </c:pt>
                <c:pt idx="99">
                  <c:v>0.8941382826797537</c:v>
                </c:pt>
                <c:pt idx="100">
                  <c:v>0.89586881411932362</c:v>
                </c:pt>
                <c:pt idx="101">
                  <c:v>0.89586881411932362</c:v>
                </c:pt>
                <c:pt idx="102">
                  <c:v>0.89758637831183341</c:v>
                </c:pt>
                <c:pt idx="103">
                  <c:v>0.89758637831183341</c:v>
                </c:pt>
                <c:pt idx="104">
                  <c:v>0.89758637831183341</c:v>
                </c:pt>
                <c:pt idx="105">
                  <c:v>0.89929117496493971</c:v>
                </c:pt>
                <c:pt idx="106">
                  <c:v>0.89929117496493971</c:v>
                </c:pt>
                <c:pt idx="107">
                  <c:v>0.90098339915633208</c:v>
                </c:pt>
                <c:pt idx="108">
                  <c:v>0.90098339915633208</c:v>
                </c:pt>
                <c:pt idx="109">
                  <c:v>0.90266324147654453</c:v>
                </c:pt>
                <c:pt idx="110">
                  <c:v>0.90433088816628038</c:v>
                </c:pt>
                <c:pt idx="111">
                  <c:v>0.90433088816628038</c:v>
                </c:pt>
                <c:pt idx="112">
                  <c:v>0.90433088816628038</c:v>
                </c:pt>
                <c:pt idx="113">
                  <c:v>0.90598652124851098</c:v>
                </c:pt>
                <c:pt idx="114">
                  <c:v>0.90598652124851098</c:v>
                </c:pt>
                <c:pt idx="115">
                  <c:v>0.90598652124851098</c:v>
                </c:pt>
                <c:pt idx="116">
                  <c:v>0.90598652124851098</c:v>
                </c:pt>
                <c:pt idx="117">
                  <c:v>0.90763031865557631</c:v>
                </c:pt>
                <c:pt idx="118">
                  <c:v>0.90926245435152309</c:v>
                </c:pt>
                <c:pt idx="119">
                  <c:v>0.91088309844988569</c:v>
                </c:pt>
                <c:pt idx="120">
                  <c:v>0.91249241732711495</c:v>
                </c:pt>
                <c:pt idx="121">
                  <c:v>0.91249241732711495</c:v>
                </c:pt>
                <c:pt idx="122">
                  <c:v>0.91249241732711495</c:v>
                </c:pt>
                <c:pt idx="123">
                  <c:v>0.91249241732711495</c:v>
                </c:pt>
                <c:pt idx="124">
                  <c:v>0.91249241732711495</c:v>
                </c:pt>
                <c:pt idx="125">
                  <c:v>0.91567772689020455</c:v>
                </c:pt>
                <c:pt idx="126">
                  <c:v>0.91725403260726335</c:v>
                </c:pt>
                <c:pt idx="127">
                  <c:v>0.91725403260726335</c:v>
                </c:pt>
                <c:pt idx="128">
                  <c:v>0.91725403260726335</c:v>
                </c:pt>
                <c:pt idx="129">
                  <c:v>0.91881964336492139</c:v>
                </c:pt>
                <c:pt idx="130">
                  <c:v>0.91881964336492139</c:v>
                </c:pt>
                <c:pt idx="131">
                  <c:v>0.91881964336492139</c:v>
                </c:pt>
                <c:pt idx="132">
                  <c:v>0.91881964336492139</c:v>
                </c:pt>
                <c:pt idx="133">
                  <c:v>0.91881964336492139</c:v>
                </c:pt>
                <c:pt idx="134">
                  <c:v>0.92037470841624591</c:v>
                </c:pt>
                <c:pt idx="135">
                  <c:v>0.92037470841624591</c:v>
                </c:pt>
                <c:pt idx="136">
                  <c:v>0.9219193738765048</c:v>
                </c:pt>
                <c:pt idx="137">
                  <c:v>0.9219193738765048</c:v>
                </c:pt>
                <c:pt idx="138">
                  <c:v>0.9219193738765048</c:v>
                </c:pt>
                <c:pt idx="139">
                  <c:v>0.9219193738765048</c:v>
                </c:pt>
                <c:pt idx="140">
                  <c:v>0.92345378281099277</c:v>
                </c:pt>
                <c:pt idx="141">
                  <c:v>0.92345378281099277</c:v>
                </c:pt>
                <c:pt idx="142">
                  <c:v>0.92497807531980136</c:v>
                </c:pt>
                <c:pt idx="143">
                  <c:v>0.92497807531980136</c:v>
                </c:pt>
                <c:pt idx="144">
                  <c:v>0.92497807531980136</c:v>
                </c:pt>
                <c:pt idx="145">
                  <c:v>0.92649238861965122</c:v>
                </c:pt>
                <c:pt idx="146">
                  <c:v>0.92649238861965122</c:v>
                </c:pt>
                <c:pt idx="147">
                  <c:v>0.92649238861965122</c:v>
                </c:pt>
                <c:pt idx="148">
                  <c:v>0.92649238861965122</c:v>
                </c:pt>
                <c:pt idx="149">
                  <c:v>0.92649238861965122</c:v>
                </c:pt>
                <c:pt idx="150">
                  <c:v>0.92799685712291069</c:v>
                </c:pt>
                <c:pt idx="151">
                  <c:v>0.92799685712291069</c:v>
                </c:pt>
                <c:pt idx="152">
                  <c:v>0.92799685712291069</c:v>
                </c:pt>
                <c:pt idx="153">
                  <c:v>0.92949161251392365</c:v>
                </c:pt>
                <c:pt idx="154">
                  <c:v>0.92949161251392365</c:v>
                </c:pt>
                <c:pt idx="155">
                  <c:v>0.92949161251392365</c:v>
                </c:pt>
                <c:pt idx="156">
                  <c:v>0.92949161251392365</c:v>
                </c:pt>
                <c:pt idx="157">
                  <c:v>0.92949161251392365</c:v>
                </c:pt>
                <c:pt idx="158">
                  <c:v>0.93097678382273941</c:v>
                </c:pt>
                <c:pt idx="159">
                  <c:v>0.93097678382273941</c:v>
                </c:pt>
                <c:pt idx="160">
                  <c:v>0.93097678382273941</c:v>
                </c:pt>
                <c:pt idx="161">
                  <c:v>0.93097678382273941</c:v>
                </c:pt>
                <c:pt idx="162">
                  <c:v>0.93245249749637038</c:v>
                </c:pt>
                <c:pt idx="163">
                  <c:v>0.93245249749637038</c:v>
                </c:pt>
                <c:pt idx="164">
                  <c:v>0.93245249749637038</c:v>
                </c:pt>
                <c:pt idx="165">
                  <c:v>0.93245249749637038</c:v>
                </c:pt>
                <c:pt idx="166">
                  <c:v>0.93245249749637038</c:v>
                </c:pt>
                <c:pt idx="167">
                  <c:v>0.93391887746765967</c:v>
                </c:pt>
                <c:pt idx="168">
                  <c:v>0.93391887746765967</c:v>
                </c:pt>
                <c:pt idx="169">
                  <c:v>0.93391887746765967</c:v>
                </c:pt>
                <c:pt idx="170">
                  <c:v>0.93537604522186246</c:v>
                </c:pt>
                <c:pt idx="171">
                  <c:v>0.93682411986103498</c:v>
                </c:pt>
                <c:pt idx="172">
                  <c:v>0.93682411986103498</c:v>
                </c:pt>
                <c:pt idx="173">
                  <c:v>0.93682411986103498</c:v>
                </c:pt>
                <c:pt idx="174">
                  <c:v>0.93826321816630731</c:v>
                </c:pt>
                <c:pt idx="175">
                  <c:v>0.9396934546581317</c:v>
                </c:pt>
                <c:pt idx="176">
                  <c:v>0.9396934546581317</c:v>
                </c:pt>
                <c:pt idx="177">
                  <c:v>0.94111494165458209</c:v>
                </c:pt>
                <c:pt idx="178">
                  <c:v>0.94111494165458209</c:v>
                </c:pt>
                <c:pt idx="179">
                  <c:v>0.94111494165458209</c:v>
                </c:pt>
                <c:pt idx="180">
                  <c:v>0.94252778932777836</c:v>
                </c:pt>
                <c:pt idx="181">
                  <c:v>0.94252778932777836</c:v>
                </c:pt>
                <c:pt idx="182">
                  <c:v>0.94252778932777836</c:v>
                </c:pt>
                <c:pt idx="183">
                  <c:v>0.94252778932777836</c:v>
                </c:pt>
                <c:pt idx="184">
                  <c:v>0.94393210575851283</c:v>
                </c:pt>
                <c:pt idx="185">
                  <c:v>0.94393210575851283</c:v>
                </c:pt>
                <c:pt idx="186">
                  <c:v>0.94393210575851283</c:v>
                </c:pt>
                <c:pt idx="187">
                  <c:v>0.94532799698913861</c:v>
                </c:pt>
                <c:pt idx="188">
                  <c:v>0.94532799698913861</c:v>
                </c:pt>
                <c:pt idx="189">
                  <c:v>0.94532799698913861</c:v>
                </c:pt>
                <c:pt idx="190">
                  <c:v>0.94532799698913861</c:v>
                </c:pt>
                <c:pt idx="191">
                  <c:v>0.94671556707479665</c:v>
                </c:pt>
                <c:pt idx="192">
                  <c:v>0.94671556707479665</c:v>
                </c:pt>
                <c:pt idx="193">
                  <c:v>0.94809491813303515</c:v>
                </c:pt>
                <c:pt idx="194">
                  <c:v>0.94946615039188265</c:v>
                </c:pt>
                <c:pt idx="195">
                  <c:v>0.94946615039188265</c:v>
                </c:pt>
                <c:pt idx="196">
                  <c:v>0.95082936223644055</c:v>
                </c:pt>
                <c:pt idx="197">
                  <c:v>0.95218465025403942</c:v>
                </c:pt>
                <c:pt idx="198">
                  <c:v>0.95218465025403942</c:v>
                </c:pt>
                <c:pt idx="199">
                  <c:v>0.95218465025403942</c:v>
                </c:pt>
                <c:pt idx="200">
                  <c:v>0.95353210927801646</c:v>
                </c:pt>
                <c:pt idx="201">
                  <c:v>0.95487183243016327</c:v>
                </c:pt>
                <c:pt idx="202">
                  <c:v>0.95620391116189785</c:v>
                </c:pt>
                <c:pt idx="203">
                  <c:v>0.95620391116189785</c:v>
                </c:pt>
                <c:pt idx="204">
                  <c:v>0.95620391116189785</c:v>
                </c:pt>
                <c:pt idx="205">
                  <c:v>0.9575284352941944</c:v>
                </c:pt>
                <c:pt idx="206">
                  <c:v>0.9575284352941944</c:v>
                </c:pt>
                <c:pt idx="207">
                  <c:v>0.95884549305632971</c:v>
                </c:pt>
                <c:pt idx="208">
                  <c:v>0.95884549305632971</c:v>
                </c:pt>
                <c:pt idx="209">
                  <c:v>0.95884549305632971</c:v>
                </c:pt>
                <c:pt idx="210">
                  <c:v>0.9601551711234797</c:v>
                </c:pt>
                <c:pt idx="211">
                  <c:v>0.9601551711234797</c:v>
                </c:pt>
                <c:pt idx="212">
                  <c:v>0.9601551711234797</c:v>
                </c:pt>
                <c:pt idx="213">
                  <c:v>0.9601551711234797</c:v>
                </c:pt>
                <c:pt idx="214">
                  <c:v>0.9601551711234797</c:v>
                </c:pt>
                <c:pt idx="215">
                  <c:v>0.96145755465320537</c:v>
                </c:pt>
                <c:pt idx="216">
                  <c:v>0.96145755465320537</c:v>
                </c:pt>
                <c:pt idx="217">
                  <c:v>0.96145755465320537</c:v>
                </c:pt>
                <c:pt idx="218">
                  <c:v>0.96145755465320537</c:v>
                </c:pt>
                <c:pt idx="219">
                  <c:v>0.96532176756590227</c:v>
                </c:pt>
                <c:pt idx="220">
                  <c:v>0.96532176756590227</c:v>
                </c:pt>
                <c:pt idx="221">
                  <c:v>0.96532176756590227</c:v>
                </c:pt>
                <c:pt idx="222">
                  <c:v>0.96659579538760187</c:v>
                </c:pt>
                <c:pt idx="223">
                  <c:v>0.96659579538760187</c:v>
                </c:pt>
                <c:pt idx="224">
                  <c:v>0.96659579538760187</c:v>
                </c:pt>
                <c:pt idx="225">
                  <c:v>0.96786293289987091</c:v>
                </c:pt>
                <c:pt idx="226">
                  <c:v>0.96786293289987091</c:v>
                </c:pt>
                <c:pt idx="227">
                  <c:v>0.96912325686357059</c:v>
                </c:pt>
                <c:pt idx="228">
                  <c:v>0.97037684274945279</c:v>
                </c:pt>
                <c:pt idx="229">
                  <c:v>0.97037684274945279</c:v>
                </c:pt>
                <c:pt idx="230">
                  <c:v>0.97286409589287492</c:v>
                </c:pt>
                <c:pt idx="231">
                  <c:v>0.97286409589287492</c:v>
                </c:pt>
                <c:pt idx="232">
                  <c:v>0.97409790789754558</c:v>
                </c:pt>
                <c:pt idx="233">
                  <c:v>0.97409790789754558</c:v>
                </c:pt>
                <c:pt idx="234">
                  <c:v>0.97409790789754558</c:v>
                </c:pt>
                <c:pt idx="235">
                  <c:v>0.97654625575596832</c:v>
                </c:pt>
                <c:pt idx="236">
                  <c:v>0.97776092935765435</c:v>
                </c:pt>
                <c:pt idx="237">
                  <c:v>0.97776092935765435</c:v>
                </c:pt>
                <c:pt idx="238">
                  <c:v>0.97896935938365148</c:v>
                </c:pt>
                <c:pt idx="239">
                  <c:v>0.97896935938365148</c:v>
                </c:pt>
                <c:pt idx="240">
                  <c:v>0.97896935938365148</c:v>
                </c:pt>
                <c:pt idx="241">
                  <c:v>0.98017161195999147</c:v>
                </c:pt>
                <c:pt idx="242">
                  <c:v>0.98017161195999147</c:v>
                </c:pt>
                <c:pt idx="243">
                  <c:v>0.98017161195999147</c:v>
                </c:pt>
                <c:pt idx="244">
                  <c:v>0.98017161195999147</c:v>
                </c:pt>
                <c:pt idx="245">
                  <c:v>0.9813677521558426</c:v>
                </c:pt>
                <c:pt idx="246">
                  <c:v>0.9813677521558426</c:v>
                </c:pt>
                <c:pt idx="247">
                  <c:v>0.98255784400603341</c:v>
                </c:pt>
                <c:pt idx="248">
                  <c:v>0.98374195053298452</c:v>
                </c:pt>
                <c:pt idx="249">
                  <c:v>0.98374195053298452</c:v>
                </c:pt>
                <c:pt idx="250">
                  <c:v>0.98492013376805465</c:v>
                </c:pt>
                <c:pt idx="251">
                  <c:v>0.98492013376805465</c:v>
                </c:pt>
                <c:pt idx="252">
                  <c:v>0.98492013376805465</c:v>
                </c:pt>
                <c:pt idx="253">
                  <c:v>0.98492013376805465</c:v>
                </c:pt>
                <c:pt idx="254">
                  <c:v>0.98492013376805465</c:v>
                </c:pt>
                <c:pt idx="255">
                  <c:v>0.98609245477233065</c:v>
                </c:pt>
                <c:pt idx="256">
                  <c:v>0.98609245477233065</c:v>
                </c:pt>
                <c:pt idx="257">
                  <c:v>0.98609245477233065</c:v>
                </c:pt>
                <c:pt idx="258">
                  <c:v>0.98609245477233065</c:v>
                </c:pt>
                <c:pt idx="259">
                  <c:v>0.98725897365686954</c:v>
                </c:pt>
                <c:pt idx="260">
                  <c:v>0.98725897365686954</c:v>
                </c:pt>
                <c:pt idx="261">
                  <c:v>0.98725897365686954</c:v>
                </c:pt>
                <c:pt idx="262">
                  <c:v>0.98841974960241386</c:v>
                </c:pt>
                <c:pt idx="263">
                  <c:v>0.98841974960241386</c:v>
                </c:pt>
                <c:pt idx="264">
                  <c:v>0.98841974960241386</c:v>
                </c:pt>
                <c:pt idx="265">
                  <c:v>0.98957484087859848</c:v>
                </c:pt>
                <c:pt idx="266">
                  <c:v>0.98957484087859848</c:v>
                </c:pt>
                <c:pt idx="267">
                  <c:v>0.99186819805767712</c:v>
                </c:pt>
                <c:pt idx="268">
                  <c:v>0.99300657611031884</c:v>
                </c:pt>
                <c:pt idx="269">
                  <c:v>0.99300657611031884</c:v>
                </c:pt>
                <c:pt idx="270">
                  <c:v>0.99300657611031884</c:v>
                </c:pt>
                <c:pt idx="271">
                  <c:v>0.99300657611031884</c:v>
                </c:pt>
                <c:pt idx="272">
                  <c:v>0.99413949382817979</c:v>
                </c:pt>
                <c:pt idx="273">
                  <c:v>0.99526700519664901</c:v>
                </c:pt>
                <c:pt idx="274">
                  <c:v>0.99638916339536987</c:v>
                </c:pt>
                <c:pt idx="275">
                  <c:v>0.99750602081428186</c:v>
                </c:pt>
                <c:pt idx="276">
                  <c:v>0.99750602081428186</c:v>
                </c:pt>
                <c:pt idx="277">
                  <c:v>0.99861762906926943</c:v>
                </c:pt>
                <c:pt idx="278">
                  <c:v>0.99972403901741869</c:v>
                </c:pt>
                <c:pt idx="279">
                  <c:v>0.99972403901741869</c:v>
                </c:pt>
                <c:pt idx="280">
                  <c:v>1.0008253007719001</c:v>
                </c:pt>
                <c:pt idx="281">
                  <c:v>1.0008253007719001</c:v>
                </c:pt>
                <c:pt idx="282">
                  <c:v>1.0008253007719001</c:v>
                </c:pt>
                <c:pt idx="283">
                  <c:v>1.0008253007719001</c:v>
                </c:pt>
                <c:pt idx="284">
                  <c:v>1.0008253007719001</c:v>
                </c:pt>
                <c:pt idx="285">
                  <c:v>1.0019214637164935</c:v>
                </c:pt>
                <c:pt idx="286">
                  <c:v>1.0019214637164935</c:v>
                </c:pt>
                <c:pt idx="287">
                  <c:v>1.0030125765197466</c:v>
                </c:pt>
                <c:pt idx="288">
                  <c:v>1.0040986871488022</c:v>
                </c:pt>
                <c:pt idx="289">
                  <c:v>1.0040986871488022</c:v>
                </c:pt>
                <c:pt idx="290">
                  <c:v>1.0040986871488022</c:v>
                </c:pt>
                <c:pt idx="291">
                  <c:v>1.0040986871488022</c:v>
                </c:pt>
                <c:pt idx="292">
                  <c:v>1.0040986871488022</c:v>
                </c:pt>
                <c:pt idx="293">
                  <c:v>1.0040986871488022</c:v>
                </c:pt>
                <c:pt idx="294">
                  <c:v>1.005179842882884</c:v>
                </c:pt>
                <c:pt idx="295">
                  <c:v>1.005179842882884</c:v>
                </c:pt>
                <c:pt idx="296">
                  <c:v>1.005179842882884</c:v>
                </c:pt>
                <c:pt idx="297">
                  <c:v>1.0062560903264641</c:v>
                </c:pt>
                <c:pt idx="298">
                  <c:v>1.0062560903264641</c:v>
                </c:pt>
                <c:pt idx="299">
                  <c:v>1.0073274754221115</c:v>
                </c:pt>
                <c:pt idx="300">
                  <c:v>1.0073274754221115</c:v>
                </c:pt>
                <c:pt idx="301">
                  <c:v>1.0083940434630407</c:v>
                </c:pt>
                <c:pt idx="302">
                  <c:v>1.0094558391053536</c:v>
                </c:pt>
                <c:pt idx="303">
                  <c:v>1.0094558391053536</c:v>
                </c:pt>
                <c:pt idx="304">
                  <c:v>1.0094558391053536</c:v>
                </c:pt>
                <c:pt idx="305">
                  <c:v>1.0115652887044875</c:v>
                </c:pt>
                <c:pt idx="306">
                  <c:v>1.0115652887044875</c:v>
                </c:pt>
                <c:pt idx="307">
                  <c:v>1.0115652887044875</c:v>
                </c:pt>
                <c:pt idx="308">
                  <c:v>1.0157288160104332</c:v>
                </c:pt>
                <c:pt idx="309">
                  <c:v>1.0157288160104332</c:v>
                </c:pt>
                <c:pt idx="310">
                  <c:v>1.0167584041588094</c:v>
                </c:pt>
                <c:pt idx="311">
                  <c:v>1.0167584041588094</c:v>
                </c:pt>
                <c:pt idx="312">
                  <c:v>1.0167584041588094</c:v>
                </c:pt>
                <c:pt idx="313">
                  <c:v>1.0167584041588094</c:v>
                </c:pt>
                <c:pt idx="314">
                  <c:v>1.017783555599757</c:v>
                </c:pt>
                <c:pt idx="315">
                  <c:v>1.0188043097615571</c:v>
                </c:pt>
                <c:pt idx="316">
                  <c:v>1.0198207055432604</c:v>
                </c:pt>
                <c:pt idx="317">
                  <c:v>1.0228441238575079</c:v>
                </c:pt>
                <c:pt idx="318">
                  <c:v>1.0228441238575079</c:v>
                </c:pt>
                <c:pt idx="319">
                  <c:v>1.0238434648522112</c:v>
                </c:pt>
                <c:pt idx="320">
                  <c:v>1.0238434648522112</c:v>
                </c:pt>
                <c:pt idx="321">
                  <c:v>1.0238434648522112</c:v>
                </c:pt>
                <c:pt idx="322">
                  <c:v>1.024838634348205</c:v>
                </c:pt>
                <c:pt idx="323">
                  <c:v>1.024838634348205</c:v>
                </c:pt>
                <c:pt idx="324">
                  <c:v>1.024838634348205</c:v>
                </c:pt>
                <c:pt idx="325">
                  <c:v>1.0258296682610628</c:v>
                </c:pt>
                <c:pt idx="326">
                  <c:v>1.0258296682610628</c:v>
                </c:pt>
                <c:pt idx="327">
                  <c:v>1.0258296682610628</c:v>
                </c:pt>
                <c:pt idx="328">
                  <c:v>1.0258296682610628</c:v>
                </c:pt>
                <c:pt idx="329">
                  <c:v>1.02681660203924</c:v>
                </c:pt>
                <c:pt idx="330">
                  <c:v>1.02681660203924</c:v>
                </c:pt>
                <c:pt idx="331">
                  <c:v>1.0277994706721905</c:v>
                </c:pt>
                <c:pt idx="332">
                  <c:v>1.0277994706721905</c:v>
                </c:pt>
                <c:pt idx="333">
                  <c:v>1.0277994706721905</c:v>
                </c:pt>
                <c:pt idx="334">
                  <c:v>1.0287783086982958</c:v>
                </c:pt>
                <c:pt idx="335">
                  <c:v>1.0287783086982958</c:v>
                </c:pt>
                <c:pt idx="336">
                  <c:v>1.0297531502126311</c:v>
                </c:pt>
                <c:pt idx="337">
                  <c:v>1.0307240288745634</c:v>
                </c:pt>
                <c:pt idx="338">
                  <c:v>1.0307240288745634</c:v>
                </c:pt>
                <c:pt idx="339">
                  <c:v>1.0326540301445757</c:v>
                </c:pt>
                <c:pt idx="340">
                  <c:v>1.033613217958957</c:v>
                </c:pt>
                <c:pt idx="341">
                  <c:v>1.033613217958957</c:v>
                </c:pt>
                <c:pt idx="342">
                  <c:v>1.033613217958957</c:v>
                </c:pt>
                <c:pt idx="343">
                  <c:v>1.033613217958957</c:v>
                </c:pt>
                <c:pt idx="344">
                  <c:v>1.033613217958957</c:v>
                </c:pt>
                <c:pt idx="345">
                  <c:v>1.0345685733476278</c:v>
                </c:pt>
                <c:pt idx="346">
                  <c:v>1.0345685733476278</c:v>
                </c:pt>
                <c:pt idx="347">
                  <c:v>1.0355201278998076</c:v>
                </c:pt>
                <c:pt idx="348">
                  <c:v>1.0355201278998076</c:v>
                </c:pt>
                <c:pt idx="349">
                  <c:v>1.0364679128113132</c:v>
                </c:pt>
                <c:pt idx="350">
                  <c:v>1.0364679128113132</c:v>
                </c:pt>
                <c:pt idx="351">
                  <c:v>1.0364679128113132</c:v>
                </c:pt>
                <c:pt idx="352">
                  <c:v>1.0383522965676737</c:v>
                </c:pt>
                <c:pt idx="353">
                  <c:v>1.0383522965676737</c:v>
                </c:pt>
                <c:pt idx="354">
                  <c:v>1.0383522965676737</c:v>
                </c:pt>
                <c:pt idx="355">
                  <c:v>1.0411513578871499</c:v>
                </c:pt>
                <c:pt idx="356">
                  <c:v>1.0420771588436795</c:v>
                </c:pt>
                <c:pt idx="357">
                  <c:v>1.0420771588436795</c:v>
                </c:pt>
                <c:pt idx="358">
                  <c:v>1.0420771588436795</c:v>
                </c:pt>
                <c:pt idx="359">
                  <c:v>1.0429993980478094</c:v>
                </c:pt>
                <c:pt idx="360">
                  <c:v>1.0429993980478094</c:v>
                </c:pt>
                <c:pt idx="361">
                  <c:v>1.0429993980478094</c:v>
                </c:pt>
                <c:pt idx="362">
                  <c:v>1.0439181037726475</c:v>
                </c:pt>
                <c:pt idx="363">
                  <c:v>1.0439181037726475</c:v>
                </c:pt>
                <c:pt idx="364">
                  <c:v>1.0448333039521578</c:v>
                </c:pt>
                <c:pt idx="365">
                  <c:v>1.0448333039521578</c:v>
                </c:pt>
                <c:pt idx="366">
                  <c:v>1.0448333039521578</c:v>
                </c:pt>
                <c:pt idx="367">
                  <c:v>1.0457450261865944</c:v>
                </c:pt>
                <c:pt idx="368">
                  <c:v>1.0457450261865944</c:v>
                </c:pt>
                <c:pt idx="369">
                  <c:v>1.0466532977478225</c:v>
                </c:pt>
                <c:pt idx="370">
                  <c:v>1.04755814558454</c:v>
                </c:pt>
                <c:pt idx="371">
                  <c:v>1.0493576762939725</c:v>
                </c:pt>
                <c:pt idx="372">
                  <c:v>1.0493576762939725</c:v>
                </c:pt>
                <c:pt idx="373">
                  <c:v>1.0493576762939725</c:v>
                </c:pt>
                <c:pt idx="374">
                  <c:v>1.0493576762939725</c:v>
                </c:pt>
                <c:pt idx="375">
                  <c:v>1.0493576762939725</c:v>
                </c:pt>
                <c:pt idx="376">
                  <c:v>1.0493576762939725</c:v>
                </c:pt>
                <c:pt idx="377">
                  <c:v>1.0493576762939725</c:v>
                </c:pt>
                <c:pt idx="378">
                  <c:v>1.0502524114937644</c:v>
                </c:pt>
                <c:pt idx="379">
                  <c:v>1.0502524114937644</c:v>
                </c:pt>
                <c:pt idx="380">
                  <c:v>1.0502524114937644</c:v>
                </c:pt>
                <c:pt idx="381">
                  <c:v>1.0502524114937644</c:v>
                </c:pt>
                <c:pt idx="382">
                  <c:v>1.0511438276329321</c:v>
                </c:pt>
                <c:pt idx="383">
                  <c:v>1.0511438276329321</c:v>
                </c:pt>
                <c:pt idx="384">
                  <c:v>1.0520319501190589</c:v>
                </c:pt>
                <c:pt idx="385">
                  <c:v>1.0529168040657773</c:v>
                </c:pt>
                <c:pt idx="386">
                  <c:v>1.0529168040657773</c:v>
                </c:pt>
                <c:pt idx="387">
                  <c:v>1.0537984142973107</c:v>
                </c:pt>
                <c:pt idx="388">
                  <c:v>1.0546768053529259</c:v>
                </c:pt>
                <c:pt idx="389">
                  <c:v>1.0546768053529259</c:v>
                </c:pt>
                <c:pt idx="390">
                  <c:v>1.0555520014913053</c:v>
                </c:pt>
                <c:pt idx="391">
                  <c:v>1.0564240266948346</c:v>
                </c:pt>
                <c:pt idx="392">
                  <c:v>1.0564240266948346</c:v>
                </c:pt>
                <c:pt idx="393">
                  <c:v>1.0590213124633614</c:v>
                </c:pt>
                <c:pt idx="394">
                  <c:v>1.0598808883707775</c:v>
                </c:pt>
                <c:pt idx="395">
                  <c:v>1.0607374092551272</c:v>
                </c:pt>
                <c:pt idx="396">
                  <c:v>1.0607374092551272</c:v>
                </c:pt>
                <c:pt idx="397">
                  <c:v>1.0615908975265351</c:v>
                </c:pt>
                <c:pt idx="398">
                  <c:v>1.0615908975265351</c:v>
                </c:pt>
                <c:pt idx="399">
                  <c:v>1.0624413753466366</c:v>
                </c:pt>
                <c:pt idx="400">
                  <c:v>1.0632888646322569</c:v>
                </c:pt>
                <c:pt idx="401">
                  <c:v>1.0632888646322569</c:v>
                </c:pt>
                <c:pt idx="402">
                  <c:v>1.0632888646322569</c:v>
                </c:pt>
                <c:pt idx="403">
                  <c:v>1.0632888646322569</c:v>
                </c:pt>
                <c:pt idx="404">
                  <c:v>1.0641333870590262</c:v>
                </c:pt>
                <c:pt idx="405">
                  <c:v>1.0649749640649193</c:v>
                </c:pt>
                <c:pt idx="406">
                  <c:v>1.0658136168537462</c:v>
                </c:pt>
                <c:pt idx="407">
                  <c:v>1.0674822334450202</c:v>
                </c:pt>
                <c:pt idx="408">
                  <c:v>1.0683122385146788</c:v>
                </c:pt>
                <c:pt idx="409">
                  <c:v>1.0683122385146788</c:v>
                </c:pt>
                <c:pt idx="410">
                  <c:v>1.0691394019082208</c:v>
                </c:pt>
                <c:pt idx="411">
                  <c:v>1.0716040417922432</c:v>
                </c:pt>
                <c:pt idx="412">
                  <c:v>1.0732332891926921</c:v>
                </c:pt>
                <c:pt idx="413">
                  <c:v>1.0732332891926921</c:v>
                </c:pt>
                <c:pt idx="414">
                  <c:v>1.0740438168683029</c:v>
                </c:pt>
                <c:pt idx="415">
                  <c:v>1.0748516390479894</c:v>
                </c:pt>
                <c:pt idx="416">
                  <c:v>1.0756567743751742</c:v>
                </c:pt>
                <c:pt idx="417">
                  <c:v>1.0764592412990397</c:v>
                </c:pt>
                <c:pt idx="418">
                  <c:v>1.0764592412990397</c:v>
                </c:pt>
                <c:pt idx="419">
                  <c:v>1.0772590580772312</c:v>
                </c:pt>
                <c:pt idx="420">
                  <c:v>1.0772590580772312</c:v>
                </c:pt>
                <c:pt idx="421">
                  <c:v>1.0780562427785152</c:v>
                </c:pt>
                <c:pt idx="422">
                  <c:v>1.0788508132853898</c:v>
                </c:pt>
                <c:pt idx="423">
                  <c:v>1.0788508132853898</c:v>
                </c:pt>
                <c:pt idx="424">
                  <c:v>1.0796427872966508</c:v>
                </c:pt>
                <c:pt idx="425">
                  <c:v>1.0796427872966508</c:v>
                </c:pt>
                <c:pt idx="426">
                  <c:v>1.0804321823299143</c:v>
                </c:pt>
                <c:pt idx="427">
                  <c:v>1.0804321823299143</c:v>
                </c:pt>
                <c:pt idx="428">
                  <c:v>1.0804321823299143</c:v>
                </c:pt>
                <c:pt idx="429">
                  <c:v>1.0812190157240922</c:v>
                </c:pt>
                <c:pt idx="430">
                  <c:v>1.0827850660719101</c:v>
                </c:pt>
                <c:pt idx="431">
                  <c:v>1.0843410735689045</c:v>
                </c:pt>
                <c:pt idx="432">
                  <c:v>1.0851153527650008</c:v>
                </c:pt>
                <c:pt idx="433">
                  <c:v>1.0858871707363051</c:v>
                </c:pt>
                <c:pt idx="434">
                  <c:v>1.0866565436367597</c:v>
                </c:pt>
                <c:pt idx="435">
                  <c:v>1.0866565436367597</c:v>
                </c:pt>
                <c:pt idx="436">
                  <c:v>1.0874234874599753</c:v>
                </c:pt>
                <c:pt idx="437">
                  <c:v>1.0881880180413601</c:v>
                </c:pt>
                <c:pt idx="438">
                  <c:v>1.0889501510602111</c:v>
                </c:pt>
                <c:pt idx="439">
                  <c:v>1.0912223192358073</c:v>
                </c:pt>
                <c:pt idx="440">
                  <c:v>1.0912223192358073</c:v>
                </c:pt>
                <c:pt idx="441">
                  <c:v>1.0919750157465358</c:v>
                </c:pt>
                <c:pt idx="442">
                  <c:v>1.0919750157465358</c:v>
                </c:pt>
                <c:pt idx="443">
                  <c:v>1.0919750157465358</c:v>
                </c:pt>
                <c:pt idx="444">
                  <c:v>1.0919750157465358</c:v>
                </c:pt>
                <c:pt idx="445">
                  <c:v>1.0919750157465358</c:v>
                </c:pt>
                <c:pt idx="446">
                  <c:v>1.0919750157465358</c:v>
                </c:pt>
                <c:pt idx="447">
                  <c:v>1.0927253908203531</c:v>
                </c:pt>
                <c:pt idx="448">
                  <c:v>1.0934734592419182</c:v>
                </c:pt>
                <c:pt idx="449">
                  <c:v>1.0942192356534823</c:v>
                </c:pt>
                <c:pt idx="450">
                  <c:v>1.0942192356534823</c:v>
                </c:pt>
                <c:pt idx="451">
                  <c:v>1.0942192356534823</c:v>
                </c:pt>
                <c:pt idx="452">
                  <c:v>1.0942192356534823</c:v>
                </c:pt>
                <c:pt idx="453">
                  <c:v>1.0949627345567325</c:v>
                </c:pt>
                <c:pt idx="454">
                  <c:v>1.0957039703145872</c:v>
                </c:pt>
                <c:pt idx="455">
                  <c:v>1.0964429571529752</c:v>
                </c:pt>
                <c:pt idx="456">
                  <c:v>1.0964429571529752</c:v>
                </c:pt>
                <c:pt idx="457">
                  <c:v>1.0964429571529752</c:v>
                </c:pt>
                <c:pt idx="458">
                  <c:v>1.0971797091625803</c:v>
                </c:pt>
                <c:pt idx="459">
                  <c:v>1.0979142403005602</c:v>
                </c:pt>
                <c:pt idx="460">
                  <c:v>1.0979142403005602</c:v>
                </c:pt>
                <c:pt idx="461">
                  <c:v>1.0979142403005602</c:v>
                </c:pt>
                <c:pt idx="462">
                  <c:v>1.0986465643922392</c:v>
                </c:pt>
                <c:pt idx="463">
                  <c:v>1.0986465643922392</c:v>
                </c:pt>
                <c:pt idx="464">
                  <c:v>1.0993766951327699</c:v>
                </c:pt>
                <c:pt idx="465">
                  <c:v>1.1001046460887736</c:v>
                </c:pt>
                <c:pt idx="466">
                  <c:v>1.1015540622806772</c:v>
                </c:pt>
                <c:pt idx="467">
                  <c:v>1.1015540622806772</c:v>
                </c:pt>
                <c:pt idx="468">
                  <c:v>1.1037121701364674</c:v>
                </c:pt>
                <c:pt idx="469">
                  <c:v>1.1044273202865926</c:v>
                </c:pt>
                <c:pt idx="470">
                  <c:v>1.1051403821519621</c:v>
                </c:pt>
                <c:pt idx="471">
                  <c:v>1.1051403821519621</c:v>
                </c:pt>
                <c:pt idx="472">
                  <c:v>1.1051403821519621</c:v>
                </c:pt>
                <c:pt idx="473">
                  <c:v>1.1058513683269249</c:v>
                </c:pt>
                <c:pt idx="474">
                  <c:v>1.1058513683269249</c:v>
                </c:pt>
                <c:pt idx="475">
                  <c:v>1.1072671634099627</c:v>
                </c:pt>
                <c:pt idx="476">
                  <c:v>1.1072671634099627</c:v>
                </c:pt>
                <c:pt idx="477">
                  <c:v>1.1072671634099627</c:v>
                </c:pt>
                <c:pt idx="478">
                  <c:v>1.1079719969378554</c:v>
                </c:pt>
                <c:pt idx="479">
                  <c:v>1.1079719969378554</c:v>
                </c:pt>
                <c:pt idx="480">
                  <c:v>1.1079719969378554</c:v>
                </c:pt>
                <c:pt idx="481">
                  <c:v>1.108674804017717</c:v>
                </c:pt>
                <c:pt idx="482">
                  <c:v>1.108674804017717</c:v>
                </c:pt>
                <c:pt idx="483">
                  <c:v>1.1093755966832353</c:v>
                </c:pt>
                <c:pt idx="484">
                  <c:v>1.11007438686</c:v>
                </c:pt>
                <c:pt idx="485">
                  <c:v>1.1107711863668062</c:v>
                </c:pt>
                <c:pt idx="486">
                  <c:v>1.1107711863668062</c:v>
                </c:pt>
                <c:pt idx="487">
                  <c:v>1.1114660069169267</c:v>
                </c:pt>
                <c:pt idx="488">
                  <c:v>1.1121588601193739</c:v>
                </c:pt>
                <c:pt idx="489">
                  <c:v>1.1121588601193739</c:v>
                </c:pt>
                <c:pt idx="490">
                  <c:v>1.1128497574801437</c:v>
                </c:pt>
                <c:pt idx="491">
                  <c:v>1.1142257301928429</c:v>
                </c:pt>
                <c:pt idx="492">
                  <c:v>1.1149108280525737</c:v>
                </c:pt>
                <c:pt idx="493">
                  <c:v>1.1169547006289773</c:v>
                </c:pt>
                <c:pt idx="494">
                  <c:v>1.1176322208643685</c:v>
                </c:pt>
                <c:pt idx="495">
                  <c:v>1.1189816698884028</c:v>
                </c:pt>
                <c:pt idx="496">
                  <c:v>1.1196536198488873</c:v>
                </c:pt>
                <c:pt idx="497">
                  <c:v>1.1203237340713397</c:v>
                </c:pt>
                <c:pt idx="498">
                  <c:v>1.1203237340713397</c:v>
                </c:pt>
                <c:pt idx="499">
                  <c:v>1.1216584966542116</c:v>
                </c:pt>
                <c:pt idx="500">
                  <c:v>1.1216584966542116</c:v>
                </c:pt>
                <c:pt idx="501">
                  <c:v>1.1216584966542116</c:v>
                </c:pt>
                <c:pt idx="502">
                  <c:v>1.1223231654705272</c:v>
                </c:pt>
                <c:pt idx="503">
                  <c:v>1.1229860394626114</c:v>
                </c:pt>
                <c:pt idx="504">
                  <c:v>1.1236471286427649</c:v>
                </c:pt>
                <c:pt idx="505">
                  <c:v>1.1243064429387877</c:v>
                </c:pt>
                <c:pt idx="506">
                  <c:v>1.1243064429387877</c:v>
                </c:pt>
                <c:pt idx="507">
                  <c:v>1.1243064429387877</c:v>
                </c:pt>
                <c:pt idx="508">
                  <c:v>1.1243064429387877</c:v>
                </c:pt>
                <c:pt idx="509">
                  <c:v>1.1243064429387877</c:v>
                </c:pt>
                <c:pt idx="510">
                  <c:v>1.1256197861728228</c:v>
                </c:pt>
                <c:pt idx="511">
                  <c:v>1.1275767328336572</c:v>
                </c:pt>
                <c:pt idx="512">
                  <c:v>1.1275767328336572</c:v>
                </c:pt>
                <c:pt idx="513">
                  <c:v>1.1282256016949388</c:v>
                </c:pt>
                <c:pt idx="514">
                  <c:v>1.1282256016949388</c:v>
                </c:pt>
                <c:pt idx="515">
                  <c:v>1.1295182256708847</c:v>
                </c:pt>
                <c:pt idx="516">
                  <c:v>1.1301619992791592</c:v>
                </c:pt>
                <c:pt idx="517">
                  <c:v>1.1308040928369034</c:v>
                </c:pt>
                <c:pt idx="518">
                  <c:v>1.1314445154024648</c:v>
                </c:pt>
                <c:pt idx="519">
                  <c:v>1.1320832759602895</c:v>
                </c:pt>
                <c:pt idx="520">
                  <c:v>1.1320832759602895</c:v>
                </c:pt>
                <c:pt idx="521">
                  <c:v>1.1327203834217312</c:v>
                </c:pt>
                <c:pt idx="522">
                  <c:v>1.1333558466258435</c:v>
                </c:pt>
                <c:pt idx="523">
                  <c:v>1.1339896743401647</c:v>
                </c:pt>
                <c:pt idx="524">
                  <c:v>1.1346218752614949</c:v>
                </c:pt>
                <c:pt idx="525">
                  <c:v>1.1358814311632384</c:v>
                </c:pt>
                <c:pt idx="526">
                  <c:v>1.1358814311632384</c:v>
                </c:pt>
                <c:pt idx="527">
                  <c:v>1.1365088031903636</c:v>
                </c:pt>
                <c:pt idx="528">
                  <c:v>1.1371345825193955</c:v>
                </c:pt>
                <c:pt idx="529">
                  <c:v>1.1377587775046738</c:v>
                </c:pt>
                <c:pt idx="530">
                  <c:v>1.1377587775046738</c:v>
                </c:pt>
                <c:pt idx="531">
                  <c:v>1.139002447530475</c:v>
                </c:pt>
                <c:pt idx="532">
                  <c:v>1.1414711357731386</c:v>
                </c:pt>
                <c:pt idx="533">
                  <c:v>1.1420844687909608</c:v>
                </c:pt>
                <c:pt idx="534">
                  <c:v>1.1420844687909608</c:v>
                </c:pt>
                <c:pt idx="535">
                  <c:v>1.1439153798826971</c:v>
                </c:pt>
                <c:pt idx="536">
                  <c:v>1.1445226799993291</c:v>
                </c:pt>
                <c:pt idx="537">
                  <c:v>1.1463356760545582</c:v>
                </c:pt>
                <c:pt idx="538">
                  <c:v>1.1469370649312198</c:v>
                </c:pt>
                <c:pt idx="539">
                  <c:v>1.1493281009733631</c:v>
                </c:pt>
                <c:pt idx="540">
                  <c:v>1.149922266287605</c:v>
                </c:pt>
                <c:pt idx="541">
                  <c:v>1.150515008400455</c:v>
                </c:pt>
                <c:pt idx="542">
                  <c:v>1.1516962511479942</c:v>
                </c:pt>
                <c:pt idx="543">
                  <c:v>1.152284765714283</c:v>
                </c:pt>
                <c:pt idx="544">
                  <c:v>1.152284765714283</c:v>
                </c:pt>
                <c:pt idx="545">
                  <c:v>1.1546249387224536</c:v>
                </c:pt>
                <c:pt idx="546">
                  <c:v>1.1546249387224536</c:v>
                </c:pt>
                <c:pt idx="547">
                  <c:v>1.1546249387224536</c:v>
                </c:pt>
                <c:pt idx="548">
                  <c:v>1.155206544465984</c:v>
                </c:pt>
                <c:pt idx="549">
                  <c:v>1.155206544465984</c:v>
                </c:pt>
                <c:pt idx="550">
                  <c:v>1.1563656775750104</c:v>
                </c:pt>
                <c:pt idx="551">
                  <c:v>1.1575194165273341</c:v>
                </c:pt>
                <c:pt idx="552">
                  <c:v>1.1580942793958289</c:v>
                </c:pt>
                <c:pt idx="553">
                  <c:v>1.1580942793958289</c:v>
                </c:pt>
                <c:pt idx="554">
                  <c:v>1.1586678130722192</c:v>
                </c:pt>
                <c:pt idx="555">
                  <c:v>1.1592400239081564</c:v>
                </c:pt>
                <c:pt idx="556">
                  <c:v>1.1615157642818215</c:v>
                </c:pt>
                <c:pt idx="557">
                  <c:v>1.1637708355802783</c:v>
                </c:pt>
                <c:pt idx="558">
                  <c:v>1.16433141924059</c:v>
                </c:pt>
                <c:pt idx="559">
                  <c:v>1.1648907411218583</c:v>
                </c:pt>
                <c:pt idx="560">
                  <c:v>1.1654488070939744</c:v>
                </c:pt>
                <c:pt idx="561">
                  <c:v>1.1654488070939744</c:v>
                </c:pt>
                <c:pt idx="562">
                  <c:v>1.1665611945840375</c:v>
                </c:pt>
                <c:pt idx="563">
                  <c:v>1.1687711523889917</c:v>
                </c:pt>
                <c:pt idx="564">
                  <c:v>1.170961654127308</c:v>
                </c:pt>
                <c:pt idx="565">
                  <c:v>1.1720497192114911</c:v>
                </c:pt>
                <c:pt idx="566">
                  <c:v>1.1720497192114911</c:v>
                </c:pt>
                <c:pt idx="567">
                  <c:v>1.173672955873688</c:v>
                </c:pt>
                <c:pt idx="568">
                  <c:v>1.175820952342244</c:v>
                </c:pt>
                <c:pt idx="569">
                  <c:v>1.175820952342244</c:v>
                </c:pt>
                <c:pt idx="570">
                  <c:v>1.1774198911502318</c:v>
                </c:pt>
                <c:pt idx="571">
                  <c:v>1.1774198911502318</c:v>
                </c:pt>
                <c:pt idx="572">
                  <c:v>1.1790086456454634</c:v>
                </c:pt>
                <c:pt idx="573">
                  <c:v>1.1800622233846663</c:v>
                </c:pt>
                <c:pt idx="574">
                  <c:v>1.1800622233846663</c:v>
                </c:pt>
                <c:pt idx="575">
                  <c:v>1.1800622233846663</c:v>
                </c:pt>
                <c:pt idx="576">
                  <c:v>1.1837151249789239</c:v>
                </c:pt>
                <c:pt idx="577">
                  <c:v>1.1883345963941649</c:v>
                </c:pt>
                <c:pt idx="578">
                  <c:v>1.1883345963941649</c:v>
                </c:pt>
                <c:pt idx="579">
                  <c:v>1.1883345963941649</c:v>
                </c:pt>
                <c:pt idx="580">
                  <c:v>1.1888426439029329</c:v>
                </c:pt>
                <c:pt idx="581">
                  <c:v>1.1908645838770018</c:v>
                </c:pt>
                <c:pt idx="582">
                  <c:v>1.1913675277069125</c:v>
                </c:pt>
                <c:pt idx="583">
                  <c:v>1.1943641675600118</c:v>
                </c:pt>
                <c:pt idx="584">
                  <c:v>1.194860142058658</c:v>
                </c:pt>
                <c:pt idx="585">
                  <c:v>1.196342205573929</c:v>
                </c:pt>
                <c:pt idx="586">
                  <c:v>1.1978155622988726</c:v>
                </c:pt>
                <c:pt idx="587">
                  <c:v>1.2012201228899229</c:v>
                </c:pt>
                <c:pt idx="588">
                  <c:v>1.2041020267768667</c:v>
                </c:pt>
                <c:pt idx="589">
                  <c:v>1.2074230120253411</c:v>
                </c:pt>
                <c:pt idx="590">
                  <c:v>1.2116294372077174</c:v>
                </c:pt>
                <c:pt idx="591">
                  <c:v>1.2148532134139431</c:v>
                </c:pt>
                <c:pt idx="592">
                  <c:v>1.2166770290059237</c:v>
                </c:pt>
                <c:pt idx="593">
                  <c:v>1.2198373207912567</c:v>
                </c:pt>
                <c:pt idx="594">
                  <c:v>1.2333765367178127</c:v>
                </c:pt>
                <c:pt idx="595">
                  <c:v>1.2354940394379019</c:v>
                </c:pt>
                <c:pt idx="596">
                  <c:v>1.2433831489265219</c:v>
                </c:pt>
                <c:pt idx="597">
                  <c:v>1.2466329622162875</c:v>
                </c:pt>
                <c:pt idx="598">
                  <c:v>1.2634239924657269</c:v>
                </c:pt>
              </c:numCache>
            </c:numRef>
          </c:yVal>
          <c:smooth val="1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71461504"/>
        <c:axId val="73806592"/>
      </c:scatterChart>
      <c:valAx>
        <c:axId val="71461504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 marL="0" marR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 sz="1400" b="1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400" b="1" i="0" baseline="0">
                    <a:effectLst/>
                  </a:rPr>
                  <a:t>C-peptide (nmol/L)</a:t>
                </a:r>
                <a:endParaRPr lang="cs-CZ" sz="1400">
                  <a:effectLst/>
                </a:endParaRPr>
              </a:p>
              <a:p>
                <a:pPr marL="0" marR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 sz="1400" b="1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endParaRPr lang="en-US" sz="1400"/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1000"/>
            </a:pPr>
            <a:endParaRPr lang="en-US"/>
          </a:p>
        </c:txPr>
        <c:crossAx val="73806592"/>
        <c:crossesAt val="-1.4"/>
        <c:crossBetween val="midCat"/>
      </c:valAx>
      <c:valAx>
        <c:axId val="73806592"/>
        <c:scaling>
          <c:orientation val="minMax"/>
          <c:min val="0.70000000000000007"/>
        </c:scaling>
        <c:delete val="0"/>
        <c:axPos val="l"/>
        <c:title>
          <c:tx>
            <c:rich>
              <a:bodyPr rot="-5400000" vert="horz"/>
              <a:lstStyle/>
              <a:p>
                <a:pPr marL="0" marR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 sz="1050" b="1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400" b="1" i="0" baseline="0">
                    <a:effectLst/>
                  </a:rPr>
                  <a:t>Amylin</a:t>
                </a:r>
                <a:r>
                  <a:rPr lang="en-US" sz="1400" b="0" i="0" baseline="0">
                    <a:effectLst/>
                  </a:rPr>
                  <a:t> </a:t>
                </a:r>
                <a:r>
                  <a:rPr lang="en-US" sz="1400" b="1" i="0" baseline="0">
                    <a:effectLst/>
                  </a:rPr>
                  <a:t>(pg/mL</a:t>
                </a:r>
                <a:r>
                  <a:rPr lang="cs-CZ" sz="1400" b="1" i="0" baseline="0">
                    <a:effectLst/>
                  </a:rPr>
                  <a:t>)</a:t>
                </a:r>
                <a:endParaRPr lang="cs-CZ" sz="1400">
                  <a:effectLst/>
                </a:endParaRPr>
              </a:p>
            </c:rich>
          </c:tx>
          <c:layout>
            <c:manualLayout>
              <c:xMode val="edge"/>
              <c:yMode val="edge"/>
              <c:x val="2.1060312279747438E-2"/>
              <c:y val="0.2582604093423112"/>
            </c:manualLayout>
          </c:layout>
          <c:overlay val="0"/>
        </c:title>
        <c:numFmt formatCode="General" sourceLinked="1"/>
        <c:majorTickMark val="out"/>
        <c:minorTickMark val="none"/>
        <c:tickLblPos val="low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1000"/>
            </a:pPr>
            <a:endParaRPr lang="en-US"/>
          </a:p>
        </c:txPr>
        <c:crossAx val="71461504"/>
        <c:crossesAt val="-1.3"/>
        <c:crossBetween val="midCat"/>
      </c:valAx>
      <c:spPr>
        <a:noFill/>
        <a:ln>
          <a:noFill/>
        </a:ln>
      </c:spPr>
    </c:plotArea>
    <c:plotVisOnly val="1"/>
    <c:dispBlanksAs val="gap"/>
    <c:showDLblsOverMax val="0"/>
  </c:chart>
  <c:spPr>
    <a:noFill/>
    <a:ln>
      <a:noFill/>
    </a:ln>
  </c:spPr>
  <c:txPr>
    <a:bodyPr/>
    <a:lstStyle/>
    <a:p>
      <a:pPr>
        <a:defRPr sz="1200"/>
      </a:pPr>
      <a:endParaRPr lang="en-US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scatterChart>
        <c:scatterStyle val="lineMarker"/>
        <c:varyColors val="0"/>
        <c:ser>
          <c:idx val="0"/>
          <c:order val="0"/>
          <c:spPr>
            <a:ln>
              <a:noFill/>
            </a:ln>
          </c:spPr>
          <c:marker>
            <c:symbol val="circle"/>
            <c:size val="2"/>
            <c:spPr>
              <a:noFill/>
              <a:ln>
                <a:solidFill>
                  <a:schemeClr val="tx1"/>
                </a:solidFill>
              </a:ln>
            </c:spPr>
          </c:marker>
          <c:xVal>
            <c:numRef>
              <c:f>datat!$F$2:$F$600</c:f>
              <c:numCache>
                <c:formatCode>General</c:formatCode>
                <c:ptCount val="599"/>
                <c:pt idx="0">
                  <c:v>0.93466820992781718</c:v>
                </c:pt>
                <c:pt idx="1">
                  <c:v>0.93466820992781718</c:v>
                </c:pt>
                <c:pt idx="2">
                  <c:v>0.93887943667849161</c:v>
                </c:pt>
                <c:pt idx="3">
                  <c:v>0.93887943667849161</c:v>
                </c:pt>
                <c:pt idx="4">
                  <c:v>0.93969097769614651</c:v>
                </c:pt>
                <c:pt idx="5">
                  <c:v>0.9404928747138972</c:v>
                </c:pt>
                <c:pt idx="6">
                  <c:v>0.9404928747138972</c:v>
                </c:pt>
                <c:pt idx="7">
                  <c:v>0.94206866603713113</c:v>
                </c:pt>
                <c:pt idx="8">
                  <c:v>0.94206866603713113</c:v>
                </c:pt>
                <c:pt idx="9">
                  <c:v>0.94436561534226349</c:v>
                </c:pt>
                <c:pt idx="10">
                  <c:v>0.94436561534226349</c:v>
                </c:pt>
                <c:pt idx="11">
                  <c:v>0.94436561534226349</c:v>
                </c:pt>
                <c:pt idx="12">
                  <c:v>0.94511428693327026</c:v>
                </c:pt>
                <c:pt idx="13">
                  <c:v>0.94585478995418004</c:v>
                </c:pt>
                <c:pt idx="14">
                  <c:v>0.94585478995418004</c:v>
                </c:pt>
                <c:pt idx="15">
                  <c:v>0.94585478995418004</c:v>
                </c:pt>
                <c:pt idx="16">
                  <c:v>0.94585478995418004</c:v>
                </c:pt>
                <c:pt idx="17">
                  <c:v>0.94658730692345749</c:v>
                </c:pt>
                <c:pt idx="18">
                  <c:v>0.94658730692345749</c:v>
                </c:pt>
                <c:pt idx="19">
                  <c:v>0.94731201424224298</c:v>
                </c:pt>
                <c:pt idx="20">
                  <c:v>0.94731201424224298</c:v>
                </c:pt>
                <c:pt idx="21">
                  <c:v>0.94731201424224298</c:v>
                </c:pt>
                <c:pt idx="22">
                  <c:v>0.94731201424224298</c:v>
                </c:pt>
                <c:pt idx="23">
                  <c:v>0.94731201424224298</c:v>
                </c:pt>
                <c:pt idx="24">
                  <c:v>0.94802908246618312</c:v>
                </c:pt>
                <c:pt idx="25">
                  <c:v>0.94802908246618312</c:v>
                </c:pt>
                <c:pt idx="26">
                  <c:v>0.94873867656228039</c:v>
                </c:pt>
                <c:pt idx="27">
                  <c:v>0.95013607573974268</c:v>
                </c:pt>
                <c:pt idx="28">
                  <c:v>0.95013607573974268</c:v>
                </c:pt>
                <c:pt idx="29">
                  <c:v>0.9508241849329242</c:v>
                </c:pt>
                <c:pt idx="30">
                  <c:v>0.95150542864543453</c:v>
                </c:pt>
                <c:pt idx="31">
                  <c:v>0.95150542864543453</c:v>
                </c:pt>
                <c:pt idx="32">
                  <c:v>0.95150542864543453</c:v>
                </c:pt>
                <c:pt idx="33">
                  <c:v>0.95150542864543453</c:v>
                </c:pt>
                <c:pt idx="34">
                  <c:v>0.95150542864543453</c:v>
                </c:pt>
                <c:pt idx="35">
                  <c:v>0.95217994729420263</c:v>
                </c:pt>
                <c:pt idx="36">
                  <c:v>0.95350934968382206</c:v>
                </c:pt>
                <c:pt idx="37">
                  <c:v>0.95350934968382206</c:v>
                </c:pt>
                <c:pt idx="38">
                  <c:v>0.95350934968382206</c:v>
                </c:pt>
                <c:pt idx="39">
                  <c:v>0.95416449339241294</c:v>
                </c:pt>
                <c:pt idx="40">
                  <c:v>0.95416449339241294</c:v>
                </c:pt>
                <c:pt idx="41">
                  <c:v>0.95481343229805826</c:v>
                </c:pt>
                <c:pt idx="42">
                  <c:v>0.95481343229805826</c:v>
                </c:pt>
                <c:pt idx="43">
                  <c:v>0.95609317429456908</c:v>
                </c:pt>
                <c:pt idx="44">
                  <c:v>0.95609317429456908</c:v>
                </c:pt>
                <c:pt idx="45">
                  <c:v>0.95609317429456908</c:v>
                </c:pt>
                <c:pt idx="46">
                  <c:v>0.9567242080259184</c:v>
                </c:pt>
                <c:pt idx="47">
                  <c:v>0.95734949850127504</c:v>
                </c:pt>
                <c:pt idx="48">
                  <c:v>0.9579691529717026</c:v>
                </c:pt>
                <c:pt idx="49">
                  <c:v>0.9579691529717026</c:v>
                </c:pt>
                <c:pt idx="50">
                  <c:v>0.9579691529717026</c:v>
                </c:pt>
                <c:pt idx="51">
                  <c:v>0.95858327567835611</c:v>
                </c:pt>
                <c:pt idx="52">
                  <c:v>0.95858327567835611</c:v>
                </c:pt>
                <c:pt idx="53">
                  <c:v>0.95858327567835611</c:v>
                </c:pt>
                <c:pt idx="54">
                  <c:v>0.95858327567835611</c:v>
                </c:pt>
                <c:pt idx="55">
                  <c:v>0.95919196796468009</c:v>
                </c:pt>
                <c:pt idx="56">
                  <c:v>0.95919196796468009</c:v>
                </c:pt>
                <c:pt idx="57">
                  <c:v>0.95919196796468009</c:v>
                </c:pt>
                <c:pt idx="58">
                  <c:v>0.95979532838340953</c:v>
                </c:pt>
                <c:pt idx="59">
                  <c:v>0.96039345279866184</c:v>
                </c:pt>
                <c:pt idx="60">
                  <c:v>0.96039345279866184</c:v>
                </c:pt>
                <c:pt idx="61">
                  <c:v>0.96039345279866184</c:v>
                </c:pt>
                <c:pt idx="62">
                  <c:v>0.96157436421242903</c:v>
                </c:pt>
                <c:pt idx="63">
                  <c:v>0.96157436421242903</c:v>
                </c:pt>
                <c:pt idx="64">
                  <c:v>0.96215733035143081</c:v>
                </c:pt>
                <c:pt idx="65">
                  <c:v>0.96215733035143081</c:v>
                </c:pt>
                <c:pt idx="66">
                  <c:v>0.96215733035143081</c:v>
                </c:pt>
                <c:pt idx="67">
                  <c:v>0.96273541894180925</c:v>
                </c:pt>
                <c:pt idx="68">
                  <c:v>0.96273541894180925</c:v>
                </c:pt>
                <c:pt idx="69">
                  <c:v>0.96273541894180925</c:v>
                </c:pt>
                <c:pt idx="70">
                  <c:v>0.96330871378200189</c:v>
                </c:pt>
                <c:pt idx="71">
                  <c:v>0.96330871378200189</c:v>
                </c:pt>
                <c:pt idx="72">
                  <c:v>0.96330871378200189</c:v>
                </c:pt>
                <c:pt idx="73">
                  <c:v>0.96387729650518417</c:v>
                </c:pt>
                <c:pt idx="74">
                  <c:v>0.96387729650518417</c:v>
                </c:pt>
                <c:pt idx="75">
                  <c:v>0.96444124665363817</c:v>
                </c:pt>
                <c:pt idx="76">
                  <c:v>0.96500064174994526</c:v>
                </c:pt>
                <c:pt idx="77">
                  <c:v>0.96500064174994526</c:v>
                </c:pt>
                <c:pt idx="78">
                  <c:v>0.96500064174994526</c:v>
                </c:pt>
                <c:pt idx="79">
                  <c:v>0.96500064174994526</c:v>
                </c:pt>
                <c:pt idx="80">
                  <c:v>0.96500064174994526</c:v>
                </c:pt>
                <c:pt idx="81">
                  <c:v>0.96555555736516441</c:v>
                </c:pt>
                <c:pt idx="82">
                  <c:v>0.96555555736516441</c:v>
                </c:pt>
                <c:pt idx="83">
                  <c:v>0.96555555736516441</c:v>
                </c:pt>
                <c:pt idx="84">
                  <c:v>0.96610606718414871</c:v>
                </c:pt>
                <c:pt idx="85">
                  <c:v>0.9666522430681429</c:v>
                </c:pt>
                <c:pt idx="86">
                  <c:v>0.9666522430681429</c:v>
                </c:pt>
                <c:pt idx="87">
                  <c:v>0.96719415511479723</c:v>
                </c:pt>
                <c:pt idx="88">
                  <c:v>0.96719415511479723</c:v>
                </c:pt>
                <c:pt idx="89">
                  <c:v>0.96719415511479723</c:v>
                </c:pt>
                <c:pt idx="90">
                  <c:v>0.96773187171572395</c:v>
                </c:pt>
                <c:pt idx="91">
                  <c:v>0.96773187171572395</c:v>
                </c:pt>
                <c:pt idx="92">
                  <c:v>0.96773187171572395</c:v>
                </c:pt>
                <c:pt idx="93">
                  <c:v>0.96826545961171828</c:v>
                </c:pt>
                <c:pt idx="94">
                  <c:v>0.96826545961171828</c:v>
                </c:pt>
                <c:pt idx="95">
                  <c:v>0.96826545961171828</c:v>
                </c:pt>
                <c:pt idx="96">
                  <c:v>0.96879498394575514</c:v>
                </c:pt>
                <c:pt idx="97">
                  <c:v>0.96879498394575514</c:v>
                </c:pt>
                <c:pt idx="98">
                  <c:v>0.96879498394575514</c:v>
                </c:pt>
                <c:pt idx="99">
                  <c:v>0.96879498394575514</c:v>
                </c:pt>
                <c:pt idx="100">
                  <c:v>0.96932050831386884</c:v>
                </c:pt>
                <c:pt idx="101">
                  <c:v>0.96932050831386884</c:v>
                </c:pt>
                <c:pt idx="102">
                  <c:v>0.96984209481401806</c:v>
                </c:pt>
                <c:pt idx="103">
                  <c:v>0.96984209481401806</c:v>
                </c:pt>
                <c:pt idx="104">
                  <c:v>0.96984209481401806</c:v>
                </c:pt>
                <c:pt idx="105">
                  <c:v>0.97035980409302924</c:v>
                </c:pt>
                <c:pt idx="106">
                  <c:v>0.97035980409302924</c:v>
                </c:pt>
                <c:pt idx="107">
                  <c:v>0.97087369539170987</c:v>
                </c:pt>
                <c:pt idx="108">
                  <c:v>0.97087369539170987</c:v>
                </c:pt>
                <c:pt idx="109">
                  <c:v>0.97138382658821665</c:v>
                </c:pt>
                <c:pt idx="110">
                  <c:v>0.97189025423975828</c:v>
                </c:pt>
                <c:pt idx="111">
                  <c:v>0.97189025423975828</c:v>
                </c:pt>
                <c:pt idx="112">
                  <c:v>0.97189025423975828</c:v>
                </c:pt>
                <c:pt idx="113">
                  <c:v>0.97239303362271101</c:v>
                </c:pt>
                <c:pt idx="114">
                  <c:v>0.97239303362271101</c:v>
                </c:pt>
                <c:pt idx="115">
                  <c:v>0.97239303362271101</c:v>
                </c:pt>
                <c:pt idx="116">
                  <c:v>0.97239303362271101</c:v>
                </c:pt>
                <c:pt idx="117">
                  <c:v>0.97289221877121634</c:v>
                </c:pt>
                <c:pt idx="118">
                  <c:v>0.97338786251433229</c:v>
                </c:pt>
                <c:pt idx="119">
                  <c:v>0.97388001651180078</c:v>
                </c:pt>
                <c:pt idx="120">
                  <c:v>0.97436873128849366</c:v>
                </c:pt>
                <c:pt idx="121">
                  <c:v>0.97436873128849366</c:v>
                </c:pt>
                <c:pt idx="122">
                  <c:v>0.97436873128849366</c:v>
                </c:pt>
                <c:pt idx="123">
                  <c:v>0.97436873128849366</c:v>
                </c:pt>
                <c:pt idx="124">
                  <c:v>0.97436873128849366</c:v>
                </c:pt>
                <c:pt idx="125">
                  <c:v>0.97533603980257944</c:v>
                </c:pt>
                <c:pt idx="126">
                  <c:v>0.97581472920802437</c:v>
                </c:pt>
                <c:pt idx="127">
                  <c:v>0.97581472920802437</c:v>
                </c:pt>
                <c:pt idx="128">
                  <c:v>0.97581472920802437</c:v>
                </c:pt>
                <c:pt idx="129">
                  <c:v>0.97629017078933111</c:v>
                </c:pt>
                <c:pt idx="130">
                  <c:v>0.97629017078933111</c:v>
                </c:pt>
                <c:pt idx="131">
                  <c:v>0.97629017078933111</c:v>
                </c:pt>
                <c:pt idx="132">
                  <c:v>0.97629017078933111</c:v>
                </c:pt>
                <c:pt idx="133">
                  <c:v>0.97629017078933111</c:v>
                </c:pt>
                <c:pt idx="134">
                  <c:v>0.97676240987137641</c:v>
                </c:pt>
                <c:pt idx="135">
                  <c:v>0.97676240987137641</c:v>
                </c:pt>
                <c:pt idx="136">
                  <c:v>0.97723149082615601</c:v>
                </c:pt>
                <c:pt idx="137">
                  <c:v>0.97723149082615601</c:v>
                </c:pt>
                <c:pt idx="138">
                  <c:v>0.97723149082615601</c:v>
                </c:pt>
                <c:pt idx="139">
                  <c:v>0.97723149082615601</c:v>
                </c:pt>
                <c:pt idx="140">
                  <c:v>0.97723149082615601</c:v>
                </c:pt>
                <c:pt idx="141">
                  <c:v>0.97769745709945599</c:v>
                </c:pt>
                <c:pt idx="142">
                  <c:v>0.97769745709945599</c:v>
                </c:pt>
                <c:pt idx="143">
                  <c:v>0.97816035123659528</c:v>
                </c:pt>
                <c:pt idx="144">
                  <c:v>0.97816035123659528</c:v>
                </c:pt>
                <c:pt idx="145">
                  <c:v>0.97816035123659528</c:v>
                </c:pt>
                <c:pt idx="146">
                  <c:v>0.97862021490727635</c:v>
                </c:pt>
                <c:pt idx="147">
                  <c:v>0.97862021490727635</c:v>
                </c:pt>
                <c:pt idx="148">
                  <c:v>0.97862021490727635</c:v>
                </c:pt>
                <c:pt idx="149">
                  <c:v>0.97862021490727635</c:v>
                </c:pt>
                <c:pt idx="150">
                  <c:v>0.97862021490727635</c:v>
                </c:pt>
                <c:pt idx="151">
                  <c:v>0.9790770889295819</c:v>
                </c:pt>
                <c:pt idx="152">
                  <c:v>0.9790770889295819</c:v>
                </c:pt>
                <c:pt idx="153">
                  <c:v>0.9790770889295819</c:v>
                </c:pt>
                <c:pt idx="154">
                  <c:v>0.97953101329315295</c:v>
                </c:pt>
                <c:pt idx="155">
                  <c:v>0.97953101329315295</c:v>
                </c:pt>
                <c:pt idx="156">
                  <c:v>0.97953101329315295</c:v>
                </c:pt>
                <c:pt idx="157">
                  <c:v>0.97953101329315295</c:v>
                </c:pt>
                <c:pt idx="158">
                  <c:v>0.97953101329315295</c:v>
                </c:pt>
                <c:pt idx="159">
                  <c:v>0.97998202718158023</c:v>
                </c:pt>
                <c:pt idx="160">
                  <c:v>0.97998202718158023</c:v>
                </c:pt>
                <c:pt idx="161">
                  <c:v>0.97998202718158023</c:v>
                </c:pt>
                <c:pt idx="162">
                  <c:v>0.97998202718158023</c:v>
                </c:pt>
                <c:pt idx="163">
                  <c:v>0.98043016899404245</c:v>
                </c:pt>
                <c:pt idx="164">
                  <c:v>0.98043016899404245</c:v>
                </c:pt>
                <c:pt idx="165">
                  <c:v>0.98043016899404245</c:v>
                </c:pt>
                <c:pt idx="166">
                  <c:v>0.98043016899404245</c:v>
                </c:pt>
                <c:pt idx="167">
                  <c:v>0.98043016899404245</c:v>
                </c:pt>
                <c:pt idx="168">
                  <c:v>0.98087547636622041</c:v>
                </c:pt>
                <c:pt idx="169">
                  <c:v>0.98087547636622041</c:v>
                </c:pt>
                <c:pt idx="170">
                  <c:v>0.98087547636622041</c:v>
                </c:pt>
                <c:pt idx="171">
                  <c:v>0.98131798619051658</c:v>
                </c:pt>
                <c:pt idx="172">
                  <c:v>0.981757734635608</c:v>
                </c:pt>
                <c:pt idx="173">
                  <c:v>0.981757734635608</c:v>
                </c:pt>
                <c:pt idx="174">
                  <c:v>0.981757734635608</c:v>
                </c:pt>
                <c:pt idx="175">
                  <c:v>0.98219475716535742</c:v>
                </c:pt>
                <c:pt idx="176">
                  <c:v>0.98262908855710951</c:v>
                </c:pt>
                <c:pt idx="177">
                  <c:v>0.98262908855710951</c:v>
                </c:pt>
                <c:pt idx="178">
                  <c:v>0.98306076291939504</c:v>
                </c:pt>
                <c:pt idx="179">
                  <c:v>0.98306076291939504</c:v>
                </c:pt>
                <c:pt idx="180">
                  <c:v>0.98306076291939504</c:v>
                </c:pt>
                <c:pt idx="181">
                  <c:v>0.98348981370906574</c:v>
                </c:pt>
                <c:pt idx="182">
                  <c:v>0.98348981370906574</c:v>
                </c:pt>
                <c:pt idx="183">
                  <c:v>0.98348981370906574</c:v>
                </c:pt>
                <c:pt idx="184">
                  <c:v>0.98348981370906574</c:v>
                </c:pt>
                <c:pt idx="185">
                  <c:v>0.98391627374788293</c:v>
                </c:pt>
                <c:pt idx="186">
                  <c:v>0.98391627374788293</c:v>
                </c:pt>
                <c:pt idx="187">
                  <c:v>0.98391627374788293</c:v>
                </c:pt>
                <c:pt idx="188">
                  <c:v>0.98434017523857897</c:v>
                </c:pt>
                <c:pt idx="189">
                  <c:v>0.98434017523857897</c:v>
                </c:pt>
                <c:pt idx="190">
                  <c:v>0.98434017523857897</c:v>
                </c:pt>
                <c:pt idx="191">
                  <c:v>0.98434017523857897</c:v>
                </c:pt>
                <c:pt idx="192">
                  <c:v>0.98476154978041353</c:v>
                </c:pt>
                <c:pt idx="193">
                  <c:v>0.98476154978041353</c:v>
                </c:pt>
                <c:pt idx="194">
                  <c:v>0.98518042838424158</c:v>
                </c:pt>
                <c:pt idx="195">
                  <c:v>0.98559684148711302</c:v>
                </c:pt>
                <c:pt idx="196">
                  <c:v>0.98559684148711302</c:v>
                </c:pt>
                <c:pt idx="197">
                  <c:v>0.98601081896642107</c:v>
                </c:pt>
                <c:pt idx="198">
                  <c:v>0.98642239015361532</c:v>
                </c:pt>
                <c:pt idx="199">
                  <c:v>0.98642239015361532</c:v>
                </c:pt>
                <c:pt idx="200">
                  <c:v>0.98642239015361532</c:v>
                </c:pt>
                <c:pt idx="201">
                  <c:v>0.98683158384749614</c:v>
                </c:pt>
                <c:pt idx="202">
                  <c:v>0.9872384283271054</c:v>
                </c:pt>
                <c:pt idx="203">
                  <c:v>0.98764295136422886</c:v>
                </c:pt>
                <c:pt idx="204">
                  <c:v>0.98764295136422886</c:v>
                </c:pt>
                <c:pt idx="205">
                  <c:v>0.98764295136422886</c:v>
                </c:pt>
                <c:pt idx="206">
                  <c:v>0.98804518023552257</c:v>
                </c:pt>
                <c:pt idx="207">
                  <c:v>0.98804518023552257</c:v>
                </c:pt>
                <c:pt idx="208">
                  <c:v>0.988445141734279</c:v>
                </c:pt>
                <c:pt idx="209">
                  <c:v>0.988445141734279</c:v>
                </c:pt>
                <c:pt idx="210">
                  <c:v>0.988445141734279</c:v>
                </c:pt>
                <c:pt idx="211">
                  <c:v>0.98884286218184414</c:v>
                </c:pt>
                <c:pt idx="212">
                  <c:v>0.98884286218184414</c:v>
                </c:pt>
                <c:pt idx="213">
                  <c:v>0.98884286218184414</c:v>
                </c:pt>
                <c:pt idx="214">
                  <c:v>0.98884286218184414</c:v>
                </c:pt>
                <c:pt idx="215">
                  <c:v>0.98884286218184414</c:v>
                </c:pt>
                <c:pt idx="216">
                  <c:v>0.98923836743869797</c:v>
                </c:pt>
                <c:pt idx="217">
                  <c:v>0.98923836743869797</c:v>
                </c:pt>
                <c:pt idx="218">
                  <c:v>0.98923836743869797</c:v>
                </c:pt>
                <c:pt idx="219">
                  <c:v>0.98923836743869797</c:v>
                </c:pt>
                <c:pt idx="220">
                  <c:v>0.99041184398050908</c:v>
                </c:pt>
                <c:pt idx="221">
                  <c:v>0.99041184398050908</c:v>
                </c:pt>
                <c:pt idx="222">
                  <c:v>0.99041184398050908</c:v>
                </c:pt>
                <c:pt idx="223">
                  <c:v>0.99079873823197928</c:v>
                </c:pt>
                <c:pt idx="224">
                  <c:v>0.99079873823197928</c:v>
                </c:pt>
                <c:pt idx="225">
                  <c:v>0.99079873823197928</c:v>
                </c:pt>
                <c:pt idx="226">
                  <c:v>0.99118354004789644</c:v>
                </c:pt>
                <c:pt idx="227">
                  <c:v>0.99118354004789644</c:v>
                </c:pt>
                <c:pt idx="228">
                  <c:v>0.99156627273884734</c:v>
                </c:pt>
                <c:pt idx="229">
                  <c:v>0.99194695922364085</c:v>
                </c:pt>
                <c:pt idx="230">
                  <c:v>0.99194695922364085</c:v>
                </c:pt>
                <c:pt idx="231">
                  <c:v>0.99270228334353128</c:v>
                </c:pt>
                <c:pt idx="232">
                  <c:v>0.99270228334353128</c:v>
                </c:pt>
                <c:pt idx="233">
                  <c:v>0.99307696493515074</c:v>
                </c:pt>
                <c:pt idx="234">
                  <c:v>0.99307696493515074</c:v>
                </c:pt>
                <c:pt idx="235">
                  <c:v>0.99307696493515074</c:v>
                </c:pt>
                <c:pt idx="236">
                  <c:v>0.99382047437496757</c:v>
                </c:pt>
                <c:pt idx="237">
                  <c:v>0.99418934405418546</c:v>
                </c:pt>
                <c:pt idx="238">
                  <c:v>0.99418934405418546</c:v>
                </c:pt>
                <c:pt idx="239">
                  <c:v>0.99455631769667496</c:v>
                </c:pt>
                <c:pt idx="240">
                  <c:v>0.99455631769667496</c:v>
                </c:pt>
                <c:pt idx="241">
                  <c:v>0.99455631769667496</c:v>
                </c:pt>
                <c:pt idx="242">
                  <c:v>0.99492141538345913</c:v>
                </c:pt>
                <c:pt idx="243">
                  <c:v>0.99492141538345913</c:v>
                </c:pt>
                <c:pt idx="244">
                  <c:v>0.99492141538345913</c:v>
                </c:pt>
                <c:pt idx="245">
                  <c:v>0.99492141538345913</c:v>
                </c:pt>
                <c:pt idx="246">
                  <c:v>0.9952846568746142</c:v>
                </c:pt>
                <c:pt idx="247">
                  <c:v>0.9952846568746142</c:v>
                </c:pt>
                <c:pt idx="248">
                  <c:v>0.99564606161611036</c:v>
                </c:pt>
                <c:pt idx="249">
                  <c:v>0.99600564874647179</c:v>
                </c:pt>
                <c:pt idx="250">
                  <c:v>0.99600564874647179</c:v>
                </c:pt>
                <c:pt idx="251">
                  <c:v>0.99636343710325903</c:v>
                </c:pt>
                <c:pt idx="252">
                  <c:v>0.99636343710325903</c:v>
                </c:pt>
                <c:pt idx="253">
                  <c:v>0.99636343710325903</c:v>
                </c:pt>
                <c:pt idx="254">
                  <c:v>0.99636343710325903</c:v>
                </c:pt>
                <c:pt idx="255">
                  <c:v>0.99636343710325903</c:v>
                </c:pt>
                <c:pt idx="256">
                  <c:v>0.99671944522938227</c:v>
                </c:pt>
                <c:pt idx="257">
                  <c:v>0.99671944522938227</c:v>
                </c:pt>
                <c:pt idx="258">
                  <c:v>0.99671944522938227</c:v>
                </c:pt>
                <c:pt idx="259">
                  <c:v>0.99671944522938227</c:v>
                </c:pt>
                <c:pt idx="260">
                  <c:v>0.99707369137924851</c:v>
                </c:pt>
                <c:pt idx="261">
                  <c:v>0.99707369137924851</c:v>
                </c:pt>
                <c:pt idx="262">
                  <c:v>0.99707369137924851</c:v>
                </c:pt>
                <c:pt idx="263">
                  <c:v>0.99742619352474848</c:v>
                </c:pt>
                <c:pt idx="264">
                  <c:v>0.99742619352474848</c:v>
                </c:pt>
                <c:pt idx="265">
                  <c:v>0.99742619352474848</c:v>
                </c:pt>
                <c:pt idx="266">
                  <c:v>0.99777696936109017</c:v>
                </c:pt>
                <c:pt idx="267">
                  <c:v>0.99777696936109017</c:v>
                </c:pt>
                <c:pt idx="268">
                  <c:v>0.99847341153765867</c:v>
                </c:pt>
                <c:pt idx="269">
                  <c:v>0.99881911193529938</c:v>
                </c:pt>
                <c:pt idx="270">
                  <c:v>0.99881911193529938</c:v>
                </c:pt>
                <c:pt idx="271">
                  <c:v>0.99881911193529938</c:v>
                </c:pt>
                <c:pt idx="272">
                  <c:v>0.99881911193529938</c:v>
                </c:pt>
                <c:pt idx="273">
                  <c:v>0.99916315414926316</c:v>
                </c:pt>
                <c:pt idx="274">
                  <c:v>0.99950555457372647</c:v>
                </c:pt>
                <c:pt idx="275">
                  <c:v>0.99984632935817819</c:v>
                </c:pt>
                <c:pt idx="276">
                  <c:v>1.0001854944122917</c:v>
                </c:pt>
                <c:pt idx="277">
                  <c:v>1.0001854944122917</c:v>
                </c:pt>
                <c:pt idx="278">
                  <c:v>1.0005230654106767</c:v>
                </c:pt>
                <c:pt idx="279">
                  <c:v>1.0008590577975127</c:v>
                </c:pt>
                <c:pt idx="280">
                  <c:v>1.0008590577975127</c:v>
                </c:pt>
                <c:pt idx="281">
                  <c:v>1.0011934867910683</c:v>
                </c:pt>
                <c:pt idx="282">
                  <c:v>1.0011934867910683</c:v>
                </c:pt>
                <c:pt idx="283">
                  <c:v>1.0011934867910683</c:v>
                </c:pt>
                <c:pt idx="284">
                  <c:v>1.0011934867910683</c:v>
                </c:pt>
                <c:pt idx="285">
                  <c:v>1.0011934867910683</c:v>
                </c:pt>
                <c:pt idx="286">
                  <c:v>1.0015263673881121</c:v>
                </c:pt>
                <c:pt idx="287">
                  <c:v>1.0015263673881121</c:v>
                </c:pt>
                <c:pt idx="288">
                  <c:v>1.0018577143682126</c:v>
                </c:pt>
                <c:pt idx="289">
                  <c:v>1.0021875422979367</c:v>
                </c:pt>
                <c:pt idx="290">
                  <c:v>1.0021875422979367</c:v>
                </c:pt>
                <c:pt idx="291">
                  <c:v>1.0021875422979367</c:v>
                </c:pt>
                <c:pt idx="292">
                  <c:v>1.0021875422979367</c:v>
                </c:pt>
                <c:pt idx="293">
                  <c:v>1.0021875422979367</c:v>
                </c:pt>
                <c:pt idx="294">
                  <c:v>1.0021875422979367</c:v>
                </c:pt>
                <c:pt idx="295">
                  <c:v>1.002515865534946</c:v>
                </c:pt>
                <c:pt idx="296">
                  <c:v>1.002515865534946</c:v>
                </c:pt>
                <c:pt idx="297">
                  <c:v>1.002515865534946</c:v>
                </c:pt>
                <c:pt idx="298">
                  <c:v>1.0028426982319942</c:v>
                </c:pt>
                <c:pt idx="299">
                  <c:v>1.0028426982319942</c:v>
                </c:pt>
                <c:pt idx="300">
                  <c:v>1.0031680543408301</c:v>
                </c:pt>
                <c:pt idx="301">
                  <c:v>1.0031680543408301</c:v>
                </c:pt>
                <c:pt idx="302">
                  <c:v>1.0034919476160074</c:v>
                </c:pt>
                <c:pt idx="303">
                  <c:v>1.0038143916186029</c:v>
                </c:pt>
                <c:pt idx="304">
                  <c:v>1.0038143916186029</c:v>
                </c:pt>
                <c:pt idx="305">
                  <c:v>1.0038143916186029</c:v>
                </c:pt>
                <c:pt idx="306">
                  <c:v>1.0044549851046871</c:v>
                </c:pt>
                <c:pt idx="307">
                  <c:v>1.0044549851046871</c:v>
                </c:pt>
                <c:pt idx="308">
                  <c:v>1.0044549851046871</c:v>
                </c:pt>
                <c:pt idx="309">
                  <c:v>1.0057193568500078</c:v>
                </c:pt>
                <c:pt idx="310">
                  <c:v>1.0057193568500078</c:v>
                </c:pt>
                <c:pt idx="311">
                  <c:v>1.0060320201444852</c:v>
                </c:pt>
                <c:pt idx="312">
                  <c:v>1.0060320201444852</c:v>
                </c:pt>
                <c:pt idx="313">
                  <c:v>1.0060320201444852</c:v>
                </c:pt>
                <c:pt idx="314">
                  <c:v>1.0060320201444852</c:v>
                </c:pt>
                <c:pt idx="315">
                  <c:v>1.0063433361084175</c:v>
                </c:pt>
                <c:pt idx="316">
                  <c:v>1.0066533167153071</c:v>
                </c:pt>
                <c:pt idx="317">
                  <c:v>1.0069619737779409</c:v>
                </c:pt>
                <c:pt idx="318">
                  <c:v>1.0078801194774685</c:v>
                </c:pt>
                <c:pt idx="319">
                  <c:v>1.0078801194774685</c:v>
                </c:pt>
                <c:pt idx="320">
                  <c:v>1.0081835973760855</c:v>
                </c:pt>
                <c:pt idx="321">
                  <c:v>1.0081835973760855</c:v>
                </c:pt>
                <c:pt idx="322">
                  <c:v>1.0081835973760855</c:v>
                </c:pt>
                <c:pt idx="323">
                  <c:v>1.0084858084822172</c:v>
                </c:pt>
                <c:pt idx="324">
                  <c:v>1.0084858084822172</c:v>
                </c:pt>
                <c:pt idx="325">
                  <c:v>1.0084858084822172</c:v>
                </c:pt>
                <c:pt idx="326">
                  <c:v>1.008786763702634</c:v>
                </c:pt>
                <c:pt idx="327">
                  <c:v>1.008786763702634</c:v>
                </c:pt>
                <c:pt idx="328">
                  <c:v>1.008786763702634</c:v>
                </c:pt>
                <c:pt idx="329">
                  <c:v>1.008786763702634</c:v>
                </c:pt>
                <c:pt idx="330">
                  <c:v>1.0090864738022527</c:v>
                </c:pt>
                <c:pt idx="331">
                  <c:v>1.0090864738022527</c:v>
                </c:pt>
                <c:pt idx="332">
                  <c:v>1.0093849494066014</c:v>
                </c:pt>
                <c:pt idx="333">
                  <c:v>1.0093849494066014</c:v>
                </c:pt>
                <c:pt idx="334">
                  <c:v>1.0093849494066014</c:v>
                </c:pt>
                <c:pt idx="335">
                  <c:v>1.0096822010042277</c:v>
                </c:pt>
                <c:pt idx="336">
                  <c:v>1.0096822010042277</c:v>
                </c:pt>
                <c:pt idx="337">
                  <c:v>1.0099782389490566</c:v>
                </c:pt>
                <c:pt idx="338">
                  <c:v>1.0102730734626981</c:v>
                </c:pt>
                <c:pt idx="339">
                  <c:v>1.0102730734626981</c:v>
                </c:pt>
                <c:pt idx="340">
                  <c:v>1.0108591724347769</c:v>
                </c:pt>
                <c:pt idx="341">
                  <c:v>1.0111504566949348</c:v>
                </c:pt>
                <c:pt idx="342">
                  <c:v>1.0111504566949348</c:v>
                </c:pt>
                <c:pt idx="343">
                  <c:v>1.0111504566949348</c:v>
                </c:pt>
                <c:pt idx="344">
                  <c:v>1.0111504566949348</c:v>
                </c:pt>
                <c:pt idx="345">
                  <c:v>1.0111504566949348</c:v>
                </c:pt>
                <c:pt idx="346">
                  <c:v>1.0114405771316255</c:v>
                </c:pt>
                <c:pt idx="347">
                  <c:v>1.0114405771316255</c:v>
                </c:pt>
                <c:pt idx="348">
                  <c:v>1.0117295433378011</c:v>
                </c:pt>
                <c:pt idx="349">
                  <c:v>1.0117295433378011</c:v>
                </c:pt>
                <c:pt idx="350">
                  <c:v>1.0120173647869453</c:v>
                </c:pt>
                <c:pt idx="351">
                  <c:v>1.0120173647869453</c:v>
                </c:pt>
                <c:pt idx="352">
                  <c:v>1.0120173647869453</c:v>
                </c:pt>
                <c:pt idx="353">
                  <c:v>1.0125896107226164</c:v>
                </c:pt>
                <c:pt idx="354">
                  <c:v>1.0125896107226164</c:v>
                </c:pt>
                <c:pt idx="355">
                  <c:v>1.0125896107226164</c:v>
                </c:pt>
                <c:pt idx="356">
                  <c:v>1.0134396241332915</c:v>
                </c:pt>
                <c:pt idx="357">
                  <c:v>1.013720769538428</c:v>
                </c:pt>
                <c:pt idx="358">
                  <c:v>1.013720769538428</c:v>
                </c:pt>
                <c:pt idx="359">
                  <c:v>1.013720769538428</c:v>
                </c:pt>
                <c:pt idx="360">
                  <c:v>1.0140008333176336</c:v>
                </c:pt>
                <c:pt idx="361">
                  <c:v>1.0140008333176336</c:v>
                </c:pt>
                <c:pt idx="362">
                  <c:v>1.0140008333176336</c:v>
                </c:pt>
                <c:pt idx="363">
                  <c:v>1.0142798240568298</c:v>
                </c:pt>
                <c:pt idx="364">
                  <c:v>1.0142798240568298</c:v>
                </c:pt>
                <c:pt idx="365">
                  <c:v>1.0145577502389478</c:v>
                </c:pt>
                <c:pt idx="366">
                  <c:v>1.0145577502389478</c:v>
                </c:pt>
                <c:pt idx="367">
                  <c:v>1.0145577502389478</c:v>
                </c:pt>
                <c:pt idx="368">
                  <c:v>1.014834620245578</c:v>
                </c:pt>
                <c:pt idx="369">
                  <c:v>1.014834620245578</c:v>
                </c:pt>
                <c:pt idx="370">
                  <c:v>1.0151104423585866</c:v>
                </c:pt>
                <c:pt idx="371">
                  <c:v>1.015385224761701</c:v>
                </c:pt>
                <c:pt idx="372">
                  <c:v>1.0159317026917469</c:v>
                </c:pt>
                <c:pt idx="373">
                  <c:v>1.0159317026917469</c:v>
                </c:pt>
                <c:pt idx="374">
                  <c:v>1.0159317026917469</c:v>
                </c:pt>
                <c:pt idx="375">
                  <c:v>1.0159317026917469</c:v>
                </c:pt>
                <c:pt idx="376">
                  <c:v>1.0159317026917469</c:v>
                </c:pt>
                <c:pt idx="377">
                  <c:v>1.0159317026917469</c:v>
                </c:pt>
                <c:pt idx="378">
                  <c:v>1.0159317026917469</c:v>
                </c:pt>
                <c:pt idx="379">
                  <c:v>1.016203414109262</c:v>
                </c:pt>
                <c:pt idx="380">
                  <c:v>1.016203414109262</c:v>
                </c:pt>
                <c:pt idx="381">
                  <c:v>1.016203414109262</c:v>
                </c:pt>
                <c:pt idx="382">
                  <c:v>1.016203414109262</c:v>
                </c:pt>
                <c:pt idx="383">
                  <c:v>1.0164741176010048</c:v>
                </c:pt>
                <c:pt idx="384">
                  <c:v>1.0164741176010048</c:v>
                </c:pt>
                <c:pt idx="385">
                  <c:v>1.0167438208827004</c:v>
                </c:pt>
                <c:pt idx="386">
                  <c:v>1.017012531580807</c:v>
                </c:pt>
                <c:pt idx="387">
                  <c:v>1.017012531580807</c:v>
                </c:pt>
                <c:pt idx="388">
                  <c:v>1.0172802572338955</c:v>
                </c:pt>
                <c:pt idx="389">
                  <c:v>1.0175470052940021</c:v>
                </c:pt>
                <c:pt idx="390">
                  <c:v>1.0175470052940021</c:v>
                </c:pt>
                <c:pt idx="391">
                  <c:v>1.0178127831279558</c:v>
                </c:pt>
                <c:pt idx="392">
                  <c:v>1.0180775980186796</c:v>
                </c:pt>
                <c:pt idx="393">
                  <c:v>1.0180775980186796</c:v>
                </c:pt>
                <c:pt idx="394">
                  <c:v>1.018866336628742</c:v>
                </c:pt>
                <c:pt idx="395">
                  <c:v>1.0191273709418216</c:v>
                </c:pt>
                <c:pt idx="396">
                  <c:v>1.0193874775115328</c:v>
                </c:pt>
                <c:pt idx="397">
                  <c:v>1.0193874775115328</c:v>
                </c:pt>
                <c:pt idx="398">
                  <c:v>1.0196466631433383</c:v>
                </c:pt>
                <c:pt idx="399">
                  <c:v>1.0196466631433383</c:v>
                </c:pt>
                <c:pt idx="400">
                  <c:v>1.0199049345672395</c:v>
                </c:pt>
                <c:pt idx="401">
                  <c:v>1.0201622984388947</c:v>
                </c:pt>
                <c:pt idx="402">
                  <c:v>1.0201622984388947</c:v>
                </c:pt>
                <c:pt idx="403">
                  <c:v>1.0201622984388947</c:v>
                </c:pt>
                <c:pt idx="404">
                  <c:v>1.0201622984388947</c:v>
                </c:pt>
                <c:pt idx="405">
                  <c:v>1.0204187613407163</c:v>
                </c:pt>
                <c:pt idx="406">
                  <c:v>1.0206743297829464</c:v>
                </c:pt>
                <c:pt idx="407">
                  <c:v>1.0209290102047159</c:v>
                </c:pt>
                <c:pt idx="408">
                  <c:v>1.0214357323940402</c:v>
                </c:pt>
                <c:pt idx="409">
                  <c:v>1.0216877866935401</c:v>
                </c:pt>
                <c:pt idx="410">
                  <c:v>1.0216877866935401</c:v>
                </c:pt>
                <c:pt idx="411">
                  <c:v>1.021938978038452</c:v>
                </c:pt>
                <c:pt idx="412">
                  <c:v>1.0226874350084108</c:v>
                </c:pt>
                <c:pt idx="413">
                  <c:v>1.023182201639657</c:v>
                </c:pt>
                <c:pt idx="414">
                  <c:v>1.023182201639657</c:v>
                </c:pt>
                <c:pt idx="415">
                  <c:v>1.023428341082619</c:v>
                </c:pt>
                <c:pt idx="416">
                  <c:v>1.0236736589259248</c:v>
                </c:pt>
                <c:pt idx="417">
                  <c:v>1.0239181608311718</c:v>
                </c:pt>
                <c:pt idx="418">
                  <c:v>1.0241618524009715</c:v>
                </c:pt>
                <c:pt idx="419">
                  <c:v>1.0241618524009715</c:v>
                </c:pt>
                <c:pt idx="420">
                  <c:v>1.0244047391797695</c:v>
                </c:pt>
                <c:pt idx="421">
                  <c:v>1.0244047391797695</c:v>
                </c:pt>
                <c:pt idx="422">
                  <c:v>1.0246468266546531</c:v>
                </c:pt>
                <c:pt idx="423">
                  <c:v>1.024888120256144</c:v>
                </c:pt>
                <c:pt idx="424">
                  <c:v>1.024888120256144</c:v>
                </c:pt>
                <c:pt idx="425">
                  <c:v>1.0251286253589775</c:v>
                </c:pt>
                <c:pt idx="426">
                  <c:v>1.0251286253589775</c:v>
                </c:pt>
                <c:pt idx="427">
                  <c:v>1.0253683472828687</c:v>
                </c:pt>
                <c:pt idx="428">
                  <c:v>1.0253683472828687</c:v>
                </c:pt>
                <c:pt idx="429">
                  <c:v>1.0253683472828687</c:v>
                </c:pt>
                <c:pt idx="430">
                  <c:v>1.0256072912932641</c:v>
                </c:pt>
                <c:pt idx="431">
                  <c:v>1.026082866368442</c:v>
                </c:pt>
                <c:pt idx="432">
                  <c:v>1.0265553916505261</c:v>
                </c:pt>
                <c:pt idx="433">
                  <c:v>1.0267905232268546</c:v>
                </c:pt>
                <c:pt idx="434">
                  <c:v>1.0270249073833015</c:v>
                </c:pt>
                <c:pt idx="435">
                  <c:v>1.0272585490254642</c:v>
                </c:pt>
                <c:pt idx="436">
                  <c:v>1.0272585490254642</c:v>
                </c:pt>
                <c:pt idx="437">
                  <c:v>1.0274914530102506</c:v>
                </c:pt>
                <c:pt idx="438">
                  <c:v>1.0277236241465264</c:v>
                </c:pt>
                <c:pt idx="439">
                  <c:v>1.0279550671957494</c:v>
                </c:pt>
                <c:pt idx="440">
                  <c:v>1.0286450747376088</c:v>
                </c:pt>
                <c:pt idx="441">
                  <c:v>1.0286450747376088</c:v>
                </c:pt>
                <c:pt idx="442">
                  <c:v>1.0288736521266912</c:v>
                </c:pt>
                <c:pt idx="443">
                  <c:v>1.0288736521266912</c:v>
                </c:pt>
                <c:pt idx="444">
                  <c:v>1.0288736521266912</c:v>
                </c:pt>
                <c:pt idx="445">
                  <c:v>1.0288736521266912</c:v>
                </c:pt>
                <c:pt idx="446">
                  <c:v>1.0288736521266912</c:v>
                </c:pt>
                <c:pt idx="447">
                  <c:v>1.0288736521266912</c:v>
                </c:pt>
                <c:pt idx="448">
                  <c:v>1.0291015245463997</c:v>
                </c:pt>
                <c:pt idx="449">
                  <c:v>1.0293286964865098</c:v>
                </c:pt>
                <c:pt idx="450">
                  <c:v>1.0295551723935519</c:v>
                </c:pt>
                <c:pt idx="451">
                  <c:v>1.0295551723935519</c:v>
                </c:pt>
                <c:pt idx="452">
                  <c:v>1.0295551723935519</c:v>
                </c:pt>
                <c:pt idx="453">
                  <c:v>1.0295551723935519</c:v>
                </c:pt>
                <c:pt idx="454">
                  <c:v>1.0297809566713694</c:v>
                </c:pt>
                <c:pt idx="455">
                  <c:v>1.0300060536816651</c:v>
                </c:pt>
                <c:pt idx="456">
                  <c:v>1.0302304677445409</c:v>
                </c:pt>
                <c:pt idx="457">
                  <c:v>1.0302304677445409</c:v>
                </c:pt>
                <c:pt idx="458">
                  <c:v>1.0302304677445409</c:v>
                </c:pt>
                <c:pt idx="459">
                  <c:v>1.0304542031390278</c:v>
                </c:pt>
                <c:pt idx="460">
                  <c:v>1.0306772641036079</c:v>
                </c:pt>
                <c:pt idx="461">
                  <c:v>1.0306772641036079</c:v>
                </c:pt>
                <c:pt idx="462">
                  <c:v>1.0306772641036079</c:v>
                </c:pt>
                <c:pt idx="463">
                  <c:v>1.0308996548367284</c:v>
                </c:pt>
                <c:pt idx="464">
                  <c:v>1.0308996548367284</c:v>
                </c:pt>
                <c:pt idx="465">
                  <c:v>1.0311213794973062</c:v>
                </c:pt>
                <c:pt idx="466">
                  <c:v>1.031342442205226</c:v>
                </c:pt>
                <c:pt idx="467">
                  <c:v>1.0317825980503998</c:v>
                </c:pt>
                <c:pt idx="468">
                  <c:v>1.0317825980503998</c:v>
                </c:pt>
                <c:pt idx="469">
                  <c:v>1.0324379679797189</c:v>
                </c:pt>
                <c:pt idx="470">
                  <c:v>1.0326551433642033</c:v>
                </c:pt>
                <c:pt idx="471">
                  <c:v>1.0328716845824994</c:v>
                </c:pt>
                <c:pt idx="472">
                  <c:v>1.0328716845824994</c:v>
                </c:pt>
                <c:pt idx="473">
                  <c:v>1.0328716845824994</c:v>
                </c:pt>
                <c:pt idx="474">
                  <c:v>1.0330875954592345</c:v>
                </c:pt>
                <c:pt idx="475">
                  <c:v>1.0330875954592345</c:v>
                </c:pt>
                <c:pt idx="476">
                  <c:v>1.0335175413125017</c:v>
                </c:pt>
                <c:pt idx="477">
                  <c:v>1.0335175413125017</c:v>
                </c:pt>
                <c:pt idx="478">
                  <c:v>1.0335175413125017</c:v>
                </c:pt>
                <c:pt idx="479">
                  <c:v>1.0337315837655319</c:v>
                </c:pt>
                <c:pt idx="480">
                  <c:v>1.0337315837655319</c:v>
                </c:pt>
                <c:pt idx="481">
                  <c:v>1.0337315837655319</c:v>
                </c:pt>
                <c:pt idx="482">
                  <c:v>1.0339450108308279</c:v>
                </c:pt>
                <c:pt idx="483">
                  <c:v>1.0339450108308279</c:v>
                </c:pt>
                <c:pt idx="484">
                  <c:v>1.0341578261627566</c:v>
                </c:pt>
                <c:pt idx="485">
                  <c:v>1.0343700333828576</c:v>
                </c:pt>
                <c:pt idx="486">
                  <c:v>1.0345816360802389</c:v>
                </c:pt>
                <c:pt idx="487">
                  <c:v>1.0345816360802389</c:v>
                </c:pt>
                <c:pt idx="488">
                  <c:v>1.0347926378119643</c:v>
                </c:pt>
                <c:pt idx="489">
                  <c:v>1.0350030421034357</c:v>
                </c:pt>
                <c:pt idx="490">
                  <c:v>1.0350030421034357</c:v>
                </c:pt>
                <c:pt idx="491">
                  <c:v>1.0352128524487711</c:v>
                </c:pt>
                <c:pt idx="492">
                  <c:v>1.0356307051233014</c:v>
                </c:pt>
                <c:pt idx="493">
                  <c:v>1.0358387542876208</c:v>
                </c:pt>
                <c:pt idx="494">
                  <c:v>1.0364594334730197</c:v>
                </c:pt>
                <c:pt idx="495">
                  <c:v>1.0366651814793528</c:v>
                </c:pt>
                <c:pt idx="496">
                  <c:v>1.0370749794925189</c:v>
                </c:pt>
                <c:pt idx="497">
                  <c:v>1.0372790359287749</c:v>
                </c:pt>
                <c:pt idx="498">
                  <c:v>1.0374825348917327</c:v>
                </c:pt>
                <c:pt idx="499">
                  <c:v>1.0374825348917327</c:v>
                </c:pt>
                <c:pt idx="500">
                  <c:v>1.0378878729554664</c:v>
                </c:pt>
                <c:pt idx="501">
                  <c:v>1.0378878729554664</c:v>
                </c:pt>
                <c:pt idx="502">
                  <c:v>1.0378878729554664</c:v>
                </c:pt>
                <c:pt idx="503">
                  <c:v>1.0380897182682485</c:v>
                </c:pt>
                <c:pt idx="504">
                  <c:v>1.0382910185323544</c:v>
                </c:pt>
                <c:pt idx="505">
                  <c:v>1.0384917767883</c:v>
                </c:pt>
                <c:pt idx="506">
                  <c:v>1.0386919960509398</c:v>
                </c:pt>
                <c:pt idx="507">
                  <c:v>1.0386919960509398</c:v>
                </c:pt>
                <c:pt idx="508">
                  <c:v>1.0386919960509398</c:v>
                </c:pt>
                <c:pt idx="509">
                  <c:v>1.0386919960509398</c:v>
                </c:pt>
                <c:pt idx="510">
                  <c:v>1.0386919960509398</c:v>
                </c:pt>
                <c:pt idx="511">
                  <c:v>1.0390908295291423</c:v>
                </c:pt>
                <c:pt idx="512">
                  <c:v>1.0396851112242631</c:v>
                </c:pt>
                <c:pt idx="513">
                  <c:v>1.0396851112242631</c:v>
                </c:pt>
                <c:pt idx="514">
                  <c:v>1.0398821584379203</c:v>
                </c:pt>
                <c:pt idx="515">
                  <c:v>1.0398821584379203</c:v>
                </c:pt>
                <c:pt idx="516">
                  <c:v>1.0402746999327668</c:v>
                </c:pt>
                <c:pt idx="517">
                  <c:v>1.040470199830059</c:v>
                </c:pt>
                <c:pt idx="518">
                  <c:v>1.0406651895329257</c:v>
                </c:pt>
                <c:pt idx="519">
                  <c:v>1.0408596717921883</c:v>
                </c:pt>
                <c:pt idx="520">
                  <c:v>1.0410536493362255</c:v>
                </c:pt>
                <c:pt idx="521">
                  <c:v>1.0410536493362255</c:v>
                </c:pt>
                <c:pt idx="522">
                  <c:v>1.0412471248712194</c:v>
                </c:pt>
                <c:pt idx="523">
                  <c:v>1.0414401010813965</c:v>
                </c:pt>
                <c:pt idx="524">
                  <c:v>1.0416325806292657</c:v>
                </c:pt>
                <c:pt idx="525">
                  <c:v>1.0418245661558536</c:v>
                </c:pt>
                <c:pt idx="526">
                  <c:v>1.0422070656032674</c:v>
                </c:pt>
                <c:pt idx="527">
                  <c:v>1.0422070656032674</c:v>
                </c:pt>
                <c:pt idx="528">
                  <c:v>1.0423975847008049</c:v>
                </c:pt>
                <c:pt idx="529">
                  <c:v>1.0425876201309325</c:v>
                </c:pt>
                <c:pt idx="530">
                  <c:v>1.0427771744306797</c:v>
                </c:pt>
                <c:pt idx="531">
                  <c:v>1.0427771744306797</c:v>
                </c:pt>
                <c:pt idx="532">
                  <c:v>1.0431548496866772</c:v>
                </c:pt>
                <c:pt idx="533">
                  <c:v>1.0439045360541885</c:v>
                </c:pt>
                <c:pt idx="534">
                  <c:v>1.0440907918131215</c:v>
                </c:pt>
                <c:pt idx="535">
                  <c:v>1.0440907918131215</c:v>
                </c:pt>
                <c:pt idx="536">
                  <c:v>1.0446467992756592</c:v>
                </c:pt>
                <c:pt idx="537">
                  <c:v>1.0448312229750794</c:v>
                </c:pt>
                <c:pt idx="538">
                  <c:v>1.04538179003473</c:v>
                </c:pt>
                <c:pt idx="539">
                  <c:v>1.0455644186204762</c:v>
                </c:pt>
                <c:pt idx="540">
                  <c:v>1.046290523721171</c:v>
                </c:pt>
                <c:pt idx="541">
                  <c:v>1.0464709586697551</c:v>
                </c:pt>
                <c:pt idx="542">
                  <c:v>1.0466509614233528</c:v>
                </c:pt>
                <c:pt idx="543">
                  <c:v>1.0470096788868413</c:v>
                </c:pt>
                <c:pt idx="544">
                  <c:v>1.0471883978274525</c:v>
                </c:pt>
                <c:pt idx="545">
                  <c:v>1.0471883978274525</c:v>
                </c:pt>
                <c:pt idx="546">
                  <c:v>1.0478990569424937</c:v>
                </c:pt>
                <c:pt idx="547">
                  <c:v>1.0478990569424937</c:v>
                </c:pt>
                <c:pt idx="548">
                  <c:v>1.0478990569424937</c:v>
                </c:pt>
                <c:pt idx="549">
                  <c:v>1.0480756778254614</c:v>
                </c:pt>
                <c:pt idx="550">
                  <c:v>1.0480756778254614</c:v>
                </c:pt>
                <c:pt idx="551">
                  <c:v>1.0484276810776139</c:v>
                </c:pt>
                <c:pt idx="552">
                  <c:v>1.0487780462429175</c:v>
                </c:pt>
                <c:pt idx="553">
                  <c:v>1.048952619462918</c:v>
                </c:pt>
                <c:pt idx="554">
                  <c:v>1.048952619462918</c:v>
                </c:pt>
                <c:pt idx="555">
                  <c:v>1.0491267890364866</c:v>
                </c:pt>
                <c:pt idx="556">
                  <c:v>1.0493005568924803</c:v>
                </c:pt>
                <c:pt idx="557">
                  <c:v>1.0499916492323909</c:v>
                </c:pt>
                <c:pt idx="558">
                  <c:v>1.0508467017666578</c:v>
                </c:pt>
                <c:pt idx="559">
                  <c:v>1.0510165555303657</c:v>
                </c:pt>
                <c:pt idx="560">
                  <c:v>1.0511860279020637</c:v>
                </c:pt>
                <c:pt idx="561">
                  <c:v>1.0511860279020637</c:v>
                </c:pt>
                <c:pt idx="562">
                  <c:v>1.0515238355370169</c:v>
                </c:pt>
                <c:pt idx="563">
                  <c:v>1.0521949511564448</c:v>
                </c:pt>
                <c:pt idx="564">
                  <c:v>1.0528601583960004</c:v>
                </c:pt>
                <c:pt idx="565">
                  <c:v>1.0531905798507959</c:v>
                </c:pt>
                <c:pt idx="566">
                  <c:v>1.0531905798507959</c:v>
                </c:pt>
                <c:pt idx="567">
                  <c:v>1.0536835211529267</c:v>
                </c:pt>
                <c:pt idx="568">
                  <c:v>1.0543358204761502</c:v>
                </c:pt>
                <c:pt idx="569">
                  <c:v>1.0543358204761502</c:v>
                </c:pt>
                <c:pt idx="570">
                  <c:v>1.0548213830539264</c:v>
                </c:pt>
                <c:pt idx="571">
                  <c:v>1.0548213830539264</c:v>
                </c:pt>
                <c:pt idx="572">
                  <c:v>1.0553038528797285</c:v>
                </c:pt>
                <c:pt idx="573">
                  <c:v>1.0556238012857457</c:v>
                </c:pt>
                <c:pt idx="574">
                  <c:v>1.0556238012857457</c:v>
                </c:pt>
                <c:pt idx="575">
                  <c:v>1.0556238012857457</c:v>
                </c:pt>
                <c:pt idx="576">
                  <c:v>1.0567331072239152</c:v>
                </c:pt>
                <c:pt idx="577">
                  <c:v>1.0581359391754208</c:v>
                </c:pt>
                <c:pt idx="578">
                  <c:v>1.0581359391754208</c:v>
                </c:pt>
                <c:pt idx="579">
                  <c:v>1.0581359391754208</c:v>
                </c:pt>
                <c:pt idx="580">
                  <c:v>1.0582902220390038</c:v>
                </c:pt>
                <c:pt idx="581">
                  <c:v>1.0589042407750635</c:v>
                </c:pt>
                <c:pt idx="582">
                  <c:v>1.0590569737635356</c:v>
                </c:pt>
                <c:pt idx="583">
                  <c:v>1.0599669874328947</c:v>
                </c:pt>
                <c:pt idx="584">
                  <c:v>1.0601176039886195</c:v>
                </c:pt>
                <c:pt idx="585">
                  <c:v>1.060567674108444</c:v>
                </c:pt>
                <c:pt idx="586">
                  <c:v>1.061015100167386</c:v>
                </c:pt>
                <c:pt idx="587">
                  <c:v>1.0620489904004125</c:v>
                </c:pt>
                <c:pt idx="588">
                  <c:v>1.0629241612782827</c:v>
                </c:pt>
                <c:pt idx="589">
                  <c:v>1.063932671516417</c:v>
                </c:pt>
                <c:pt idx="590">
                  <c:v>1.0652100704040877</c:v>
                </c:pt>
                <c:pt idx="591">
                  <c:v>1.0661890603923527</c:v>
                </c:pt>
                <c:pt idx="592">
                  <c:v>1.066742913107545</c:v>
                </c:pt>
                <c:pt idx="593">
                  <c:v>1.0677026242723158</c:v>
                </c:pt>
                <c:pt idx="594">
                  <c:v>1.0718141866119901</c:v>
                </c:pt>
                <c:pt idx="595">
                  <c:v>1.0724572256539335</c:v>
                </c:pt>
                <c:pt idx="596">
                  <c:v>1.0748529748349003</c:v>
                </c:pt>
                <c:pt idx="597">
                  <c:v>1.0758398717132465</c:v>
                </c:pt>
                <c:pt idx="598">
                  <c:v>1.0809389386010504</c:v>
                </c:pt>
              </c:numCache>
            </c:numRef>
          </c:xVal>
          <c:yVal>
            <c:numRef>
              <c:f>datat!$G$2:$G$600</c:f>
              <c:numCache>
                <c:formatCode>General</c:formatCode>
                <c:ptCount val="599"/>
                <c:pt idx="0">
                  <c:v>0.8814149089313178</c:v>
                </c:pt>
                <c:pt idx="1">
                  <c:v>0.97053237160902184</c:v>
                </c:pt>
                <c:pt idx="2">
                  <c:v>0.8814149089313178</c:v>
                </c:pt>
                <c:pt idx="3">
                  <c:v>0.90725843608215606</c:v>
                </c:pt>
                <c:pt idx="4">
                  <c:v>0.91825252135887492</c:v>
                </c:pt>
                <c:pt idx="5">
                  <c:v>0.8814149089313178</c:v>
                </c:pt>
                <c:pt idx="6">
                  <c:v>0.8814149089313178</c:v>
                </c:pt>
                <c:pt idx="7">
                  <c:v>0.8814149089313178</c:v>
                </c:pt>
                <c:pt idx="8">
                  <c:v>0.8686110763317676</c:v>
                </c:pt>
                <c:pt idx="9">
                  <c:v>0.8814149089313178</c:v>
                </c:pt>
                <c:pt idx="10">
                  <c:v>0.84464983229781776</c:v>
                </c:pt>
                <c:pt idx="11">
                  <c:v>1.0227175974910505</c:v>
                </c:pt>
                <c:pt idx="12">
                  <c:v>0.8814149089313178</c:v>
                </c:pt>
                <c:pt idx="13">
                  <c:v>0.8814149089313178</c:v>
                </c:pt>
                <c:pt idx="14">
                  <c:v>0.8814149089313178</c:v>
                </c:pt>
                <c:pt idx="15">
                  <c:v>0.92500012067400528</c:v>
                </c:pt>
                <c:pt idx="16">
                  <c:v>0.8814149089313178</c:v>
                </c:pt>
                <c:pt idx="17">
                  <c:v>0.97589341780739425</c:v>
                </c:pt>
                <c:pt idx="18">
                  <c:v>0.89715536487626768</c:v>
                </c:pt>
                <c:pt idx="19">
                  <c:v>0.8814149089313178</c:v>
                </c:pt>
                <c:pt idx="20">
                  <c:v>0.92981685898787225</c:v>
                </c:pt>
                <c:pt idx="21">
                  <c:v>0.8814149089313178</c:v>
                </c:pt>
                <c:pt idx="22">
                  <c:v>0.8814149089313178</c:v>
                </c:pt>
                <c:pt idx="23">
                  <c:v>1.0091606125049104</c:v>
                </c:pt>
                <c:pt idx="24">
                  <c:v>0.8814149089313178</c:v>
                </c:pt>
                <c:pt idx="25">
                  <c:v>0.91645026514654859</c:v>
                </c:pt>
                <c:pt idx="26">
                  <c:v>0.8814149089313178</c:v>
                </c:pt>
                <c:pt idx="27">
                  <c:v>0.9335702571459864</c:v>
                </c:pt>
                <c:pt idx="28">
                  <c:v>0.94633211710452037</c:v>
                </c:pt>
                <c:pt idx="29">
                  <c:v>0.94824240989833775</c:v>
                </c:pt>
                <c:pt idx="30">
                  <c:v>1.0851154251886719</c:v>
                </c:pt>
                <c:pt idx="31">
                  <c:v>0.99275471908119672</c:v>
                </c:pt>
                <c:pt idx="32">
                  <c:v>0.8814149089313178</c:v>
                </c:pt>
                <c:pt idx="33">
                  <c:v>0.92503054897889647</c:v>
                </c:pt>
                <c:pt idx="34">
                  <c:v>0.96053278833495559</c:v>
                </c:pt>
                <c:pt idx="35">
                  <c:v>0.96778886420752375</c:v>
                </c:pt>
                <c:pt idx="36">
                  <c:v>1.0845777649126387</c:v>
                </c:pt>
                <c:pt idx="37">
                  <c:v>0.87384808039134698</c:v>
                </c:pt>
                <c:pt idx="38">
                  <c:v>0.98251462036064996</c:v>
                </c:pt>
                <c:pt idx="39">
                  <c:v>0.99899649847544369</c:v>
                </c:pt>
                <c:pt idx="40">
                  <c:v>1.0615274639266448</c:v>
                </c:pt>
                <c:pt idx="41">
                  <c:v>0.93237110607718265</c:v>
                </c:pt>
                <c:pt idx="42">
                  <c:v>0.90827873057594577</c:v>
                </c:pt>
                <c:pt idx="43">
                  <c:v>0.90070787222122595</c:v>
                </c:pt>
                <c:pt idx="44">
                  <c:v>0.93695161937070481</c:v>
                </c:pt>
                <c:pt idx="45">
                  <c:v>0.89179047476481044</c:v>
                </c:pt>
                <c:pt idx="46">
                  <c:v>0.9287455848710533</c:v>
                </c:pt>
                <c:pt idx="47">
                  <c:v>0.92735665476188078</c:v>
                </c:pt>
                <c:pt idx="48">
                  <c:v>1.0463854085590252</c:v>
                </c:pt>
                <c:pt idx="49">
                  <c:v>0.91685626672686638</c:v>
                </c:pt>
                <c:pt idx="50">
                  <c:v>1.0036446611439154</c:v>
                </c:pt>
                <c:pt idx="51">
                  <c:v>1.0001167785082228</c:v>
                </c:pt>
                <c:pt idx="52">
                  <c:v>0.98850022095750645</c:v>
                </c:pt>
                <c:pt idx="53">
                  <c:v>0.90620566959751236</c:v>
                </c:pt>
                <c:pt idx="54">
                  <c:v>0.9913711614073315</c:v>
                </c:pt>
                <c:pt idx="55">
                  <c:v>0.9406635735482497</c:v>
                </c:pt>
                <c:pt idx="56">
                  <c:v>1.0593660406912659</c:v>
                </c:pt>
                <c:pt idx="57">
                  <c:v>1.0692345306294995</c:v>
                </c:pt>
                <c:pt idx="58">
                  <c:v>1.0970133551673533</c:v>
                </c:pt>
                <c:pt idx="59">
                  <c:v>0.96334713951042195</c:v>
                </c:pt>
                <c:pt idx="60">
                  <c:v>1.0536130395543861</c:v>
                </c:pt>
                <c:pt idx="61">
                  <c:v>1.0264924541122902</c:v>
                </c:pt>
                <c:pt idx="62">
                  <c:v>0.95161485584033234</c:v>
                </c:pt>
                <c:pt idx="63">
                  <c:v>1.0042695352272204</c:v>
                </c:pt>
                <c:pt idx="64">
                  <c:v>0.9972230223553733</c:v>
                </c:pt>
                <c:pt idx="65">
                  <c:v>0.92975329304870957</c:v>
                </c:pt>
                <c:pt idx="66">
                  <c:v>0.99103933229954233</c:v>
                </c:pt>
                <c:pt idx="67">
                  <c:v>1.0827719093617381</c:v>
                </c:pt>
                <c:pt idx="68">
                  <c:v>0.8831854135940016</c:v>
                </c:pt>
                <c:pt idx="69">
                  <c:v>0.90054479966315226</c:v>
                </c:pt>
                <c:pt idx="70">
                  <c:v>0.9365569907556861</c:v>
                </c:pt>
                <c:pt idx="71">
                  <c:v>0.98063994895731466</c:v>
                </c:pt>
                <c:pt idx="72">
                  <c:v>0.97947912863733455</c:v>
                </c:pt>
                <c:pt idx="73">
                  <c:v>1.0143723500356752</c:v>
                </c:pt>
                <c:pt idx="74">
                  <c:v>0.92371789544804417</c:v>
                </c:pt>
                <c:pt idx="75">
                  <c:v>0.92495920640163032</c:v>
                </c:pt>
                <c:pt idx="76">
                  <c:v>0.95089923096182405</c:v>
                </c:pt>
                <c:pt idx="77">
                  <c:v>0.93553925255835524</c:v>
                </c:pt>
                <c:pt idx="78">
                  <c:v>0.97316390604921277</c:v>
                </c:pt>
                <c:pt idx="79">
                  <c:v>0.97290336155409107</c:v>
                </c:pt>
                <c:pt idx="80">
                  <c:v>1.0016348175879841</c:v>
                </c:pt>
                <c:pt idx="81">
                  <c:v>0.90294903883630606</c:v>
                </c:pt>
                <c:pt idx="82">
                  <c:v>1.0279568033565394</c:v>
                </c:pt>
                <c:pt idx="83">
                  <c:v>0.90871283015782944</c:v>
                </c:pt>
                <c:pt idx="84">
                  <c:v>0.99058321894295076</c:v>
                </c:pt>
                <c:pt idx="85">
                  <c:v>0.8814149089313178</c:v>
                </c:pt>
                <c:pt idx="86">
                  <c:v>1.0574175843722782</c:v>
                </c:pt>
                <c:pt idx="87">
                  <c:v>0.98737013497900272</c:v>
                </c:pt>
                <c:pt idx="88">
                  <c:v>0.98320372670228096</c:v>
                </c:pt>
                <c:pt idx="89">
                  <c:v>0.8814149089313178</c:v>
                </c:pt>
                <c:pt idx="90">
                  <c:v>0.84030220115345433</c:v>
                </c:pt>
                <c:pt idx="91">
                  <c:v>0.95540895068340037</c:v>
                </c:pt>
                <c:pt idx="92">
                  <c:v>0.9402406415696416</c:v>
                </c:pt>
                <c:pt idx="93">
                  <c:v>1.0244922406084918</c:v>
                </c:pt>
                <c:pt idx="94">
                  <c:v>0.97880485766057934</c:v>
                </c:pt>
                <c:pt idx="95">
                  <c:v>0.98161045670932046</c:v>
                </c:pt>
                <c:pt idx="96">
                  <c:v>0.91157724778811122</c:v>
                </c:pt>
                <c:pt idx="97">
                  <c:v>1.0328810180006829</c:v>
                </c:pt>
                <c:pt idx="98">
                  <c:v>0.90232817163448231</c:v>
                </c:pt>
                <c:pt idx="99">
                  <c:v>0.96475054797914606</c:v>
                </c:pt>
                <c:pt idx="100">
                  <c:v>0.92500012067400528</c:v>
                </c:pt>
                <c:pt idx="101">
                  <c:v>0.9407763949388207</c:v>
                </c:pt>
                <c:pt idx="102">
                  <c:v>0.92120564391872661</c:v>
                </c:pt>
                <c:pt idx="103">
                  <c:v>0.96950956662972299</c:v>
                </c:pt>
                <c:pt idx="104">
                  <c:v>0.91440455502234808</c:v>
                </c:pt>
                <c:pt idx="105">
                  <c:v>1.0903967052950303</c:v>
                </c:pt>
                <c:pt idx="106">
                  <c:v>0.99125315702507</c:v>
                </c:pt>
                <c:pt idx="107">
                  <c:v>0.92943001629489297</c:v>
                </c:pt>
                <c:pt idx="108">
                  <c:v>1.0214956333585521</c:v>
                </c:pt>
                <c:pt idx="109">
                  <c:v>0.90170663418526042</c:v>
                </c:pt>
                <c:pt idx="110">
                  <c:v>1.0027442194436003</c:v>
                </c:pt>
                <c:pt idx="111">
                  <c:v>0.99510426256737106</c:v>
                </c:pt>
                <c:pt idx="112">
                  <c:v>0.96406947299354595</c:v>
                </c:pt>
                <c:pt idx="113">
                  <c:v>0.90784072137776328</c:v>
                </c:pt>
                <c:pt idx="114">
                  <c:v>0.94781056332661373</c:v>
                </c:pt>
                <c:pt idx="115">
                  <c:v>0.90082008737966157</c:v>
                </c:pt>
                <c:pt idx="116">
                  <c:v>0.97921872380991082</c:v>
                </c:pt>
                <c:pt idx="117">
                  <c:v>0.9914231516010138</c:v>
                </c:pt>
                <c:pt idx="118">
                  <c:v>0.94661177680149444</c:v>
                </c:pt>
                <c:pt idx="119">
                  <c:v>1.0192301479198018</c:v>
                </c:pt>
                <c:pt idx="120">
                  <c:v>0.93341965758741041</c:v>
                </c:pt>
                <c:pt idx="121">
                  <c:v>1.051629670771409</c:v>
                </c:pt>
                <c:pt idx="122">
                  <c:v>0.97136063789534099</c:v>
                </c:pt>
                <c:pt idx="123">
                  <c:v>0.94615604486639837</c:v>
                </c:pt>
                <c:pt idx="124">
                  <c:v>0.89536388265161104</c:v>
                </c:pt>
                <c:pt idx="125">
                  <c:v>0.90876629288189237</c:v>
                </c:pt>
                <c:pt idx="126">
                  <c:v>0.99695647291425471</c:v>
                </c:pt>
                <c:pt idx="127">
                  <c:v>0.92776388130952248</c:v>
                </c:pt>
                <c:pt idx="128">
                  <c:v>0.96532719444267912</c:v>
                </c:pt>
                <c:pt idx="129">
                  <c:v>0.91616367631427387</c:v>
                </c:pt>
                <c:pt idx="130">
                  <c:v>0.87480459866549642</c:v>
                </c:pt>
                <c:pt idx="131">
                  <c:v>0.92017688874737991</c:v>
                </c:pt>
                <c:pt idx="132">
                  <c:v>1.0296110378450338</c:v>
                </c:pt>
                <c:pt idx="133">
                  <c:v>0.9793779908349497</c:v>
                </c:pt>
                <c:pt idx="134">
                  <c:v>0.97701326232340369</c:v>
                </c:pt>
                <c:pt idx="135">
                  <c:v>0.86358392161369391</c:v>
                </c:pt>
                <c:pt idx="136">
                  <c:v>0.95344692351613103</c:v>
                </c:pt>
                <c:pt idx="137">
                  <c:v>1.0054901197424921</c:v>
                </c:pt>
                <c:pt idx="138">
                  <c:v>1.027556756885438</c:v>
                </c:pt>
                <c:pt idx="139">
                  <c:v>1.0644152269144962</c:v>
                </c:pt>
                <c:pt idx="140">
                  <c:v>1.0020426734415628</c:v>
                </c:pt>
                <c:pt idx="141">
                  <c:v>1.0225079035559796</c:v>
                </c:pt>
                <c:pt idx="142">
                  <c:v>0.96101049072445455</c:v>
                </c:pt>
                <c:pt idx="143">
                  <c:v>1.0553251425943326</c:v>
                </c:pt>
                <c:pt idx="144">
                  <c:v>1.0053789095857795</c:v>
                </c:pt>
                <c:pt idx="145">
                  <c:v>0.95277808964067212</c:v>
                </c:pt>
                <c:pt idx="146">
                  <c:v>0.99598202637527622</c:v>
                </c:pt>
                <c:pt idx="147">
                  <c:v>0.93834020059542422</c:v>
                </c:pt>
                <c:pt idx="148">
                  <c:v>0.98821625016748083</c:v>
                </c:pt>
                <c:pt idx="149">
                  <c:v>0.98078664936712756</c:v>
                </c:pt>
                <c:pt idx="150">
                  <c:v>0.91164794693489759</c:v>
                </c:pt>
                <c:pt idx="151">
                  <c:v>1.0565947860601239</c:v>
                </c:pt>
                <c:pt idx="152">
                  <c:v>0.970346971859814</c:v>
                </c:pt>
                <c:pt idx="153">
                  <c:v>1.0345759369074972</c:v>
                </c:pt>
                <c:pt idx="154">
                  <c:v>1.0070825822146419</c:v>
                </c:pt>
                <c:pt idx="155">
                  <c:v>0.90428237287005808</c:v>
                </c:pt>
                <c:pt idx="156">
                  <c:v>0.87706868426941487</c:v>
                </c:pt>
                <c:pt idx="157">
                  <c:v>1.0285089437067534</c:v>
                </c:pt>
                <c:pt idx="158">
                  <c:v>1.0266632331548993</c:v>
                </c:pt>
                <c:pt idx="159">
                  <c:v>0.96027896118594092</c:v>
                </c:pt>
                <c:pt idx="160">
                  <c:v>0.92262670290160398</c:v>
                </c:pt>
                <c:pt idx="161">
                  <c:v>0.96134433687830123</c:v>
                </c:pt>
                <c:pt idx="162">
                  <c:v>1.0688696779799578</c:v>
                </c:pt>
                <c:pt idx="163">
                  <c:v>1.0106653317707806</c:v>
                </c:pt>
                <c:pt idx="164">
                  <c:v>1.1589278959600389</c:v>
                </c:pt>
                <c:pt idx="165">
                  <c:v>0.93451452103353438</c:v>
                </c:pt>
                <c:pt idx="166">
                  <c:v>0.99689405125038333</c:v>
                </c:pt>
                <c:pt idx="167">
                  <c:v>1.0126035625795808</c:v>
                </c:pt>
                <c:pt idx="168">
                  <c:v>1.004589746390439</c:v>
                </c:pt>
                <c:pt idx="169">
                  <c:v>1.0063652335042517</c:v>
                </c:pt>
                <c:pt idx="170">
                  <c:v>1.0201664168236884</c:v>
                </c:pt>
                <c:pt idx="171">
                  <c:v>1.0050062532127793</c:v>
                </c:pt>
                <c:pt idx="172">
                  <c:v>1.0053891455898414</c:v>
                </c:pt>
                <c:pt idx="173">
                  <c:v>0.93889212692744217</c:v>
                </c:pt>
                <c:pt idx="174">
                  <c:v>0.96223894562106194</c:v>
                </c:pt>
                <c:pt idx="175">
                  <c:v>0.95027168956046215</c:v>
                </c:pt>
                <c:pt idx="176">
                  <c:v>0.99163983433743963</c:v>
                </c:pt>
                <c:pt idx="177">
                  <c:v>1.0228553077738338</c:v>
                </c:pt>
                <c:pt idx="178">
                  <c:v>0.90917874461000392</c:v>
                </c:pt>
                <c:pt idx="179">
                  <c:v>1.0357784472298841</c:v>
                </c:pt>
                <c:pt idx="180">
                  <c:v>0.93277789482370643</c:v>
                </c:pt>
                <c:pt idx="181">
                  <c:v>0.98563982432805664</c:v>
                </c:pt>
                <c:pt idx="182">
                  <c:v>1.0780965555070392</c:v>
                </c:pt>
                <c:pt idx="183">
                  <c:v>1.0100968536799375</c:v>
                </c:pt>
                <c:pt idx="184">
                  <c:v>1.0011049375910606</c:v>
                </c:pt>
                <c:pt idx="185">
                  <c:v>1.0023048071217975</c:v>
                </c:pt>
                <c:pt idx="186">
                  <c:v>0.87295372650950342</c:v>
                </c:pt>
                <c:pt idx="187">
                  <c:v>0.97232285986802891</c:v>
                </c:pt>
                <c:pt idx="188">
                  <c:v>0.95189209722097035</c:v>
                </c:pt>
                <c:pt idx="189">
                  <c:v>1.0253071566812149</c:v>
                </c:pt>
                <c:pt idx="190">
                  <c:v>1.0438982841965287</c:v>
                </c:pt>
                <c:pt idx="191">
                  <c:v>0.92441250037599942</c:v>
                </c:pt>
                <c:pt idx="192">
                  <c:v>1.0116371946337686</c:v>
                </c:pt>
                <c:pt idx="193">
                  <c:v>1.029688198960484</c:v>
                </c:pt>
                <c:pt idx="194">
                  <c:v>0.91722124225812474</c:v>
                </c:pt>
                <c:pt idx="195">
                  <c:v>1.0057759054189814</c:v>
                </c:pt>
                <c:pt idx="196">
                  <c:v>0.94718939824233428</c:v>
                </c:pt>
                <c:pt idx="197">
                  <c:v>1.0176769988913508</c:v>
                </c:pt>
                <c:pt idx="198">
                  <c:v>1.0862715432632284</c:v>
                </c:pt>
                <c:pt idx="199">
                  <c:v>0.9347314664217703</c:v>
                </c:pt>
                <c:pt idx="200">
                  <c:v>1.0192935056123782</c:v>
                </c:pt>
                <c:pt idx="201">
                  <c:v>1.0541191908093823</c:v>
                </c:pt>
                <c:pt idx="202">
                  <c:v>1.0217930069936145</c:v>
                </c:pt>
                <c:pt idx="203">
                  <c:v>0.9905649896088814</c:v>
                </c:pt>
                <c:pt idx="204">
                  <c:v>1.0380045727167277</c:v>
                </c:pt>
                <c:pt idx="205">
                  <c:v>0.91123629319379629</c:v>
                </c:pt>
                <c:pt idx="206">
                  <c:v>1.0293245260242603</c:v>
                </c:pt>
                <c:pt idx="207">
                  <c:v>0.98216285466428022</c:v>
                </c:pt>
                <c:pt idx="208">
                  <c:v>1.0085943266365698</c:v>
                </c:pt>
                <c:pt idx="209">
                  <c:v>1.0684019163063585</c:v>
                </c:pt>
                <c:pt idx="210">
                  <c:v>1.0354784734268252</c:v>
                </c:pt>
                <c:pt idx="211">
                  <c:v>0.95961128386041783</c:v>
                </c:pt>
                <c:pt idx="212">
                  <c:v>0.98010590544144793</c:v>
                </c:pt>
                <c:pt idx="213">
                  <c:v>1.0978363582512098</c:v>
                </c:pt>
                <c:pt idx="214">
                  <c:v>1.0024951548960719</c:v>
                </c:pt>
                <c:pt idx="215">
                  <c:v>1.0036413092989687</c:v>
                </c:pt>
                <c:pt idx="216">
                  <c:v>0.94007364132790017</c:v>
                </c:pt>
                <c:pt idx="217">
                  <c:v>0.95169051521620163</c:v>
                </c:pt>
                <c:pt idx="218">
                  <c:v>1.0186837231612336</c:v>
                </c:pt>
                <c:pt idx="219">
                  <c:v>1.0001471279742127</c:v>
                </c:pt>
                <c:pt idx="220">
                  <c:v>1.1181197645495382</c:v>
                </c:pt>
                <c:pt idx="221">
                  <c:v>0.91863582258316312</c:v>
                </c:pt>
                <c:pt idx="222">
                  <c:v>0.99596545981619966</c:v>
                </c:pt>
                <c:pt idx="223">
                  <c:v>1.0393590306593246</c:v>
                </c:pt>
                <c:pt idx="224">
                  <c:v>0.97531173485685607</c:v>
                </c:pt>
                <c:pt idx="225">
                  <c:v>0.96445932199543938</c:v>
                </c:pt>
                <c:pt idx="226">
                  <c:v>0.99220636384223382</c:v>
                </c:pt>
                <c:pt idx="227">
                  <c:v>0.8814149089313178</c:v>
                </c:pt>
                <c:pt idx="228">
                  <c:v>1.1574227992550365</c:v>
                </c:pt>
                <c:pt idx="229">
                  <c:v>1.0249801770783082</c:v>
                </c:pt>
                <c:pt idx="230">
                  <c:v>1.1053478439857953</c:v>
                </c:pt>
                <c:pt idx="231">
                  <c:v>0.90860303694446065</c:v>
                </c:pt>
                <c:pt idx="232">
                  <c:v>0.93746976934186899</c:v>
                </c:pt>
                <c:pt idx="233">
                  <c:v>1.1662649511339096</c:v>
                </c:pt>
                <c:pt idx="234">
                  <c:v>1.0110783414370357</c:v>
                </c:pt>
                <c:pt idx="235">
                  <c:v>0.9834257717613003</c:v>
                </c:pt>
                <c:pt idx="236">
                  <c:v>1.0565016465037687</c:v>
                </c:pt>
                <c:pt idx="237">
                  <c:v>0.8814149089313178</c:v>
                </c:pt>
                <c:pt idx="238">
                  <c:v>1.1497874698496307</c:v>
                </c:pt>
                <c:pt idx="239">
                  <c:v>0.96322607521176085</c:v>
                </c:pt>
                <c:pt idx="240">
                  <c:v>0.98094933403430928</c:v>
                </c:pt>
                <c:pt idx="241">
                  <c:v>0.99774945968051354</c:v>
                </c:pt>
                <c:pt idx="242">
                  <c:v>1.0329012894596505</c:v>
                </c:pt>
                <c:pt idx="243">
                  <c:v>0.98180526261828927</c:v>
                </c:pt>
                <c:pt idx="244">
                  <c:v>0.98926212950749393</c:v>
                </c:pt>
                <c:pt idx="245">
                  <c:v>1.0377545583241854</c:v>
                </c:pt>
                <c:pt idx="246">
                  <c:v>1.0459356710452008</c:v>
                </c:pt>
                <c:pt idx="247">
                  <c:v>0.98315411847601619</c:v>
                </c:pt>
                <c:pt idx="248">
                  <c:v>0.85018844580566943</c:v>
                </c:pt>
                <c:pt idx="249">
                  <c:v>1.0884203181092427</c:v>
                </c:pt>
                <c:pt idx="250">
                  <c:v>1.0560405398512009</c:v>
                </c:pt>
                <c:pt idx="251">
                  <c:v>1.0036460022813674</c:v>
                </c:pt>
                <c:pt idx="252">
                  <c:v>0.95094514618254733</c:v>
                </c:pt>
                <c:pt idx="253">
                  <c:v>1.0045239898514495</c:v>
                </c:pt>
                <c:pt idx="254">
                  <c:v>0.94186244693494892</c:v>
                </c:pt>
                <c:pt idx="255">
                  <c:v>0.98018931254038388</c:v>
                </c:pt>
                <c:pt idx="256">
                  <c:v>1.0975038065178446</c:v>
                </c:pt>
                <c:pt idx="257">
                  <c:v>1.0369246559800867</c:v>
                </c:pt>
                <c:pt idx="258">
                  <c:v>1.1020725927735138</c:v>
                </c:pt>
                <c:pt idx="259">
                  <c:v>0.98632113115977404</c:v>
                </c:pt>
                <c:pt idx="260">
                  <c:v>1.0664050077269966</c:v>
                </c:pt>
                <c:pt idx="261">
                  <c:v>1.0530255555349288</c:v>
                </c:pt>
                <c:pt idx="262">
                  <c:v>0.9093568083825827</c:v>
                </c:pt>
                <c:pt idx="263">
                  <c:v>0.97564078780812113</c:v>
                </c:pt>
                <c:pt idx="264">
                  <c:v>0.99082519641763889</c:v>
                </c:pt>
                <c:pt idx="265">
                  <c:v>0.88637322675027141</c:v>
                </c:pt>
                <c:pt idx="266">
                  <c:v>1.0260603659212537</c:v>
                </c:pt>
                <c:pt idx="267">
                  <c:v>0.98671091515894005</c:v>
                </c:pt>
                <c:pt idx="268">
                  <c:v>0.91474614793981412</c:v>
                </c:pt>
                <c:pt idx="269">
                  <c:v>1.0089075391923366</c:v>
                </c:pt>
                <c:pt idx="270">
                  <c:v>0.98980401344160374</c:v>
                </c:pt>
                <c:pt idx="271">
                  <c:v>1.0000523552012459</c:v>
                </c:pt>
                <c:pt idx="272">
                  <c:v>0.99621370089828232</c:v>
                </c:pt>
                <c:pt idx="273">
                  <c:v>0.99797249899142593</c:v>
                </c:pt>
                <c:pt idx="274">
                  <c:v>0.96680902917621947</c:v>
                </c:pt>
                <c:pt idx="275">
                  <c:v>1.0069610344673126</c:v>
                </c:pt>
                <c:pt idx="276">
                  <c:v>1.0104825089075602</c:v>
                </c:pt>
                <c:pt idx="277">
                  <c:v>1.0701094806622169</c:v>
                </c:pt>
                <c:pt idx="278">
                  <c:v>1.0721859488730312</c:v>
                </c:pt>
                <c:pt idx="279">
                  <c:v>1.0423878264846278</c:v>
                </c:pt>
                <c:pt idx="280">
                  <c:v>0.92607993333997085</c:v>
                </c:pt>
                <c:pt idx="281">
                  <c:v>0.88465407634080839</c:v>
                </c:pt>
                <c:pt idx="282">
                  <c:v>0.92532099146691715</c:v>
                </c:pt>
                <c:pt idx="283">
                  <c:v>1.0165386940569279</c:v>
                </c:pt>
                <c:pt idx="284">
                  <c:v>0.98869457924374882</c:v>
                </c:pt>
                <c:pt idx="285">
                  <c:v>0.96608885651057275</c:v>
                </c:pt>
                <c:pt idx="286">
                  <c:v>1.0377753200383608</c:v>
                </c:pt>
                <c:pt idx="287">
                  <c:v>0.97398918043248128</c:v>
                </c:pt>
                <c:pt idx="288">
                  <c:v>1.0161934026825807</c:v>
                </c:pt>
                <c:pt idx="289">
                  <c:v>1.0357681516873385</c:v>
                </c:pt>
                <c:pt idx="290">
                  <c:v>1.0243150750048788</c:v>
                </c:pt>
                <c:pt idx="291">
                  <c:v>0.98999683376741854</c:v>
                </c:pt>
                <c:pt idx="292">
                  <c:v>1.0147255635299008</c:v>
                </c:pt>
                <c:pt idx="293">
                  <c:v>0.96419488660564612</c:v>
                </c:pt>
                <c:pt idx="294">
                  <c:v>1.0537844107011938</c:v>
                </c:pt>
                <c:pt idx="295">
                  <c:v>1.0308447421975735</c:v>
                </c:pt>
                <c:pt idx="296">
                  <c:v>1.0557141107879759</c:v>
                </c:pt>
                <c:pt idx="297">
                  <c:v>0.9573803255326282</c:v>
                </c:pt>
                <c:pt idx="298">
                  <c:v>0.98171289178745791</c:v>
                </c:pt>
                <c:pt idx="299">
                  <c:v>1.0953653635754697</c:v>
                </c:pt>
                <c:pt idx="300">
                  <c:v>1.0591323261070271</c:v>
                </c:pt>
                <c:pt idx="301">
                  <c:v>0.94186244693494892</c:v>
                </c:pt>
                <c:pt idx="302">
                  <c:v>1.0252460899413394</c:v>
                </c:pt>
                <c:pt idx="303">
                  <c:v>0.98757584097266105</c:v>
                </c:pt>
                <c:pt idx="304">
                  <c:v>0.94944782982266451</c:v>
                </c:pt>
                <c:pt idx="305">
                  <c:v>0.96125308293608358</c:v>
                </c:pt>
                <c:pt idx="306">
                  <c:v>0.94173456820501644</c:v>
                </c:pt>
                <c:pt idx="307">
                  <c:v>0.99016404208194175</c:v>
                </c:pt>
                <c:pt idx="308">
                  <c:v>1.0005166266863474</c:v>
                </c:pt>
                <c:pt idx="309">
                  <c:v>1.0577503814770381</c:v>
                </c:pt>
                <c:pt idx="310">
                  <c:v>1.0045239898514495</c:v>
                </c:pt>
                <c:pt idx="311">
                  <c:v>1.027051298511253</c:v>
                </c:pt>
                <c:pt idx="312">
                  <c:v>1.058493744116511</c:v>
                </c:pt>
                <c:pt idx="313">
                  <c:v>0.97048631103665306</c:v>
                </c:pt>
                <c:pt idx="314">
                  <c:v>0.93560561893945682</c:v>
                </c:pt>
                <c:pt idx="315">
                  <c:v>0.97846801866974342</c:v>
                </c:pt>
                <c:pt idx="316">
                  <c:v>0.94418317778734029</c:v>
                </c:pt>
                <c:pt idx="317">
                  <c:v>1.0046730924552301</c:v>
                </c:pt>
                <c:pt idx="318">
                  <c:v>1.1172009952566011</c:v>
                </c:pt>
                <c:pt idx="319">
                  <c:v>0.9827600524329726</c:v>
                </c:pt>
                <c:pt idx="320">
                  <c:v>1.071663837678279</c:v>
                </c:pt>
                <c:pt idx="321">
                  <c:v>1.0833378679159262</c:v>
                </c:pt>
                <c:pt idx="322">
                  <c:v>1.0156642599451027</c:v>
                </c:pt>
                <c:pt idx="323">
                  <c:v>0.99220152641154213</c:v>
                </c:pt>
                <c:pt idx="324">
                  <c:v>1.0565899532346636</c:v>
                </c:pt>
                <c:pt idx="325">
                  <c:v>1.0789794735202465</c:v>
                </c:pt>
                <c:pt idx="326">
                  <c:v>1.1163123359270555</c:v>
                </c:pt>
                <c:pt idx="327">
                  <c:v>1.0203439294039665</c:v>
                </c:pt>
                <c:pt idx="328">
                  <c:v>1.061011782538928</c:v>
                </c:pt>
                <c:pt idx="329">
                  <c:v>1.130972326799992</c:v>
                </c:pt>
                <c:pt idx="330">
                  <c:v>1.0268375459932688</c:v>
                </c:pt>
                <c:pt idx="331">
                  <c:v>0.95825456608171089</c:v>
                </c:pt>
                <c:pt idx="332">
                  <c:v>1.0362309071433458</c:v>
                </c:pt>
                <c:pt idx="333">
                  <c:v>0.91560546885439953</c:v>
                </c:pt>
                <c:pt idx="334">
                  <c:v>1.0711002763081412</c:v>
                </c:pt>
                <c:pt idx="335">
                  <c:v>1.0574179954948935</c:v>
                </c:pt>
                <c:pt idx="336">
                  <c:v>0.87005968812885215</c:v>
                </c:pt>
                <c:pt idx="337">
                  <c:v>0.98371817217570257</c:v>
                </c:pt>
                <c:pt idx="338">
                  <c:v>1.0030765951944438</c:v>
                </c:pt>
                <c:pt idx="339">
                  <c:v>1.0454474243542478</c:v>
                </c:pt>
                <c:pt idx="340">
                  <c:v>1.0256933068110285</c:v>
                </c:pt>
                <c:pt idx="341">
                  <c:v>1.0911609291117559</c:v>
                </c:pt>
                <c:pt idx="342">
                  <c:v>0.91665305422544785</c:v>
                </c:pt>
                <c:pt idx="343">
                  <c:v>1.0241009671486474</c:v>
                </c:pt>
                <c:pt idx="344">
                  <c:v>0.99114725495458134</c:v>
                </c:pt>
                <c:pt idx="345">
                  <c:v>1.019548153772833</c:v>
                </c:pt>
                <c:pt idx="346">
                  <c:v>1.0230249263718081</c:v>
                </c:pt>
                <c:pt idx="347">
                  <c:v>1.0176515727603992</c:v>
                </c:pt>
                <c:pt idx="348">
                  <c:v>0.94899526118345112</c:v>
                </c:pt>
                <c:pt idx="349">
                  <c:v>1.0019271339715397</c:v>
                </c:pt>
                <c:pt idx="350">
                  <c:v>1.0271932930643812</c:v>
                </c:pt>
                <c:pt idx="351">
                  <c:v>0.9590890223929307</c:v>
                </c:pt>
                <c:pt idx="352">
                  <c:v>1.0351702057458452</c:v>
                </c:pt>
                <c:pt idx="353">
                  <c:v>1.0156103003789092</c:v>
                </c:pt>
                <c:pt idx="354">
                  <c:v>1.0456138687695777</c:v>
                </c:pt>
                <c:pt idx="355">
                  <c:v>1.013846892530827</c:v>
                </c:pt>
                <c:pt idx="356">
                  <c:v>1.0227175974910505</c:v>
                </c:pt>
                <c:pt idx="357">
                  <c:v>1.0846008931138051</c:v>
                </c:pt>
                <c:pt idx="358">
                  <c:v>1.0099411166033572</c:v>
                </c:pt>
                <c:pt idx="359">
                  <c:v>1.027879526624442</c:v>
                </c:pt>
                <c:pt idx="360">
                  <c:v>1.1080947142476125</c:v>
                </c:pt>
                <c:pt idx="361">
                  <c:v>1.1596195567644774</c:v>
                </c:pt>
                <c:pt idx="362">
                  <c:v>1.0083786548798375</c:v>
                </c:pt>
                <c:pt idx="363">
                  <c:v>1.0739321405808406</c:v>
                </c:pt>
                <c:pt idx="364">
                  <c:v>0.97446318327487713</c:v>
                </c:pt>
                <c:pt idx="365">
                  <c:v>1.0697956333519492</c:v>
                </c:pt>
                <c:pt idx="366">
                  <c:v>1.0005000550711765</c:v>
                </c:pt>
                <c:pt idx="367">
                  <c:v>1.0376946642783518</c:v>
                </c:pt>
                <c:pt idx="368">
                  <c:v>1.0386212460346875</c:v>
                </c:pt>
                <c:pt idx="369">
                  <c:v>1.0044636200687593</c:v>
                </c:pt>
                <c:pt idx="370">
                  <c:v>1.0388925039021288</c:v>
                </c:pt>
                <c:pt idx="371">
                  <c:v>1.0807180533010932</c:v>
                </c:pt>
                <c:pt idx="372">
                  <c:v>1.0018286225026143</c:v>
                </c:pt>
                <c:pt idx="373">
                  <c:v>1.0278576987799766</c:v>
                </c:pt>
                <c:pt idx="374">
                  <c:v>1.0236010337177111</c:v>
                </c:pt>
                <c:pt idx="375">
                  <c:v>0.98480849457063058</c:v>
                </c:pt>
                <c:pt idx="376">
                  <c:v>1.0392600507091385</c:v>
                </c:pt>
                <c:pt idx="377">
                  <c:v>1.0192941988821385</c:v>
                </c:pt>
                <c:pt idx="378">
                  <c:v>1.0669131128912936</c:v>
                </c:pt>
                <c:pt idx="379">
                  <c:v>1.0364585573452467</c:v>
                </c:pt>
                <c:pt idx="380">
                  <c:v>1.0592084412229688</c:v>
                </c:pt>
                <c:pt idx="381">
                  <c:v>1.0224981913550801</c:v>
                </c:pt>
                <c:pt idx="382">
                  <c:v>1.070107411385719</c:v>
                </c:pt>
                <c:pt idx="383">
                  <c:v>1.0848948853153884</c:v>
                </c:pt>
                <c:pt idx="384">
                  <c:v>1.0375975301542397</c:v>
                </c:pt>
                <c:pt idx="385">
                  <c:v>1.0534928123728029</c:v>
                </c:pt>
                <c:pt idx="386">
                  <c:v>1.013875119295806</c:v>
                </c:pt>
                <c:pt idx="387">
                  <c:v>0.97836952555179657</c:v>
                </c:pt>
                <c:pt idx="388">
                  <c:v>1.0616538051863351</c:v>
                </c:pt>
                <c:pt idx="389">
                  <c:v>1.0265531211422598</c:v>
                </c:pt>
                <c:pt idx="390">
                  <c:v>1.096644629131601</c:v>
                </c:pt>
                <c:pt idx="391">
                  <c:v>1.1519139746951248</c:v>
                </c:pt>
                <c:pt idx="392">
                  <c:v>1.0301263147746031</c:v>
                </c:pt>
                <c:pt idx="393">
                  <c:v>1.0053343432163249</c:v>
                </c:pt>
                <c:pt idx="394">
                  <c:v>0.98759485663551427</c:v>
                </c:pt>
                <c:pt idx="395">
                  <c:v>0.97661549111421864</c:v>
                </c:pt>
                <c:pt idx="396">
                  <c:v>1.0636189699693488</c:v>
                </c:pt>
                <c:pt idx="397">
                  <c:v>0.98927040857362547</c:v>
                </c:pt>
                <c:pt idx="398">
                  <c:v>1.1035981657434242</c:v>
                </c:pt>
                <c:pt idx="399">
                  <c:v>1.0245231672083408</c:v>
                </c:pt>
                <c:pt idx="400">
                  <c:v>0.99885383094378388</c:v>
                </c:pt>
                <c:pt idx="401">
                  <c:v>1.0505592265181376</c:v>
                </c:pt>
                <c:pt idx="402">
                  <c:v>1.0279808532580395</c:v>
                </c:pt>
                <c:pt idx="403">
                  <c:v>0.99765395201660079</c:v>
                </c:pt>
                <c:pt idx="404">
                  <c:v>1.0096355894898776</c:v>
                </c:pt>
                <c:pt idx="405">
                  <c:v>1.039542522989845</c:v>
                </c:pt>
                <c:pt idx="406">
                  <c:v>1.1145588441687182</c:v>
                </c:pt>
                <c:pt idx="407">
                  <c:v>1.0701052908948618</c:v>
                </c:pt>
                <c:pt idx="408">
                  <c:v>0.98175215525875759</c:v>
                </c:pt>
                <c:pt idx="409">
                  <c:v>0.97880485766057934</c:v>
                </c:pt>
                <c:pt idx="410">
                  <c:v>1.0588936943250045</c:v>
                </c:pt>
                <c:pt idx="411">
                  <c:v>1.0378117477202633</c:v>
                </c:pt>
                <c:pt idx="412">
                  <c:v>1.0918687829758436</c:v>
                </c:pt>
                <c:pt idx="413">
                  <c:v>1.0046254606607479</c:v>
                </c:pt>
                <c:pt idx="414">
                  <c:v>1.010236373633165</c:v>
                </c:pt>
                <c:pt idx="415">
                  <c:v>1.0265991967199248</c:v>
                </c:pt>
                <c:pt idx="416">
                  <c:v>0.9668685096215528</c:v>
                </c:pt>
                <c:pt idx="417">
                  <c:v>1.0161934026825807</c:v>
                </c:pt>
                <c:pt idx="418">
                  <c:v>1.0423878264846278</c:v>
                </c:pt>
                <c:pt idx="419">
                  <c:v>1.077574864930712</c:v>
                </c:pt>
                <c:pt idx="420">
                  <c:v>1.1093655849235267</c:v>
                </c:pt>
                <c:pt idx="421">
                  <c:v>1.0125599466609341</c:v>
                </c:pt>
                <c:pt idx="422">
                  <c:v>1.0078641143131175</c:v>
                </c:pt>
                <c:pt idx="423">
                  <c:v>1.0436965477699698</c:v>
                </c:pt>
                <c:pt idx="424">
                  <c:v>1.0290544992002137</c:v>
                </c:pt>
                <c:pt idx="425">
                  <c:v>0.9718342456659711</c:v>
                </c:pt>
                <c:pt idx="426">
                  <c:v>0.99714790463019398</c:v>
                </c:pt>
                <c:pt idx="427">
                  <c:v>1.0322104870945696</c:v>
                </c:pt>
                <c:pt idx="428">
                  <c:v>0.95540370035039968</c:v>
                </c:pt>
                <c:pt idx="429">
                  <c:v>0.9960165667653309</c:v>
                </c:pt>
                <c:pt idx="430">
                  <c:v>1.0418779252333377</c:v>
                </c:pt>
                <c:pt idx="431">
                  <c:v>0.96009478305924389</c:v>
                </c:pt>
                <c:pt idx="432">
                  <c:v>0.99453016104633751</c:v>
                </c:pt>
                <c:pt idx="433">
                  <c:v>1.0015496497151279</c:v>
                </c:pt>
                <c:pt idx="434">
                  <c:v>0.99855361408584176</c:v>
                </c:pt>
                <c:pt idx="435">
                  <c:v>0.97414030503608129</c:v>
                </c:pt>
                <c:pt idx="436">
                  <c:v>0.89903782636447716</c:v>
                </c:pt>
                <c:pt idx="437">
                  <c:v>0.94270676204310189</c:v>
                </c:pt>
                <c:pt idx="438">
                  <c:v>1.0030765951944438</c:v>
                </c:pt>
                <c:pt idx="439">
                  <c:v>1.063850075011576</c:v>
                </c:pt>
                <c:pt idx="440">
                  <c:v>1.0425810965094302</c:v>
                </c:pt>
                <c:pt idx="441">
                  <c:v>1.1127989521472545</c:v>
                </c:pt>
                <c:pt idx="442">
                  <c:v>1.0451545544801204</c:v>
                </c:pt>
                <c:pt idx="443">
                  <c:v>1.0411107480734958</c:v>
                </c:pt>
                <c:pt idx="444">
                  <c:v>0.91362745267307732</c:v>
                </c:pt>
                <c:pt idx="445">
                  <c:v>1.0194141192833643</c:v>
                </c:pt>
                <c:pt idx="446">
                  <c:v>1.0396290441467466</c:v>
                </c:pt>
                <c:pt idx="447">
                  <c:v>1.0188972727573598</c:v>
                </c:pt>
                <c:pt idx="448">
                  <c:v>1.0099309068584403</c:v>
                </c:pt>
                <c:pt idx="449">
                  <c:v>1.0344628997259271</c:v>
                </c:pt>
                <c:pt idx="450">
                  <c:v>0.96090637900322595</c:v>
                </c:pt>
                <c:pt idx="451">
                  <c:v>0.98349869788657929</c:v>
                </c:pt>
                <c:pt idx="452">
                  <c:v>1.0383578778439302</c:v>
                </c:pt>
                <c:pt idx="453">
                  <c:v>1.0220479771974122</c:v>
                </c:pt>
                <c:pt idx="454">
                  <c:v>1.0452999266600762</c:v>
                </c:pt>
                <c:pt idx="455">
                  <c:v>0.98903125349596566</c:v>
                </c:pt>
                <c:pt idx="456">
                  <c:v>1.0360031072848133</c:v>
                </c:pt>
                <c:pt idx="457">
                  <c:v>0.96221226921330416</c:v>
                </c:pt>
                <c:pt idx="458">
                  <c:v>1.0382998377737502</c:v>
                </c:pt>
                <c:pt idx="459">
                  <c:v>1.0729333048406049</c:v>
                </c:pt>
                <c:pt idx="460">
                  <c:v>1.0108910242677545</c:v>
                </c:pt>
                <c:pt idx="461">
                  <c:v>1.081933420627561</c:v>
                </c:pt>
                <c:pt idx="462">
                  <c:v>1.01085342459391</c:v>
                </c:pt>
                <c:pt idx="463">
                  <c:v>1.0876242997887962</c:v>
                </c:pt>
                <c:pt idx="464">
                  <c:v>1.0988176410237531</c:v>
                </c:pt>
                <c:pt idx="465">
                  <c:v>0.98167980392585363</c:v>
                </c:pt>
                <c:pt idx="466">
                  <c:v>1.091696172091408</c:v>
                </c:pt>
                <c:pt idx="467">
                  <c:v>1.0686460450372126</c:v>
                </c:pt>
                <c:pt idx="468">
                  <c:v>0.9778364291373246</c:v>
                </c:pt>
                <c:pt idx="469">
                  <c:v>0.98341688213766021</c:v>
                </c:pt>
                <c:pt idx="470">
                  <c:v>1.0107548452891073</c:v>
                </c:pt>
                <c:pt idx="471">
                  <c:v>1.0579568791571505</c:v>
                </c:pt>
                <c:pt idx="472">
                  <c:v>1.0060713044303893</c:v>
                </c:pt>
                <c:pt idx="473">
                  <c:v>1.0165679546040978</c:v>
                </c:pt>
                <c:pt idx="474">
                  <c:v>1.0118809741535184</c:v>
                </c:pt>
                <c:pt idx="475">
                  <c:v>0.99602108000671419</c:v>
                </c:pt>
                <c:pt idx="476">
                  <c:v>1.0489758081651179</c:v>
                </c:pt>
                <c:pt idx="477">
                  <c:v>0.91900623007364424</c:v>
                </c:pt>
                <c:pt idx="478">
                  <c:v>1.0157836425574602</c:v>
                </c:pt>
                <c:pt idx="479">
                  <c:v>1.0326443628399866</c:v>
                </c:pt>
                <c:pt idx="480">
                  <c:v>0.9538841393066031</c:v>
                </c:pt>
                <c:pt idx="481">
                  <c:v>1.0195574404769412</c:v>
                </c:pt>
                <c:pt idx="482">
                  <c:v>1.0619653815096288</c:v>
                </c:pt>
                <c:pt idx="483">
                  <c:v>0.94915651152759006</c:v>
                </c:pt>
                <c:pt idx="484">
                  <c:v>1.0199199771308216</c:v>
                </c:pt>
                <c:pt idx="485">
                  <c:v>1.0398624148076683</c:v>
                </c:pt>
                <c:pt idx="486">
                  <c:v>1.0452532346450705</c:v>
                </c:pt>
                <c:pt idx="487">
                  <c:v>1.0154888113363028</c:v>
                </c:pt>
                <c:pt idx="488">
                  <c:v>1.1409637668316563</c:v>
                </c:pt>
                <c:pt idx="489">
                  <c:v>1.1206556300147232</c:v>
                </c:pt>
                <c:pt idx="490">
                  <c:v>0.99789773615071509</c:v>
                </c:pt>
                <c:pt idx="491">
                  <c:v>1.0079765959762885</c:v>
                </c:pt>
                <c:pt idx="492">
                  <c:v>1.0311346493831943</c:v>
                </c:pt>
                <c:pt idx="493">
                  <c:v>0.95919044611335302</c:v>
                </c:pt>
                <c:pt idx="494">
                  <c:v>1.0962070305017391</c:v>
                </c:pt>
                <c:pt idx="495">
                  <c:v>1.0555758356744875</c:v>
                </c:pt>
                <c:pt idx="496">
                  <c:v>1.0301507465809199</c:v>
                </c:pt>
                <c:pt idx="497">
                  <c:v>1.0706007867798555</c:v>
                </c:pt>
                <c:pt idx="498">
                  <c:v>0.99993747773665453</c:v>
                </c:pt>
                <c:pt idx="499">
                  <c:v>1.1197991695278517</c:v>
                </c:pt>
                <c:pt idx="500">
                  <c:v>1.0150241763386847</c:v>
                </c:pt>
                <c:pt idx="501">
                  <c:v>1.0429883928554804</c:v>
                </c:pt>
                <c:pt idx="502">
                  <c:v>1.0406278830677309</c:v>
                </c:pt>
                <c:pt idx="503">
                  <c:v>1.0927777856812946</c:v>
                </c:pt>
                <c:pt idx="504">
                  <c:v>1.0425548123550532</c:v>
                </c:pt>
                <c:pt idx="505">
                  <c:v>0.98752940783308751</c:v>
                </c:pt>
                <c:pt idx="506">
                  <c:v>1.0901796700512925</c:v>
                </c:pt>
                <c:pt idx="507">
                  <c:v>0.95248984784778779</c:v>
                </c:pt>
                <c:pt idx="508">
                  <c:v>1.0260257076592274</c:v>
                </c:pt>
                <c:pt idx="509">
                  <c:v>0.97077569968009303</c:v>
                </c:pt>
                <c:pt idx="510">
                  <c:v>1.0311122974534872</c:v>
                </c:pt>
                <c:pt idx="511">
                  <c:v>1.0639043337657339</c:v>
                </c:pt>
                <c:pt idx="512">
                  <c:v>1.1190141515496146</c:v>
                </c:pt>
                <c:pt idx="513">
                  <c:v>1.037828073573662</c:v>
                </c:pt>
                <c:pt idx="514">
                  <c:v>0.96794397817471278</c:v>
                </c:pt>
                <c:pt idx="515">
                  <c:v>1.0399597215280607</c:v>
                </c:pt>
                <c:pt idx="516">
                  <c:v>1.0449360741262941</c:v>
                </c:pt>
                <c:pt idx="517">
                  <c:v>1.0663626295456352</c:v>
                </c:pt>
                <c:pt idx="518">
                  <c:v>1.0122008996409573</c:v>
                </c:pt>
                <c:pt idx="519">
                  <c:v>0.99699131014356723</c:v>
                </c:pt>
                <c:pt idx="520">
                  <c:v>0.98305469284962743</c:v>
                </c:pt>
                <c:pt idx="521">
                  <c:v>1.0207176094007371</c:v>
                </c:pt>
                <c:pt idx="522">
                  <c:v>1.1785512686367636</c:v>
                </c:pt>
                <c:pt idx="523">
                  <c:v>1.1248816228699681</c:v>
                </c:pt>
                <c:pt idx="524">
                  <c:v>0.95017496380624678</c:v>
                </c:pt>
                <c:pt idx="525">
                  <c:v>1.1010992064028833</c:v>
                </c:pt>
                <c:pt idx="526">
                  <c:v>0.96732528719530375</c:v>
                </c:pt>
                <c:pt idx="527">
                  <c:v>0.98102048710771084</c:v>
                </c:pt>
                <c:pt idx="528">
                  <c:v>1.0154927180406554</c:v>
                </c:pt>
                <c:pt idx="529">
                  <c:v>1.1249230579162477</c:v>
                </c:pt>
                <c:pt idx="530">
                  <c:v>1.0324190309628642</c:v>
                </c:pt>
                <c:pt idx="531">
                  <c:v>1.0155952408495572</c:v>
                </c:pt>
                <c:pt idx="532">
                  <c:v>0.92697056495595198</c:v>
                </c:pt>
                <c:pt idx="533">
                  <c:v>1.0019183488961356</c:v>
                </c:pt>
                <c:pt idx="534">
                  <c:v>1.0321874812821579</c:v>
                </c:pt>
                <c:pt idx="535">
                  <c:v>0.97946559039816161</c:v>
                </c:pt>
                <c:pt idx="536">
                  <c:v>1.0076501337276502</c:v>
                </c:pt>
                <c:pt idx="537">
                  <c:v>0.96484334683856821</c:v>
                </c:pt>
                <c:pt idx="538">
                  <c:v>0.99978558815062835</c:v>
                </c:pt>
                <c:pt idx="539">
                  <c:v>1.0013873540030147</c:v>
                </c:pt>
                <c:pt idx="540">
                  <c:v>1.0377784879400784</c:v>
                </c:pt>
                <c:pt idx="541">
                  <c:v>0.9573431551767615</c:v>
                </c:pt>
                <c:pt idx="542">
                  <c:v>1.0538172398654739</c:v>
                </c:pt>
                <c:pt idx="543">
                  <c:v>1.0424198387024397</c:v>
                </c:pt>
                <c:pt idx="544">
                  <c:v>0.97837067780488418</c:v>
                </c:pt>
                <c:pt idx="545">
                  <c:v>0.98586955759380401</c:v>
                </c:pt>
                <c:pt idx="546">
                  <c:v>0.93699408020159503</c:v>
                </c:pt>
                <c:pt idx="547">
                  <c:v>1.034971781950812</c:v>
                </c:pt>
                <c:pt idx="548">
                  <c:v>0.98569876397363643</c:v>
                </c:pt>
                <c:pt idx="549">
                  <c:v>1.0586447225590088</c:v>
                </c:pt>
                <c:pt idx="550">
                  <c:v>1.0343521681872558</c:v>
                </c:pt>
                <c:pt idx="551">
                  <c:v>0.99142697231079102</c:v>
                </c:pt>
                <c:pt idx="552">
                  <c:v>0.99596809106192752</c:v>
                </c:pt>
                <c:pt idx="553">
                  <c:v>0.98365852244759078</c:v>
                </c:pt>
                <c:pt idx="554">
                  <c:v>1.0759021574029211</c:v>
                </c:pt>
                <c:pt idx="555">
                  <c:v>1.0031774990038818</c:v>
                </c:pt>
                <c:pt idx="556">
                  <c:v>1.0086733461584307</c:v>
                </c:pt>
                <c:pt idx="557">
                  <c:v>0.93335630568938566</c:v>
                </c:pt>
                <c:pt idx="558">
                  <c:v>1.0069610344673126</c:v>
                </c:pt>
                <c:pt idx="559">
                  <c:v>1.0137624707276134</c:v>
                </c:pt>
                <c:pt idx="560">
                  <c:v>0.97089567672146249</c:v>
                </c:pt>
                <c:pt idx="561">
                  <c:v>1.1578948818570758</c:v>
                </c:pt>
                <c:pt idx="562">
                  <c:v>1.0414828299458652</c:v>
                </c:pt>
                <c:pt idx="563">
                  <c:v>1.0308349401745129</c:v>
                </c:pt>
                <c:pt idx="564">
                  <c:v>0.98288711916648497</c:v>
                </c:pt>
                <c:pt idx="565">
                  <c:v>1.0991624959531672</c:v>
                </c:pt>
                <c:pt idx="566">
                  <c:v>0.99898407471057915</c:v>
                </c:pt>
                <c:pt idx="567">
                  <c:v>0.91673984585612112</c:v>
                </c:pt>
                <c:pt idx="568">
                  <c:v>1.0359101807036997</c:v>
                </c:pt>
                <c:pt idx="569">
                  <c:v>1.1683692593067212</c:v>
                </c:pt>
                <c:pt idx="570">
                  <c:v>1.0510069165075286</c:v>
                </c:pt>
                <c:pt idx="571">
                  <c:v>1.0291610096973109</c:v>
                </c:pt>
                <c:pt idx="572">
                  <c:v>1.0467781431973193</c:v>
                </c:pt>
                <c:pt idx="573">
                  <c:v>1.0411490445430351</c:v>
                </c:pt>
                <c:pt idx="574">
                  <c:v>1.013576692507169</c:v>
                </c:pt>
                <c:pt idx="575">
                  <c:v>0.93226655689271798</c:v>
                </c:pt>
                <c:pt idx="576">
                  <c:v>1.0067876690136186</c:v>
                </c:pt>
                <c:pt idx="577">
                  <c:v>0.8814149089313178</c:v>
                </c:pt>
                <c:pt idx="578">
                  <c:v>1.1562631298042902</c:v>
                </c:pt>
                <c:pt idx="579">
                  <c:v>1.0109882572420892</c:v>
                </c:pt>
                <c:pt idx="580">
                  <c:v>0.89544548455685868</c:v>
                </c:pt>
                <c:pt idx="581">
                  <c:v>1.1263528428553202</c:v>
                </c:pt>
                <c:pt idx="582">
                  <c:v>0.9849281282001453</c:v>
                </c:pt>
                <c:pt idx="583">
                  <c:v>0.97615804401330164</c:v>
                </c:pt>
                <c:pt idx="584">
                  <c:v>0.98657539910447567</c:v>
                </c:pt>
                <c:pt idx="585">
                  <c:v>1.0089388921472331</c:v>
                </c:pt>
                <c:pt idx="586">
                  <c:v>1.0393537590060646</c:v>
                </c:pt>
                <c:pt idx="587">
                  <c:v>1.1890675676956528</c:v>
                </c:pt>
                <c:pt idx="588">
                  <c:v>1.126302777062963</c:v>
                </c:pt>
                <c:pt idx="589">
                  <c:v>1.0208537674610574</c:v>
                </c:pt>
                <c:pt idx="590">
                  <c:v>1.0141368058821434</c:v>
                </c:pt>
                <c:pt idx="591">
                  <c:v>0.89288429832426675</c:v>
                </c:pt>
                <c:pt idx="592">
                  <c:v>1.0370570030691453</c:v>
                </c:pt>
                <c:pt idx="593">
                  <c:v>0.98677647575213867</c:v>
                </c:pt>
                <c:pt idx="594">
                  <c:v>1.0295653909923497</c:v>
                </c:pt>
                <c:pt idx="595">
                  <c:v>1.0600409067931047</c:v>
                </c:pt>
                <c:pt idx="596">
                  <c:v>1.0046422168797271</c:v>
                </c:pt>
                <c:pt idx="597">
                  <c:v>0.97575656627311957</c:v>
                </c:pt>
                <c:pt idx="598">
                  <c:v>1.0002817503902501</c:v>
                </c:pt>
              </c:numCache>
            </c:numRef>
          </c:yVal>
          <c:smooth val="0"/>
        </c:ser>
        <c:ser>
          <c:idx val="1"/>
          <c:order val="1"/>
          <c:spPr>
            <a:ln w="19050">
              <a:solidFill>
                <a:schemeClr val="tx1"/>
              </a:solidFill>
            </a:ln>
          </c:spPr>
          <c:marker>
            <c:symbol val="none"/>
          </c:marker>
          <c:xVal>
            <c:numRef>
              <c:f>datat!$F$2:$F$600</c:f>
              <c:numCache>
                <c:formatCode>General</c:formatCode>
                <c:ptCount val="599"/>
                <c:pt idx="0">
                  <c:v>0.93466820992781718</c:v>
                </c:pt>
                <c:pt idx="1">
                  <c:v>0.93466820992781718</c:v>
                </c:pt>
                <c:pt idx="2">
                  <c:v>0.93887943667849161</c:v>
                </c:pt>
                <c:pt idx="3">
                  <c:v>0.93887943667849161</c:v>
                </c:pt>
                <c:pt idx="4">
                  <c:v>0.93969097769614651</c:v>
                </c:pt>
                <c:pt idx="5">
                  <c:v>0.9404928747138972</c:v>
                </c:pt>
                <c:pt idx="6">
                  <c:v>0.9404928747138972</c:v>
                </c:pt>
                <c:pt idx="7">
                  <c:v>0.94206866603713113</c:v>
                </c:pt>
                <c:pt idx="8">
                  <c:v>0.94206866603713113</c:v>
                </c:pt>
                <c:pt idx="9">
                  <c:v>0.94436561534226349</c:v>
                </c:pt>
                <c:pt idx="10">
                  <c:v>0.94436561534226349</c:v>
                </c:pt>
                <c:pt idx="11">
                  <c:v>0.94436561534226349</c:v>
                </c:pt>
                <c:pt idx="12">
                  <c:v>0.94511428693327026</c:v>
                </c:pt>
                <c:pt idx="13">
                  <c:v>0.94585478995418004</c:v>
                </c:pt>
                <c:pt idx="14">
                  <c:v>0.94585478995418004</c:v>
                </c:pt>
                <c:pt idx="15">
                  <c:v>0.94585478995418004</c:v>
                </c:pt>
                <c:pt idx="16">
                  <c:v>0.94585478995418004</c:v>
                </c:pt>
                <c:pt idx="17">
                  <c:v>0.94658730692345749</c:v>
                </c:pt>
                <c:pt idx="18">
                  <c:v>0.94658730692345749</c:v>
                </c:pt>
                <c:pt idx="19">
                  <c:v>0.94731201424224298</c:v>
                </c:pt>
                <c:pt idx="20">
                  <c:v>0.94731201424224298</c:v>
                </c:pt>
                <c:pt idx="21">
                  <c:v>0.94731201424224298</c:v>
                </c:pt>
                <c:pt idx="22">
                  <c:v>0.94731201424224298</c:v>
                </c:pt>
                <c:pt idx="23">
                  <c:v>0.94731201424224298</c:v>
                </c:pt>
                <c:pt idx="24">
                  <c:v>0.94802908246618312</c:v>
                </c:pt>
                <c:pt idx="25">
                  <c:v>0.94802908246618312</c:v>
                </c:pt>
                <c:pt idx="26">
                  <c:v>0.94873867656228039</c:v>
                </c:pt>
                <c:pt idx="27">
                  <c:v>0.95013607573974268</c:v>
                </c:pt>
                <c:pt idx="28">
                  <c:v>0.95013607573974268</c:v>
                </c:pt>
                <c:pt idx="29">
                  <c:v>0.9508241849329242</c:v>
                </c:pt>
                <c:pt idx="30">
                  <c:v>0.95150542864543453</c:v>
                </c:pt>
                <c:pt idx="31">
                  <c:v>0.95150542864543453</c:v>
                </c:pt>
                <c:pt idx="32">
                  <c:v>0.95150542864543453</c:v>
                </c:pt>
                <c:pt idx="33">
                  <c:v>0.95150542864543453</c:v>
                </c:pt>
                <c:pt idx="34">
                  <c:v>0.95150542864543453</c:v>
                </c:pt>
                <c:pt idx="35">
                  <c:v>0.95217994729420263</c:v>
                </c:pt>
                <c:pt idx="36">
                  <c:v>0.95350934968382206</c:v>
                </c:pt>
                <c:pt idx="37">
                  <c:v>0.95350934968382206</c:v>
                </c:pt>
                <c:pt idx="38">
                  <c:v>0.95350934968382206</c:v>
                </c:pt>
                <c:pt idx="39">
                  <c:v>0.95416449339241294</c:v>
                </c:pt>
                <c:pt idx="40">
                  <c:v>0.95416449339241294</c:v>
                </c:pt>
                <c:pt idx="41">
                  <c:v>0.95481343229805826</c:v>
                </c:pt>
                <c:pt idx="42">
                  <c:v>0.95481343229805826</c:v>
                </c:pt>
                <c:pt idx="43">
                  <c:v>0.95609317429456908</c:v>
                </c:pt>
                <c:pt idx="44">
                  <c:v>0.95609317429456908</c:v>
                </c:pt>
                <c:pt idx="45">
                  <c:v>0.95609317429456908</c:v>
                </c:pt>
                <c:pt idx="46">
                  <c:v>0.9567242080259184</c:v>
                </c:pt>
                <c:pt idx="47">
                  <c:v>0.95734949850127504</c:v>
                </c:pt>
                <c:pt idx="48">
                  <c:v>0.9579691529717026</c:v>
                </c:pt>
                <c:pt idx="49">
                  <c:v>0.9579691529717026</c:v>
                </c:pt>
                <c:pt idx="50">
                  <c:v>0.9579691529717026</c:v>
                </c:pt>
                <c:pt idx="51">
                  <c:v>0.95858327567835611</c:v>
                </c:pt>
                <c:pt idx="52">
                  <c:v>0.95858327567835611</c:v>
                </c:pt>
                <c:pt idx="53">
                  <c:v>0.95858327567835611</c:v>
                </c:pt>
                <c:pt idx="54">
                  <c:v>0.95858327567835611</c:v>
                </c:pt>
                <c:pt idx="55">
                  <c:v>0.95919196796468009</c:v>
                </c:pt>
                <c:pt idx="56">
                  <c:v>0.95919196796468009</c:v>
                </c:pt>
                <c:pt idx="57">
                  <c:v>0.95919196796468009</c:v>
                </c:pt>
                <c:pt idx="58">
                  <c:v>0.95979532838340953</c:v>
                </c:pt>
                <c:pt idx="59">
                  <c:v>0.96039345279866184</c:v>
                </c:pt>
                <c:pt idx="60">
                  <c:v>0.96039345279866184</c:v>
                </c:pt>
                <c:pt idx="61">
                  <c:v>0.96039345279866184</c:v>
                </c:pt>
                <c:pt idx="62">
                  <c:v>0.96157436421242903</c:v>
                </c:pt>
                <c:pt idx="63">
                  <c:v>0.96157436421242903</c:v>
                </c:pt>
                <c:pt idx="64">
                  <c:v>0.96215733035143081</c:v>
                </c:pt>
                <c:pt idx="65">
                  <c:v>0.96215733035143081</c:v>
                </c:pt>
                <c:pt idx="66">
                  <c:v>0.96215733035143081</c:v>
                </c:pt>
                <c:pt idx="67">
                  <c:v>0.96273541894180925</c:v>
                </c:pt>
                <c:pt idx="68">
                  <c:v>0.96273541894180925</c:v>
                </c:pt>
                <c:pt idx="69">
                  <c:v>0.96273541894180925</c:v>
                </c:pt>
                <c:pt idx="70">
                  <c:v>0.96330871378200189</c:v>
                </c:pt>
                <c:pt idx="71">
                  <c:v>0.96330871378200189</c:v>
                </c:pt>
                <c:pt idx="72">
                  <c:v>0.96330871378200189</c:v>
                </c:pt>
                <c:pt idx="73">
                  <c:v>0.96387729650518417</c:v>
                </c:pt>
                <c:pt idx="74">
                  <c:v>0.96387729650518417</c:v>
                </c:pt>
                <c:pt idx="75">
                  <c:v>0.96444124665363817</c:v>
                </c:pt>
                <c:pt idx="76">
                  <c:v>0.96500064174994526</c:v>
                </c:pt>
                <c:pt idx="77">
                  <c:v>0.96500064174994526</c:v>
                </c:pt>
                <c:pt idx="78">
                  <c:v>0.96500064174994526</c:v>
                </c:pt>
                <c:pt idx="79">
                  <c:v>0.96500064174994526</c:v>
                </c:pt>
                <c:pt idx="80">
                  <c:v>0.96500064174994526</c:v>
                </c:pt>
                <c:pt idx="81">
                  <c:v>0.96555555736516441</c:v>
                </c:pt>
                <c:pt idx="82">
                  <c:v>0.96555555736516441</c:v>
                </c:pt>
                <c:pt idx="83">
                  <c:v>0.96555555736516441</c:v>
                </c:pt>
                <c:pt idx="84">
                  <c:v>0.96610606718414871</c:v>
                </c:pt>
                <c:pt idx="85">
                  <c:v>0.9666522430681429</c:v>
                </c:pt>
                <c:pt idx="86">
                  <c:v>0.9666522430681429</c:v>
                </c:pt>
                <c:pt idx="87">
                  <c:v>0.96719415511479723</c:v>
                </c:pt>
                <c:pt idx="88">
                  <c:v>0.96719415511479723</c:v>
                </c:pt>
                <c:pt idx="89">
                  <c:v>0.96719415511479723</c:v>
                </c:pt>
                <c:pt idx="90">
                  <c:v>0.96773187171572395</c:v>
                </c:pt>
                <c:pt idx="91">
                  <c:v>0.96773187171572395</c:v>
                </c:pt>
                <c:pt idx="92">
                  <c:v>0.96773187171572395</c:v>
                </c:pt>
                <c:pt idx="93">
                  <c:v>0.96826545961171828</c:v>
                </c:pt>
                <c:pt idx="94">
                  <c:v>0.96826545961171828</c:v>
                </c:pt>
                <c:pt idx="95">
                  <c:v>0.96826545961171828</c:v>
                </c:pt>
                <c:pt idx="96">
                  <c:v>0.96879498394575514</c:v>
                </c:pt>
                <c:pt idx="97">
                  <c:v>0.96879498394575514</c:v>
                </c:pt>
                <c:pt idx="98">
                  <c:v>0.96879498394575514</c:v>
                </c:pt>
                <c:pt idx="99">
                  <c:v>0.96879498394575514</c:v>
                </c:pt>
                <c:pt idx="100">
                  <c:v>0.96932050831386884</c:v>
                </c:pt>
                <c:pt idx="101">
                  <c:v>0.96932050831386884</c:v>
                </c:pt>
                <c:pt idx="102">
                  <c:v>0.96984209481401806</c:v>
                </c:pt>
                <c:pt idx="103">
                  <c:v>0.96984209481401806</c:v>
                </c:pt>
                <c:pt idx="104">
                  <c:v>0.96984209481401806</c:v>
                </c:pt>
                <c:pt idx="105">
                  <c:v>0.97035980409302924</c:v>
                </c:pt>
                <c:pt idx="106">
                  <c:v>0.97035980409302924</c:v>
                </c:pt>
                <c:pt idx="107">
                  <c:v>0.97087369539170987</c:v>
                </c:pt>
                <c:pt idx="108">
                  <c:v>0.97087369539170987</c:v>
                </c:pt>
                <c:pt idx="109">
                  <c:v>0.97138382658821665</c:v>
                </c:pt>
                <c:pt idx="110">
                  <c:v>0.97189025423975828</c:v>
                </c:pt>
                <c:pt idx="111">
                  <c:v>0.97189025423975828</c:v>
                </c:pt>
                <c:pt idx="112">
                  <c:v>0.97189025423975828</c:v>
                </c:pt>
                <c:pt idx="113">
                  <c:v>0.97239303362271101</c:v>
                </c:pt>
                <c:pt idx="114">
                  <c:v>0.97239303362271101</c:v>
                </c:pt>
                <c:pt idx="115">
                  <c:v>0.97239303362271101</c:v>
                </c:pt>
                <c:pt idx="116">
                  <c:v>0.97239303362271101</c:v>
                </c:pt>
                <c:pt idx="117">
                  <c:v>0.97289221877121634</c:v>
                </c:pt>
                <c:pt idx="118">
                  <c:v>0.97338786251433229</c:v>
                </c:pt>
                <c:pt idx="119">
                  <c:v>0.97388001651180078</c:v>
                </c:pt>
                <c:pt idx="120">
                  <c:v>0.97436873128849366</c:v>
                </c:pt>
                <c:pt idx="121">
                  <c:v>0.97436873128849366</c:v>
                </c:pt>
                <c:pt idx="122">
                  <c:v>0.97436873128849366</c:v>
                </c:pt>
                <c:pt idx="123">
                  <c:v>0.97436873128849366</c:v>
                </c:pt>
                <c:pt idx="124">
                  <c:v>0.97436873128849366</c:v>
                </c:pt>
                <c:pt idx="125">
                  <c:v>0.97533603980257944</c:v>
                </c:pt>
                <c:pt idx="126">
                  <c:v>0.97581472920802437</c:v>
                </c:pt>
                <c:pt idx="127">
                  <c:v>0.97581472920802437</c:v>
                </c:pt>
                <c:pt idx="128">
                  <c:v>0.97581472920802437</c:v>
                </c:pt>
                <c:pt idx="129">
                  <c:v>0.97629017078933111</c:v>
                </c:pt>
                <c:pt idx="130">
                  <c:v>0.97629017078933111</c:v>
                </c:pt>
                <c:pt idx="131">
                  <c:v>0.97629017078933111</c:v>
                </c:pt>
                <c:pt idx="132">
                  <c:v>0.97629017078933111</c:v>
                </c:pt>
                <c:pt idx="133">
                  <c:v>0.97629017078933111</c:v>
                </c:pt>
                <c:pt idx="134">
                  <c:v>0.97676240987137641</c:v>
                </c:pt>
                <c:pt idx="135">
                  <c:v>0.97676240987137641</c:v>
                </c:pt>
                <c:pt idx="136">
                  <c:v>0.97723149082615601</c:v>
                </c:pt>
                <c:pt idx="137">
                  <c:v>0.97723149082615601</c:v>
                </c:pt>
                <c:pt idx="138">
                  <c:v>0.97723149082615601</c:v>
                </c:pt>
                <c:pt idx="139">
                  <c:v>0.97723149082615601</c:v>
                </c:pt>
                <c:pt idx="140">
                  <c:v>0.97723149082615601</c:v>
                </c:pt>
                <c:pt idx="141">
                  <c:v>0.97769745709945599</c:v>
                </c:pt>
                <c:pt idx="142">
                  <c:v>0.97769745709945599</c:v>
                </c:pt>
                <c:pt idx="143">
                  <c:v>0.97816035123659528</c:v>
                </c:pt>
                <c:pt idx="144">
                  <c:v>0.97816035123659528</c:v>
                </c:pt>
                <c:pt idx="145">
                  <c:v>0.97816035123659528</c:v>
                </c:pt>
                <c:pt idx="146">
                  <c:v>0.97862021490727635</c:v>
                </c:pt>
                <c:pt idx="147">
                  <c:v>0.97862021490727635</c:v>
                </c:pt>
                <c:pt idx="148">
                  <c:v>0.97862021490727635</c:v>
                </c:pt>
                <c:pt idx="149">
                  <c:v>0.97862021490727635</c:v>
                </c:pt>
                <c:pt idx="150">
                  <c:v>0.97862021490727635</c:v>
                </c:pt>
                <c:pt idx="151">
                  <c:v>0.9790770889295819</c:v>
                </c:pt>
                <c:pt idx="152">
                  <c:v>0.9790770889295819</c:v>
                </c:pt>
                <c:pt idx="153">
                  <c:v>0.9790770889295819</c:v>
                </c:pt>
                <c:pt idx="154">
                  <c:v>0.97953101329315295</c:v>
                </c:pt>
                <c:pt idx="155">
                  <c:v>0.97953101329315295</c:v>
                </c:pt>
                <c:pt idx="156">
                  <c:v>0.97953101329315295</c:v>
                </c:pt>
                <c:pt idx="157">
                  <c:v>0.97953101329315295</c:v>
                </c:pt>
                <c:pt idx="158">
                  <c:v>0.97953101329315295</c:v>
                </c:pt>
                <c:pt idx="159">
                  <c:v>0.97998202718158023</c:v>
                </c:pt>
                <c:pt idx="160">
                  <c:v>0.97998202718158023</c:v>
                </c:pt>
                <c:pt idx="161">
                  <c:v>0.97998202718158023</c:v>
                </c:pt>
                <c:pt idx="162">
                  <c:v>0.97998202718158023</c:v>
                </c:pt>
                <c:pt idx="163">
                  <c:v>0.98043016899404245</c:v>
                </c:pt>
                <c:pt idx="164">
                  <c:v>0.98043016899404245</c:v>
                </c:pt>
                <c:pt idx="165">
                  <c:v>0.98043016899404245</c:v>
                </c:pt>
                <c:pt idx="166">
                  <c:v>0.98043016899404245</c:v>
                </c:pt>
                <c:pt idx="167">
                  <c:v>0.98043016899404245</c:v>
                </c:pt>
                <c:pt idx="168">
                  <c:v>0.98087547636622041</c:v>
                </c:pt>
                <c:pt idx="169">
                  <c:v>0.98087547636622041</c:v>
                </c:pt>
                <c:pt idx="170">
                  <c:v>0.98087547636622041</c:v>
                </c:pt>
                <c:pt idx="171">
                  <c:v>0.98131798619051658</c:v>
                </c:pt>
                <c:pt idx="172">
                  <c:v>0.981757734635608</c:v>
                </c:pt>
                <c:pt idx="173">
                  <c:v>0.981757734635608</c:v>
                </c:pt>
                <c:pt idx="174">
                  <c:v>0.981757734635608</c:v>
                </c:pt>
                <c:pt idx="175">
                  <c:v>0.98219475716535742</c:v>
                </c:pt>
                <c:pt idx="176">
                  <c:v>0.98262908855710951</c:v>
                </c:pt>
                <c:pt idx="177">
                  <c:v>0.98262908855710951</c:v>
                </c:pt>
                <c:pt idx="178">
                  <c:v>0.98306076291939504</c:v>
                </c:pt>
                <c:pt idx="179">
                  <c:v>0.98306076291939504</c:v>
                </c:pt>
                <c:pt idx="180">
                  <c:v>0.98306076291939504</c:v>
                </c:pt>
                <c:pt idx="181">
                  <c:v>0.98348981370906574</c:v>
                </c:pt>
                <c:pt idx="182">
                  <c:v>0.98348981370906574</c:v>
                </c:pt>
                <c:pt idx="183">
                  <c:v>0.98348981370906574</c:v>
                </c:pt>
                <c:pt idx="184">
                  <c:v>0.98348981370906574</c:v>
                </c:pt>
                <c:pt idx="185">
                  <c:v>0.98391627374788293</c:v>
                </c:pt>
                <c:pt idx="186">
                  <c:v>0.98391627374788293</c:v>
                </c:pt>
                <c:pt idx="187">
                  <c:v>0.98391627374788293</c:v>
                </c:pt>
                <c:pt idx="188">
                  <c:v>0.98434017523857897</c:v>
                </c:pt>
                <c:pt idx="189">
                  <c:v>0.98434017523857897</c:v>
                </c:pt>
                <c:pt idx="190">
                  <c:v>0.98434017523857897</c:v>
                </c:pt>
                <c:pt idx="191">
                  <c:v>0.98434017523857897</c:v>
                </c:pt>
                <c:pt idx="192">
                  <c:v>0.98476154978041353</c:v>
                </c:pt>
                <c:pt idx="193">
                  <c:v>0.98476154978041353</c:v>
                </c:pt>
                <c:pt idx="194">
                  <c:v>0.98518042838424158</c:v>
                </c:pt>
                <c:pt idx="195">
                  <c:v>0.98559684148711302</c:v>
                </c:pt>
                <c:pt idx="196">
                  <c:v>0.98559684148711302</c:v>
                </c:pt>
                <c:pt idx="197">
                  <c:v>0.98601081896642107</c:v>
                </c:pt>
                <c:pt idx="198">
                  <c:v>0.98642239015361532</c:v>
                </c:pt>
                <c:pt idx="199">
                  <c:v>0.98642239015361532</c:v>
                </c:pt>
                <c:pt idx="200">
                  <c:v>0.98642239015361532</c:v>
                </c:pt>
                <c:pt idx="201">
                  <c:v>0.98683158384749614</c:v>
                </c:pt>
                <c:pt idx="202">
                  <c:v>0.9872384283271054</c:v>
                </c:pt>
                <c:pt idx="203">
                  <c:v>0.98764295136422886</c:v>
                </c:pt>
                <c:pt idx="204">
                  <c:v>0.98764295136422886</c:v>
                </c:pt>
                <c:pt idx="205">
                  <c:v>0.98764295136422886</c:v>
                </c:pt>
                <c:pt idx="206">
                  <c:v>0.98804518023552257</c:v>
                </c:pt>
                <c:pt idx="207">
                  <c:v>0.98804518023552257</c:v>
                </c:pt>
                <c:pt idx="208">
                  <c:v>0.988445141734279</c:v>
                </c:pt>
                <c:pt idx="209">
                  <c:v>0.988445141734279</c:v>
                </c:pt>
                <c:pt idx="210">
                  <c:v>0.988445141734279</c:v>
                </c:pt>
                <c:pt idx="211">
                  <c:v>0.98884286218184414</c:v>
                </c:pt>
                <c:pt idx="212">
                  <c:v>0.98884286218184414</c:v>
                </c:pt>
                <c:pt idx="213">
                  <c:v>0.98884286218184414</c:v>
                </c:pt>
                <c:pt idx="214">
                  <c:v>0.98884286218184414</c:v>
                </c:pt>
                <c:pt idx="215">
                  <c:v>0.98884286218184414</c:v>
                </c:pt>
                <c:pt idx="216">
                  <c:v>0.98923836743869797</c:v>
                </c:pt>
                <c:pt idx="217">
                  <c:v>0.98923836743869797</c:v>
                </c:pt>
                <c:pt idx="218">
                  <c:v>0.98923836743869797</c:v>
                </c:pt>
                <c:pt idx="219">
                  <c:v>0.98923836743869797</c:v>
                </c:pt>
                <c:pt idx="220">
                  <c:v>0.99041184398050908</c:v>
                </c:pt>
                <c:pt idx="221">
                  <c:v>0.99041184398050908</c:v>
                </c:pt>
                <c:pt idx="222">
                  <c:v>0.99041184398050908</c:v>
                </c:pt>
                <c:pt idx="223">
                  <c:v>0.99079873823197928</c:v>
                </c:pt>
                <c:pt idx="224">
                  <c:v>0.99079873823197928</c:v>
                </c:pt>
                <c:pt idx="225">
                  <c:v>0.99079873823197928</c:v>
                </c:pt>
                <c:pt idx="226">
                  <c:v>0.99118354004789644</c:v>
                </c:pt>
                <c:pt idx="227">
                  <c:v>0.99118354004789644</c:v>
                </c:pt>
                <c:pt idx="228">
                  <c:v>0.99156627273884734</c:v>
                </c:pt>
                <c:pt idx="229">
                  <c:v>0.99194695922364085</c:v>
                </c:pt>
                <c:pt idx="230">
                  <c:v>0.99194695922364085</c:v>
                </c:pt>
                <c:pt idx="231">
                  <c:v>0.99270228334353128</c:v>
                </c:pt>
                <c:pt idx="232">
                  <c:v>0.99270228334353128</c:v>
                </c:pt>
                <c:pt idx="233">
                  <c:v>0.99307696493515074</c:v>
                </c:pt>
                <c:pt idx="234">
                  <c:v>0.99307696493515074</c:v>
                </c:pt>
                <c:pt idx="235">
                  <c:v>0.99307696493515074</c:v>
                </c:pt>
                <c:pt idx="236">
                  <c:v>0.99382047437496757</c:v>
                </c:pt>
                <c:pt idx="237">
                  <c:v>0.99418934405418546</c:v>
                </c:pt>
                <c:pt idx="238">
                  <c:v>0.99418934405418546</c:v>
                </c:pt>
                <c:pt idx="239">
                  <c:v>0.99455631769667496</c:v>
                </c:pt>
                <c:pt idx="240">
                  <c:v>0.99455631769667496</c:v>
                </c:pt>
                <c:pt idx="241">
                  <c:v>0.99455631769667496</c:v>
                </c:pt>
                <c:pt idx="242">
                  <c:v>0.99492141538345913</c:v>
                </c:pt>
                <c:pt idx="243">
                  <c:v>0.99492141538345913</c:v>
                </c:pt>
                <c:pt idx="244">
                  <c:v>0.99492141538345913</c:v>
                </c:pt>
                <c:pt idx="245">
                  <c:v>0.99492141538345913</c:v>
                </c:pt>
                <c:pt idx="246">
                  <c:v>0.9952846568746142</c:v>
                </c:pt>
                <c:pt idx="247">
                  <c:v>0.9952846568746142</c:v>
                </c:pt>
                <c:pt idx="248">
                  <c:v>0.99564606161611036</c:v>
                </c:pt>
                <c:pt idx="249">
                  <c:v>0.99600564874647179</c:v>
                </c:pt>
                <c:pt idx="250">
                  <c:v>0.99600564874647179</c:v>
                </c:pt>
                <c:pt idx="251">
                  <c:v>0.99636343710325903</c:v>
                </c:pt>
                <c:pt idx="252">
                  <c:v>0.99636343710325903</c:v>
                </c:pt>
                <c:pt idx="253">
                  <c:v>0.99636343710325903</c:v>
                </c:pt>
                <c:pt idx="254">
                  <c:v>0.99636343710325903</c:v>
                </c:pt>
                <c:pt idx="255">
                  <c:v>0.99636343710325903</c:v>
                </c:pt>
                <c:pt idx="256">
                  <c:v>0.99671944522938227</c:v>
                </c:pt>
                <c:pt idx="257">
                  <c:v>0.99671944522938227</c:v>
                </c:pt>
                <c:pt idx="258">
                  <c:v>0.99671944522938227</c:v>
                </c:pt>
                <c:pt idx="259">
                  <c:v>0.99671944522938227</c:v>
                </c:pt>
                <c:pt idx="260">
                  <c:v>0.99707369137924851</c:v>
                </c:pt>
                <c:pt idx="261">
                  <c:v>0.99707369137924851</c:v>
                </c:pt>
                <c:pt idx="262">
                  <c:v>0.99707369137924851</c:v>
                </c:pt>
                <c:pt idx="263">
                  <c:v>0.99742619352474848</c:v>
                </c:pt>
                <c:pt idx="264">
                  <c:v>0.99742619352474848</c:v>
                </c:pt>
                <c:pt idx="265">
                  <c:v>0.99742619352474848</c:v>
                </c:pt>
                <c:pt idx="266">
                  <c:v>0.99777696936109017</c:v>
                </c:pt>
                <c:pt idx="267">
                  <c:v>0.99777696936109017</c:v>
                </c:pt>
                <c:pt idx="268">
                  <c:v>0.99847341153765867</c:v>
                </c:pt>
                <c:pt idx="269">
                  <c:v>0.99881911193529938</c:v>
                </c:pt>
                <c:pt idx="270">
                  <c:v>0.99881911193529938</c:v>
                </c:pt>
                <c:pt idx="271">
                  <c:v>0.99881911193529938</c:v>
                </c:pt>
                <c:pt idx="272">
                  <c:v>0.99881911193529938</c:v>
                </c:pt>
                <c:pt idx="273">
                  <c:v>0.99916315414926316</c:v>
                </c:pt>
                <c:pt idx="274">
                  <c:v>0.99950555457372647</c:v>
                </c:pt>
                <c:pt idx="275">
                  <c:v>0.99984632935817819</c:v>
                </c:pt>
                <c:pt idx="276">
                  <c:v>1.0001854944122917</c:v>
                </c:pt>
                <c:pt idx="277">
                  <c:v>1.0001854944122917</c:v>
                </c:pt>
                <c:pt idx="278">
                  <c:v>1.0005230654106767</c:v>
                </c:pt>
                <c:pt idx="279">
                  <c:v>1.0008590577975127</c:v>
                </c:pt>
                <c:pt idx="280">
                  <c:v>1.0008590577975127</c:v>
                </c:pt>
                <c:pt idx="281">
                  <c:v>1.0011934867910683</c:v>
                </c:pt>
                <c:pt idx="282">
                  <c:v>1.0011934867910683</c:v>
                </c:pt>
                <c:pt idx="283">
                  <c:v>1.0011934867910683</c:v>
                </c:pt>
                <c:pt idx="284">
                  <c:v>1.0011934867910683</c:v>
                </c:pt>
                <c:pt idx="285">
                  <c:v>1.0011934867910683</c:v>
                </c:pt>
                <c:pt idx="286">
                  <c:v>1.0015263673881121</c:v>
                </c:pt>
                <c:pt idx="287">
                  <c:v>1.0015263673881121</c:v>
                </c:pt>
                <c:pt idx="288">
                  <c:v>1.0018577143682126</c:v>
                </c:pt>
                <c:pt idx="289">
                  <c:v>1.0021875422979367</c:v>
                </c:pt>
                <c:pt idx="290">
                  <c:v>1.0021875422979367</c:v>
                </c:pt>
                <c:pt idx="291">
                  <c:v>1.0021875422979367</c:v>
                </c:pt>
                <c:pt idx="292">
                  <c:v>1.0021875422979367</c:v>
                </c:pt>
                <c:pt idx="293">
                  <c:v>1.0021875422979367</c:v>
                </c:pt>
                <c:pt idx="294">
                  <c:v>1.0021875422979367</c:v>
                </c:pt>
                <c:pt idx="295">
                  <c:v>1.002515865534946</c:v>
                </c:pt>
                <c:pt idx="296">
                  <c:v>1.002515865534946</c:v>
                </c:pt>
                <c:pt idx="297">
                  <c:v>1.002515865534946</c:v>
                </c:pt>
                <c:pt idx="298">
                  <c:v>1.0028426982319942</c:v>
                </c:pt>
                <c:pt idx="299">
                  <c:v>1.0028426982319942</c:v>
                </c:pt>
                <c:pt idx="300">
                  <c:v>1.0031680543408301</c:v>
                </c:pt>
                <c:pt idx="301">
                  <c:v>1.0031680543408301</c:v>
                </c:pt>
                <c:pt idx="302">
                  <c:v>1.0034919476160074</c:v>
                </c:pt>
                <c:pt idx="303">
                  <c:v>1.0038143916186029</c:v>
                </c:pt>
                <c:pt idx="304">
                  <c:v>1.0038143916186029</c:v>
                </c:pt>
                <c:pt idx="305">
                  <c:v>1.0038143916186029</c:v>
                </c:pt>
                <c:pt idx="306">
                  <c:v>1.0044549851046871</c:v>
                </c:pt>
                <c:pt idx="307">
                  <c:v>1.0044549851046871</c:v>
                </c:pt>
                <c:pt idx="308">
                  <c:v>1.0044549851046871</c:v>
                </c:pt>
                <c:pt idx="309">
                  <c:v>1.0057193568500078</c:v>
                </c:pt>
                <c:pt idx="310">
                  <c:v>1.0057193568500078</c:v>
                </c:pt>
                <c:pt idx="311">
                  <c:v>1.0060320201444852</c:v>
                </c:pt>
                <c:pt idx="312">
                  <c:v>1.0060320201444852</c:v>
                </c:pt>
                <c:pt idx="313">
                  <c:v>1.0060320201444852</c:v>
                </c:pt>
                <c:pt idx="314">
                  <c:v>1.0060320201444852</c:v>
                </c:pt>
                <c:pt idx="315">
                  <c:v>1.0063433361084175</c:v>
                </c:pt>
                <c:pt idx="316">
                  <c:v>1.0066533167153071</c:v>
                </c:pt>
                <c:pt idx="317">
                  <c:v>1.0069619737779409</c:v>
                </c:pt>
                <c:pt idx="318">
                  <c:v>1.0078801194774685</c:v>
                </c:pt>
                <c:pt idx="319">
                  <c:v>1.0078801194774685</c:v>
                </c:pt>
                <c:pt idx="320">
                  <c:v>1.0081835973760855</c:v>
                </c:pt>
                <c:pt idx="321">
                  <c:v>1.0081835973760855</c:v>
                </c:pt>
                <c:pt idx="322">
                  <c:v>1.0081835973760855</c:v>
                </c:pt>
                <c:pt idx="323">
                  <c:v>1.0084858084822172</c:v>
                </c:pt>
                <c:pt idx="324">
                  <c:v>1.0084858084822172</c:v>
                </c:pt>
                <c:pt idx="325">
                  <c:v>1.0084858084822172</c:v>
                </c:pt>
                <c:pt idx="326">
                  <c:v>1.008786763702634</c:v>
                </c:pt>
                <c:pt idx="327">
                  <c:v>1.008786763702634</c:v>
                </c:pt>
                <c:pt idx="328">
                  <c:v>1.008786763702634</c:v>
                </c:pt>
                <c:pt idx="329">
                  <c:v>1.008786763702634</c:v>
                </c:pt>
                <c:pt idx="330">
                  <c:v>1.0090864738022527</c:v>
                </c:pt>
                <c:pt idx="331">
                  <c:v>1.0090864738022527</c:v>
                </c:pt>
                <c:pt idx="332">
                  <c:v>1.0093849494066014</c:v>
                </c:pt>
                <c:pt idx="333">
                  <c:v>1.0093849494066014</c:v>
                </c:pt>
                <c:pt idx="334">
                  <c:v>1.0093849494066014</c:v>
                </c:pt>
                <c:pt idx="335">
                  <c:v>1.0096822010042277</c:v>
                </c:pt>
                <c:pt idx="336">
                  <c:v>1.0096822010042277</c:v>
                </c:pt>
                <c:pt idx="337">
                  <c:v>1.0099782389490566</c:v>
                </c:pt>
                <c:pt idx="338">
                  <c:v>1.0102730734626981</c:v>
                </c:pt>
                <c:pt idx="339">
                  <c:v>1.0102730734626981</c:v>
                </c:pt>
                <c:pt idx="340">
                  <c:v>1.0108591724347769</c:v>
                </c:pt>
                <c:pt idx="341">
                  <c:v>1.0111504566949348</c:v>
                </c:pt>
                <c:pt idx="342">
                  <c:v>1.0111504566949348</c:v>
                </c:pt>
                <c:pt idx="343">
                  <c:v>1.0111504566949348</c:v>
                </c:pt>
                <c:pt idx="344">
                  <c:v>1.0111504566949348</c:v>
                </c:pt>
                <c:pt idx="345">
                  <c:v>1.0111504566949348</c:v>
                </c:pt>
                <c:pt idx="346">
                  <c:v>1.0114405771316255</c:v>
                </c:pt>
                <c:pt idx="347">
                  <c:v>1.0114405771316255</c:v>
                </c:pt>
                <c:pt idx="348">
                  <c:v>1.0117295433378011</c:v>
                </c:pt>
                <c:pt idx="349">
                  <c:v>1.0117295433378011</c:v>
                </c:pt>
                <c:pt idx="350">
                  <c:v>1.0120173647869453</c:v>
                </c:pt>
                <c:pt idx="351">
                  <c:v>1.0120173647869453</c:v>
                </c:pt>
                <c:pt idx="352">
                  <c:v>1.0120173647869453</c:v>
                </c:pt>
                <c:pt idx="353">
                  <c:v>1.0125896107226164</c:v>
                </c:pt>
                <c:pt idx="354">
                  <c:v>1.0125896107226164</c:v>
                </c:pt>
                <c:pt idx="355">
                  <c:v>1.0125896107226164</c:v>
                </c:pt>
                <c:pt idx="356">
                  <c:v>1.0134396241332915</c:v>
                </c:pt>
                <c:pt idx="357">
                  <c:v>1.013720769538428</c:v>
                </c:pt>
                <c:pt idx="358">
                  <c:v>1.013720769538428</c:v>
                </c:pt>
                <c:pt idx="359">
                  <c:v>1.013720769538428</c:v>
                </c:pt>
                <c:pt idx="360">
                  <c:v>1.0140008333176336</c:v>
                </c:pt>
                <c:pt idx="361">
                  <c:v>1.0140008333176336</c:v>
                </c:pt>
                <c:pt idx="362">
                  <c:v>1.0140008333176336</c:v>
                </c:pt>
                <c:pt idx="363">
                  <c:v>1.0142798240568298</c:v>
                </c:pt>
                <c:pt idx="364">
                  <c:v>1.0142798240568298</c:v>
                </c:pt>
                <c:pt idx="365">
                  <c:v>1.0145577502389478</c:v>
                </c:pt>
                <c:pt idx="366">
                  <c:v>1.0145577502389478</c:v>
                </c:pt>
                <c:pt idx="367">
                  <c:v>1.0145577502389478</c:v>
                </c:pt>
                <c:pt idx="368">
                  <c:v>1.014834620245578</c:v>
                </c:pt>
                <c:pt idx="369">
                  <c:v>1.014834620245578</c:v>
                </c:pt>
                <c:pt idx="370">
                  <c:v>1.0151104423585866</c:v>
                </c:pt>
                <c:pt idx="371">
                  <c:v>1.015385224761701</c:v>
                </c:pt>
                <c:pt idx="372">
                  <c:v>1.0159317026917469</c:v>
                </c:pt>
                <c:pt idx="373">
                  <c:v>1.0159317026917469</c:v>
                </c:pt>
                <c:pt idx="374">
                  <c:v>1.0159317026917469</c:v>
                </c:pt>
                <c:pt idx="375">
                  <c:v>1.0159317026917469</c:v>
                </c:pt>
                <c:pt idx="376">
                  <c:v>1.0159317026917469</c:v>
                </c:pt>
                <c:pt idx="377">
                  <c:v>1.0159317026917469</c:v>
                </c:pt>
                <c:pt idx="378">
                  <c:v>1.0159317026917469</c:v>
                </c:pt>
                <c:pt idx="379">
                  <c:v>1.016203414109262</c:v>
                </c:pt>
                <c:pt idx="380">
                  <c:v>1.016203414109262</c:v>
                </c:pt>
                <c:pt idx="381">
                  <c:v>1.016203414109262</c:v>
                </c:pt>
                <c:pt idx="382">
                  <c:v>1.016203414109262</c:v>
                </c:pt>
                <c:pt idx="383">
                  <c:v>1.0164741176010048</c:v>
                </c:pt>
                <c:pt idx="384">
                  <c:v>1.0164741176010048</c:v>
                </c:pt>
                <c:pt idx="385">
                  <c:v>1.0167438208827004</c:v>
                </c:pt>
                <c:pt idx="386">
                  <c:v>1.017012531580807</c:v>
                </c:pt>
                <c:pt idx="387">
                  <c:v>1.017012531580807</c:v>
                </c:pt>
                <c:pt idx="388">
                  <c:v>1.0172802572338955</c:v>
                </c:pt>
                <c:pt idx="389">
                  <c:v>1.0175470052940021</c:v>
                </c:pt>
                <c:pt idx="390">
                  <c:v>1.0175470052940021</c:v>
                </c:pt>
                <c:pt idx="391">
                  <c:v>1.0178127831279558</c:v>
                </c:pt>
                <c:pt idx="392">
                  <c:v>1.0180775980186796</c:v>
                </c:pt>
                <c:pt idx="393">
                  <c:v>1.0180775980186796</c:v>
                </c:pt>
                <c:pt idx="394">
                  <c:v>1.018866336628742</c:v>
                </c:pt>
                <c:pt idx="395">
                  <c:v>1.0191273709418216</c:v>
                </c:pt>
                <c:pt idx="396">
                  <c:v>1.0193874775115328</c:v>
                </c:pt>
                <c:pt idx="397">
                  <c:v>1.0193874775115328</c:v>
                </c:pt>
                <c:pt idx="398">
                  <c:v>1.0196466631433383</c:v>
                </c:pt>
                <c:pt idx="399">
                  <c:v>1.0196466631433383</c:v>
                </c:pt>
                <c:pt idx="400">
                  <c:v>1.0199049345672395</c:v>
                </c:pt>
                <c:pt idx="401">
                  <c:v>1.0201622984388947</c:v>
                </c:pt>
                <c:pt idx="402">
                  <c:v>1.0201622984388947</c:v>
                </c:pt>
                <c:pt idx="403">
                  <c:v>1.0201622984388947</c:v>
                </c:pt>
                <c:pt idx="404">
                  <c:v>1.0201622984388947</c:v>
                </c:pt>
                <c:pt idx="405">
                  <c:v>1.0204187613407163</c:v>
                </c:pt>
                <c:pt idx="406">
                  <c:v>1.0206743297829464</c:v>
                </c:pt>
                <c:pt idx="407">
                  <c:v>1.0209290102047159</c:v>
                </c:pt>
                <c:pt idx="408">
                  <c:v>1.0214357323940402</c:v>
                </c:pt>
                <c:pt idx="409">
                  <c:v>1.0216877866935401</c:v>
                </c:pt>
                <c:pt idx="410">
                  <c:v>1.0216877866935401</c:v>
                </c:pt>
                <c:pt idx="411">
                  <c:v>1.021938978038452</c:v>
                </c:pt>
                <c:pt idx="412">
                  <c:v>1.0226874350084108</c:v>
                </c:pt>
                <c:pt idx="413">
                  <c:v>1.023182201639657</c:v>
                </c:pt>
                <c:pt idx="414">
                  <c:v>1.023182201639657</c:v>
                </c:pt>
                <c:pt idx="415">
                  <c:v>1.023428341082619</c:v>
                </c:pt>
                <c:pt idx="416">
                  <c:v>1.0236736589259248</c:v>
                </c:pt>
                <c:pt idx="417">
                  <c:v>1.0239181608311718</c:v>
                </c:pt>
                <c:pt idx="418">
                  <c:v>1.0241618524009715</c:v>
                </c:pt>
                <c:pt idx="419">
                  <c:v>1.0241618524009715</c:v>
                </c:pt>
                <c:pt idx="420">
                  <c:v>1.0244047391797695</c:v>
                </c:pt>
                <c:pt idx="421">
                  <c:v>1.0244047391797695</c:v>
                </c:pt>
                <c:pt idx="422">
                  <c:v>1.0246468266546531</c:v>
                </c:pt>
                <c:pt idx="423">
                  <c:v>1.024888120256144</c:v>
                </c:pt>
                <c:pt idx="424">
                  <c:v>1.024888120256144</c:v>
                </c:pt>
                <c:pt idx="425">
                  <c:v>1.0251286253589775</c:v>
                </c:pt>
                <c:pt idx="426">
                  <c:v>1.0251286253589775</c:v>
                </c:pt>
                <c:pt idx="427">
                  <c:v>1.0253683472828687</c:v>
                </c:pt>
                <c:pt idx="428">
                  <c:v>1.0253683472828687</c:v>
                </c:pt>
                <c:pt idx="429">
                  <c:v>1.0253683472828687</c:v>
                </c:pt>
                <c:pt idx="430">
                  <c:v>1.0256072912932641</c:v>
                </c:pt>
                <c:pt idx="431">
                  <c:v>1.026082866368442</c:v>
                </c:pt>
                <c:pt idx="432">
                  <c:v>1.0265553916505261</c:v>
                </c:pt>
                <c:pt idx="433">
                  <c:v>1.0267905232268546</c:v>
                </c:pt>
                <c:pt idx="434">
                  <c:v>1.0270249073833015</c:v>
                </c:pt>
                <c:pt idx="435">
                  <c:v>1.0272585490254642</c:v>
                </c:pt>
                <c:pt idx="436">
                  <c:v>1.0272585490254642</c:v>
                </c:pt>
                <c:pt idx="437">
                  <c:v>1.0274914530102506</c:v>
                </c:pt>
                <c:pt idx="438">
                  <c:v>1.0277236241465264</c:v>
                </c:pt>
                <c:pt idx="439">
                  <c:v>1.0279550671957494</c:v>
                </c:pt>
                <c:pt idx="440">
                  <c:v>1.0286450747376088</c:v>
                </c:pt>
                <c:pt idx="441">
                  <c:v>1.0286450747376088</c:v>
                </c:pt>
                <c:pt idx="442">
                  <c:v>1.0288736521266912</c:v>
                </c:pt>
                <c:pt idx="443">
                  <c:v>1.0288736521266912</c:v>
                </c:pt>
                <c:pt idx="444">
                  <c:v>1.0288736521266912</c:v>
                </c:pt>
                <c:pt idx="445">
                  <c:v>1.0288736521266912</c:v>
                </c:pt>
                <c:pt idx="446">
                  <c:v>1.0288736521266912</c:v>
                </c:pt>
                <c:pt idx="447">
                  <c:v>1.0288736521266912</c:v>
                </c:pt>
                <c:pt idx="448">
                  <c:v>1.0291015245463997</c:v>
                </c:pt>
                <c:pt idx="449">
                  <c:v>1.0293286964865098</c:v>
                </c:pt>
                <c:pt idx="450">
                  <c:v>1.0295551723935519</c:v>
                </c:pt>
                <c:pt idx="451">
                  <c:v>1.0295551723935519</c:v>
                </c:pt>
                <c:pt idx="452">
                  <c:v>1.0295551723935519</c:v>
                </c:pt>
                <c:pt idx="453">
                  <c:v>1.0295551723935519</c:v>
                </c:pt>
                <c:pt idx="454">
                  <c:v>1.0297809566713694</c:v>
                </c:pt>
                <c:pt idx="455">
                  <c:v>1.0300060536816651</c:v>
                </c:pt>
                <c:pt idx="456">
                  <c:v>1.0302304677445409</c:v>
                </c:pt>
                <c:pt idx="457">
                  <c:v>1.0302304677445409</c:v>
                </c:pt>
                <c:pt idx="458">
                  <c:v>1.0302304677445409</c:v>
                </c:pt>
                <c:pt idx="459">
                  <c:v>1.0304542031390278</c:v>
                </c:pt>
                <c:pt idx="460">
                  <c:v>1.0306772641036079</c:v>
                </c:pt>
                <c:pt idx="461">
                  <c:v>1.0306772641036079</c:v>
                </c:pt>
                <c:pt idx="462">
                  <c:v>1.0306772641036079</c:v>
                </c:pt>
                <c:pt idx="463">
                  <c:v>1.0308996548367284</c:v>
                </c:pt>
                <c:pt idx="464">
                  <c:v>1.0308996548367284</c:v>
                </c:pt>
                <c:pt idx="465">
                  <c:v>1.0311213794973062</c:v>
                </c:pt>
                <c:pt idx="466">
                  <c:v>1.031342442205226</c:v>
                </c:pt>
                <c:pt idx="467">
                  <c:v>1.0317825980503998</c:v>
                </c:pt>
                <c:pt idx="468">
                  <c:v>1.0317825980503998</c:v>
                </c:pt>
                <c:pt idx="469">
                  <c:v>1.0324379679797189</c:v>
                </c:pt>
                <c:pt idx="470">
                  <c:v>1.0326551433642033</c:v>
                </c:pt>
                <c:pt idx="471">
                  <c:v>1.0328716845824994</c:v>
                </c:pt>
                <c:pt idx="472">
                  <c:v>1.0328716845824994</c:v>
                </c:pt>
                <c:pt idx="473">
                  <c:v>1.0328716845824994</c:v>
                </c:pt>
                <c:pt idx="474">
                  <c:v>1.0330875954592345</c:v>
                </c:pt>
                <c:pt idx="475">
                  <c:v>1.0330875954592345</c:v>
                </c:pt>
                <c:pt idx="476">
                  <c:v>1.0335175413125017</c:v>
                </c:pt>
                <c:pt idx="477">
                  <c:v>1.0335175413125017</c:v>
                </c:pt>
                <c:pt idx="478">
                  <c:v>1.0335175413125017</c:v>
                </c:pt>
                <c:pt idx="479">
                  <c:v>1.0337315837655319</c:v>
                </c:pt>
                <c:pt idx="480">
                  <c:v>1.0337315837655319</c:v>
                </c:pt>
                <c:pt idx="481">
                  <c:v>1.0337315837655319</c:v>
                </c:pt>
                <c:pt idx="482">
                  <c:v>1.0339450108308279</c:v>
                </c:pt>
                <c:pt idx="483">
                  <c:v>1.0339450108308279</c:v>
                </c:pt>
                <c:pt idx="484">
                  <c:v>1.0341578261627566</c:v>
                </c:pt>
                <c:pt idx="485">
                  <c:v>1.0343700333828576</c:v>
                </c:pt>
                <c:pt idx="486">
                  <c:v>1.0345816360802389</c:v>
                </c:pt>
                <c:pt idx="487">
                  <c:v>1.0345816360802389</c:v>
                </c:pt>
                <c:pt idx="488">
                  <c:v>1.0347926378119643</c:v>
                </c:pt>
                <c:pt idx="489">
                  <c:v>1.0350030421034357</c:v>
                </c:pt>
                <c:pt idx="490">
                  <c:v>1.0350030421034357</c:v>
                </c:pt>
                <c:pt idx="491">
                  <c:v>1.0352128524487711</c:v>
                </c:pt>
                <c:pt idx="492">
                  <c:v>1.0356307051233014</c:v>
                </c:pt>
                <c:pt idx="493">
                  <c:v>1.0358387542876208</c:v>
                </c:pt>
                <c:pt idx="494">
                  <c:v>1.0364594334730197</c:v>
                </c:pt>
                <c:pt idx="495">
                  <c:v>1.0366651814793528</c:v>
                </c:pt>
                <c:pt idx="496">
                  <c:v>1.0370749794925189</c:v>
                </c:pt>
                <c:pt idx="497">
                  <c:v>1.0372790359287749</c:v>
                </c:pt>
                <c:pt idx="498">
                  <c:v>1.0374825348917327</c:v>
                </c:pt>
                <c:pt idx="499">
                  <c:v>1.0374825348917327</c:v>
                </c:pt>
                <c:pt idx="500">
                  <c:v>1.0378878729554664</c:v>
                </c:pt>
                <c:pt idx="501">
                  <c:v>1.0378878729554664</c:v>
                </c:pt>
                <c:pt idx="502">
                  <c:v>1.0378878729554664</c:v>
                </c:pt>
                <c:pt idx="503">
                  <c:v>1.0380897182682485</c:v>
                </c:pt>
                <c:pt idx="504">
                  <c:v>1.0382910185323544</c:v>
                </c:pt>
                <c:pt idx="505">
                  <c:v>1.0384917767883</c:v>
                </c:pt>
                <c:pt idx="506">
                  <c:v>1.0386919960509398</c:v>
                </c:pt>
                <c:pt idx="507">
                  <c:v>1.0386919960509398</c:v>
                </c:pt>
                <c:pt idx="508">
                  <c:v>1.0386919960509398</c:v>
                </c:pt>
                <c:pt idx="509">
                  <c:v>1.0386919960509398</c:v>
                </c:pt>
                <c:pt idx="510">
                  <c:v>1.0386919960509398</c:v>
                </c:pt>
                <c:pt idx="511">
                  <c:v>1.0390908295291423</c:v>
                </c:pt>
                <c:pt idx="512">
                  <c:v>1.0396851112242631</c:v>
                </c:pt>
                <c:pt idx="513">
                  <c:v>1.0396851112242631</c:v>
                </c:pt>
                <c:pt idx="514">
                  <c:v>1.0398821584379203</c:v>
                </c:pt>
                <c:pt idx="515">
                  <c:v>1.0398821584379203</c:v>
                </c:pt>
                <c:pt idx="516">
                  <c:v>1.0402746999327668</c:v>
                </c:pt>
                <c:pt idx="517">
                  <c:v>1.040470199830059</c:v>
                </c:pt>
                <c:pt idx="518">
                  <c:v>1.0406651895329257</c:v>
                </c:pt>
                <c:pt idx="519">
                  <c:v>1.0408596717921883</c:v>
                </c:pt>
                <c:pt idx="520">
                  <c:v>1.0410536493362255</c:v>
                </c:pt>
                <c:pt idx="521">
                  <c:v>1.0410536493362255</c:v>
                </c:pt>
                <c:pt idx="522">
                  <c:v>1.0412471248712194</c:v>
                </c:pt>
                <c:pt idx="523">
                  <c:v>1.0414401010813965</c:v>
                </c:pt>
                <c:pt idx="524">
                  <c:v>1.0416325806292657</c:v>
                </c:pt>
                <c:pt idx="525">
                  <c:v>1.0418245661558536</c:v>
                </c:pt>
                <c:pt idx="526">
                  <c:v>1.0422070656032674</c:v>
                </c:pt>
                <c:pt idx="527">
                  <c:v>1.0422070656032674</c:v>
                </c:pt>
                <c:pt idx="528">
                  <c:v>1.0423975847008049</c:v>
                </c:pt>
                <c:pt idx="529">
                  <c:v>1.0425876201309325</c:v>
                </c:pt>
                <c:pt idx="530">
                  <c:v>1.0427771744306797</c:v>
                </c:pt>
                <c:pt idx="531">
                  <c:v>1.0427771744306797</c:v>
                </c:pt>
                <c:pt idx="532">
                  <c:v>1.0431548496866772</c:v>
                </c:pt>
                <c:pt idx="533">
                  <c:v>1.0439045360541885</c:v>
                </c:pt>
                <c:pt idx="534">
                  <c:v>1.0440907918131215</c:v>
                </c:pt>
                <c:pt idx="535">
                  <c:v>1.0440907918131215</c:v>
                </c:pt>
                <c:pt idx="536">
                  <c:v>1.0446467992756592</c:v>
                </c:pt>
                <c:pt idx="537">
                  <c:v>1.0448312229750794</c:v>
                </c:pt>
                <c:pt idx="538">
                  <c:v>1.04538179003473</c:v>
                </c:pt>
                <c:pt idx="539">
                  <c:v>1.0455644186204762</c:v>
                </c:pt>
                <c:pt idx="540">
                  <c:v>1.046290523721171</c:v>
                </c:pt>
                <c:pt idx="541">
                  <c:v>1.0464709586697551</c:v>
                </c:pt>
                <c:pt idx="542">
                  <c:v>1.0466509614233528</c:v>
                </c:pt>
                <c:pt idx="543">
                  <c:v>1.0470096788868413</c:v>
                </c:pt>
                <c:pt idx="544">
                  <c:v>1.0471883978274525</c:v>
                </c:pt>
                <c:pt idx="545">
                  <c:v>1.0471883978274525</c:v>
                </c:pt>
                <c:pt idx="546">
                  <c:v>1.0478990569424937</c:v>
                </c:pt>
                <c:pt idx="547">
                  <c:v>1.0478990569424937</c:v>
                </c:pt>
                <c:pt idx="548">
                  <c:v>1.0478990569424937</c:v>
                </c:pt>
                <c:pt idx="549">
                  <c:v>1.0480756778254614</c:v>
                </c:pt>
                <c:pt idx="550">
                  <c:v>1.0480756778254614</c:v>
                </c:pt>
                <c:pt idx="551">
                  <c:v>1.0484276810776139</c:v>
                </c:pt>
                <c:pt idx="552">
                  <c:v>1.0487780462429175</c:v>
                </c:pt>
                <c:pt idx="553">
                  <c:v>1.048952619462918</c:v>
                </c:pt>
                <c:pt idx="554">
                  <c:v>1.048952619462918</c:v>
                </c:pt>
                <c:pt idx="555">
                  <c:v>1.0491267890364866</c:v>
                </c:pt>
                <c:pt idx="556">
                  <c:v>1.0493005568924803</c:v>
                </c:pt>
                <c:pt idx="557">
                  <c:v>1.0499916492323909</c:v>
                </c:pt>
                <c:pt idx="558">
                  <c:v>1.0508467017666578</c:v>
                </c:pt>
                <c:pt idx="559">
                  <c:v>1.0510165555303657</c:v>
                </c:pt>
                <c:pt idx="560">
                  <c:v>1.0511860279020637</c:v>
                </c:pt>
                <c:pt idx="561">
                  <c:v>1.0511860279020637</c:v>
                </c:pt>
                <c:pt idx="562">
                  <c:v>1.0515238355370169</c:v>
                </c:pt>
                <c:pt idx="563">
                  <c:v>1.0521949511564448</c:v>
                </c:pt>
                <c:pt idx="564">
                  <c:v>1.0528601583960004</c:v>
                </c:pt>
                <c:pt idx="565">
                  <c:v>1.0531905798507959</c:v>
                </c:pt>
                <c:pt idx="566">
                  <c:v>1.0531905798507959</c:v>
                </c:pt>
                <c:pt idx="567">
                  <c:v>1.0536835211529267</c:v>
                </c:pt>
                <c:pt idx="568">
                  <c:v>1.0543358204761502</c:v>
                </c:pt>
                <c:pt idx="569">
                  <c:v>1.0543358204761502</c:v>
                </c:pt>
                <c:pt idx="570">
                  <c:v>1.0548213830539264</c:v>
                </c:pt>
                <c:pt idx="571">
                  <c:v>1.0548213830539264</c:v>
                </c:pt>
                <c:pt idx="572">
                  <c:v>1.0553038528797285</c:v>
                </c:pt>
                <c:pt idx="573">
                  <c:v>1.0556238012857457</c:v>
                </c:pt>
                <c:pt idx="574">
                  <c:v>1.0556238012857457</c:v>
                </c:pt>
                <c:pt idx="575">
                  <c:v>1.0556238012857457</c:v>
                </c:pt>
                <c:pt idx="576">
                  <c:v>1.0567331072239152</c:v>
                </c:pt>
                <c:pt idx="577">
                  <c:v>1.0581359391754208</c:v>
                </c:pt>
                <c:pt idx="578">
                  <c:v>1.0581359391754208</c:v>
                </c:pt>
                <c:pt idx="579">
                  <c:v>1.0581359391754208</c:v>
                </c:pt>
                <c:pt idx="580">
                  <c:v>1.0582902220390038</c:v>
                </c:pt>
                <c:pt idx="581">
                  <c:v>1.0589042407750635</c:v>
                </c:pt>
                <c:pt idx="582">
                  <c:v>1.0590569737635356</c:v>
                </c:pt>
                <c:pt idx="583">
                  <c:v>1.0599669874328947</c:v>
                </c:pt>
                <c:pt idx="584">
                  <c:v>1.0601176039886195</c:v>
                </c:pt>
                <c:pt idx="585">
                  <c:v>1.060567674108444</c:v>
                </c:pt>
                <c:pt idx="586">
                  <c:v>1.061015100167386</c:v>
                </c:pt>
                <c:pt idx="587">
                  <c:v>1.0620489904004125</c:v>
                </c:pt>
                <c:pt idx="588">
                  <c:v>1.0629241612782827</c:v>
                </c:pt>
                <c:pt idx="589">
                  <c:v>1.063932671516417</c:v>
                </c:pt>
                <c:pt idx="590">
                  <c:v>1.0652100704040877</c:v>
                </c:pt>
                <c:pt idx="591">
                  <c:v>1.0661890603923527</c:v>
                </c:pt>
                <c:pt idx="592">
                  <c:v>1.066742913107545</c:v>
                </c:pt>
                <c:pt idx="593">
                  <c:v>1.0677026242723158</c:v>
                </c:pt>
                <c:pt idx="594">
                  <c:v>1.0718141866119901</c:v>
                </c:pt>
                <c:pt idx="595">
                  <c:v>1.0724572256539335</c:v>
                </c:pt>
                <c:pt idx="596">
                  <c:v>1.0748529748349003</c:v>
                </c:pt>
                <c:pt idx="597">
                  <c:v>1.0758398717132465</c:v>
                </c:pt>
                <c:pt idx="598">
                  <c:v>1.0809389386010504</c:v>
                </c:pt>
              </c:numCache>
            </c:numRef>
          </c:xVal>
          <c:yVal>
            <c:numRef>
              <c:f>datat!$J$2:$J$600</c:f>
              <c:numCache>
                <c:formatCode>General</c:formatCode>
                <c:ptCount val="599"/>
                <c:pt idx="0">
                  <c:v>0.85596041541796453</c:v>
                </c:pt>
                <c:pt idx="1">
                  <c:v>0.85596041541796453</c:v>
                </c:pt>
                <c:pt idx="2">
                  <c:v>0.86418611042803684</c:v>
                </c:pt>
                <c:pt idx="3">
                  <c:v>0.86418611042803684</c:v>
                </c:pt>
                <c:pt idx="4">
                  <c:v>0.86577127534425125</c:v>
                </c:pt>
                <c:pt idx="5">
                  <c:v>0.86733760285118211</c:v>
                </c:pt>
                <c:pt idx="6">
                  <c:v>0.86733760285118211</c:v>
                </c:pt>
                <c:pt idx="7">
                  <c:v>0.8704155607935713</c:v>
                </c:pt>
                <c:pt idx="8">
                  <c:v>0.8704155607935713</c:v>
                </c:pt>
                <c:pt idx="9">
                  <c:v>0.87490214049023352</c:v>
                </c:pt>
                <c:pt idx="10">
                  <c:v>0.87490214049023352</c:v>
                </c:pt>
                <c:pt idx="11">
                  <c:v>0.87490214049023352</c:v>
                </c:pt>
                <c:pt idx="12">
                  <c:v>0.87636450396171872</c:v>
                </c:pt>
                <c:pt idx="13">
                  <c:v>0.87781091194795824</c:v>
                </c:pt>
                <c:pt idx="14">
                  <c:v>0.87781091194795824</c:v>
                </c:pt>
                <c:pt idx="15">
                  <c:v>0.87781091194795824</c:v>
                </c:pt>
                <c:pt idx="16">
                  <c:v>0.87781091194795824</c:v>
                </c:pt>
                <c:pt idx="17">
                  <c:v>0.87924172095818642</c:v>
                </c:pt>
                <c:pt idx="18">
                  <c:v>0.87924172095818642</c:v>
                </c:pt>
                <c:pt idx="19">
                  <c:v>0.88065727555280482</c:v>
                </c:pt>
                <c:pt idx="20">
                  <c:v>0.88065727555280482</c:v>
                </c:pt>
                <c:pt idx="21">
                  <c:v>0.88065727555280482</c:v>
                </c:pt>
                <c:pt idx="22">
                  <c:v>0.88065727555280482</c:v>
                </c:pt>
                <c:pt idx="23">
                  <c:v>0.88065727555280482</c:v>
                </c:pt>
                <c:pt idx="24">
                  <c:v>0.88205790887434254</c:v>
                </c:pt>
                <c:pt idx="25">
                  <c:v>0.88205790887434254</c:v>
                </c:pt>
                <c:pt idx="26">
                  <c:v>0.88344394314915564</c:v>
                </c:pt>
                <c:pt idx="27">
                  <c:v>0.8861734517037092</c:v>
                </c:pt>
                <c:pt idx="28">
                  <c:v>0.8861734517037092</c:v>
                </c:pt>
                <c:pt idx="29">
                  <c:v>0.88751751999825812</c:v>
                </c:pt>
                <c:pt idx="30">
                  <c:v>0.88884817810298777</c:v>
                </c:pt>
                <c:pt idx="31">
                  <c:v>0.88884817810298777</c:v>
                </c:pt>
                <c:pt idx="32">
                  <c:v>0.88884817810298777</c:v>
                </c:pt>
                <c:pt idx="33">
                  <c:v>0.88884817810298777</c:v>
                </c:pt>
                <c:pt idx="34">
                  <c:v>0.88884817810298777</c:v>
                </c:pt>
                <c:pt idx="35">
                  <c:v>0.8901657002911445</c:v>
                </c:pt>
                <c:pt idx="36">
                  <c:v>0.89276239224104237</c:v>
                </c:pt>
                <c:pt idx="37">
                  <c:v>0.89276239224104237</c:v>
                </c:pt>
                <c:pt idx="38">
                  <c:v>0.89276239224104237</c:v>
                </c:pt>
                <c:pt idx="39">
                  <c:v>0.894042069791954</c:v>
                </c:pt>
                <c:pt idx="40">
                  <c:v>0.894042069791954</c:v>
                </c:pt>
                <c:pt idx="41">
                  <c:v>0.89530962764006894</c:v>
                </c:pt>
                <c:pt idx="42">
                  <c:v>0.89530962764006894</c:v>
                </c:pt>
                <c:pt idx="43">
                  <c:v>0.89780931905497385</c:v>
                </c:pt>
                <c:pt idx="44">
                  <c:v>0.89780931905497385</c:v>
                </c:pt>
                <c:pt idx="45">
                  <c:v>0.89780931905497385</c:v>
                </c:pt>
                <c:pt idx="46">
                  <c:v>0.89904190312666188</c:v>
                </c:pt>
                <c:pt idx="47">
                  <c:v>0.90026326902489173</c:v>
                </c:pt>
                <c:pt idx="48">
                  <c:v>0.90147362624076677</c:v>
                </c:pt>
                <c:pt idx="49">
                  <c:v>0.90147362624076677</c:v>
                </c:pt>
                <c:pt idx="50">
                  <c:v>0.90147362624076677</c:v>
                </c:pt>
                <c:pt idx="51">
                  <c:v>0.90267317838620342</c:v>
                </c:pt>
                <c:pt idx="52">
                  <c:v>0.90267317838620342</c:v>
                </c:pt>
                <c:pt idx="53">
                  <c:v>0.90267317838620342</c:v>
                </c:pt>
                <c:pt idx="54">
                  <c:v>0.90267317838620342</c:v>
                </c:pt>
                <c:pt idx="55">
                  <c:v>0.90386212341308503</c:v>
                </c:pt>
                <c:pt idx="56">
                  <c:v>0.90386212341308503</c:v>
                </c:pt>
                <c:pt idx="57">
                  <c:v>0.90386212341308503</c:v>
                </c:pt>
                <c:pt idx="58">
                  <c:v>0.90504065382226395</c:v>
                </c:pt>
                <c:pt idx="59">
                  <c:v>0.90620895686297653</c:v>
                </c:pt>
                <c:pt idx="60">
                  <c:v>0.90620895686297653</c:v>
                </c:pt>
                <c:pt idx="61">
                  <c:v>0.90620895686297653</c:v>
                </c:pt>
                <c:pt idx="62">
                  <c:v>0.90851560471137538</c:v>
                </c:pt>
                <c:pt idx="63">
                  <c:v>0.90851560471137538</c:v>
                </c:pt>
                <c:pt idx="64">
                  <c:v>0.90965429943016729</c:v>
                </c:pt>
                <c:pt idx="65">
                  <c:v>0.90965429943016729</c:v>
                </c:pt>
                <c:pt idx="66">
                  <c:v>0.90965429943016729</c:v>
                </c:pt>
                <c:pt idx="67">
                  <c:v>0.91078346694234025</c:v>
                </c:pt>
                <c:pt idx="68">
                  <c:v>0.91078346694234025</c:v>
                </c:pt>
                <c:pt idx="69">
                  <c:v>0.91078346694234025</c:v>
                </c:pt>
                <c:pt idx="70">
                  <c:v>0.91190327092950807</c:v>
                </c:pt>
                <c:pt idx="71">
                  <c:v>0.91190327092950807</c:v>
                </c:pt>
                <c:pt idx="72">
                  <c:v>0.91190327092950807</c:v>
                </c:pt>
                <c:pt idx="73">
                  <c:v>0.91301387084392616</c:v>
                </c:pt>
                <c:pt idx="74">
                  <c:v>0.91301387084392616</c:v>
                </c:pt>
                <c:pt idx="75">
                  <c:v>0.91411542205375462</c:v>
                </c:pt>
                <c:pt idx="76">
                  <c:v>0.91520807598211773</c:v>
                </c:pt>
                <c:pt idx="77">
                  <c:v>0.91520807598211773</c:v>
                </c:pt>
                <c:pt idx="78">
                  <c:v>0.91520807598211773</c:v>
                </c:pt>
                <c:pt idx="79">
                  <c:v>0.91520807598211773</c:v>
                </c:pt>
                <c:pt idx="80">
                  <c:v>0.91520807598211773</c:v>
                </c:pt>
                <c:pt idx="81">
                  <c:v>0.91629198024027447</c:v>
                </c:pt>
                <c:pt idx="82">
                  <c:v>0.91629198024027447</c:v>
                </c:pt>
                <c:pt idx="83">
                  <c:v>0.91629198024027447</c:v>
                </c:pt>
                <c:pt idx="84">
                  <c:v>0.91736727875520008</c:v>
                </c:pt>
                <c:pt idx="85">
                  <c:v>0.91843411189185642</c:v>
                </c:pt>
                <c:pt idx="86">
                  <c:v>0.91843411189185642</c:v>
                </c:pt>
                <c:pt idx="87">
                  <c:v>0.91949261657041559</c:v>
                </c:pt>
                <c:pt idx="88">
                  <c:v>0.91949261657041559</c:v>
                </c:pt>
                <c:pt idx="89">
                  <c:v>0.91949261657041559</c:v>
                </c:pt>
                <c:pt idx="90">
                  <c:v>0.92054292637868396</c:v>
                </c:pt>
                <c:pt idx="91">
                  <c:v>0.92054292637868396</c:v>
                </c:pt>
                <c:pt idx="92">
                  <c:v>0.92054292637868396</c:v>
                </c:pt>
                <c:pt idx="93">
                  <c:v>0.92158517167996412</c:v>
                </c:pt>
                <c:pt idx="94">
                  <c:v>0.92158517167996412</c:v>
                </c:pt>
                <c:pt idx="95">
                  <c:v>0.92158517167996412</c:v>
                </c:pt>
                <c:pt idx="96">
                  <c:v>0.92261947971657166</c:v>
                </c:pt>
                <c:pt idx="97">
                  <c:v>0.92261947971657166</c:v>
                </c:pt>
                <c:pt idx="98">
                  <c:v>0.92261947971657166</c:v>
                </c:pt>
                <c:pt idx="99">
                  <c:v>0.92261947971657166</c:v>
                </c:pt>
                <c:pt idx="100">
                  <c:v>0.92364597470921761</c:v>
                </c:pt>
                <c:pt idx="101">
                  <c:v>0.92364597470921761</c:v>
                </c:pt>
                <c:pt idx="102">
                  <c:v>0.92466477795245594</c:v>
                </c:pt>
                <c:pt idx="103">
                  <c:v>0.92466477795245594</c:v>
                </c:pt>
                <c:pt idx="104">
                  <c:v>0.92466477795245594</c:v>
                </c:pt>
                <c:pt idx="105">
                  <c:v>0.92567600790637572</c:v>
                </c:pt>
                <c:pt idx="106">
                  <c:v>0.92567600790637572</c:v>
                </c:pt>
                <c:pt idx="107">
                  <c:v>0.92667978028472131</c:v>
                </c:pt>
                <c:pt idx="108">
                  <c:v>0.92667978028472131</c:v>
                </c:pt>
                <c:pt idx="109">
                  <c:v>0.92767620813960128</c:v>
                </c:pt>
                <c:pt idx="110">
                  <c:v>0.92866540194294656</c:v>
                </c:pt>
                <c:pt idx="111">
                  <c:v>0.92866540194294656</c:v>
                </c:pt>
                <c:pt idx="112">
                  <c:v>0.92866540194294656</c:v>
                </c:pt>
                <c:pt idx="113">
                  <c:v>0.929647469664866</c:v>
                </c:pt>
                <c:pt idx="114">
                  <c:v>0.929647469664866</c:v>
                </c:pt>
                <c:pt idx="115">
                  <c:v>0.929647469664866</c:v>
                </c:pt>
                <c:pt idx="116">
                  <c:v>0.929647469664866</c:v>
                </c:pt>
                <c:pt idx="117">
                  <c:v>0.93062251684903985</c:v>
                </c:pt>
                <c:pt idx="118">
                  <c:v>0.93159064668528524</c:v>
                </c:pt>
                <c:pt idx="119">
                  <c:v>0.93255196007942054</c:v>
                </c:pt>
                <c:pt idx="120">
                  <c:v>0.93350655572054753</c:v>
                </c:pt>
                <c:pt idx="121">
                  <c:v>0.93350655572054753</c:v>
                </c:pt>
                <c:pt idx="122">
                  <c:v>0.93350655572054753</c:v>
                </c:pt>
                <c:pt idx="123">
                  <c:v>0.93350655572054753</c:v>
                </c:pt>
                <c:pt idx="124">
                  <c:v>0.93350655572054753</c:v>
                </c:pt>
                <c:pt idx="125">
                  <c:v>0.93539597780313688</c:v>
                </c:pt>
                <c:pt idx="126">
                  <c:v>0.93633099111086548</c:v>
                </c:pt>
                <c:pt idx="127">
                  <c:v>0.93633099111086548</c:v>
                </c:pt>
                <c:pt idx="128">
                  <c:v>0.93633099111086548</c:v>
                </c:pt>
                <c:pt idx="129">
                  <c:v>0.93725966051635634</c:v>
                </c:pt>
                <c:pt idx="130">
                  <c:v>0.93725966051635634</c:v>
                </c:pt>
                <c:pt idx="131">
                  <c:v>0.93725966051635634</c:v>
                </c:pt>
                <c:pt idx="132">
                  <c:v>0.93725966051635634</c:v>
                </c:pt>
                <c:pt idx="133">
                  <c:v>0.93725966051635634</c:v>
                </c:pt>
                <c:pt idx="134">
                  <c:v>0.93818207455167735</c:v>
                </c:pt>
                <c:pt idx="135">
                  <c:v>0.93818207455167735</c:v>
                </c:pt>
                <c:pt idx="136">
                  <c:v>0.93909831988765502</c:v>
                </c:pt>
                <c:pt idx="137">
                  <c:v>0.93909831988765502</c:v>
                </c:pt>
                <c:pt idx="138">
                  <c:v>0.93909831988765502</c:v>
                </c:pt>
                <c:pt idx="139">
                  <c:v>0.93909831988765502</c:v>
                </c:pt>
                <c:pt idx="140">
                  <c:v>0.93909831988765502</c:v>
                </c:pt>
                <c:pt idx="141">
                  <c:v>0.94000848138597193</c:v>
                </c:pt>
                <c:pt idx="142">
                  <c:v>0.94000848138597193</c:v>
                </c:pt>
                <c:pt idx="143">
                  <c:v>0.94091264214944759</c:v>
                </c:pt>
                <c:pt idx="144">
                  <c:v>0.94091264214944759</c:v>
                </c:pt>
                <c:pt idx="145">
                  <c:v>0.94091264214944759</c:v>
                </c:pt>
                <c:pt idx="146">
                  <c:v>0.9418108835705794</c:v>
                </c:pt>
                <c:pt idx="147">
                  <c:v>0.9418108835705794</c:v>
                </c:pt>
                <c:pt idx="148">
                  <c:v>0.9418108835705794</c:v>
                </c:pt>
                <c:pt idx="149">
                  <c:v>0.9418108835705794</c:v>
                </c:pt>
                <c:pt idx="150">
                  <c:v>0.9418108835705794</c:v>
                </c:pt>
                <c:pt idx="151">
                  <c:v>0.94270328537841586</c:v>
                </c:pt>
                <c:pt idx="152">
                  <c:v>0.94270328537841586</c:v>
                </c:pt>
                <c:pt idx="153">
                  <c:v>0.94270328537841586</c:v>
                </c:pt>
                <c:pt idx="154">
                  <c:v>0.9435899256838276</c:v>
                </c:pt>
                <c:pt idx="155">
                  <c:v>0.9435899256838276</c:v>
                </c:pt>
                <c:pt idx="156">
                  <c:v>0.9435899256838276</c:v>
                </c:pt>
                <c:pt idx="157">
                  <c:v>0.9435899256838276</c:v>
                </c:pt>
                <c:pt idx="158">
                  <c:v>0.9435899256838276</c:v>
                </c:pt>
                <c:pt idx="159">
                  <c:v>0.9444708810232465</c:v>
                </c:pt>
                <c:pt idx="160">
                  <c:v>0.9444708810232465</c:v>
                </c:pt>
                <c:pt idx="161">
                  <c:v>0.9444708810232465</c:v>
                </c:pt>
                <c:pt idx="162">
                  <c:v>0.9444708810232465</c:v>
                </c:pt>
                <c:pt idx="163">
                  <c:v>0.94534622640092869</c:v>
                </c:pt>
                <c:pt idx="164">
                  <c:v>0.94534622640092869</c:v>
                </c:pt>
                <c:pt idx="165">
                  <c:v>0.94534622640092869</c:v>
                </c:pt>
                <c:pt idx="166">
                  <c:v>0.94534622640092869</c:v>
                </c:pt>
                <c:pt idx="167">
                  <c:v>0.94534622640092869</c:v>
                </c:pt>
                <c:pt idx="168">
                  <c:v>0.94621603532980836</c:v>
                </c:pt>
                <c:pt idx="169">
                  <c:v>0.94621603532980836</c:v>
                </c:pt>
                <c:pt idx="170">
                  <c:v>0.94621603532980836</c:v>
                </c:pt>
                <c:pt idx="171">
                  <c:v>0.94708037987098925</c:v>
                </c:pt>
                <c:pt idx="172">
                  <c:v>0.94793933067193969</c:v>
                </c:pt>
                <c:pt idx="173">
                  <c:v>0.94793933067193969</c:v>
                </c:pt>
                <c:pt idx="174">
                  <c:v>0.94793933067193969</c:v>
                </c:pt>
                <c:pt idx="175">
                  <c:v>0.94879295700342925</c:v>
                </c:pt>
                <c:pt idx="176">
                  <c:v>0.94964132679526747</c:v>
                </c:pt>
                <c:pt idx="177">
                  <c:v>0.94964132679526747</c:v>
                </c:pt>
                <c:pt idx="178">
                  <c:v>0.95048450667088447</c:v>
                </c:pt>
                <c:pt idx="179">
                  <c:v>0.95048450667088447</c:v>
                </c:pt>
                <c:pt idx="180">
                  <c:v>0.95048450667088447</c:v>
                </c:pt>
                <c:pt idx="181">
                  <c:v>0.95132256198080012</c:v>
                </c:pt>
                <c:pt idx="182">
                  <c:v>0.95132256198080012</c:v>
                </c:pt>
                <c:pt idx="183">
                  <c:v>0.95132256198080012</c:v>
                </c:pt>
                <c:pt idx="184">
                  <c:v>0.95132256198080012</c:v>
                </c:pt>
                <c:pt idx="185">
                  <c:v>0.95215555683502684</c:v>
                </c:pt>
                <c:pt idx="186">
                  <c:v>0.95215555683502684</c:v>
                </c:pt>
                <c:pt idx="187">
                  <c:v>0.95215555683502684</c:v>
                </c:pt>
                <c:pt idx="188">
                  <c:v>0.95298355413444136</c:v>
                </c:pt>
                <c:pt idx="189">
                  <c:v>0.95298355413444136</c:v>
                </c:pt>
                <c:pt idx="190">
                  <c:v>0.95298355413444136</c:v>
                </c:pt>
                <c:pt idx="191">
                  <c:v>0.95298355413444136</c:v>
                </c:pt>
                <c:pt idx="192">
                  <c:v>0.95380661560117086</c:v>
                </c:pt>
                <c:pt idx="193">
                  <c:v>0.95380661560117086</c:v>
                </c:pt>
                <c:pt idx="194">
                  <c:v>0.95462480180802434</c:v>
                </c:pt>
                <c:pt idx="195">
                  <c:v>0.95543817220701066</c:v>
                </c:pt>
                <c:pt idx="196">
                  <c:v>0.95543817220701066</c:v>
                </c:pt>
                <c:pt idx="197">
                  <c:v>0.95624678515697381</c:v>
                </c:pt>
                <c:pt idx="198">
                  <c:v>0.95705069795037812</c:v>
                </c:pt>
                <c:pt idx="199">
                  <c:v>0.95705069795037812</c:v>
                </c:pt>
                <c:pt idx="200">
                  <c:v>0.95705069795037812</c:v>
                </c:pt>
                <c:pt idx="201">
                  <c:v>0.95784996683927592</c:v>
                </c:pt>
                <c:pt idx="202">
                  <c:v>0.95864464706048746</c:v>
                </c:pt>
                <c:pt idx="203">
                  <c:v>0.9594347928600202</c:v>
                </c:pt>
                <c:pt idx="204">
                  <c:v>0.9594347928600202</c:v>
                </c:pt>
                <c:pt idx="205">
                  <c:v>0.9594347928600202</c:v>
                </c:pt>
                <c:pt idx="206">
                  <c:v>0.96022045751675678</c:v>
                </c:pt>
                <c:pt idx="207">
                  <c:v>0.96022045751675678</c:v>
                </c:pt>
                <c:pt idx="208">
                  <c:v>0.96100169336543551</c:v>
                </c:pt>
                <c:pt idx="209">
                  <c:v>0.96100169336543551</c:v>
                </c:pt>
                <c:pt idx="210">
                  <c:v>0.96100169336543551</c:v>
                </c:pt>
                <c:pt idx="211">
                  <c:v>0.961778551818953</c:v>
                </c:pt>
                <c:pt idx="212">
                  <c:v>0.961778551818953</c:v>
                </c:pt>
                <c:pt idx="213">
                  <c:v>0.961778551818953</c:v>
                </c:pt>
                <c:pt idx="214">
                  <c:v>0.961778551818953</c:v>
                </c:pt>
                <c:pt idx="215">
                  <c:v>0.961778551818953</c:v>
                </c:pt>
                <c:pt idx="216">
                  <c:v>0.96255108339000617</c:v>
                </c:pt>
                <c:pt idx="217">
                  <c:v>0.96255108339000617</c:v>
                </c:pt>
                <c:pt idx="218">
                  <c:v>0.96255108339000617</c:v>
                </c:pt>
                <c:pt idx="219">
                  <c:v>0.96255108339000617</c:v>
                </c:pt>
                <c:pt idx="220">
                  <c:v>0.96484320886932573</c:v>
                </c:pt>
                <c:pt idx="221">
                  <c:v>0.96484320886932573</c:v>
                </c:pt>
                <c:pt idx="222">
                  <c:v>0.96484320886932573</c:v>
                </c:pt>
                <c:pt idx="223">
                  <c:v>0.96559892075618481</c:v>
                </c:pt>
                <c:pt idx="224">
                  <c:v>0.96559892075618481</c:v>
                </c:pt>
                <c:pt idx="225">
                  <c:v>0.96559892075618481</c:v>
                </c:pt>
                <c:pt idx="226">
                  <c:v>0.96635054553548461</c:v>
                </c:pt>
                <c:pt idx="227">
                  <c:v>0.96635054553548461</c:v>
                </c:pt>
                <c:pt idx="228">
                  <c:v>0.96709812873927237</c:v>
                </c:pt>
                <c:pt idx="229">
                  <c:v>0.96784171513434525</c:v>
                </c:pt>
                <c:pt idx="230">
                  <c:v>0.96784171513434525</c:v>
                </c:pt>
                <c:pt idx="231">
                  <c:v>0.96931707284168667</c:v>
                </c:pt>
                <c:pt idx="232">
                  <c:v>0.96931707284168667</c:v>
                </c:pt>
                <c:pt idx="233">
                  <c:v>0.97004893001324755</c:v>
                </c:pt>
                <c:pt idx="234">
                  <c:v>0.97004893001324755</c:v>
                </c:pt>
                <c:pt idx="235">
                  <c:v>0.97004893001324755</c:v>
                </c:pt>
                <c:pt idx="236">
                  <c:v>0.97150121037028692</c:v>
                </c:pt>
                <c:pt idx="237">
                  <c:v>0.97222171526336187</c:v>
                </c:pt>
                <c:pt idx="238">
                  <c:v>0.97222171526336187</c:v>
                </c:pt>
                <c:pt idx="239">
                  <c:v>0.9729385166703084</c:v>
                </c:pt>
                <c:pt idx="240">
                  <c:v>0.9729385166703084</c:v>
                </c:pt>
                <c:pt idx="241">
                  <c:v>0.9729385166703084</c:v>
                </c:pt>
                <c:pt idx="242">
                  <c:v>0.97365165381493934</c:v>
                </c:pt>
                <c:pt idx="243">
                  <c:v>0.97365165381493934</c:v>
                </c:pt>
                <c:pt idx="244">
                  <c:v>0.97365165381493934</c:v>
                </c:pt>
                <c:pt idx="245">
                  <c:v>0.97365165381493934</c:v>
                </c:pt>
                <c:pt idx="246">
                  <c:v>0.97436116529416972</c:v>
                </c:pt>
                <c:pt idx="247">
                  <c:v>0.97436116529416972</c:v>
                </c:pt>
                <c:pt idx="248">
                  <c:v>0.97506708909137818</c:v>
                </c:pt>
                <c:pt idx="249">
                  <c:v>0.97576946258941555</c:v>
                </c:pt>
                <c:pt idx="250">
                  <c:v>0.97576946258941555</c:v>
                </c:pt>
                <c:pt idx="251">
                  <c:v>0.97646832258326799</c:v>
                </c:pt>
                <c:pt idx="252">
                  <c:v>0.97646832258326799</c:v>
                </c:pt>
                <c:pt idx="253">
                  <c:v>0.97646832258326799</c:v>
                </c:pt>
                <c:pt idx="254">
                  <c:v>0.97646832258326799</c:v>
                </c:pt>
                <c:pt idx="255">
                  <c:v>0.97646832258326799</c:v>
                </c:pt>
                <c:pt idx="256">
                  <c:v>0.9771637052923865</c:v>
                </c:pt>
                <c:pt idx="257">
                  <c:v>0.9771637052923865</c:v>
                </c:pt>
                <c:pt idx="258">
                  <c:v>0.9771637052923865</c:v>
                </c:pt>
                <c:pt idx="259">
                  <c:v>0.9771637052923865</c:v>
                </c:pt>
                <c:pt idx="260">
                  <c:v>0.97785564637269662</c:v>
                </c:pt>
                <c:pt idx="261">
                  <c:v>0.97785564637269662</c:v>
                </c:pt>
                <c:pt idx="262">
                  <c:v>0.97785564637269662</c:v>
                </c:pt>
                <c:pt idx="263">
                  <c:v>0.97854418092828999</c:v>
                </c:pt>
                <c:pt idx="264">
                  <c:v>0.97854418092828999</c:v>
                </c:pt>
                <c:pt idx="265">
                  <c:v>0.97854418092828999</c:v>
                </c:pt>
                <c:pt idx="266">
                  <c:v>0.97922934352282098</c:v>
                </c:pt>
                <c:pt idx="267">
                  <c:v>0.97922934352282098</c:v>
                </c:pt>
                <c:pt idx="268">
                  <c:v>0.98058968844741701</c:v>
                </c:pt>
                <c:pt idx="269">
                  <c:v>0.98126493730106712</c:v>
                </c:pt>
                <c:pt idx="270">
                  <c:v>0.98126493730106712</c:v>
                </c:pt>
                <c:pt idx="271">
                  <c:v>0.98126493730106712</c:v>
                </c:pt>
                <c:pt idx="272">
                  <c:v>0.98126493730106712</c:v>
                </c:pt>
                <c:pt idx="273">
                  <c:v>0.98193694726163328</c:v>
                </c:pt>
                <c:pt idx="274">
                  <c:v>0.982605750351494</c:v>
                </c:pt>
                <c:pt idx="275">
                  <c:v>0.98327137811508414</c:v>
                </c:pt>
                <c:pt idx="276">
                  <c:v>0.98393386162841323</c:v>
                </c:pt>
                <c:pt idx="277">
                  <c:v>0.98393386162841323</c:v>
                </c:pt>
                <c:pt idx="278">
                  <c:v>0.98459323150834588</c:v>
                </c:pt>
                <c:pt idx="279">
                  <c:v>0.98524951792165205</c:v>
                </c:pt>
                <c:pt idx="280">
                  <c:v>0.98524951792165205</c:v>
                </c:pt>
                <c:pt idx="281">
                  <c:v>0.98590275059383559</c:v>
                </c:pt>
                <c:pt idx="282">
                  <c:v>0.98590275059383559</c:v>
                </c:pt>
                <c:pt idx="283">
                  <c:v>0.98590275059383559</c:v>
                </c:pt>
                <c:pt idx="284">
                  <c:v>0.98590275059383559</c:v>
                </c:pt>
                <c:pt idx="285">
                  <c:v>0.98590275059383559</c:v>
                </c:pt>
                <c:pt idx="286">
                  <c:v>0.98655295881774907</c:v>
                </c:pt>
                <c:pt idx="287">
                  <c:v>0.98655295881774907</c:v>
                </c:pt>
                <c:pt idx="288">
                  <c:v>0.98720017146199313</c:v>
                </c:pt>
                <c:pt idx="289">
                  <c:v>0.98784441697911696</c:v>
                </c:pt>
                <c:pt idx="290">
                  <c:v>0.98784441697911696</c:v>
                </c:pt>
                <c:pt idx="291">
                  <c:v>0.98784441697911696</c:v>
                </c:pt>
                <c:pt idx="292">
                  <c:v>0.98784441697911696</c:v>
                </c:pt>
                <c:pt idx="293">
                  <c:v>0.98784441697911696</c:v>
                </c:pt>
                <c:pt idx="294">
                  <c:v>0.98784441697911696</c:v>
                </c:pt>
                <c:pt idx="295">
                  <c:v>0.98848572341361973</c:v>
                </c:pt>
                <c:pt idx="296">
                  <c:v>0.98848572341361973</c:v>
                </c:pt>
                <c:pt idx="297">
                  <c:v>0.98848572341361973</c:v>
                </c:pt>
                <c:pt idx="298">
                  <c:v>0.989124118409759</c:v>
                </c:pt>
                <c:pt idx="299">
                  <c:v>0.989124118409759</c:v>
                </c:pt>
                <c:pt idx="300">
                  <c:v>0.98975962921917326</c:v>
                </c:pt>
                <c:pt idx="301">
                  <c:v>0.98975962921917326</c:v>
                </c:pt>
                <c:pt idx="302">
                  <c:v>0.99039228270832447</c:v>
                </c:pt>
                <c:pt idx="303">
                  <c:v>0.99102210536576107</c:v>
                </c:pt>
                <c:pt idx="304">
                  <c:v>0.99102210536576107</c:v>
                </c:pt>
                <c:pt idx="305">
                  <c:v>0.99102210536576107</c:v>
                </c:pt>
                <c:pt idx="306">
                  <c:v>0.99227336229252816</c:v>
                </c:pt>
                <c:pt idx="307">
                  <c:v>0.99227336229252816</c:v>
                </c:pt>
                <c:pt idx="308">
                  <c:v>0.99227336229252816</c:v>
                </c:pt>
                <c:pt idx="309">
                  <c:v>0.99474303133960462</c:v>
                </c:pt>
                <c:pt idx="310">
                  <c:v>0.99474303133960462</c:v>
                </c:pt>
                <c:pt idx="311">
                  <c:v>0.99535374955866129</c:v>
                </c:pt>
                <c:pt idx="312">
                  <c:v>0.99535374955866129</c:v>
                </c:pt>
                <c:pt idx="313">
                  <c:v>0.99535374955866129</c:v>
                </c:pt>
                <c:pt idx="314">
                  <c:v>0.99535374955866129</c:v>
                </c:pt>
                <c:pt idx="315">
                  <c:v>0.99596183606710298</c:v>
                </c:pt>
                <c:pt idx="316">
                  <c:v>0.996567314252504</c:v>
                </c:pt>
                <c:pt idx="317">
                  <c:v>0.99717020718851712</c:v>
                </c:pt>
                <c:pt idx="318">
                  <c:v>0.99896360064516565</c:v>
                </c:pt>
                <c:pt idx="319">
                  <c:v>0.99896360064516565</c:v>
                </c:pt>
                <c:pt idx="320">
                  <c:v>0.9995563772359588</c:v>
                </c:pt>
                <c:pt idx="321">
                  <c:v>0.9995563772359588</c:v>
                </c:pt>
                <c:pt idx="322">
                  <c:v>0.9995563772359588</c:v>
                </c:pt>
                <c:pt idx="323">
                  <c:v>1.0001466794293274</c:v>
                </c:pt>
                <c:pt idx="324">
                  <c:v>1.0001466794293274</c:v>
                </c:pt>
                <c:pt idx="325">
                  <c:v>1.0001466794293274</c:v>
                </c:pt>
                <c:pt idx="326">
                  <c:v>1.0007345285292224</c:v>
                </c:pt>
                <c:pt idx="327">
                  <c:v>1.0007345285292224</c:v>
                </c:pt>
                <c:pt idx="328">
                  <c:v>1.0007345285292224</c:v>
                </c:pt>
                <c:pt idx="329">
                  <c:v>1.0007345285292224</c:v>
                </c:pt>
                <c:pt idx="330">
                  <c:v>1.001319945562515</c:v>
                </c:pt>
                <c:pt idx="331">
                  <c:v>1.001319945562515</c:v>
                </c:pt>
                <c:pt idx="332">
                  <c:v>1.0019029512838113</c:v>
                </c:pt>
                <c:pt idx="333">
                  <c:v>1.0019029512838113</c:v>
                </c:pt>
                <c:pt idx="334">
                  <c:v>1.0019029512838113</c:v>
                </c:pt>
                <c:pt idx="335">
                  <c:v>1.0024835661801568</c:v>
                </c:pt>
                <c:pt idx="336">
                  <c:v>1.0024835661801568</c:v>
                </c:pt>
                <c:pt idx="337">
                  <c:v>1.0030618104756419</c:v>
                </c:pt>
                <c:pt idx="338">
                  <c:v>1.0036377041359084</c:v>
                </c:pt>
                <c:pt idx="339">
                  <c:v>1.0036377041359084</c:v>
                </c:pt>
                <c:pt idx="340">
                  <c:v>1.0047825181474703</c:v>
                </c:pt>
                <c:pt idx="341">
                  <c:v>1.0053514771770238</c:v>
                </c:pt>
                <c:pt idx="342">
                  <c:v>1.0053514771770238</c:v>
                </c:pt>
                <c:pt idx="343">
                  <c:v>1.0053514771770238</c:v>
                </c:pt>
                <c:pt idx="344">
                  <c:v>1.0053514771770238</c:v>
                </c:pt>
                <c:pt idx="345">
                  <c:v>1.0053514771770238</c:v>
                </c:pt>
                <c:pt idx="346">
                  <c:v>1.0059181629362328</c:v>
                </c:pt>
                <c:pt idx="347">
                  <c:v>1.0059181629362328</c:v>
                </c:pt>
                <c:pt idx="348">
                  <c:v>1.0064825941627957</c:v>
                </c:pt>
                <c:pt idx="349">
                  <c:v>1.0064825941627957</c:v>
                </c:pt>
                <c:pt idx="350">
                  <c:v>1.0070447893610568</c:v>
                </c:pt>
                <c:pt idx="351">
                  <c:v>1.0070447893610568</c:v>
                </c:pt>
                <c:pt idx="352">
                  <c:v>1.0070447893610568</c:v>
                </c:pt>
                <c:pt idx="353">
                  <c:v>1.0081625445464859</c:v>
                </c:pt>
                <c:pt idx="354">
                  <c:v>1.0081625445464859</c:v>
                </c:pt>
                <c:pt idx="355">
                  <c:v>1.0081625445464859</c:v>
                </c:pt>
                <c:pt idx="356">
                  <c:v>1.0098228567273877</c:v>
                </c:pt>
                <c:pt idx="357">
                  <c:v>1.0103720117582269</c:v>
                </c:pt>
                <c:pt idx="358">
                  <c:v>1.0103720117582269</c:v>
                </c:pt>
                <c:pt idx="359">
                  <c:v>1.0103720117582269</c:v>
                </c:pt>
                <c:pt idx="360">
                  <c:v>1.0109190540733299</c:v>
                </c:pt>
                <c:pt idx="361">
                  <c:v>1.0109190540733299</c:v>
                </c:pt>
                <c:pt idx="362">
                  <c:v>1.0109190540733299</c:v>
                </c:pt>
                <c:pt idx="363">
                  <c:v>1.0114640004433859</c:v>
                </c:pt>
                <c:pt idx="364">
                  <c:v>1.0114640004433859</c:v>
                </c:pt>
                <c:pt idx="365">
                  <c:v>1.0120068674379143</c:v>
                </c:pt>
                <c:pt idx="366">
                  <c:v>1.0120068674379143</c:v>
                </c:pt>
                <c:pt idx="367">
                  <c:v>1.0120068674379143</c:v>
                </c:pt>
                <c:pt idx="368">
                  <c:v>1.0125476714284884</c:v>
                </c:pt>
                <c:pt idx="369">
                  <c:v>1.0125476714284884</c:v>
                </c:pt>
                <c:pt idx="370">
                  <c:v>1.0130864285918919</c:v>
                </c:pt>
                <c:pt idx="371">
                  <c:v>1.0136231549132166</c:v>
                </c:pt>
                <c:pt idx="372">
                  <c:v>1.0146905780296693</c:v>
                </c:pt>
                <c:pt idx="373">
                  <c:v>1.0146905780296693</c:v>
                </c:pt>
                <c:pt idx="374">
                  <c:v>1.0146905780296693</c:v>
                </c:pt>
                <c:pt idx="375">
                  <c:v>1.0146905780296693</c:v>
                </c:pt>
                <c:pt idx="376">
                  <c:v>1.0146905780296693</c:v>
                </c:pt>
                <c:pt idx="377">
                  <c:v>1.0146905780296693</c:v>
                </c:pt>
                <c:pt idx="378">
                  <c:v>1.0146905780296693</c:v>
                </c:pt>
                <c:pt idx="379">
                  <c:v>1.0152213058635184</c:v>
                </c:pt>
                <c:pt idx="380">
                  <c:v>1.0152213058635184</c:v>
                </c:pt>
                <c:pt idx="381">
                  <c:v>1.0152213058635184</c:v>
                </c:pt>
                <c:pt idx="382">
                  <c:v>1.0152213058635184</c:v>
                </c:pt>
                <c:pt idx="383">
                  <c:v>1.0157500649385034</c:v>
                </c:pt>
                <c:pt idx="384">
                  <c:v>1.0157500649385034</c:v>
                </c:pt>
                <c:pt idx="385">
                  <c:v>1.0162768703255769</c:v>
                </c:pt>
                <c:pt idx="386">
                  <c:v>1.0168017369213294</c:v>
                </c:pt>
                <c:pt idx="387">
                  <c:v>1.0168017369213294</c:v>
                </c:pt>
                <c:pt idx="388">
                  <c:v>1.0173246794506827</c:v>
                </c:pt>
                <c:pt idx="389">
                  <c:v>1.0178457124695328</c:v>
                </c:pt>
                <c:pt idx="390">
                  <c:v>1.0178457124695328</c:v>
                </c:pt>
                <c:pt idx="391">
                  <c:v>1.0183648503673413</c:v>
                </c:pt>
                <c:pt idx="392">
                  <c:v>1.0188821073696794</c:v>
                </c:pt>
                <c:pt idx="393">
                  <c:v>1.0188821073696794</c:v>
                </c:pt>
                <c:pt idx="394">
                  <c:v>1.0204227328532165</c:v>
                </c:pt>
                <c:pt idx="395">
                  <c:v>1.0209326053378107</c:v>
                </c:pt>
                <c:pt idx="396">
                  <c:v>1.0214406656820365</c:v>
                </c:pt>
                <c:pt idx="397">
                  <c:v>1.0214406656820365</c:v>
                </c:pt>
                <c:pt idx="398">
                  <c:v>1.0219469271788519</c:v>
                </c:pt>
                <c:pt idx="399">
                  <c:v>1.0219469271788519</c:v>
                </c:pt>
                <c:pt idx="400">
                  <c:v>1.0224514029738179</c:v>
                </c:pt>
                <c:pt idx="401">
                  <c:v>1.0229541060672831</c:v>
                </c:pt>
                <c:pt idx="402">
                  <c:v>1.0229541060672831</c:v>
                </c:pt>
                <c:pt idx="403">
                  <c:v>1.0229541060672831</c:v>
                </c:pt>
                <c:pt idx="404">
                  <c:v>1.0229541060672831</c:v>
                </c:pt>
                <c:pt idx="405">
                  <c:v>1.0234550493165262</c:v>
                </c:pt>
                <c:pt idx="406">
                  <c:v>1.0239542454378576</c:v>
                </c:pt>
                <c:pt idx="407">
                  <c:v>1.0244517070086878</c:v>
                </c:pt>
                <c:pt idx="408">
                  <c:v>1.0254414761260953</c:v>
                </c:pt>
                <c:pt idx="409">
                  <c:v>1.0259338081510407</c:v>
                </c:pt>
                <c:pt idx="410">
                  <c:v>1.0259338081510407</c:v>
                </c:pt>
                <c:pt idx="411">
                  <c:v>1.026424454586093</c:v>
                </c:pt>
                <c:pt idx="412">
                  <c:v>1.027886398843086</c:v>
                </c:pt>
                <c:pt idx="413">
                  <c:v>1.0288528154363366</c:v>
                </c:pt>
                <c:pt idx="414">
                  <c:v>1.0288528154363366</c:v>
                </c:pt>
                <c:pt idx="415">
                  <c:v>1.0293335941043174</c:v>
                </c:pt>
                <c:pt idx="416">
                  <c:v>1.0298127679600682</c:v>
                </c:pt>
                <c:pt idx="417">
                  <c:v>1.0302903480622609</c:v>
                </c:pt>
                <c:pt idx="418">
                  <c:v>1.030766345354351</c:v>
                </c:pt>
                <c:pt idx="419">
                  <c:v>1.030766345354351</c:v>
                </c:pt>
                <c:pt idx="420">
                  <c:v>1.0312407706661799</c:v>
                </c:pt>
                <c:pt idx="421">
                  <c:v>1.0312407706661799</c:v>
                </c:pt>
                <c:pt idx="422">
                  <c:v>1.0317136347155527</c:v>
                </c:pt>
                <c:pt idx="423">
                  <c:v>1.032184948109786</c:v>
                </c:pt>
                <c:pt idx="424">
                  <c:v>1.032184948109786</c:v>
                </c:pt>
                <c:pt idx="425">
                  <c:v>1.0326547213472297</c:v>
                </c:pt>
                <c:pt idx="426">
                  <c:v>1.0326547213472297</c:v>
                </c:pt>
                <c:pt idx="427">
                  <c:v>1.0331229648187648</c:v>
                </c:pt>
                <c:pt idx="428">
                  <c:v>1.0331229648187648</c:v>
                </c:pt>
                <c:pt idx="429">
                  <c:v>1.0331229648187648</c:v>
                </c:pt>
                <c:pt idx="430">
                  <c:v>1.0335896888092699</c:v>
                </c:pt>
                <c:pt idx="431">
                  <c:v>1.0345186189653532</c:v>
                </c:pt>
                <c:pt idx="432">
                  <c:v>1.0354415920288076</c:v>
                </c:pt>
                <c:pt idx="433">
                  <c:v>1.0359008692771312</c:v>
                </c:pt>
                <c:pt idx="434">
                  <c:v>1.036358686606919</c:v>
                </c:pt>
                <c:pt idx="435">
                  <c:v>1.0368150536001652</c:v>
                </c:pt>
                <c:pt idx="436">
                  <c:v>1.0368150536001652</c:v>
                </c:pt>
                <c:pt idx="437">
                  <c:v>1.037269979743759</c:v>
                </c:pt>
                <c:pt idx="438">
                  <c:v>1.0377234744307502</c:v>
                </c:pt>
                <c:pt idx="439">
                  <c:v>1.0381755469615881</c:v>
                </c:pt>
                <c:pt idx="440">
                  <c:v>1.0395233232581449</c:v>
                </c:pt>
                <c:pt idx="441">
                  <c:v>1.0395233232581449</c:v>
                </c:pt>
                <c:pt idx="442">
                  <c:v>1.0399697983591329</c:v>
                </c:pt>
                <c:pt idx="443">
                  <c:v>1.0399697983591329</c:v>
                </c:pt>
                <c:pt idx="444">
                  <c:v>1.0399697983591329</c:v>
                </c:pt>
                <c:pt idx="445">
                  <c:v>1.0399697983591329</c:v>
                </c:pt>
                <c:pt idx="446">
                  <c:v>1.0399697983591329</c:v>
                </c:pt>
                <c:pt idx="447">
                  <c:v>1.0399697983591329</c:v>
                </c:pt>
                <c:pt idx="448">
                  <c:v>1.0404148964592126</c:v>
                </c:pt>
                <c:pt idx="449">
                  <c:v>1.0408586263281616</c:v>
                </c:pt>
                <c:pt idx="450">
                  <c:v>1.0413009966512889</c:v>
                </c:pt>
                <c:pt idx="451">
                  <c:v>1.0413009966512889</c:v>
                </c:pt>
                <c:pt idx="452">
                  <c:v>1.0413009966512889</c:v>
                </c:pt>
                <c:pt idx="453">
                  <c:v>1.0413009966512889</c:v>
                </c:pt>
                <c:pt idx="454">
                  <c:v>1.0417420160305231</c:v>
                </c:pt>
                <c:pt idx="455">
                  <c:v>1.0421816929854806</c:v>
                </c:pt>
                <c:pt idx="456">
                  <c:v>1.0426200359545195</c:v>
                </c:pt>
                <c:pt idx="457">
                  <c:v>1.0426200359545195</c:v>
                </c:pt>
                <c:pt idx="458">
                  <c:v>1.0426200359545195</c:v>
                </c:pt>
                <c:pt idx="459">
                  <c:v>1.0430570532957757</c:v>
                </c:pt>
                <c:pt idx="460">
                  <c:v>1.0434927532881819</c:v>
                </c:pt>
                <c:pt idx="461">
                  <c:v>1.0434927532881819</c:v>
                </c:pt>
                <c:pt idx="462">
                  <c:v>1.0434927532881819</c:v>
                </c:pt>
                <c:pt idx="463">
                  <c:v>1.0439271441324702</c:v>
                </c:pt>
                <c:pt idx="464">
                  <c:v>1.0439271441324702</c:v>
                </c:pt>
                <c:pt idx="465">
                  <c:v>1.0443602339521607</c:v>
                </c:pt>
                <c:pt idx="466">
                  <c:v>1.0447920307945313</c:v>
                </c:pt>
                <c:pt idx="467">
                  <c:v>1.0456517773609495</c:v>
                </c:pt>
                <c:pt idx="468">
                  <c:v>1.0456517773609495</c:v>
                </c:pt>
                <c:pt idx="469">
                  <c:v>1.0469318967837491</c:v>
                </c:pt>
                <c:pt idx="470">
                  <c:v>1.0473561006042102</c:v>
                </c:pt>
                <c:pt idx="471">
                  <c:v>1.0477790657220416</c:v>
                </c:pt>
                <c:pt idx="472">
                  <c:v>1.0477790657220416</c:v>
                </c:pt>
                <c:pt idx="473">
                  <c:v>1.0477790657220416</c:v>
                </c:pt>
                <c:pt idx="474">
                  <c:v>1.048200799607802</c:v>
                </c:pt>
                <c:pt idx="475">
                  <c:v>1.048200799607802</c:v>
                </c:pt>
                <c:pt idx="476">
                  <c:v>1.0490406032254189</c:v>
                </c:pt>
                <c:pt idx="477">
                  <c:v>1.0490406032254189</c:v>
                </c:pt>
                <c:pt idx="478">
                  <c:v>1.0490406032254189</c:v>
                </c:pt>
                <c:pt idx="479">
                  <c:v>1.049458687560952</c:v>
                </c:pt>
                <c:pt idx="480">
                  <c:v>1.049458687560952</c:v>
                </c:pt>
                <c:pt idx="481">
                  <c:v>1.049458687560952</c:v>
                </c:pt>
                <c:pt idx="482">
                  <c:v>1.0498755698733893</c:v>
                </c:pt>
                <c:pt idx="483">
                  <c:v>1.0498755698733893</c:v>
                </c:pt>
                <c:pt idx="484">
                  <c:v>1.0502912573007246</c:v>
                </c:pt>
                <c:pt idx="485">
                  <c:v>1.0507057569168297</c:v>
                </c:pt>
                <c:pt idx="486">
                  <c:v>1.0511190757322291</c:v>
                </c:pt>
                <c:pt idx="487">
                  <c:v>1.0511190757322291</c:v>
                </c:pt>
                <c:pt idx="488">
                  <c:v>1.0515312206948557</c:v>
                </c:pt>
                <c:pt idx="489">
                  <c:v>1.0519421986907991</c:v>
                </c:pt>
                <c:pt idx="490">
                  <c:v>1.0519421986907991</c:v>
                </c:pt>
                <c:pt idx="491">
                  <c:v>1.0523520165450411</c:v>
                </c:pt>
                <c:pt idx="492">
                  <c:v>1.0531681988271464</c:v>
                </c:pt>
                <c:pt idx="493">
                  <c:v>1.0535745766059061</c:v>
                </c:pt>
                <c:pt idx="494">
                  <c:v>1.0547869353746122</c:v>
                </c:pt>
                <c:pt idx="495">
                  <c:v>1.0551888183529525</c:v>
                </c:pt>
                <c:pt idx="496">
                  <c:v>1.0559892676451923</c:v>
                </c:pt>
                <c:pt idx="497">
                  <c:v>1.0563878465175398</c:v>
                </c:pt>
                <c:pt idx="498">
                  <c:v>1.0567853364897644</c:v>
                </c:pt>
                <c:pt idx="499">
                  <c:v>1.0567853364897644</c:v>
                </c:pt>
                <c:pt idx="500">
                  <c:v>1.0575770742625432</c:v>
                </c:pt>
                <c:pt idx="501">
                  <c:v>1.0575770742625432</c:v>
                </c:pt>
                <c:pt idx="502">
                  <c:v>1.0575770742625432</c:v>
                </c:pt>
                <c:pt idx="503">
                  <c:v>1.0579713341968706</c:v>
                </c:pt>
                <c:pt idx="504">
                  <c:v>1.058364529499811</c:v>
                </c:pt>
                <c:pt idx="505">
                  <c:v>1.0587566661103363</c:v>
                </c:pt>
                <c:pt idx="506">
                  <c:v>1.0591477499172941</c:v>
                </c:pt>
                <c:pt idx="507">
                  <c:v>1.0591477499172941</c:v>
                </c:pt>
                <c:pt idx="508">
                  <c:v>1.0591477499172941</c:v>
                </c:pt>
                <c:pt idx="509">
                  <c:v>1.0591477499172941</c:v>
                </c:pt>
                <c:pt idx="510">
                  <c:v>1.0591477499172941</c:v>
                </c:pt>
                <c:pt idx="511">
                  <c:v>1.059926782428658</c:v>
                </c:pt>
                <c:pt idx="512">
                  <c:v>1.0610875795700967</c:v>
                </c:pt>
                <c:pt idx="513">
                  <c:v>1.0610875795700967</c:v>
                </c:pt>
                <c:pt idx="514">
                  <c:v>1.0614724674847331</c:v>
                </c:pt>
                <c:pt idx="515">
                  <c:v>1.0614724674847331</c:v>
                </c:pt>
                <c:pt idx="516">
                  <c:v>1.0622392100057547</c:v>
                </c:pt>
                <c:pt idx="517">
                  <c:v>1.0626210755819476</c:v>
                </c:pt>
                <c:pt idx="518">
                  <c:v>1.0630019446067822</c:v>
                </c:pt>
                <c:pt idx="519">
                  <c:v>1.063381822453376</c:v>
                </c:pt>
                <c:pt idx="520">
                  <c:v>1.0637607144510099</c:v>
                </c:pt>
                <c:pt idx="521">
                  <c:v>1.0637607144510099</c:v>
                </c:pt>
                <c:pt idx="522">
                  <c:v>1.0641386258856091</c:v>
                </c:pt>
                <c:pt idx="523">
                  <c:v>1.0645155620002134</c:v>
                </c:pt>
                <c:pt idx="524">
                  <c:v>1.0648915279954416</c:v>
                </c:pt>
                <c:pt idx="525">
                  <c:v>1.0652665290299519</c:v>
                </c:pt>
                <c:pt idx="526">
                  <c:v>1.0660136566443559</c:v>
                </c:pt>
                <c:pt idx="527">
                  <c:v>1.0660136566443559</c:v>
                </c:pt>
                <c:pt idx="528">
                  <c:v>1.0663857933358052</c:v>
                </c:pt>
                <c:pt idx="529">
                  <c:v>1.0667569852905217</c:v>
                </c:pt>
                <c:pt idx="530">
                  <c:v>1.0671272374640288</c:v>
                </c:pt>
                <c:pt idx="531">
                  <c:v>1.0671272374640288</c:v>
                </c:pt>
                <c:pt idx="532">
                  <c:v>1.0678649420932531</c:v>
                </c:pt>
                <c:pt idx="533">
                  <c:v>1.0693292877049851</c:v>
                </c:pt>
                <c:pt idx="534">
                  <c:v>1.0696930969125054</c:v>
                </c:pt>
                <c:pt idx="535">
                  <c:v>1.0696930969125054</c:v>
                </c:pt>
                <c:pt idx="536">
                  <c:v>1.0707791338516055</c:v>
                </c:pt>
                <c:pt idx="537">
                  <c:v>1.0711393645382616</c:v>
                </c:pt>
                <c:pt idx="538">
                  <c:v>1.0722147748601005</c:v>
                </c:pt>
                <c:pt idx="539">
                  <c:v>1.0725714991913724</c:v>
                </c:pt>
                <c:pt idx="540">
                  <c:v>1.0739897840421271</c:v>
                </c:pt>
                <c:pt idx="541">
                  <c:v>1.0743422235910003</c:v>
                </c:pt>
                <c:pt idx="542">
                  <c:v>1.0746938189430744</c:v>
                </c:pt>
                <c:pt idx="543">
                  <c:v>1.0753944937402629</c:v>
                </c:pt>
                <c:pt idx="544">
                  <c:v>1.0757435814491487</c:v>
                </c:pt>
                <c:pt idx="545">
                  <c:v>1.0757435814491487</c:v>
                </c:pt>
                <c:pt idx="546">
                  <c:v>1.077131696001641</c:v>
                </c:pt>
                <c:pt idx="547">
                  <c:v>1.077131696001641</c:v>
                </c:pt>
                <c:pt idx="548">
                  <c:v>1.077131696001641</c:v>
                </c:pt>
                <c:pt idx="549">
                  <c:v>1.0774766856214637</c:v>
                </c:pt>
                <c:pt idx="550">
                  <c:v>1.0774766856214637</c:v>
                </c:pt>
                <c:pt idx="551">
                  <c:v>1.0781642456998413</c:v>
                </c:pt>
                <c:pt idx="552">
                  <c:v>1.0788486061398197</c:v>
                </c:pt>
                <c:pt idx="553">
                  <c:v>1.0791895961053732</c:v>
                </c:pt>
                <c:pt idx="554">
                  <c:v>1.0791895961053732</c:v>
                </c:pt>
                <c:pt idx="555">
                  <c:v>1.0795297976373808</c:v>
                </c:pt>
                <c:pt idx="556">
                  <c:v>1.0798692145034352</c:v>
                </c:pt>
                <c:pt idx="557">
                  <c:v>1.0812191097117589</c:v>
                </c:pt>
                <c:pt idx="558">
                  <c:v>1.0828892647000516</c:v>
                </c:pt>
                <c:pt idx="559">
                  <c:v>1.0832210362571992</c:v>
                </c:pt>
                <c:pt idx="560">
                  <c:v>1.083552062849866</c:v>
                </c:pt>
                <c:pt idx="561">
                  <c:v>1.083552062849866</c:v>
                </c:pt>
                <c:pt idx="562">
                  <c:v>1.0842118949467137</c:v>
                </c:pt>
                <c:pt idx="563">
                  <c:v>1.0855227700737833</c:v>
                </c:pt>
                <c:pt idx="564">
                  <c:v>1.0868221044946147</c:v>
                </c:pt>
                <c:pt idx="565">
                  <c:v>1.0874675093309836</c:v>
                </c:pt>
                <c:pt idx="566">
                  <c:v>1.0874675093309836</c:v>
                </c:pt>
                <c:pt idx="567">
                  <c:v>1.0884303605497043</c:v>
                </c:pt>
                <c:pt idx="568">
                  <c:v>1.0897044822263047</c:v>
                </c:pt>
                <c:pt idx="569">
                  <c:v>1.0897044822263047</c:v>
                </c:pt>
                <c:pt idx="570">
                  <c:v>1.0906529207478</c:v>
                </c:pt>
                <c:pt idx="571">
                  <c:v>1.0906529207478</c:v>
                </c:pt>
                <c:pt idx="572">
                  <c:v>1.0915953182660469</c:v>
                </c:pt>
                <c:pt idx="573">
                  <c:v>1.0922202663305118</c:v>
                </c:pt>
                <c:pt idx="574">
                  <c:v>1.0922202663305118</c:v>
                </c:pt>
                <c:pt idx="575">
                  <c:v>1.0922202663305118</c:v>
                </c:pt>
                <c:pt idx="576">
                  <c:v>1.094387048805187</c:v>
                </c:pt>
                <c:pt idx="577">
                  <c:v>1.0971271690757523</c:v>
                </c:pt>
                <c:pt idx="578">
                  <c:v>1.0971271690757523</c:v>
                </c:pt>
                <c:pt idx="579">
                  <c:v>1.0971271690757523</c:v>
                </c:pt>
                <c:pt idx="580">
                  <c:v>1.0974285263419958</c:v>
                </c:pt>
                <c:pt idx="581">
                  <c:v>1.0986278754039971</c:v>
                </c:pt>
                <c:pt idx="582">
                  <c:v>1.098926205333856</c:v>
                </c:pt>
                <c:pt idx="583">
                  <c:v>1.1007037146778844</c:v>
                </c:pt>
                <c:pt idx="584">
                  <c:v>1.1009979106270007</c:v>
                </c:pt>
                <c:pt idx="585">
                  <c:v>1.1018770225243191</c:v>
                </c:pt>
                <c:pt idx="586">
                  <c:v>1.1027509698366613</c:v>
                </c:pt>
                <c:pt idx="587">
                  <c:v>1.1047704445014739</c:v>
                </c:pt>
                <c:pt idx="588">
                  <c:v>1.1064798962002944</c:v>
                </c:pt>
                <c:pt idx="589">
                  <c:v>1.1084497966888158</c:v>
                </c:pt>
                <c:pt idx="590">
                  <c:v>1.110944911361637</c:v>
                </c:pt>
                <c:pt idx="591">
                  <c:v>1.1128571506064346</c:v>
                </c:pt>
                <c:pt idx="592">
                  <c:v>1.1139389787257452</c:v>
                </c:pt>
                <c:pt idx="593">
                  <c:v>1.1158135610758648</c:v>
                </c:pt>
                <c:pt idx="594">
                  <c:v>1.1238445838213498</c:v>
                </c:pt>
                <c:pt idx="595">
                  <c:v>1.1251006175976712</c:v>
                </c:pt>
                <c:pt idx="596">
                  <c:v>1.1297801808817207</c:v>
                </c:pt>
                <c:pt idx="597">
                  <c:v>1.1317078644780432</c:v>
                </c:pt>
                <c:pt idx="598">
                  <c:v>1.1416677577676448</c:v>
                </c:pt>
              </c:numCache>
            </c:numRef>
          </c:yVal>
          <c:smooth val="1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79221888"/>
        <c:axId val="79223808"/>
      </c:scatterChart>
      <c:valAx>
        <c:axId val="79221888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 marL="0" marR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 sz="1400" b="1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400" b="1" i="0" baseline="0">
                    <a:effectLst/>
                  </a:rPr>
                  <a:t>C-peptide (nmol/L)</a:t>
                </a:r>
                <a:endParaRPr lang="cs-CZ" sz="1400">
                  <a:effectLst/>
                </a:endParaRP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1000"/>
            </a:pPr>
            <a:endParaRPr lang="en-US"/>
          </a:p>
        </c:txPr>
        <c:crossAx val="79223808"/>
        <c:crossesAt val="-1.4"/>
        <c:crossBetween val="midCat"/>
      </c:valAx>
      <c:valAx>
        <c:axId val="79223808"/>
        <c:scaling>
          <c:orientation val="minMax"/>
          <c:min val="0.70000000000000007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1050"/>
                </a:pPr>
                <a:r>
                  <a:rPr lang="en-US" sz="1400" b="1" i="0" u="none" strike="noStrike" baseline="0">
                    <a:effectLst/>
                  </a:rPr>
                  <a:t>GLP-1 (pg/mL</a:t>
                </a:r>
                <a:endParaRPr lang="cs-CZ" sz="1400" b="0">
                  <a:effectLst/>
                </a:endParaRPr>
              </a:p>
            </c:rich>
          </c:tx>
          <c:layout>
            <c:manualLayout>
              <c:xMode val="edge"/>
              <c:yMode val="edge"/>
              <c:x val="3.530538917678025E-2"/>
              <c:y val="0.32585401289418731"/>
            </c:manualLayout>
          </c:layout>
          <c:overlay val="0"/>
        </c:title>
        <c:numFmt formatCode="General" sourceLinked="1"/>
        <c:majorTickMark val="out"/>
        <c:minorTickMark val="none"/>
        <c:tickLblPos val="low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1000"/>
            </a:pPr>
            <a:endParaRPr lang="en-US"/>
          </a:p>
        </c:txPr>
        <c:crossAx val="79221888"/>
        <c:crossesAt val="-1.3"/>
        <c:crossBetween val="midCat"/>
      </c:valAx>
      <c:spPr>
        <a:noFill/>
        <a:ln>
          <a:noFill/>
        </a:ln>
      </c:spPr>
    </c:plotArea>
    <c:plotVisOnly val="1"/>
    <c:dispBlanksAs val="gap"/>
    <c:showDLblsOverMax val="0"/>
  </c:chart>
  <c:spPr>
    <a:noFill/>
    <a:ln>
      <a:noFill/>
    </a:ln>
  </c:spPr>
  <c:txPr>
    <a:bodyPr/>
    <a:lstStyle/>
    <a:p>
      <a:pPr>
        <a:defRPr sz="1200"/>
      </a:pPr>
      <a:endParaRPr lang="en-US"/>
    </a:p>
  </c:tx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Úvodní sníme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cs-CZ" smtClean="0"/>
              <a:t>Klepnutím lze upravit styl předlohy nadpisů.</a:t>
            </a:r>
            <a:endParaRPr lang="cs-CZ"/>
          </a:p>
        </p:txBody>
      </p:sp>
      <p:sp>
        <p:nvSpPr>
          <p:cNvPr id="3" name="Podnadpis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cs-CZ" smtClean="0"/>
              <a:t>Klepnutím lze upravit styl předlohy podnadpisů.</a:t>
            </a:r>
            <a:endParaRPr lang="cs-CZ"/>
          </a:p>
        </p:txBody>
      </p:sp>
      <p:sp>
        <p:nvSpPr>
          <p:cNvPr id="4" name="Zástupný symbol pro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EC1D4A-A796-47C3-A63E-CE236FB377E2}" type="datetimeFigureOut">
              <a:rPr lang="cs-CZ" smtClean="0"/>
              <a:t>4.2.2019</a:t>
            </a:fld>
            <a:endParaRPr lang="cs-CZ"/>
          </a:p>
        </p:txBody>
      </p:sp>
      <p:sp>
        <p:nvSpPr>
          <p:cNvPr id="5" name="Zástupný symbol pro zápatí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6" name="Zástupný symbol pro číslo snímk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57A5DF-1266-40EA-9282-1E66B9DE06C0}" type="slidenum">
              <a:rPr lang="cs-CZ" smtClean="0"/>
              <a:t>‹#›</a:t>
            </a:fld>
            <a:endParaRPr lang="cs-CZ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Nadpis a svislý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s-CZ" smtClean="0"/>
              <a:t>Klepnutím lze upravit styl předlohy nadpisů.</a:t>
            </a:r>
            <a:endParaRPr lang="cs-CZ"/>
          </a:p>
        </p:txBody>
      </p:sp>
      <p:sp>
        <p:nvSpPr>
          <p:cNvPr id="3" name="Zástupný symbol pro svislý text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cs-CZ" smtClean="0"/>
              <a:t>Klep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cs-CZ"/>
          </a:p>
        </p:txBody>
      </p:sp>
      <p:sp>
        <p:nvSpPr>
          <p:cNvPr id="4" name="Zástupný symbol pro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EC1D4A-A796-47C3-A63E-CE236FB377E2}" type="datetimeFigureOut">
              <a:rPr lang="cs-CZ" smtClean="0"/>
              <a:t>4.2.2019</a:t>
            </a:fld>
            <a:endParaRPr lang="cs-CZ"/>
          </a:p>
        </p:txBody>
      </p:sp>
      <p:sp>
        <p:nvSpPr>
          <p:cNvPr id="5" name="Zástupný symbol pro zápatí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6" name="Zástupný symbol pro číslo snímk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57A5DF-1266-40EA-9282-1E66B9DE06C0}" type="slidenum">
              <a:rPr lang="cs-CZ" smtClean="0"/>
              <a:t>‹#›</a:t>
            </a:fld>
            <a:endParaRPr lang="cs-CZ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Svislý nadpis a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vislý nadpis 1"/>
          <p:cNvSpPr>
            <a:spLocks noGrp="1"/>
          </p:cNvSpPr>
          <p:nvPr>
            <p:ph type="title" orient="vert"/>
          </p:nvPr>
        </p:nvSpPr>
        <p:spPr>
          <a:xfrm>
            <a:off x="4972050" y="396700"/>
            <a:ext cx="1543050" cy="8452203"/>
          </a:xfrm>
        </p:spPr>
        <p:txBody>
          <a:bodyPr vert="eaVert"/>
          <a:lstStyle/>
          <a:p>
            <a:r>
              <a:rPr lang="cs-CZ" smtClean="0"/>
              <a:t>Klepnutím lze upravit styl předlohy nadpisů.</a:t>
            </a:r>
            <a:endParaRPr lang="cs-CZ"/>
          </a:p>
        </p:txBody>
      </p:sp>
      <p:sp>
        <p:nvSpPr>
          <p:cNvPr id="3" name="Zástupný symbol pro svislý text 2"/>
          <p:cNvSpPr>
            <a:spLocks noGrp="1"/>
          </p:cNvSpPr>
          <p:nvPr>
            <p:ph type="body" orient="vert" idx="1"/>
          </p:nvPr>
        </p:nvSpPr>
        <p:spPr>
          <a:xfrm>
            <a:off x="342900" y="396700"/>
            <a:ext cx="4514850" cy="8452203"/>
          </a:xfrm>
        </p:spPr>
        <p:txBody>
          <a:bodyPr vert="eaVert"/>
          <a:lstStyle/>
          <a:p>
            <a:pPr lvl="0"/>
            <a:r>
              <a:rPr lang="cs-CZ" smtClean="0"/>
              <a:t>Klep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cs-CZ"/>
          </a:p>
        </p:txBody>
      </p:sp>
      <p:sp>
        <p:nvSpPr>
          <p:cNvPr id="4" name="Zástupný symbol pro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EC1D4A-A796-47C3-A63E-CE236FB377E2}" type="datetimeFigureOut">
              <a:rPr lang="cs-CZ" smtClean="0"/>
              <a:t>4.2.2019</a:t>
            </a:fld>
            <a:endParaRPr lang="cs-CZ"/>
          </a:p>
        </p:txBody>
      </p:sp>
      <p:sp>
        <p:nvSpPr>
          <p:cNvPr id="5" name="Zástupný symbol pro zápatí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6" name="Zástupný symbol pro číslo snímk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57A5DF-1266-40EA-9282-1E66B9DE06C0}" type="slidenum">
              <a:rPr lang="cs-CZ" smtClean="0"/>
              <a:t>‹#›</a:t>
            </a:fld>
            <a:endParaRPr lang="cs-CZ"/>
          </a:p>
        </p:txBody>
      </p:sp>
    </p:spTree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it-IT" smtClean="0"/>
              <a:t>Fare clic per modificare lo stile del sottotitolo dello schema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A6FC93-FDD0-403F-8843-6356E6050B4D}" type="datetimeFigureOut">
              <a:rPr lang="it-IT" smtClean="0">
                <a:solidFill>
                  <a:prstClr val="black">
                    <a:tint val="75000"/>
                  </a:prstClr>
                </a:solidFill>
              </a:rPr>
              <a:pPr/>
              <a:t>04/02/2019</a:t>
            </a:fld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C5521E-7460-4170-A51F-12B49DAD7A93}" type="slidenum">
              <a:rPr lang="it-IT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828587095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A6FC93-FDD0-403F-8843-6356E6050B4D}" type="datetimeFigureOut">
              <a:rPr lang="it-IT" smtClean="0">
                <a:solidFill>
                  <a:prstClr val="black">
                    <a:tint val="75000"/>
                  </a:prstClr>
                </a:solidFill>
              </a:rPr>
              <a:pPr/>
              <a:t>04/02/2019</a:t>
            </a:fld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C5521E-7460-4170-A51F-12B49DAD7A93}" type="slidenum">
              <a:rPr lang="it-IT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739978949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7" y="2469625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7" y="6629228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A6FC93-FDD0-403F-8843-6356E6050B4D}" type="datetimeFigureOut">
              <a:rPr lang="it-IT" smtClean="0">
                <a:solidFill>
                  <a:prstClr val="black">
                    <a:tint val="75000"/>
                  </a:prstClr>
                </a:solidFill>
              </a:rPr>
              <a:pPr/>
              <a:t>04/02/2019</a:t>
            </a:fld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C5521E-7460-4170-A51F-12B49DAD7A93}" type="slidenum">
              <a:rPr lang="it-IT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296038819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A6FC93-FDD0-403F-8843-6356E6050B4D}" type="datetimeFigureOut">
              <a:rPr lang="it-IT" smtClean="0">
                <a:solidFill>
                  <a:prstClr val="black">
                    <a:tint val="75000"/>
                  </a:prstClr>
                </a:solidFill>
              </a:rPr>
              <a:pPr/>
              <a:t>04/02/2019</a:t>
            </a:fld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C5521E-7460-4170-A51F-12B49DAD7A93}" type="slidenum">
              <a:rPr lang="it-IT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894606526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2" y="527405"/>
            <a:ext cx="5915025" cy="1914702"/>
          </a:xfrm>
        </p:spPr>
        <p:txBody>
          <a:bodyPr/>
          <a:lstStyle/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8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3"/>
            <a:ext cx="2901255" cy="5322183"/>
          </a:xfrm>
        </p:spPr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4" y="2428348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4" y="3618443"/>
            <a:ext cx="2915543" cy="5322183"/>
          </a:xfrm>
        </p:spPr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A6FC93-FDD0-403F-8843-6356E6050B4D}" type="datetimeFigureOut">
              <a:rPr lang="it-IT" smtClean="0">
                <a:solidFill>
                  <a:prstClr val="black">
                    <a:tint val="75000"/>
                  </a:prstClr>
                </a:solidFill>
              </a:rPr>
              <a:pPr/>
              <a:t>04/02/2019</a:t>
            </a:fld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C5521E-7460-4170-A51F-12B49DAD7A93}" type="slidenum">
              <a:rPr lang="it-IT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060659688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A6FC93-FDD0-403F-8843-6356E6050B4D}" type="datetimeFigureOut">
              <a:rPr lang="it-IT" smtClean="0">
                <a:solidFill>
                  <a:prstClr val="black">
                    <a:tint val="75000"/>
                  </a:prstClr>
                </a:solidFill>
              </a:rPr>
              <a:pPr/>
              <a:t>04/02/2019</a:t>
            </a:fld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C5521E-7460-4170-A51F-12B49DAD7A93}" type="slidenum">
              <a:rPr lang="it-IT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517075291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A6FC93-FDD0-403F-8843-6356E6050B4D}" type="datetimeFigureOut">
              <a:rPr lang="it-IT" smtClean="0">
                <a:solidFill>
                  <a:prstClr val="black">
                    <a:tint val="75000"/>
                  </a:prstClr>
                </a:solidFill>
              </a:rPr>
              <a:pPr/>
              <a:t>04/02/2019</a:t>
            </a:fld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C5521E-7460-4170-A51F-12B49DAD7A93}" type="slidenum">
              <a:rPr lang="it-IT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244139557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4" y="1426284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A6FC93-FDD0-403F-8843-6356E6050B4D}" type="datetimeFigureOut">
              <a:rPr lang="it-IT" smtClean="0">
                <a:solidFill>
                  <a:prstClr val="black">
                    <a:tint val="75000"/>
                  </a:prstClr>
                </a:solidFill>
              </a:rPr>
              <a:pPr/>
              <a:t>04/02/2019</a:t>
            </a:fld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C5521E-7460-4170-A51F-12B49DAD7A93}" type="slidenum">
              <a:rPr lang="it-IT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10167122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Nadpis a obsa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s-CZ" smtClean="0"/>
              <a:t>Klepnutím lze upravit styl předlohy nadpisů.</a:t>
            </a:r>
            <a:endParaRPr lang="cs-CZ"/>
          </a:p>
        </p:txBody>
      </p:sp>
      <p:sp>
        <p:nvSpPr>
          <p:cNvPr id="3" name="Zástupný symbol pro obsah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cs-CZ" smtClean="0"/>
              <a:t>Klep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cs-CZ"/>
          </a:p>
        </p:txBody>
      </p:sp>
      <p:sp>
        <p:nvSpPr>
          <p:cNvPr id="4" name="Zástupný symbol pro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EC1D4A-A796-47C3-A63E-CE236FB377E2}" type="datetimeFigureOut">
              <a:rPr lang="cs-CZ" smtClean="0"/>
              <a:t>4.2.2019</a:t>
            </a:fld>
            <a:endParaRPr lang="cs-CZ"/>
          </a:p>
        </p:txBody>
      </p:sp>
      <p:sp>
        <p:nvSpPr>
          <p:cNvPr id="5" name="Zástupný symbol pro zápatí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6" name="Zástupný symbol pro číslo snímk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57A5DF-1266-40EA-9282-1E66B9DE06C0}" type="slidenum">
              <a:rPr lang="cs-CZ" smtClean="0"/>
              <a:t>‹#›</a:t>
            </a:fld>
            <a:endParaRPr lang="cs-CZ"/>
          </a:p>
        </p:txBody>
      </p:sp>
    </p:spTree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4" y="1426284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it-IT" smtClean="0"/>
              <a:t>Fare clic sull'icona per inserire un'immagi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A6FC93-FDD0-403F-8843-6356E6050B4D}" type="datetimeFigureOut">
              <a:rPr lang="it-IT" smtClean="0">
                <a:solidFill>
                  <a:prstClr val="black">
                    <a:tint val="75000"/>
                  </a:prstClr>
                </a:solidFill>
              </a:rPr>
              <a:pPr/>
              <a:t>04/02/2019</a:t>
            </a:fld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C5521E-7460-4170-A51F-12B49DAD7A93}" type="slidenum">
              <a:rPr lang="it-IT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503578871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A6FC93-FDD0-403F-8843-6356E6050B4D}" type="datetimeFigureOut">
              <a:rPr lang="it-IT" smtClean="0">
                <a:solidFill>
                  <a:prstClr val="black">
                    <a:tint val="75000"/>
                  </a:prstClr>
                </a:solidFill>
              </a:rPr>
              <a:pPr/>
              <a:t>04/02/2019</a:t>
            </a:fld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C5521E-7460-4170-A51F-12B49DAD7A93}" type="slidenum">
              <a:rPr lang="it-IT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18736342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8" y="527403"/>
            <a:ext cx="1478756" cy="8394877"/>
          </a:xfrm>
        </p:spPr>
        <p:txBody>
          <a:bodyPr vert="eaVert"/>
          <a:lstStyle/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9" y="527403"/>
            <a:ext cx="4350544" cy="8394877"/>
          </a:xfrm>
        </p:spPr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A6FC93-FDD0-403F-8843-6356E6050B4D}" type="datetimeFigureOut">
              <a:rPr lang="it-IT" smtClean="0">
                <a:solidFill>
                  <a:prstClr val="black">
                    <a:tint val="75000"/>
                  </a:prstClr>
                </a:solidFill>
              </a:rPr>
              <a:pPr/>
              <a:t>04/02/2019</a:t>
            </a:fld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C5521E-7460-4170-A51F-12B49DAD7A93}" type="slidenum">
              <a:rPr lang="it-IT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3172713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Záhlaví čás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cs-CZ" smtClean="0"/>
              <a:t>Klepnutím lze upravit styl předlohy nadpisů.</a:t>
            </a:r>
            <a:endParaRPr lang="cs-CZ"/>
          </a:p>
        </p:txBody>
      </p:sp>
      <p:sp>
        <p:nvSpPr>
          <p:cNvPr id="3" name="Zástupný symbol pro text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cs-CZ" smtClean="0"/>
              <a:t>Klepnutím lze upravit styly předlohy textu.</a:t>
            </a:r>
          </a:p>
        </p:txBody>
      </p:sp>
      <p:sp>
        <p:nvSpPr>
          <p:cNvPr id="4" name="Zástupný symbol pro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EC1D4A-A796-47C3-A63E-CE236FB377E2}" type="datetimeFigureOut">
              <a:rPr lang="cs-CZ" smtClean="0"/>
              <a:t>4.2.2019</a:t>
            </a:fld>
            <a:endParaRPr lang="cs-CZ"/>
          </a:p>
        </p:txBody>
      </p:sp>
      <p:sp>
        <p:nvSpPr>
          <p:cNvPr id="5" name="Zástupný symbol pro zápatí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6" name="Zástupný symbol pro číslo snímk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57A5DF-1266-40EA-9282-1E66B9DE06C0}" type="slidenum">
              <a:rPr lang="cs-CZ" smtClean="0"/>
              <a:t>‹#›</a:t>
            </a:fld>
            <a:endParaRPr lang="cs-CZ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va obsah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s-CZ" smtClean="0"/>
              <a:t>Klepnutím lze upravit styl předlohy nadpisů.</a:t>
            </a:r>
            <a:endParaRPr lang="cs-CZ"/>
          </a:p>
        </p:txBody>
      </p:sp>
      <p:sp>
        <p:nvSpPr>
          <p:cNvPr id="3" name="Zástupný symbol pro obsah 2"/>
          <p:cNvSpPr>
            <a:spLocks noGrp="1"/>
          </p:cNvSpPr>
          <p:nvPr>
            <p:ph sz="half" idx="1"/>
          </p:nvPr>
        </p:nvSpPr>
        <p:spPr>
          <a:xfrm>
            <a:off x="342900" y="2311401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cs-CZ" smtClean="0"/>
              <a:t>Klep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cs-CZ"/>
          </a:p>
        </p:txBody>
      </p:sp>
      <p:sp>
        <p:nvSpPr>
          <p:cNvPr id="4" name="Zástupný symbol pro obsah 3"/>
          <p:cNvSpPr>
            <a:spLocks noGrp="1"/>
          </p:cNvSpPr>
          <p:nvPr>
            <p:ph sz="half" idx="2"/>
          </p:nvPr>
        </p:nvSpPr>
        <p:spPr>
          <a:xfrm>
            <a:off x="3486150" y="2311401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cs-CZ" smtClean="0"/>
              <a:t>Klep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cs-CZ"/>
          </a:p>
        </p:txBody>
      </p:sp>
      <p:sp>
        <p:nvSpPr>
          <p:cNvPr id="5" name="Zástupný symbol pro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EC1D4A-A796-47C3-A63E-CE236FB377E2}" type="datetimeFigureOut">
              <a:rPr lang="cs-CZ" smtClean="0"/>
              <a:t>4.2.2019</a:t>
            </a:fld>
            <a:endParaRPr lang="cs-CZ"/>
          </a:p>
        </p:txBody>
      </p:sp>
      <p:sp>
        <p:nvSpPr>
          <p:cNvPr id="6" name="Zástupný symbol pro zápatí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7" name="Zástupný symbol pro číslo snímku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57A5DF-1266-40EA-9282-1E66B9DE06C0}" type="slidenum">
              <a:rPr lang="cs-CZ" smtClean="0"/>
              <a:t>‹#›</a:t>
            </a:fld>
            <a:endParaRPr lang="cs-CZ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Porovnání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cs-CZ" smtClean="0"/>
              <a:t>Klepnutím lze upravit styl předlohy nadpisů.</a:t>
            </a:r>
            <a:endParaRPr lang="cs-CZ"/>
          </a:p>
        </p:txBody>
      </p:sp>
      <p:sp>
        <p:nvSpPr>
          <p:cNvPr id="3" name="Zástupný symbol pro text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cs-CZ" smtClean="0"/>
              <a:t>Klepnutím lze upravit styly předlohy textu.</a:t>
            </a:r>
          </a:p>
        </p:txBody>
      </p:sp>
      <p:sp>
        <p:nvSpPr>
          <p:cNvPr id="4" name="Zástupný symbol pro obsah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cs-CZ" smtClean="0"/>
              <a:t>Klep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cs-CZ"/>
          </a:p>
        </p:txBody>
      </p:sp>
      <p:sp>
        <p:nvSpPr>
          <p:cNvPr id="5" name="Zástupný symbol pro text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cs-CZ" smtClean="0"/>
              <a:t>Klepnutím lze upravit styly předlohy textu.</a:t>
            </a:r>
          </a:p>
        </p:txBody>
      </p:sp>
      <p:sp>
        <p:nvSpPr>
          <p:cNvPr id="6" name="Zástupný symbol pro obsah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cs-CZ" smtClean="0"/>
              <a:t>Klep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cs-CZ"/>
          </a:p>
        </p:txBody>
      </p:sp>
      <p:sp>
        <p:nvSpPr>
          <p:cNvPr id="7" name="Zástupný symbol pro datum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EC1D4A-A796-47C3-A63E-CE236FB377E2}" type="datetimeFigureOut">
              <a:rPr lang="cs-CZ" smtClean="0"/>
              <a:t>4.2.2019</a:t>
            </a:fld>
            <a:endParaRPr lang="cs-CZ"/>
          </a:p>
        </p:txBody>
      </p:sp>
      <p:sp>
        <p:nvSpPr>
          <p:cNvPr id="8" name="Zástupný symbol pro zápatí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9" name="Zástupný symbol pro číslo snímku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57A5DF-1266-40EA-9282-1E66B9DE06C0}" type="slidenum">
              <a:rPr lang="cs-CZ" smtClean="0"/>
              <a:t>‹#›</a:t>
            </a:fld>
            <a:endParaRPr lang="cs-CZ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Pouze nadp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s-CZ" smtClean="0"/>
              <a:t>Klepnutím lze upravit styl předlohy nadpisů.</a:t>
            </a:r>
            <a:endParaRPr lang="cs-CZ"/>
          </a:p>
        </p:txBody>
      </p:sp>
      <p:sp>
        <p:nvSpPr>
          <p:cNvPr id="3" name="Zástupný symbol pro datum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EC1D4A-A796-47C3-A63E-CE236FB377E2}" type="datetimeFigureOut">
              <a:rPr lang="cs-CZ" smtClean="0"/>
              <a:t>4.2.2019</a:t>
            </a:fld>
            <a:endParaRPr lang="cs-CZ"/>
          </a:p>
        </p:txBody>
      </p:sp>
      <p:sp>
        <p:nvSpPr>
          <p:cNvPr id="4" name="Zástupný symbol pro zápatí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5" name="Zástupný symbol pro číslo snímku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57A5DF-1266-40EA-9282-1E66B9DE06C0}" type="slidenum">
              <a:rPr lang="cs-CZ" smtClean="0"/>
              <a:t>‹#›</a:t>
            </a:fld>
            <a:endParaRPr lang="cs-CZ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Prázdn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ástupný symbol pro datum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EC1D4A-A796-47C3-A63E-CE236FB377E2}" type="datetimeFigureOut">
              <a:rPr lang="cs-CZ" smtClean="0"/>
              <a:t>4.2.2019</a:t>
            </a:fld>
            <a:endParaRPr lang="cs-CZ"/>
          </a:p>
        </p:txBody>
      </p:sp>
      <p:sp>
        <p:nvSpPr>
          <p:cNvPr id="3" name="Zástupný symbol pro zápatí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4" name="Zástupný symbol pro číslo snímku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57A5DF-1266-40EA-9282-1E66B9DE06C0}" type="slidenum">
              <a:rPr lang="cs-CZ" smtClean="0"/>
              <a:t>‹#›</a:t>
            </a:fld>
            <a:endParaRPr lang="cs-CZ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Obsah s titulk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cs-CZ" smtClean="0"/>
              <a:t>Klepnutím lze upravit styl předlohy nadpisů.</a:t>
            </a:r>
            <a:endParaRPr lang="cs-CZ"/>
          </a:p>
        </p:txBody>
      </p:sp>
      <p:sp>
        <p:nvSpPr>
          <p:cNvPr id="3" name="Zástupný symbol pro obsah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cs-CZ" smtClean="0"/>
              <a:t>Klep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cs-CZ"/>
          </a:p>
        </p:txBody>
      </p:sp>
      <p:sp>
        <p:nvSpPr>
          <p:cNvPr id="4" name="Zástupný symbol pro text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cs-CZ" smtClean="0"/>
              <a:t>Klepnutím lze upravit styly předlohy textu.</a:t>
            </a:r>
          </a:p>
        </p:txBody>
      </p:sp>
      <p:sp>
        <p:nvSpPr>
          <p:cNvPr id="5" name="Zástupný symbol pro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EC1D4A-A796-47C3-A63E-CE236FB377E2}" type="datetimeFigureOut">
              <a:rPr lang="cs-CZ" smtClean="0"/>
              <a:t>4.2.2019</a:t>
            </a:fld>
            <a:endParaRPr lang="cs-CZ"/>
          </a:p>
        </p:txBody>
      </p:sp>
      <p:sp>
        <p:nvSpPr>
          <p:cNvPr id="6" name="Zástupný symbol pro zápatí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7" name="Zástupný symbol pro číslo snímku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57A5DF-1266-40EA-9282-1E66B9DE06C0}" type="slidenum">
              <a:rPr lang="cs-CZ" smtClean="0"/>
              <a:t>‹#›</a:t>
            </a:fld>
            <a:endParaRPr lang="cs-CZ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Obrázek s titulk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cs-CZ" smtClean="0"/>
              <a:t>Klepnutím lze upravit styl předlohy nadpisů.</a:t>
            </a:r>
            <a:endParaRPr lang="cs-CZ"/>
          </a:p>
        </p:txBody>
      </p:sp>
      <p:sp>
        <p:nvSpPr>
          <p:cNvPr id="3" name="Zástupný symbol pro obrázek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cs-CZ"/>
          </a:p>
        </p:txBody>
      </p:sp>
      <p:sp>
        <p:nvSpPr>
          <p:cNvPr id="4" name="Zástupný symbol pro text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cs-CZ" smtClean="0"/>
              <a:t>Klepnutím lze upravit styly předlohy textu.</a:t>
            </a:r>
          </a:p>
        </p:txBody>
      </p:sp>
      <p:sp>
        <p:nvSpPr>
          <p:cNvPr id="5" name="Zástupný symbol pro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EC1D4A-A796-47C3-A63E-CE236FB377E2}" type="datetimeFigureOut">
              <a:rPr lang="cs-CZ" smtClean="0"/>
              <a:t>4.2.2019</a:t>
            </a:fld>
            <a:endParaRPr lang="cs-CZ"/>
          </a:p>
        </p:txBody>
      </p:sp>
      <p:sp>
        <p:nvSpPr>
          <p:cNvPr id="6" name="Zástupný symbol pro zápatí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7" name="Zástupný symbol pro číslo snímku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57A5DF-1266-40EA-9282-1E66B9DE06C0}" type="slidenum">
              <a:rPr lang="cs-CZ" smtClean="0"/>
              <a:t>‹#›</a:t>
            </a:fld>
            <a:endParaRPr lang="cs-CZ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19.xml"/><Relationship Id="rId3" Type="http://schemas.openxmlformats.org/officeDocument/2006/relationships/slideLayout" Target="../slideLayouts/slideLayout14.xml"/><Relationship Id="rId7" Type="http://schemas.openxmlformats.org/officeDocument/2006/relationships/slideLayout" Target="../slideLayouts/slideLayout18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13.xml"/><Relationship Id="rId1" Type="http://schemas.openxmlformats.org/officeDocument/2006/relationships/slideLayout" Target="../slideLayouts/slideLayout12.xml"/><Relationship Id="rId6" Type="http://schemas.openxmlformats.org/officeDocument/2006/relationships/slideLayout" Target="../slideLayouts/slideLayout17.xml"/><Relationship Id="rId11" Type="http://schemas.openxmlformats.org/officeDocument/2006/relationships/slideLayout" Target="../slideLayouts/slideLayout22.xml"/><Relationship Id="rId5" Type="http://schemas.openxmlformats.org/officeDocument/2006/relationships/slideLayout" Target="../slideLayouts/slideLayout16.xml"/><Relationship Id="rId10" Type="http://schemas.openxmlformats.org/officeDocument/2006/relationships/slideLayout" Target="../slideLayouts/slideLayout21.xml"/><Relationship Id="rId4" Type="http://schemas.openxmlformats.org/officeDocument/2006/relationships/slideLayout" Target="../slideLayouts/slideLayout15.xml"/><Relationship Id="rId9" Type="http://schemas.openxmlformats.org/officeDocument/2006/relationships/slideLayout" Target="../slideLayouts/slideLayout2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ástupný symbol pro nadpis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cs-CZ" smtClean="0"/>
              <a:t>Klepnutím lze upravit styl předlohy nadpisů.</a:t>
            </a:r>
            <a:endParaRPr lang="cs-CZ"/>
          </a:p>
        </p:txBody>
      </p:sp>
      <p:sp>
        <p:nvSpPr>
          <p:cNvPr id="3" name="Zástupný symbol pro text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cs-CZ" smtClean="0"/>
              <a:t>Klep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cs-CZ"/>
          </a:p>
        </p:txBody>
      </p:sp>
      <p:sp>
        <p:nvSpPr>
          <p:cNvPr id="4" name="Zástupný symbol pro datum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5EC1D4A-A796-47C3-A63E-CE236FB377E2}" type="datetimeFigureOut">
              <a:rPr lang="cs-CZ" smtClean="0"/>
              <a:t>4.2.2019</a:t>
            </a:fld>
            <a:endParaRPr lang="cs-CZ"/>
          </a:p>
        </p:txBody>
      </p:sp>
      <p:sp>
        <p:nvSpPr>
          <p:cNvPr id="5" name="Zástupný symbol pro zápatí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cs-CZ"/>
          </a:p>
        </p:txBody>
      </p:sp>
      <p:sp>
        <p:nvSpPr>
          <p:cNvPr id="6" name="Zástupný symbol pro číslo snímku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C57A5DF-1266-40EA-9282-1E66B9DE06C0}" type="slidenum">
              <a:rPr lang="cs-CZ" smtClean="0"/>
              <a:t>‹#›</a:t>
            </a:fld>
            <a:endParaRPr lang="cs-CZ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cs-CZ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8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0A6FC93-FDD0-403F-8843-6356E6050B4D}" type="datetimeFigureOut">
              <a:rPr lang="it-IT" smtClean="0">
                <a:solidFill>
                  <a:prstClr val="black">
                    <a:tint val="75000"/>
                  </a:prstClr>
                </a:solidFill>
              </a:rPr>
              <a:pPr/>
              <a:t>04/02/2019</a:t>
            </a:fld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8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8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AC5521E-7460-4170-A51F-12B49DAD7A93}" type="slidenum">
              <a:rPr lang="it-IT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566804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7" name="Rectangle 187"/>
          <p:cNvSpPr>
            <a:spLocks noChangeArrowheads="1"/>
          </p:cNvSpPr>
          <p:nvPr/>
        </p:nvSpPr>
        <p:spPr bwMode="auto">
          <a:xfrm>
            <a:off x="4508084" y="-29753"/>
            <a:ext cx="110433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r>
              <a:rPr lang="it-IT" altLang="it-IT" sz="1000" smtClean="0">
                <a:solidFill>
                  <a:srgbClr val="000000"/>
                </a:solidFill>
                <a:latin typeface="Helvetica" panose="020B0604020202020204" pitchFamily="34" charset="0"/>
              </a:rPr>
              <a:t> </a:t>
            </a:r>
            <a:endParaRPr lang="it-IT" altLang="it-IT" smtClean="0">
              <a:solidFill>
                <a:prstClr val="black"/>
              </a:solidFill>
            </a:endParaRPr>
          </a:p>
        </p:txBody>
      </p:sp>
      <p:cxnSp>
        <p:nvCxnSpPr>
          <p:cNvPr id="10" name="Straight Connector 9"/>
          <p:cNvCxnSpPr/>
          <p:nvPr/>
        </p:nvCxnSpPr>
        <p:spPr>
          <a:xfrm>
            <a:off x="5855368" y="1331493"/>
            <a:ext cx="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TextBox 13"/>
          <p:cNvSpPr txBox="1"/>
          <p:nvPr/>
        </p:nvSpPr>
        <p:spPr>
          <a:xfrm>
            <a:off x="306442" y="103893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solidFill>
                  <a:prstClr val="black"/>
                </a:solidFill>
              </a:rPr>
              <a:t>A</a:t>
            </a:r>
            <a:endParaRPr lang="en-US" b="1" dirty="0">
              <a:solidFill>
                <a:prstClr val="black"/>
              </a:solidFill>
            </a:endParaRPr>
          </a:p>
        </p:txBody>
      </p:sp>
      <p:sp>
        <p:nvSpPr>
          <p:cNvPr id="192" name="TextBox 191"/>
          <p:cNvSpPr txBox="1"/>
          <p:nvPr/>
        </p:nvSpPr>
        <p:spPr>
          <a:xfrm>
            <a:off x="3568558" y="72189"/>
            <a:ext cx="3145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solidFill>
                  <a:prstClr val="black"/>
                </a:solidFill>
              </a:rPr>
              <a:t>B</a:t>
            </a:r>
            <a:endParaRPr lang="en-US" b="1" dirty="0">
              <a:solidFill>
                <a:prstClr val="black"/>
              </a:solidFill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630571" y="103852"/>
            <a:ext cx="21644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solidFill>
                  <a:prstClr val="black"/>
                </a:solidFill>
              </a:rPr>
              <a:t>Δ GLP-1 and Δ c-peptide </a:t>
            </a:r>
            <a:r>
              <a:rPr lang="cs-CZ" sz="1400" b="1" dirty="0" smtClean="0">
                <a:solidFill>
                  <a:prstClr val="black"/>
                </a:solidFill>
              </a:rPr>
              <a:t> </a:t>
            </a:r>
            <a:endParaRPr lang="en-US" sz="1400" b="1" dirty="0">
              <a:solidFill>
                <a:prstClr val="black"/>
              </a:solidFill>
            </a:endParaRPr>
          </a:p>
        </p:txBody>
      </p:sp>
      <p:sp>
        <p:nvSpPr>
          <p:cNvPr id="53" name="TextBox 52"/>
          <p:cNvSpPr txBox="1"/>
          <p:nvPr/>
        </p:nvSpPr>
        <p:spPr>
          <a:xfrm>
            <a:off x="3877446" y="123070"/>
            <a:ext cx="216040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400" b="1" dirty="0" smtClean="0">
                <a:solidFill>
                  <a:prstClr val="black"/>
                </a:solidFill>
              </a:rPr>
              <a:t>Δ</a:t>
            </a:r>
            <a:r>
              <a:rPr lang="cs-CZ" sz="1400" b="1" dirty="0" smtClean="0">
                <a:solidFill>
                  <a:prstClr val="black"/>
                </a:solidFill>
              </a:rPr>
              <a:t> </a:t>
            </a:r>
            <a:r>
              <a:rPr lang="cs-CZ" sz="1400" b="1" dirty="0" err="1">
                <a:solidFill>
                  <a:prstClr val="black"/>
                </a:solidFill>
              </a:rPr>
              <a:t>a</a:t>
            </a:r>
            <a:r>
              <a:rPr lang="cs-CZ" sz="1400" b="1" dirty="0" err="1" smtClean="0">
                <a:solidFill>
                  <a:prstClr val="black"/>
                </a:solidFill>
              </a:rPr>
              <a:t>mylin</a:t>
            </a:r>
            <a:r>
              <a:rPr lang="cs-CZ" sz="1400" b="1" dirty="0" smtClean="0">
                <a:solidFill>
                  <a:prstClr val="black"/>
                </a:solidFill>
              </a:rPr>
              <a:t> and </a:t>
            </a:r>
            <a:r>
              <a:rPr lang="el-GR" sz="1400" b="1" dirty="0">
                <a:solidFill>
                  <a:prstClr val="black"/>
                </a:solidFill>
              </a:rPr>
              <a:t>Δ </a:t>
            </a:r>
            <a:r>
              <a:rPr lang="cs-CZ" sz="1400" b="1" dirty="0">
                <a:solidFill>
                  <a:prstClr val="black"/>
                </a:solidFill>
              </a:rPr>
              <a:t>c-peptide   </a:t>
            </a:r>
            <a:endParaRPr lang="en-US" sz="1400" b="1" dirty="0">
              <a:solidFill>
                <a:prstClr val="black"/>
              </a:solidFill>
            </a:endParaRPr>
          </a:p>
        </p:txBody>
      </p:sp>
      <p:graphicFrame>
        <p:nvGraphicFramePr>
          <p:cNvPr id="47" name="Graf 4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602304125"/>
              </p:ext>
            </p:extLst>
          </p:nvPr>
        </p:nvGraphicFramePr>
        <p:xfrm>
          <a:off x="3284984" y="411629"/>
          <a:ext cx="3384376" cy="316276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48" name="Graf 4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664260720"/>
              </p:ext>
            </p:extLst>
          </p:nvPr>
        </p:nvGraphicFramePr>
        <p:xfrm>
          <a:off x="0" y="395243"/>
          <a:ext cx="3573016" cy="311721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3" name="Obdélník 2"/>
          <p:cNvSpPr/>
          <p:nvPr/>
        </p:nvSpPr>
        <p:spPr>
          <a:xfrm>
            <a:off x="1227001" y="2495432"/>
            <a:ext cx="1250663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cs-CZ" sz="1200" dirty="0"/>
              <a:t>r=0.416, </a:t>
            </a:r>
            <a:r>
              <a:rPr lang="cs-CZ" sz="1200" dirty="0" smtClean="0"/>
              <a:t>p&lt;0.001</a:t>
            </a:r>
            <a:endParaRPr lang="cs-CZ" sz="1200" dirty="0"/>
          </a:p>
        </p:txBody>
      </p:sp>
      <p:sp>
        <p:nvSpPr>
          <p:cNvPr id="54" name="TextovéPole 4"/>
          <p:cNvSpPr txBox="1"/>
          <p:nvPr/>
        </p:nvSpPr>
        <p:spPr>
          <a:xfrm>
            <a:off x="4977077" y="2495432"/>
            <a:ext cx="4320540" cy="226695"/>
          </a:xfrm>
          <a:prstGeom prst="rect">
            <a:avLst/>
          </a:prstGeom>
          <a:noFill/>
          <a:ln w="9525" cmpd="sng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wrap="square" rtlCol="0" anchor="t"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cs-CZ" sz="1200" dirty="0"/>
              <a:t>r=0.829, </a:t>
            </a:r>
            <a:r>
              <a:rPr lang="cs-CZ" sz="1200" dirty="0" smtClean="0"/>
              <a:t>p&lt;0.001</a:t>
            </a:r>
            <a:endParaRPr lang="cs-CZ" sz="1200" dirty="0"/>
          </a:p>
        </p:txBody>
      </p:sp>
      <p:sp>
        <p:nvSpPr>
          <p:cNvPr id="16" name="TextBox 15"/>
          <p:cNvSpPr txBox="1"/>
          <p:nvPr/>
        </p:nvSpPr>
        <p:spPr>
          <a:xfrm>
            <a:off x="3537" y="3656856"/>
            <a:ext cx="68580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/>
              <a:t>Supplemental Figure 3. </a:t>
            </a:r>
            <a:r>
              <a:rPr lang="en-US" sz="1200" b="1" dirty="0"/>
              <a:t>Correlations of postprandial concentrations </a:t>
            </a:r>
            <a:r>
              <a:rPr lang="en-US" sz="1200" b="1" dirty="0" smtClean="0"/>
              <a:t>of </a:t>
            </a:r>
            <a:r>
              <a:rPr lang="en-US" sz="1200" b="1" dirty="0"/>
              <a:t>Δ GLP-1 </a:t>
            </a:r>
            <a:r>
              <a:rPr lang="en-US" sz="1200" b="1" dirty="0" smtClean="0"/>
              <a:t> </a:t>
            </a:r>
            <a:r>
              <a:rPr lang="en-US" sz="1200" b="1" dirty="0"/>
              <a:t>with Δ C-peptide and of Δ </a:t>
            </a:r>
            <a:r>
              <a:rPr lang="en-US" sz="1200" b="1" dirty="0" smtClean="0"/>
              <a:t>amylin </a:t>
            </a:r>
            <a:r>
              <a:rPr lang="en-US" sz="1200" b="1" smtClean="0"/>
              <a:t>with Δ </a:t>
            </a:r>
            <a:r>
              <a:rPr lang="en-US" sz="1200" b="1" dirty="0" smtClean="0"/>
              <a:t>C-peptide </a:t>
            </a:r>
            <a:r>
              <a:rPr lang="en-US" sz="1200" b="1" dirty="0"/>
              <a:t>(after both meals in </a:t>
            </a:r>
            <a:r>
              <a:rPr lang="en-US" sz="1200" b="1" dirty="0" smtClean="0"/>
              <a:t>all participants). </a:t>
            </a:r>
            <a:r>
              <a:rPr lang="en-US" sz="1200" dirty="0"/>
              <a:t>Spearman's correlations were calculated for the relationship between changes in concentrations of investigated parameters</a:t>
            </a:r>
            <a:r>
              <a:rPr lang="en-US" sz="1200" dirty="0" smtClean="0"/>
              <a:t>.</a:t>
            </a:r>
          </a:p>
        </p:txBody>
      </p:sp>
    </p:spTree>
    <p:extLst>
      <p:ext uri="{BB962C8B-B14F-4D97-AF65-F5344CB8AC3E}">
        <p14:creationId xmlns:p14="http://schemas.microsoft.com/office/powerpoint/2010/main" val="3010015950"/>
      </p:ext>
    </p:extLst>
  </p:cSld>
  <p:clrMapOvr>
    <a:masterClrMapping/>
  </p:clrMapOvr>
</p:sld>
</file>

<file path=ppt/theme/theme1.xml><?xml version="1.0" encoding="utf-8"?>
<a:theme xmlns:a="http://schemas.openxmlformats.org/drawingml/2006/main" name="Motiv sady Office">
  <a:themeElements>
    <a:clrScheme name="Kancelář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Kancelář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Kancelář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ema di Office">
  <a:themeElements>
    <a:clrScheme name="Tema di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i 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i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48</TotalTime>
  <Words>78</Words>
  <Application>Microsoft Office PowerPoint</Application>
  <PresentationFormat>A4 Paper (210x297 mm)</PresentationFormat>
  <Paragraphs>12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2</vt:i4>
      </vt:variant>
      <vt:variant>
        <vt:lpstr>Slide Titles</vt:lpstr>
      </vt:variant>
      <vt:variant>
        <vt:i4>1</vt:i4>
      </vt:variant>
    </vt:vector>
  </HeadingPairs>
  <TitlesOfParts>
    <vt:vector size="3" baseType="lpstr">
      <vt:lpstr>Motiv sady Office</vt:lpstr>
      <vt:lpstr>Tema di Offic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zentace aplikace PowerPoint</dc:title>
  <dc:creator>MUDr. Lenka Thieme, Ph.D.</dc:creator>
  <cp:lastModifiedBy>Hana Kahleova</cp:lastModifiedBy>
  <cp:revision>24</cp:revision>
  <dcterms:created xsi:type="dcterms:W3CDTF">2018-03-16T12:25:18Z</dcterms:created>
  <dcterms:modified xsi:type="dcterms:W3CDTF">2019-02-04T13:38:52Z</dcterms:modified>
</cp:coreProperties>
</file>